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Override PartName="/docProps/core.xml" ContentType="application/vnd.openxmlformats-package.core-propertie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Default Extension="png" ContentType="image/png"/>
  <Override PartName="/ppt/slides/slide1.xml" ContentType="application/vnd.openxmlformats-officedocument.presentationml.slide+xml"/>
  <Override PartName="/docProps/custom.xml" ContentType="application/vnd.openxmlformats-officedocument.custom-properties+xml"/>
</Types>
</file>

<file path=_rels/.rels><?xml version="1.0" encoding="UTF-8" standalone="yes"?>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officeDocument/2006/relationships/extended-properties" Target="docProps/app.xml"/><Relationship Id="rId3" Type="http://schemas.openxmlformats.org/package/2006/relationships/metadata/core-properties" Target="docProps/core.xml"/><Relationship Id="rId4" Type="http://schemas.openxmlformats.org/officeDocument/2006/relationships/custom-properties" Target="docProps/custom.xml"/></Relationships>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6"/>
  </p:sldIdLst>
  <p:sldSz cx="9144000" cy="6400800"/>
  <p:notesSz cx="9144000" cy="6400800"/>
  <p:defaultTextStyle>
    <a:defPPr>
      <a:defRPr kern="0"/>
    </a:def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theme" Target="theme/theme1.xml"/><Relationship Id="rId3" Type="http://schemas.openxmlformats.org/officeDocument/2006/relationships/viewProps" Target="viewProps.xml"/><Relationship Id="rId4" Type="http://schemas.openxmlformats.org/officeDocument/2006/relationships/presProps" Target="presProps.xml"/><Relationship Id="rId5" Type="http://schemas.openxmlformats.org/officeDocument/2006/relationships/tableStyles" Target="tableStyles.xml"/><Relationship Id="rId6" Type="http://schemas.openxmlformats.org/officeDocument/2006/relationships/slide" Target="slides/slide1.xml"/></Relationships>

</file>

<file path=ppt/slideLayouts/_rels/slideLayout1.xml.rels><?xml version="1.0" encoding="UTF-8" standalone="yes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2.xml.rels><?xml version="1.0" encoding="UTF-8" standalone="yes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3.xml.rels><?xml version="1.0" encoding="UTF-8" standalone="yes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4.xml.rels><?xml version="1.0" encoding="UTF-8" standalone="yes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_rels/slideLayout5.xml.rels><?xml version="1.0" encoding="UTF-8" standalone="yes"?>
<Relationships xmlns="http://schemas.openxmlformats.org/package/2006/relationships"><Relationship Id="rId1" Type="http://schemas.openxmlformats.org/officeDocument/2006/relationships/slideMaster" Target="../slideMasters/slideMaster1.xml"/></Relationships>
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1984248"/>
            <a:ext cx="7772400" cy="134416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584448"/>
            <a:ext cx="6400800" cy="1600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idx="2" sz="half"/>
          </p:nvPr>
        </p:nvSpPr>
        <p:spPr>
          <a:xfrm>
            <a:off x="457200" y="1472184"/>
            <a:ext cx="3977640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idx="3" sz="half"/>
          </p:nvPr>
        </p:nvSpPr>
        <p:spPr>
          <a:xfrm>
            <a:off x="4709160" y="1472184"/>
            <a:ext cx="3977640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7" name="Holder 7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5" name="Holder 5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type="obj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idx="5" sz="quarter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idx="6" sz="half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4" name="Holder 4"/>
          <p:cNvSpPr>
            <a:spLocks noGrp="1"/>
          </p:cNvSpPr>
          <p:nvPr>
            <p:ph type="sldNum" idx="7" sz="quarter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Ovr>
    <a:masterClrMapping/>
  </p:clrMapOvr>
</p:sldLayout>
</file>

<file path=ppt/slideMasters/_rels/slideMaster1.xml.rels><?xml version="1.0" encoding="UTF-8" standalone="yes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theme" Target="../theme/theme1.xml"/><Relationship Id="rId7" Type="http://schemas.openxmlformats.org/officeDocument/2006/relationships/image" Target="../media/image1.png"/></Relationships>
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g object 16"/>
          <p:cNvSpPr/>
          <p:nvPr/>
        </p:nvSpPr>
        <p:spPr>
          <a:xfrm>
            <a:off x="2758788" y="2696315"/>
            <a:ext cx="0" cy="215265"/>
          </a:xfrm>
          <a:custGeom>
            <a:avLst/>
            <a:gdLst/>
            <a:ahLst/>
            <a:cxnLst/>
            <a:rect l="l" t="t" r="r" b="b"/>
            <a:pathLst>
              <a:path w="0" h="215264">
                <a:moveTo>
                  <a:pt x="0" y="0"/>
                </a:moveTo>
                <a:lnTo>
                  <a:pt x="0" y="214863"/>
                </a:lnTo>
              </a:path>
            </a:pathLst>
          </a:custGeom>
          <a:ln w="22444">
            <a:solidFill>
              <a:srgbClr val="9D343C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" name="bg object 17"/>
          <p:cNvSpPr/>
          <p:nvPr/>
        </p:nvSpPr>
        <p:spPr>
          <a:xfrm>
            <a:off x="2719510" y="2895477"/>
            <a:ext cx="78740" cy="78740"/>
          </a:xfrm>
          <a:custGeom>
            <a:avLst/>
            <a:gdLst/>
            <a:ahLst/>
            <a:cxnLst/>
            <a:rect l="l" t="t" r="r" b="b"/>
            <a:pathLst>
              <a:path w="78739" h="78739">
                <a:moveTo>
                  <a:pt x="0" y="0"/>
                </a:moveTo>
                <a:lnTo>
                  <a:pt x="78554" y="0"/>
                </a:lnTo>
                <a:lnTo>
                  <a:pt x="39277" y="78554"/>
                </a:lnTo>
                <a:lnTo>
                  <a:pt x="0" y="0"/>
                </a:lnTo>
                <a:close/>
              </a:path>
            </a:pathLst>
          </a:custGeom>
          <a:solidFill>
            <a:srgbClr val="9D343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" name="bg object 18"/>
          <p:cNvSpPr/>
          <p:nvPr/>
        </p:nvSpPr>
        <p:spPr>
          <a:xfrm>
            <a:off x="2820109" y="1967815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0"/>
                </a:move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" name="bg object 19"/>
          <p:cNvSpPr/>
          <p:nvPr/>
        </p:nvSpPr>
        <p:spPr>
          <a:xfrm>
            <a:off x="2822609" y="1967670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0"/>
                </a:move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" name="bg object 20"/>
          <p:cNvSpPr/>
          <p:nvPr/>
        </p:nvSpPr>
        <p:spPr>
          <a:xfrm>
            <a:off x="2820109" y="2001100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0"/>
                </a:move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" name="bg object 21"/>
          <p:cNvSpPr/>
          <p:nvPr/>
        </p:nvSpPr>
        <p:spPr>
          <a:xfrm>
            <a:off x="2822609" y="2000955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0"/>
                </a:move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" name="bg object 22"/>
          <p:cNvSpPr/>
          <p:nvPr/>
        </p:nvSpPr>
        <p:spPr>
          <a:xfrm>
            <a:off x="2820109" y="2034385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0"/>
                </a:move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" name="bg object 23"/>
          <p:cNvSpPr/>
          <p:nvPr/>
        </p:nvSpPr>
        <p:spPr>
          <a:xfrm>
            <a:off x="2822609" y="2034241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0"/>
                </a:move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" name="bg object 24"/>
          <p:cNvSpPr/>
          <p:nvPr/>
        </p:nvSpPr>
        <p:spPr>
          <a:xfrm>
            <a:off x="2820109" y="2067670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0"/>
                </a:move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" name="bg object 25"/>
          <p:cNvSpPr/>
          <p:nvPr/>
        </p:nvSpPr>
        <p:spPr>
          <a:xfrm>
            <a:off x="2822609" y="2067527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0"/>
                </a:move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6" name="bg object 26"/>
          <p:cNvSpPr/>
          <p:nvPr/>
        </p:nvSpPr>
        <p:spPr>
          <a:xfrm>
            <a:off x="2812901" y="2100956"/>
            <a:ext cx="27940" cy="38100"/>
          </a:xfrm>
          <a:custGeom>
            <a:avLst/>
            <a:gdLst/>
            <a:ahLst/>
            <a:cxnLst/>
            <a:rect l="l" t="t" r="r" b="b"/>
            <a:pathLst>
              <a:path w="27939" h="38100">
                <a:moveTo>
                  <a:pt x="7207" y="0"/>
                </a:moveTo>
                <a:lnTo>
                  <a:pt x="27571" y="0"/>
                </a:lnTo>
                <a:lnTo>
                  <a:pt x="27571" y="5571"/>
                </a:lnTo>
                <a:lnTo>
                  <a:pt x="15194" y="38045"/>
                </a:lnTo>
                <a:lnTo>
                  <a:pt x="0" y="24487"/>
                </a:lnTo>
                <a:lnTo>
                  <a:pt x="1618" y="22502"/>
                </a:lnTo>
                <a:lnTo>
                  <a:pt x="2358" y="21457"/>
                </a:lnTo>
                <a:lnTo>
                  <a:pt x="7142" y="7502"/>
                </a:lnTo>
                <a:lnTo>
                  <a:pt x="7207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7" name="bg object 27"/>
          <p:cNvSpPr/>
          <p:nvPr/>
        </p:nvSpPr>
        <p:spPr>
          <a:xfrm>
            <a:off x="2814682" y="2100812"/>
            <a:ext cx="23495" cy="36830"/>
          </a:xfrm>
          <a:custGeom>
            <a:avLst/>
            <a:gdLst/>
            <a:ahLst/>
            <a:cxnLst/>
            <a:rect l="l" t="t" r="r" b="b"/>
            <a:pathLst>
              <a:path w="23494" h="36830">
                <a:moveTo>
                  <a:pt x="7927" y="0"/>
                </a:moveTo>
                <a:lnTo>
                  <a:pt x="23290" y="0"/>
                </a:lnTo>
                <a:lnTo>
                  <a:pt x="23290" y="5715"/>
                </a:lnTo>
                <a:lnTo>
                  <a:pt x="11420" y="36668"/>
                </a:lnTo>
                <a:lnTo>
                  <a:pt x="0" y="26392"/>
                </a:lnTo>
                <a:lnTo>
                  <a:pt x="1819" y="24172"/>
                </a:lnTo>
                <a:lnTo>
                  <a:pt x="2649" y="23002"/>
                </a:lnTo>
                <a:lnTo>
                  <a:pt x="7857" y="7814"/>
                </a:lnTo>
                <a:lnTo>
                  <a:pt x="7927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8" name="bg object 28"/>
          <p:cNvSpPr/>
          <p:nvPr/>
        </p:nvSpPr>
        <p:spPr>
          <a:xfrm>
            <a:off x="2790897" y="2125237"/>
            <a:ext cx="38100" cy="30480"/>
          </a:xfrm>
          <a:custGeom>
            <a:avLst/>
            <a:gdLst/>
            <a:ahLst/>
            <a:cxnLst/>
            <a:rect l="l" t="t" r="r" b="b"/>
            <a:pathLst>
              <a:path w="38100" h="30480">
                <a:moveTo>
                  <a:pt x="22187" y="0"/>
                </a:moveTo>
                <a:lnTo>
                  <a:pt x="37512" y="13411"/>
                </a:lnTo>
                <a:lnTo>
                  <a:pt x="35284" y="15792"/>
                </a:lnTo>
                <a:lnTo>
                  <a:pt x="33008" y="17927"/>
                </a:lnTo>
                <a:lnTo>
                  <a:pt x="0" y="30081"/>
                </a:lnTo>
                <a:lnTo>
                  <a:pt x="0" y="9718"/>
                </a:lnTo>
                <a:lnTo>
                  <a:pt x="2715" y="9653"/>
                </a:lnTo>
                <a:lnTo>
                  <a:pt x="4631" y="9461"/>
                </a:lnTo>
                <a:lnTo>
                  <a:pt x="19554" y="2641"/>
                </a:lnTo>
                <a:lnTo>
                  <a:pt x="22187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9" name="bg object 29"/>
          <p:cNvSpPr/>
          <p:nvPr/>
        </p:nvSpPr>
        <p:spPr>
          <a:xfrm>
            <a:off x="2790737" y="2126796"/>
            <a:ext cx="36195" cy="26034"/>
          </a:xfrm>
          <a:custGeom>
            <a:avLst/>
            <a:gdLst/>
            <a:ahLst/>
            <a:cxnLst/>
            <a:rect l="l" t="t" r="r" b="b"/>
            <a:pathLst>
              <a:path w="36194" h="26035">
                <a:moveTo>
                  <a:pt x="24305" y="0"/>
                </a:moveTo>
                <a:lnTo>
                  <a:pt x="35904" y="10074"/>
                </a:lnTo>
                <a:lnTo>
                  <a:pt x="33676" y="12465"/>
                </a:lnTo>
                <a:lnTo>
                  <a:pt x="31516" y="14491"/>
                </a:lnTo>
                <a:lnTo>
                  <a:pt x="0" y="26022"/>
                </a:lnTo>
                <a:lnTo>
                  <a:pt x="0" y="10659"/>
                </a:lnTo>
                <a:lnTo>
                  <a:pt x="3042" y="10589"/>
                </a:lnTo>
                <a:lnTo>
                  <a:pt x="5124" y="10380"/>
                </a:lnTo>
                <a:lnTo>
                  <a:pt x="23821" y="545"/>
                </a:lnTo>
                <a:lnTo>
                  <a:pt x="24305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bg object 30"/>
          <p:cNvSpPr/>
          <p:nvPr/>
        </p:nvSpPr>
        <p:spPr>
          <a:xfrm>
            <a:off x="2757612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60" y="0"/>
                </a:lnTo>
                <a:lnTo>
                  <a:pt x="33660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1" name="bg object 31"/>
          <p:cNvSpPr/>
          <p:nvPr/>
        </p:nvSpPr>
        <p:spPr>
          <a:xfrm>
            <a:off x="2757452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2" name="bg object 32"/>
          <p:cNvSpPr/>
          <p:nvPr/>
        </p:nvSpPr>
        <p:spPr>
          <a:xfrm>
            <a:off x="2724326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" name="bg object 33"/>
          <p:cNvSpPr/>
          <p:nvPr/>
        </p:nvSpPr>
        <p:spPr>
          <a:xfrm>
            <a:off x="2724166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4" name="bg object 34"/>
          <p:cNvSpPr/>
          <p:nvPr/>
        </p:nvSpPr>
        <p:spPr>
          <a:xfrm>
            <a:off x="2691041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5" name="bg object 35"/>
          <p:cNvSpPr/>
          <p:nvPr/>
        </p:nvSpPr>
        <p:spPr>
          <a:xfrm>
            <a:off x="2690881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6" name="bg object 36"/>
          <p:cNvSpPr/>
          <p:nvPr/>
        </p:nvSpPr>
        <p:spPr>
          <a:xfrm>
            <a:off x="2657756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7" name="bg object 37"/>
          <p:cNvSpPr/>
          <p:nvPr/>
        </p:nvSpPr>
        <p:spPr>
          <a:xfrm>
            <a:off x="2657595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5" y="0"/>
                </a:lnTo>
                <a:lnTo>
                  <a:pt x="33965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" name="bg object 38"/>
          <p:cNvSpPr/>
          <p:nvPr/>
        </p:nvSpPr>
        <p:spPr>
          <a:xfrm>
            <a:off x="2624470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60" y="0"/>
                </a:lnTo>
                <a:lnTo>
                  <a:pt x="33660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9" name="bg object 39"/>
          <p:cNvSpPr/>
          <p:nvPr/>
        </p:nvSpPr>
        <p:spPr>
          <a:xfrm>
            <a:off x="2624310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5" y="0"/>
                </a:lnTo>
                <a:lnTo>
                  <a:pt x="33965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0" name="bg object 40"/>
          <p:cNvSpPr/>
          <p:nvPr/>
        </p:nvSpPr>
        <p:spPr>
          <a:xfrm>
            <a:off x="2591185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60" y="0"/>
                </a:lnTo>
                <a:lnTo>
                  <a:pt x="33660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" name="bg object 41"/>
          <p:cNvSpPr/>
          <p:nvPr/>
        </p:nvSpPr>
        <p:spPr>
          <a:xfrm>
            <a:off x="2591025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" name="bg object 42"/>
          <p:cNvSpPr/>
          <p:nvPr/>
        </p:nvSpPr>
        <p:spPr>
          <a:xfrm>
            <a:off x="2557900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60" y="0"/>
                </a:lnTo>
                <a:lnTo>
                  <a:pt x="33660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3" name="bg object 43"/>
          <p:cNvSpPr/>
          <p:nvPr/>
        </p:nvSpPr>
        <p:spPr>
          <a:xfrm>
            <a:off x="2557740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" name="bg object 44"/>
          <p:cNvSpPr/>
          <p:nvPr/>
        </p:nvSpPr>
        <p:spPr>
          <a:xfrm>
            <a:off x="2524615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" name="bg object 45"/>
          <p:cNvSpPr/>
          <p:nvPr/>
        </p:nvSpPr>
        <p:spPr>
          <a:xfrm>
            <a:off x="2524455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" name="bg object 46"/>
          <p:cNvSpPr/>
          <p:nvPr/>
        </p:nvSpPr>
        <p:spPr>
          <a:xfrm>
            <a:off x="2491330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" name="bg object 47"/>
          <p:cNvSpPr/>
          <p:nvPr/>
        </p:nvSpPr>
        <p:spPr>
          <a:xfrm>
            <a:off x="2491170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8" name="bg object 48"/>
          <p:cNvSpPr/>
          <p:nvPr/>
        </p:nvSpPr>
        <p:spPr>
          <a:xfrm>
            <a:off x="2458045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9" name="bg object 49"/>
          <p:cNvSpPr/>
          <p:nvPr/>
        </p:nvSpPr>
        <p:spPr>
          <a:xfrm>
            <a:off x="2457884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5" y="0"/>
                </a:lnTo>
                <a:lnTo>
                  <a:pt x="33965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" name="bg object 50"/>
          <p:cNvSpPr/>
          <p:nvPr/>
        </p:nvSpPr>
        <p:spPr>
          <a:xfrm>
            <a:off x="2424760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59" y="0"/>
                </a:lnTo>
                <a:lnTo>
                  <a:pt x="33659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1" name="bg object 51"/>
          <p:cNvSpPr/>
          <p:nvPr/>
        </p:nvSpPr>
        <p:spPr>
          <a:xfrm>
            <a:off x="2424599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5" y="0"/>
                </a:lnTo>
                <a:lnTo>
                  <a:pt x="33965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" name="bg object 52"/>
          <p:cNvSpPr/>
          <p:nvPr/>
        </p:nvSpPr>
        <p:spPr>
          <a:xfrm>
            <a:off x="2391473" y="2134955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0" y="0"/>
                </a:moveTo>
                <a:lnTo>
                  <a:pt x="33660" y="0"/>
                </a:lnTo>
                <a:lnTo>
                  <a:pt x="33660" y="20363"/>
                </a:lnTo>
                <a:lnTo>
                  <a:pt x="0" y="20363"/>
                </a:lnTo>
                <a:lnTo>
                  <a:pt x="0" y="0"/>
                </a:lnTo>
                <a:close/>
              </a:path>
            </a:pathLst>
          </a:custGeom>
          <a:solidFill>
            <a:srgbClr val="315482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3" name="bg object 53"/>
          <p:cNvSpPr/>
          <p:nvPr/>
        </p:nvSpPr>
        <p:spPr>
          <a:xfrm>
            <a:off x="2391313" y="2137455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0" y="0"/>
                </a:moveTo>
                <a:lnTo>
                  <a:pt x="33964" y="0"/>
                </a:lnTo>
                <a:lnTo>
                  <a:pt x="33964" y="15362"/>
                </a:lnTo>
                <a:lnTo>
                  <a:pt x="0" y="15362"/>
                </a:lnTo>
                <a:lnTo>
                  <a:pt x="0" y="0"/>
                </a:lnTo>
                <a:close/>
              </a:path>
            </a:pathLst>
          </a:custGeom>
          <a:solidFill>
            <a:srgbClr val="B4C1D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4" name="bg object 54"/>
          <p:cNvSpPr/>
          <p:nvPr/>
        </p:nvSpPr>
        <p:spPr>
          <a:xfrm>
            <a:off x="2284849" y="1106384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5" name="bg object 55"/>
          <p:cNvSpPr/>
          <p:nvPr/>
        </p:nvSpPr>
        <p:spPr>
          <a:xfrm>
            <a:off x="2287349" y="1106239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6" name="bg object 56"/>
          <p:cNvSpPr/>
          <p:nvPr/>
        </p:nvSpPr>
        <p:spPr>
          <a:xfrm>
            <a:off x="2284849" y="1139669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7" name="bg object 57"/>
          <p:cNvSpPr/>
          <p:nvPr/>
        </p:nvSpPr>
        <p:spPr>
          <a:xfrm>
            <a:off x="2287349" y="1139525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8" name="bg object 58"/>
          <p:cNvSpPr/>
          <p:nvPr/>
        </p:nvSpPr>
        <p:spPr>
          <a:xfrm>
            <a:off x="2284849" y="1172954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9" name="bg object 59"/>
          <p:cNvSpPr/>
          <p:nvPr/>
        </p:nvSpPr>
        <p:spPr>
          <a:xfrm>
            <a:off x="2287349" y="1172811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" name="bg object 60"/>
          <p:cNvSpPr/>
          <p:nvPr/>
        </p:nvSpPr>
        <p:spPr>
          <a:xfrm>
            <a:off x="2284849" y="1206240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" name="bg object 61"/>
          <p:cNvSpPr/>
          <p:nvPr/>
        </p:nvSpPr>
        <p:spPr>
          <a:xfrm>
            <a:off x="2287349" y="1206096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2" name="bg object 62"/>
          <p:cNvSpPr/>
          <p:nvPr/>
        </p:nvSpPr>
        <p:spPr>
          <a:xfrm>
            <a:off x="2284849" y="1239525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3" name="bg object 63"/>
          <p:cNvSpPr/>
          <p:nvPr/>
        </p:nvSpPr>
        <p:spPr>
          <a:xfrm>
            <a:off x="2287349" y="1239381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4" name="bg object 64"/>
          <p:cNvSpPr/>
          <p:nvPr/>
        </p:nvSpPr>
        <p:spPr>
          <a:xfrm>
            <a:off x="2284849" y="1272811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5" name="bg object 65"/>
          <p:cNvSpPr/>
          <p:nvPr/>
        </p:nvSpPr>
        <p:spPr>
          <a:xfrm>
            <a:off x="2287349" y="1272666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6" name="bg object 66"/>
          <p:cNvSpPr/>
          <p:nvPr/>
        </p:nvSpPr>
        <p:spPr>
          <a:xfrm>
            <a:off x="2284849" y="1306096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7" name="bg object 67"/>
          <p:cNvSpPr/>
          <p:nvPr/>
        </p:nvSpPr>
        <p:spPr>
          <a:xfrm>
            <a:off x="2287349" y="1305951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8" name="bg object 68"/>
          <p:cNvSpPr/>
          <p:nvPr/>
        </p:nvSpPr>
        <p:spPr>
          <a:xfrm>
            <a:off x="2284849" y="1339381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9" name="bg object 69"/>
          <p:cNvSpPr/>
          <p:nvPr/>
        </p:nvSpPr>
        <p:spPr>
          <a:xfrm>
            <a:off x="2287349" y="1339236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0" name="bg object 70"/>
          <p:cNvSpPr/>
          <p:nvPr/>
        </p:nvSpPr>
        <p:spPr>
          <a:xfrm>
            <a:off x="2284849" y="1372666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" name="bg object 71"/>
          <p:cNvSpPr/>
          <p:nvPr/>
        </p:nvSpPr>
        <p:spPr>
          <a:xfrm>
            <a:off x="2287349" y="1372521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2" name="bg object 72"/>
          <p:cNvSpPr/>
          <p:nvPr/>
        </p:nvSpPr>
        <p:spPr>
          <a:xfrm>
            <a:off x="2284849" y="1405951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3" name="bg object 73"/>
          <p:cNvSpPr/>
          <p:nvPr/>
        </p:nvSpPr>
        <p:spPr>
          <a:xfrm>
            <a:off x="2287349" y="1405807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4" name="bg object 74"/>
          <p:cNvSpPr/>
          <p:nvPr/>
        </p:nvSpPr>
        <p:spPr>
          <a:xfrm>
            <a:off x="2284849" y="1439236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5" name="bg object 75"/>
          <p:cNvSpPr/>
          <p:nvPr/>
        </p:nvSpPr>
        <p:spPr>
          <a:xfrm>
            <a:off x="2287349" y="1439092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6" name="bg object 76"/>
          <p:cNvSpPr/>
          <p:nvPr/>
        </p:nvSpPr>
        <p:spPr>
          <a:xfrm>
            <a:off x="2284849" y="1472521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7" name="bg object 77"/>
          <p:cNvSpPr/>
          <p:nvPr/>
        </p:nvSpPr>
        <p:spPr>
          <a:xfrm>
            <a:off x="2287349" y="1472378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" name="bg object 78"/>
          <p:cNvSpPr/>
          <p:nvPr/>
        </p:nvSpPr>
        <p:spPr>
          <a:xfrm>
            <a:off x="2284849" y="1505807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9" name="bg object 79"/>
          <p:cNvSpPr/>
          <p:nvPr/>
        </p:nvSpPr>
        <p:spPr>
          <a:xfrm>
            <a:off x="2287349" y="1505663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" name="bg object 80"/>
          <p:cNvSpPr/>
          <p:nvPr/>
        </p:nvSpPr>
        <p:spPr>
          <a:xfrm>
            <a:off x="2284849" y="1539093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1" name="bg object 81"/>
          <p:cNvSpPr/>
          <p:nvPr/>
        </p:nvSpPr>
        <p:spPr>
          <a:xfrm>
            <a:off x="2287349" y="1538948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" name="bg object 82"/>
          <p:cNvSpPr/>
          <p:nvPr/>
        </p:nvSpPr>
        <p:spPr>
          <a:xfrm>
            <a:off x="2284849" y="1572378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3" name="bg object 83"/>
          <p:cNvSpPr/>
          <p:nvPr/>
        </p:nvSpPr>
        <p:spPr>
          <a:xfrm>
            <a:off x="2287349" y="1572233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90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4" name="bg object 84"/>
          <p:cNvSpPr/>
          <p:nvPr/>
        </p:nvSpPr>
        <p:spPr>
          <a:xfrm>
            <a:off x="2284849" y="1605663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5" name="bg object 85"/>
          <p:cNvSpPr/>
          <p:nvPr/>
        </p:nvSpPr>
        <p:spPr>
          <a:xfrm>
            <a:off x="2287349" y="1605518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6" name="bg object 86"/>
          <p:cNvSpPr/>
          <p:nvPr/>
        </p:nvSpPr>
        <p:spPr>
          <a:xfrm>
            <a:off x="2284849" y="1638948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" name="bg object 87"/>
          <p:cNvSpPr/>
          <p:nvPr/>
        </p:nvSpPr>
        <p:spPr>
          <a:xfrm>
            <a:off x="2287349" y="1638804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8" name="bg object 88"/>
          <p:cNvSpPr/>
          <p:nvPr/>
        </p:nvSpPr>
        <p:spPr>
          <a:xfrm>
            <a:off x="2284849" y="1672233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60"/>
                </a:moveTo>
                <a:lnTo>
                  <a:pt x="0" y="0"/>
                </a:lnTo>
                <a:lnTo>
                  <a:pt x="20363" y="0"/>
                </a:lnTo>
                <a:lnTo>
                  <a:pt x="20363" y="33660"/>
                </a:lnTo>
                <a:lnTo>
                  <a:pt x="0" y="33660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9" name="bg object 89"/>
          <p:cNvSpPr/>
          <p:nvPr/>
        </p:nvSpPr>
        <p:spPr>
          <a:xfrm>
            <a:off x="2287349" y="1672089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0" name="bg object 90"/>
          <p:cNvSpPr/>
          <p:nvPr/>
        </p:nvSpPr>
        <p:spPr>
          <a:xfrm>
            <a:off x="2284849" y="1705519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" name="bg object 91"/>
          <p:cNvSpPr/>
          <p:nvPr/>
        </p:nvSpPr>
        <p:spPr>
          <a:xfrm>
            <a:off x="2287349" y="1705374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2" name="bg object 92"/>
          <p:cNvSpPr/>
          <p:nvPr/>
        </p:nvSpPr>
        <p:spPr>
          <a:xfrm>
            <a:off x="2284849" y="1738804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3" name="bg object 93"/>
          <p:cNvSpPr/>
          <p:nvPr/>
        </p:nvSpPr>
        <p:spPr>
          <a:xfrm>
            <a:off x="2287349" y="1738659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4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4"/>
                </a:lnTo>
                <a:lnTo>
                  <a:pt x="0" y="33964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4" name="bg object 94"/>
          <p:cNvSpPr/>
          <p:nvPr/>
        </p:nvSpPr>
        <p:spPr>
          <a:xfrm>
            <a:off x="2284849" y="1772089"/>
            <a:ext cx="20955" cy="33655"/>
          </a:xfrm>
          <a:custGeom>
            <a:avLst/>
            <a:gdLst/>
            <a:ahLst/>
            <a:cxnLst/>
            <a:rect l="l" t="t" r="r" b="b"/>
            <a:pathLst>
              <a:path w="20955" h="33655">
                <a:moveTo>
                  <a:pt x="0" y="33659"/>
                </a:moveTo>
                <a:lnTo>
                  <a:pt x="0" y="0"/>
                </a:lnTo>
                <a:lnTo>
                  <a:pt x="20363" y="0"/>
                </a:lnTo>
                <a:lnTo>
                  <a:pt x="20363" y="33659"/>
                </a:lnTo>
                <a:lnTo>
                  <a:pt x="0" y="33659"/>
                </a:lnTo>
                <a:close/>
              </a:path>
            </a:pathLst>
          </a:custGeom>
          <a:solidFill>
            <a:srgbClr val="BB5D74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" name="bg object 95"/>
          <p:cNvSpPr/>
          <p:nvPr/>
        </p:nvSpPr>
        <p:spPr>
          <a:xfrm>
            <a:off x="2287349" y="1771945"/>
            <a:ext cx="15875" cy="34290"/>
          </a:xfrm>
          <a:custGeom>
            <a:avLst/>
            <a:gdLst/>
            <a:ahLst/>
            <a:cxnLst/>
            <a:rect l="l" t="t" r="r" b="b"/>
            <a:pathLst>
              <a:path w="15875" h="34289">
                <a:moveTo>
                  <a:pt x="0" y="33965"/>
                </a:moveTo>
                <a:lnTo>
                  <a:pt x="0" y="0"/>
                </a:lnTo>
                <a:lnTo>
                  <a:pt x="15362" y="0"/>
                </a:lnTo>
                <a:lnTo>
                  <a:pt x="15362" y="33965"/>
                </a:lnTo>
                <a:lnTo>
                  <a:pt x="0" y="33965"/>
                </a:lnTo>
                <a:close/>
              </a:path>
            </a:pathLst>
          </a:custGeom>
          <a:solidFill>
            <a:srgbClr val="EAC8C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6" name="bg object 96"/>
          <p:cNvSpPr/>
          <p:nvPr/>
        </p:nvSpPr>
        <p:spPr>
          <a:xfrm>
            <a:off x="1636555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" name="bg object 97"/>
          <p:cNvSpPr/>
          <p:nvPr/>
        </p:nvSpPr>
        <p:spPr>
          <a:xfrm>
            <a:off x="1636410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5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5" y="0"/>
                </a:lnTo>
                <a:lnTo>
                  <a:pt x="33965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8" name="bg object 98"/>
          <p:cNvSpPr/>
          <p:nvPr/>
        </p:nvSpPr>
        <p:spPr>
          <a:xfrm>
            <a:off x="1669840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9" name="bg object 99"/>
          <p:cNvSpPr/>
          <p:nvPr/>
        </p:nvSpPr>
        <p:spPr>
          <a:xfrm>
            <a:off x="1669697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0" name="bg object 100"/>
          <p:cNvSpPr/>
          <p:nvPr/>
        </p:nvSpPr>
        <p:spPr>
          <a:xfrm>
            <a:off x="1703125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1" name="bg object 101"/>
          <p:cNvSpPr/>
          <p:nvPr/>
        </p:nvSpPr>
        <p:spPr>
          <a:xfrm>
            <a:off x="1702982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" name="bg object 102"/>
          <p:cNvSpPr/>
          <p:nvPr/>
        </p:nvSpPr>
        <p:spPr>
          <a:xfrm>
            <a:off x="1736411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" name="bg object 103"/>
          <p:cNvSpPr/>
          <p:nvPr/>
        </p:nvSpPr>
        <p:spPr>
          <a:xfrm>
            <a:off x="1736267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4" name="bg object 104"/>
          <p:cNvSpPr/>
          <p:nvPr/>
        </p:nvSpPr>
        <p:spPr>
          <a:xfrm>
            <a:off x="1769697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5" name="bg object 105"/>
          <p:cNvSpPr/>
          <p:nvPr/>
        </p:nvSpPr>
        <p:spPr>
          <a:xfrm>
            <a:off x="1769552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6" name="bg object 106"/>
          <p:cNvSpPr/>
          <p:nvPr/>
        </p:nvSpPr>
        <p:spPr>
          <a:xfrm>
            <a:off x="1802982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" name="bg object 107"/>
          <p:cNvSpPr/>
          <p:nvPr/>
        </p:nvSpPr>
        <p:spPr>
          <a:xfrm>
            <a:off x="1802837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8" name="bg object 108"/>
          <p:cNvSpPr/>
          <p:nvPr/>
        </p:nvSpPr>
        <p:spPr>
          <a:xfrm>
            <a:off x="1836267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9" name="bg object 109"/>
          <p:cNvSpPr/>
          <p:nvPr/>
        </p:nvSpPr>
        <p:spPr>
          <a:xfrm>
            <a:off x="1836122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5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5" y="0"/>
                </a:lnTo>
                <a:lnTo>
                  <a:pt x="33965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0" name="bg object 110"/>
          <p:cNvSpPr/>
          <p:nvPr/>
        </p:nvSpPr>
        <p:spPr>
          <a:xfrm>
            <a:off x="1869552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" name="bg object 111"/>
          <p:cNvSpPr/>
          <p:nvPr/>
        </p:nvSpPr>
        <p:spPr>
          <a:xfrm>
            <a:off x="1869407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5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5" y="0"/>
                </a:lnTo>
                <a:lnTo>
                  <a:pt x="33965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2" name="bg object 112"/>
          <p:cNvSpPr/>
          <p:nvPr/>
        </p:nvSpPr>
        <p:spPr>
          <a:xfrm>
            <a:off x="1902837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3" name="bg object 113"/>
          <p:cNvSpPr/>
          <p:nvPr/>
        </p:nvSpPr>
        <p:spPr>
          <a:xfrm>
            <a:off x="1902693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4" name="bg object 114"/>
          <p:cNvSpPr/>
          <p:nvPr/>
        </p:nvSpPr>
        <p:spPr>
          <a:xfrm>
            <a:off x="1936122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5" name="bg object 115"/>
          <p:cNvSpPr/>
          <p:nvPr/>
        </p:nvSpPr>
        <p:spPr>
          <a:xfrm>
            <a:off x="1935978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6" name="bg object 116"/>
          <p:cNvSpPr/>
          <p:nvPr/>
        </p:nvSpPr>
        <p:spPr>
          <a:xfrm>
            <a:off x="1969407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7" name="bg object 117"/>
          <p:cNvSpPr/>
          <p:nvPr/>
        </p:nvSpPr>
        <p:spPr>
          <a:xfrm>
            <a:off x="1969264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" name="bg object 118"/>
          <p:cNvSpPr/>
          <p:nvPr/>
        </p:nvSpPr>
        <p:spPr>
          <a:xfrm>
            <a:off x="2002693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" name="bg object 119"/>
          <p:cNvSpPr/>
          <p:nvPr/>
        </p:nvSpPr>
        <p:spPr>
          <a:xfrm>
            <a:off x="2002549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" name="bg object 120"/>
          <p:cNvSpPr/>
          <p:nvPr/>
        </p:nvSpPr>
        <p:spPr>
          <a:xfrm>
            <a:off x="2035978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" name="bg object 121"/>
          <p:cNvSpPr/>
          <p:nvPr/>
        </p:nvSpPr>
        <p:spPr>
          <a:xfrm>
            <a:off x="2035834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5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5" y="0"/>
                </a:lnTo>
                <a:lnTo>
                  <a:pt x="33965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" name="bg object 122"/>
          <p:cNvSpPr/>
          <p:nvPr/>
        </p:nvSpPr>
        <p:spPr>
          <a:xfrm>
            <a:off x="2069264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" name="bg object 123"/>
          <p:cNvSpPr/>
          <p:nvPr/>
        </p:nvSpPr>
        <p:spPr>
          <a:xfrm>
            <a:off x="2069119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5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5" y="0"/>
                </a:lnTo>
                <a:lnTo>
                  <a:pt x="33965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" name="bg object 124"/>
          <p:cNvSpPr/>
          <p:nvPr/>
        </p:nvSpPr>
        <p:spPr>
          <a:xfrm>
            <a:off x="2102549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" name="bg object 125"/>
          <p:cNvSpPr/>
          <p:nvPr/>
        </p:nvSpPr>
        <p:spPr>
          <a:xfrm>
            <a:off x="2102405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" name="bg object 126"/>
          <p:cNvSpPr/>
          <p:nvPr/>
        </p:nvSpPr>
        <p:spPr>
          <a:xfrm>
            <a:off x="2135834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" name="bg object 127"/>
          <p:cNvSpPr/>
          <p:nvPr/>
        </p:nvSpPr>
        <p:spPr>
          <a:xfrm>
            <a:off x="2135690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" name="bg object 128"/>
          <p:cNvSpPr/>
          <p:nvPr/>
        </p:nvSpPr>
        <p:spPr>
          <a:xfrm>
            <a:off x="2169119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60" y="20363"/>
                </a:moveTo>
                <a:lnTo>
                  <a:pt x="0" y="20363"/>
                </a:lnTo>
                <a:lnTo>
                  <a:pt x="0" y="0"/>
                </a:lnTo>
                <a:lnTo>
                  <a:pt x="33660" y="0"/>
                </a:lnTo>
                <a:lnTo>
                  <a:pt x="33660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" name="bg object 129"/>
          <p:cNvSpPr/>
          <p:nvPr/>
        </p:nvSpPr>
        <p:spPr>
          <a:xfrm>
            <a:off x="2168975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" name="bg object 130"/>
          <p:cNvSpPr/>
          <p:nvPr/>
        </p:nvSpPr>
        <p:spPr>
          <a:xfrm>
            <a:off x="2202405" y="1939379"/>
            <a:ext cx="33655" cy="20955"/>
          </a:xfrm>
          <a:custGeom>
            <a:avLst/>
            <a:gdLst/>
            <a:ahLst/>
            <a:cxnLst/>
            <a:rect l="l" t="t" r="r" b="b"/>
            <a:pathLst>
              <a:path w="33655" h="20955">
                <a:moveTo>
                  <a:pt x="33659" y="20363"/>
                </a:moveTo>
                <a:lnTo>
                  <a:pt x="0" y="20363"/>
                </a:lnTo>
                <a:lnTo>
                  <a:pt x="0" y="0"/>
                </a:lnTo>
                <a:lnTo>
                  <a:pt x="33659" y="0"/>
                </a:lnTo>
                <a:lnTo>
                  <a:pt x="33659" y="20363"/>
                </a:lnTo>
                <a:close/>
              </a:path>
            </a:pathLst>
          </a:custGeom>
          <a:solidFill>
            <a:srgbClr val="707171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" name="bg object 131"/>
          <p:cNvSpPr/>
          <p:nvPr/>
        </p:nvSpPr>
        <p:spPr>
          <a:xfrm>
            <a:off x="2202260" y="1941879"/>
            <a:ext cx="34290" cy="15875"/>
          </a:xfrm>
          <a:custGeom>
            <a:avLst/>
            <a:gdLst/>
            <a:ahLst/>
            <a:cxnLst/>
            <a:rect l="l" t="t" r="r" b="b"/>
            <a:pathLst>
              <a:path w="34289" h="15875">
                <a:moveTo>
                  <a:pt x="33964" y="15362"/>
                </a:moveTo>
                <a:lnTo>
                  <a:pt x="0" y="15362"/>
                </a:lnTo>
                <a:lnTo>
                  <a:pt x="0" y="0"/>
                </a:lnTo>
                <a:lnTo>
                  <a:pt x="33964" y="0"/>
                </a:lnTo>
                <a:lnTo>
                  <a:pt x="33964" y="15362"/>
                </a:lnTo>
                <a:close/>
              </a:path>
            </a:pathLst>
          </a:custGeom>
          <a:solidFill>
            <a:srgbClr val="CECDCC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" name="bg object 132"/>
          <p:cNvSpPr/>
          <p:nvPr/>
        </p:nvSpPr>
        <p:spPr>
          <a:xfrm>
            <a:off x="2361222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" name="bg object 133"/>
          <p:cNvSpPr/>
          <p:nvPr/>
        </p:nvSpPr>
        <p:spPr>
          <a:xfrm>
            <a:off x="2361080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" name="bg object 134"/>
          <p:cNvSpPr/>
          <p:nvPr/>
        </p:nvSpPr>
        <p:spPr>
          <a:xfrm>
            <a:off x="2393898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" name="bg object 135"/>
          <p:cNvSpPr/>
          <p:nvPr/>
        </p:nvSpPr>
        <p:spPr>
          <a:xfrm>
            <a:off x="2393756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" name="bg object 136"/>
          <p:cNvSpPr/>
          <p:nvPr/>
        </p:nvSpPr>
        <p:spPr>
          <a:xfrm>
            <a:off x="2426573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" name="bg object 137"/>
          <p:cNvSpPr/>
          <p:nvPr/>
        </p:nvSpPr>
        <p:spPr>
          <a:xfrm>
            <a:off x="2426431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" name="bg object 138"/>
          <p:cNvSpPr/>
          <p:nvPr/>
        </p:nvSpPr>
        <p:spPr>
          <a:xfrm>
            <a:off x="2459249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" name="bg object 139"/>
          <p:cNvSpPr/>
          <p:nvPr/>
        </p:nvSpPr>
        <p:spPr>
          <a:xfrm>
            <a:off x="2459107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" name="bg object 140"/>
          <p:cNvSpPr/>
          <p:nvPr/>
        </p:nvSpPr>
        <p:spPr>
          <a:xfrm>
            <a:off x="2491924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" name="bg object 141"/>
          <p:cNvSpPr/>
          <p:nvPr/>
        </p:nvSpPr>
        <p:spPr>
          <a:xfrm>
            <a:off x="2491782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" name="bg object 142"/>
          <p:cNvSpPr/>
          <p:nvPr/>
        </p:nvSpPr>
        <p:spPr>
          <a:xfrm>
            <a:off x="2524600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" name="bg object 143"/>
          <p:cNvSpPr/>
          <p:nvPr/>
        </p:nvSpPr>
        <p:spPr>
          <a:xfrm>
            <a:off x="2524459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" name="bg object 144"/>
          <p:cNvSpPr/>
          <p:nvPr/>
        </p:nvSpPr>
        <p:spPr>
          <a:xfrm>
            <a:off x="2557276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" name="bg object 145"/>
          <p:cNvSpPr/>
          <p:nvPr/>
        </p:nvSpPr>
        <p:spPr>
          <a:xfrm>
            <a:off x="2557134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" name="bg object 146"/>
          <p:cNvSpPr/>
          <p:nvPr/>
        </p:nvSpPr>
        <p:spPr>
          <a:xfrm>
            <a:off x="2589952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" name="bg object 147"/>
          <p:cNvSpPr/>
          <p:nvPr/>
        </p:nvSpPr>
        <p:spPr>
          <a:xfrm>
            <a:off x="2589810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" name="bg object 148"/>
          <p:cNvSpPr/>
          <p:nvPr/>
        </p:nvSpPr>
        <p:spPr>
          <a:xfrm>
            <a:off x="2622627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" name="bg object 149"/>
          <p:cNvSpPr/>
          <p:nvPr/>
        </p:nvSpPr>
        <p:spPr>
          <a:xfrm>
            <a:off x="2622485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" name="bg object 150"/>
          <p:cNvSpPr/>
          <p:nvPr/>
        </p:nvSpPr>
        <p:spPr>
          <a:xfrm>
            <a:off x="2655303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" name="bg object 151"/>
          <p:cNvSpPr/>
          <p:nvPr/>
        </p:nvSpPr>
        <p:spPr>
          <a:xfrm>
            <a:off x="2655161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" name="bg object 152"/>
          <p:cNvSpPr/>
          <p:nvPr/>
        </p:nvSpPr>
        <p:spPr>
          <a:xfrm>
            <a:off x="2687978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" name="bg object 153"/>
          <p:cNvSpPr/>
          <p:nvPr/>
        </p:nvSpPr>
        <p:spPr>
          <a:xfrm>
            <a:off x="2687836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" name="bg object 154"/>
          <p:cNvSpPr/>
          <p:nvPr/>
        </p:nvSpPr>
        <p:spPr>
          <a:xfrm>
            <a:off x="2720654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5" name="bg object 155"/>
          <p:cNvSpPr/>
          <p:nvPr/>
        </p:nvSpPr>
        <p:spPr>
          <a:xfrm>
            <a:off x="2720512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6" name="bg object 156"/>
          <p:cNvSpPr/>
          <p:nvPr/>
        </p:nvSpPr>
        <p:spPr>
          <a:xfrm>
            <a:off x="2753329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7" name="bg object 157"/>
          <p:cNvSpPr/>
          <p:nvPr/>
        </p:nvSpPr>
        <p:spPr>
          <a:xfrm>
            <a:off x="2753187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8" name="bg object 158"/>
          <p:cNvSpPr/>
          <p:nvPr/>
        </p:nvSpPr>
        <p:spPr>
          <a:xfrm>
            <a:off x="2786005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9" name="bg object 159"/>
          <p:cNvSpPr/>
          <p:nvPr/>
        </p:nvSpPr>
        <p:spPr>
          <a:xfrm>
            <a:off x="2785864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0" name="bg object 160"/>
          <p:cNvSpPr/>
          <p:nvPr/>
        </p:nvSpPr>
        <p:spPr>
          <a:xfrm>
            <a:off x="2818681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1" name="bg object 161"/>
          <p:cNvSpPr/>
          <p:nvPr/>
        </p:nvSpPr>
        <p:spPr>
          <a:xfrm>
            <a:off x="2818539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2" name="bg object 162"/>
          <p:cNvSpPr/>
          <p:nvPr/>
        </p:nvSpPr>
        <p:spPr>
          <a:xfrm>
            <a:off x="2851357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3" name="bg object 163"/>
          <p:cNvSpPr/>
          <p:nvPr/>
        </p:nvSpPr>
        <p:spPr>
          <a:xfrm>
            <a:off x="2851215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4" name="bg object 164"/>
          <p:cNvSpPr/>
          <p:nvPr/>
        </p:nvSpPr>
        <p:spPr>
          <a:xfrm>
            <a:off x="2884032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5" name="bg object 165"/>
          <p:cNvSpPr/>
          <p:nvPr/>
        </p:nvSpPr>
        <p:spPr>
          <a:xfrm>
            <a:off x="2883890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6" name="bg object 166"/>
          <p:cNvSpPr/>
          <p:nvPr/>
        </p:nvSpPr>
        <p:spPr>
          <a:xfrm>
            <a:off x="2916708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7" name="bg object 167"/>
          <p:cNvSpPr/>
          <p:nvPr/>
        </p:nvSpPr>
        <p:spPr>
          <a:xfrm>
            <a:off x="2916566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8" name="bg object 168"/>
          <p:cNvSpPr/>
          <p:nvPr/>
        </p:nvSpPr>
        <p:spPr>
          <a:xfrm>
            <a:off x="2949383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9" name="bg object 169"/>
          <p:cNvSpPr/>
          <p:nvPr/>
        </p:nvSpPr>
        <p:spPr>
          <a:xfrm>
            <a:off x="2949241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0" name="bg object 170"/>
          <p:cNvSpPr/>
          <p:nvPr/>
        </p:nvSpPr>
        <p:spPr>
          <a:xfrm>
            <a:off x="2982059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1" name="bg object 171"/>
          <p:cNvSpPr/>
          <p:nvPr/>
        </p:nvSpPr>
        <p:spPr>
          <a:xfrm>
            <a:off x="2981917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2" name="bg object 172"/>
          <p:cNvSpPr/>
          <p:nvPr/>
        </p:nvSpPr>
        <p:spPr>
          <a:xfrm>
            <a:off x="3014734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3" name="bg object 173"/>
          <p:cNvSpPr/>
          <p:nvPr/>
        </p:nvSpPr>
        <p:spPr>
          <a:xfrm>
            <a:off x="3014592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4" name="bg object 174"/>
          <p:cNvSpPr/>
          <p:nvPr/>
        </p:nvSpPr>
        <p:spPr>
          <a:xfrm>
            <a:off x="3047410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5" name="bg object 175"/>
          <p:cNvSpPr/>
          <p:nvPr/>
        </p:nvSpPr>
        <p:spPr>
          <a:xfrm>
            <a:off x="3047269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6" name="bg object 176"/>
          <p:cNvSpPr/>
          <p:nvPr/>
        </p:nvSpPr>
        <p:spPr>
          <a:xfrm>
            <a:off x="3080086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7" name="bg object 177"/>
          <p:cNvSpPr/>
          <p:nvPr/>
        </p:nvSpPr>
        <p:spPr>
          <a:xfrm>
            <a:off x="3079944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8" name="bg object 178"/>
          <p:cNvSpPr/>
          <p:nvPr/>
        </p:nvSpPr>
        <p:spPr>
          <a:xfrm>
            <a:off x="3112762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9" name="bg object 179"/>
          <p:cNvSpPr/>
          <p:nvPr/>
        </p:nvSpPr>
        <p:spPr>
          <a:xfrm>
            <a:off x="3112620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0" name="bg object 180"/>
          <p:cNvSpPr/>
          <p:nvPr/>
        </p:nvSpPr>
        <p:spPr>
          <a:xfrm>
            <a:off x="3145437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1" name="bg object 181"/>
          <p:cNvSpPr/>
          <p:nvPr/>
        </p:nvSpPr>
        <p:spPr>
          <a:xfrm>
            <a:off x="3145295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2" name="bg object 182"/>
          <p:cNvSpPr/>
          <p:nvPr/>
        </p:nvSpPr>
        <p:spPr>
          <a:xfrm>
            <a:off x="3178113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3" name="bg object 183"/>
          <p:cNvSpPr/>
          <p:nvPr/>
        </p:nvSpPr>
        <p:spPr>
          <a:xfrm>
            <a:off x="3177971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4" name="bg object 184"/>
          <p:cNvSpPr/>
          <p:nvPr/>
        </p:nvSpPr>
        <p:spPr>
          <a:xfrm>
            <a:off x="3210788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5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5" name="bg object 185"/>
          <p:cNvSpPr/>
          <p:nvPr/>
        </p:nvSpPr>
        <p:spPr>
          <a:xfrm>
            <a:off x="3210646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5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6" name="bg object 186"/>
          <p:cNvSpPr/>
          <p:nvPr/>
        </p:nvSpPr>
        <p:spPr>
          <a:xfrm>
            <a:off x="3243464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7" name="bg object 187"/>
          <p:cNvSpPr/>
          <p:nvPr/>
        </p:nvSpPr>
        <p:spPr>
          <a:xfrm>
            <a:off x="3243322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8" name="bg object 188"/>
          <p:cNvSpPr/>
          <p:nvPr/>
        </p:nvSpPr>
        <p:spPr>
          <a:xfrm>
            <a:off x="3276139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9" name="bg object 189"/>
          <p:cNvSpPr/>
          <p:nvPr/>
        </p:nvSpPr>
        <p:spPr>
          <a:xfrm>
            <a:off x="3275997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0" name="bg object 190"/>
          <p:cNvSpPr/>
          <p:nvPr/>
        </p:nvSpPr>
        <p:spPr>
          <a:xfrm>
            <a:off x="3308815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1" name="bg object 191"/>
          <p:cNvSpPr/>
          <p:nvPr/>
        </p:nvSpPr>
        <p:spPr>
          <a:xfrm>
            <a:off x="3308674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2" name="bg object 192"/>
          <p:cNvSpPr/>
          <p:nvPr/>
        </p:nvSpPr>
        <p:spPr>
          <a:xfrm>
            <a:off x="3341491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3" name="bg object 193"/>
          <p:cNvSpPr/>
          <p:nvPr/>
        </p:nvSpPr>
        <p:spPr>
          <a:xfrm>
            <a:off x="3341349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4" name="bg object 194"/>
          <p:cNvSpPr/>
          <p:nvPr/>
        </p:nvSpPr>
        <p:spPr>
          <a:xfrm>
            <a:off x="3374167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5" name="bg object 195"/>
          <p:cNvSpPr/>
          <p:nvPr/>
        </p:nvSpPr>
        <p:spPr>
          <a:xfrm>
            <a:off x="3374025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6" name="bg object 196"/>
          <p:cNvSpPr/>
          <p:nvPr/>
        </p:nvSpPr>
        <p:spPr>
          <a:xfrm>
            <a:off x="3406842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7" name="bg object 197"/>
          <p:cNvSpPr/>
          <p:nvPr/>
        </p:nvSpPr>
        <p:spPr>
          <a:xfrm>
            <a:off x="3406700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8" name="bg object 198"/>
          <p:cNvSpPr/>
          <p:nvPr/>
        </p:nvSpPr>
        <p:spPr>
          <a:xfrm>
            <a:off x="3439518" y="1016695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9" name="bg object 199"/>
          <p:cNvSpPr/>
          <p:nvPr/>
        </p:nvSpPr>
        <p:spPr>
          <a:xfrm>
            <a:off x="3439376" y="1019150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40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0" name="bg object 200"/>
          <p:cNvSpPr/>
          <p:nvPr/>
        </p:nvSpPr>
        <p:spPr>
          <a:xfrm>
            <a:off x="3472193" y="1016695"/>
            <a:ext cx="36195" cy="20320"/>
          </a:xfrm>
          <a:custGeom>
            <a:avLst/>
            <a:gdLst/>
            <a:ahLst/>
            <a:cxnLst/>
            <a:rect l="l" t="t" r="r" b="b"/>
            <a:pathLst>
              <a:path w="36195" h="20319">
                <a:moveTo>
                  <a:pt x="21687" y="19991"/>
                </a:moveTo>
                <a:lnTo>
                  <a:pt x="0" y="19991"/>
                </a:lnTo>
                <a:lnTo>
                  <a:pt x="0" y="0"/>
                </a:lnTo>
                <a:lnTo>
                  <a:pt x="23782" y="0"/>
                </a:lnTo>
                <a:lnTo>
                  <a:pt x="26139" y="463"/>
                </a:lnTo>
                <a:lnTo>
                  <a:pt x="25982" y="463"/>
                </a:lnTo>
                <a:lnTo>
                  <a:pt x="26577" y="642"/>
                </a:lnTo>
                <a:lnTo>
                  <a:pt x="36068" y="15591"/>
                </a:lnTo>
                <a:lnTo>
                  <a:pt x="16030" y="15591"/>
                </a:lnTo>
                <a:lnTo>
                  <a:pt x="16105" y="18814"/>
                </a:lnTo>
                <a:lnTo>
                  <a:pt x="18627" y="18814"/>
                </a:lnTo>
                <a:lnTo>
                  <a:pt x="19337" y="19220"/>
                </a:lnTo>
                <a:lnTo>
                  <a:pt x="20018" y="19521"/>
                </a:lnTo>
                <a:lnTo>
                  <a:pt x="19803" y="19521"/>
                </a:lnTo>
                <a:lnTo>
                  <a:pt x="21687" y="19991"/>
                </a:lnTo>
                <a:close/>
              </a:path>
              <a:path w="36195" h="20319">
                <a:moveTo>
                  <a:pt x="36096" y="18814"/>
                </a:moveTo>
                <a:lnTo>
                  <a:pt x="18640" y="18814"/>
                </a:lnTo>
                <a:lnTo>
                  <a:pt x="18097" y="18428"/>
                </a:lnTo>
                <a:lnTo>
                  <a:pt x="16030" y="15591"/>
                </a:lnTo>
                <a:lnTo>
                  <a:pt x="36068" y="15591"/>
                </a:lnTo>
                <a:lnTo>
                  <a:pt x="36096" y="18814"/>
                </a:lnTo>
                <a:close/>
              </a:path>
              <a:path w="36195" h="20319">
                <a:moveTo>
                  <a:pt x="18640" y="18814"/>
                </a:moveTo>
                <a:lnTo>
                  <a:pt x="16105" y="18814"/>
                </a:lnTo>
                <a:lnTo>
                  <a:pt x="16036" y="15830"/>
                </a:lnTo>
                <a:lnTo>
                  <a:pt x="16802" y="17088"/>
                </a:lnTo>
                <a:lnTo>
                  <a:pt x="17151" y="17527"/>
                </a:lnTo>
                <a:lnTo>
                  <a:pt x="17580" y="17978"/>
                </a:lnTo>
                <a:lnTo>
                  <a:pt x="18097" y="18428"/>
                </a:lnTo>
                <a:lnTo>
                  <a:pt x="18640" y="1881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1" name="bg object 201"/>
          <p:cNvSpPr/>
          <p:nvPr/>
        </p:nvSpPr>
        <p:spPr>
          <a:xfrm>
            <a:off x="3472051" y="1019150"/>
            <a:ext cx="34290" cy="17145"/>
          </a:xfrm>
          <a:custGeom>
            <a:avLst/>
            <a:gdLst/>
            <a:ahLst/>
            <a:cxnLst/>
            <a:rect l="l" t="t" r="r" b="b"/>
            <a:pathLst>
              <a:path w="34289" h="17144">
                <a:moveTo>
                  <a:pt x="18659" y="15081"/>
                </a:moveTo>
                <a:lnTo>
                  <a:pt x="0" y="15081"/>
                </a:lnTo>
                <a:lnTo>
                  <a:pt x="0" y="0"/>
                </a:lnTo>
                <a:lnTo>
                  <a:pt x="24053" y="0"/>
                </a:lnTo>
                <a:lnTo>
                  <a:pt x="25956" y="521"/>
                </a:lnTo>
                <a:lnTo>
                  <a:pt x="33680" y="12518"/>
                </a:lnTo>
                <a:lnTo>
                  <a:pt x="18548" y="12518"/>
                </a:lnTo>
                <a:lnTo>
                  <a:pt x="18659" y="15081"/>
                </a:lnTo>
                <a:close/>
              </a:path>
              <a:path w="34289" h="17144">
                <a:moveTo>
                  <a:pt x="33746" y="15081"/>
                </a:moveTo>
                <a:lnTo>
                  <a:pt x="21783" y="15081"/>
                </a:lnTo>
                <a:lnTo>
                  <a:pt x="20366" y="14456"/>
                </a:lnTo>
                <a:lnTo>
                  <a:pt x="18548" y="12518"/>
                </a:lnTo>
                <a:lnTo>
                  <a:pt x="33680" y="12518"/>
                </a:lnTo>
                <a:lnTo>
                  <a:pt x="33746" y="15081"/>
                </a:lnTo>
                <a:close/>
              </a:path>
              <a:path w="34289" h="17144">
                <a:moveTo>
                  <a:pt x="33784" y="16517"/>
                </a:moveTo>
                <a:lnTo>
                  <a:pt x="18702" y="16517"/>
                </a:lnTo>
                <a:lnTo>
                  <a:pt x="18589" y="12716"/>
                </a:lnTo>
                <a:lnTo>
                  <a:pt x="18928" y="13189"/>
                </a:lnTo>
                <a:lnTo>
                  <a:pt x="19422" y="13753"/>
                </a:lnTo>
                <a:lnTo>
                  <a:pt x="19952" y="14191"/>
                </a:lnTo>
                <a:lnTo>
                  <a:pt x="20366" y="14456"/>
                </a:lnTo>
                <a:lnTo>
                  <a:pt x="21783" y="15081"/>
                </a:lnTo>
                <a:lnTo>
                  <a:pt x="33746" y="15081"/>
                </a:lnTo>
                <a:lnTo>
                  <a:pt x="33784" y="16517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2" name="bg object 202"/>
          <p:cNvSpPr/>
          <p:nvPr/>
        </p:nvSpPr>
        <p:spPr>
          <a:xfrm>
            <a:off x="3488299" y="1035142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3" name="bg object 203"/>
          <p:cNvSpPr/>
          <p:nvPr/>
        </p:nvSpPr>
        <p:spPr>
          <a:xfrm>
            <a:off x="3490754" y="1035000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4" name="bg object 204"/>
          <p:cNvSpPr/>
          <p:nvPr/>
        </p:nvSpPr>
        <p:spPr>
          <a:xfrm>
            <a:off x="3488299" y="1067818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5" name="bg object 205"/>
          <p:cNvSpPr/>
          <p:nvPr/>
        </p:nvSpPr>
        <p:spPr>
          <a:xfrm>
            <a:off x="3490754" y="1067676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6" name="bg object 206"/>
          <p:cNvSpPr/>
          <p:nvPr/>
        </p:nvSpPr>
        <p:spPr>
          <a:xfrm>
            <a:off x="3488299" y="1100493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7" name="bg object 207"/>
          <p:cNvSpPr/>
          <p:nvPr/>
        </p:nvSpPr>
        <p:spPr>
          <a:xfrm>
            <a:off x="3490754" y="1100351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8" name="bg object 208"/>
          <p:cNvSpPr/>
          <p:nvPr/>
        </p:nvSpPr>
        <p:spPr>
          <a:xfrm>
            <a:off x="3488299" y="1133169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9" name="bg object 209"/>
          <p:cNvSpPr/>
          <p:nvPr/>
        </p:nvSpPr>
        <p:spPr>
          <a:xfrm>
            <a:off x="3490754" y="1133027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0" name="bg object 210"/>
          <p:cNvSpPr/>
          <p:nvPr/>
        </p:nvSpPr>
        <p:spPr>
          <a:xfrm>
            <a:off x="3488299" y="1165844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1" name="bg object 211"/>
          <p:cNvSpPr/>
          <p:nvPr/>
        </p:nvSpPr>
        <p:spPr>
          <a:xfrm>
            <a:off x="3490754" y="1165703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2" name="bg object 212"/>
          <p:cNvSpPr/>
          <p:nvPr/>
        </p:nvSpPr>
        <p:spPr>
          <a:xfrm>
            <a:off x="3488299" y="1198520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3" name="bg object 213"/>
          <p:cNvSpPr/>
          <p:nvPr/>
        </p:nvSpPr>
        <p:spPr>
          <a:xfrm>
            <a:off x="3490754" y="1198379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4" name="bg object 214"/>
          <p:cNvSpPr/>
          <p:nvPr/>
        </p:nvSpPr>
        <p:spPr>
          <a:xfrm>
            <a:off x="3488299" y="1231196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5" name="bg object 215"/>
          <p:cNvSpPr/>
          <p:nvPr/>
        </p:nvSpPr>
        <p:spPr>
          <a:xfrm>
            <a:off x="3490754" y="1231054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6" name="bg object 216"/>
          <p:cNvSpPr/>
          <p:nvPr/>
        </p:nvSpPr>
        <p:spPr>
          <a:xfrm>
            <a:off x="3488299" y="1263872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7" name="bg object 217"/>
          <p:cNvSpPr/>
          <p:nvPr/>
        </p:nvSpPr>
        <p:spPr>
          <a:xfrm>
            <a:off x="3490754" y="1263730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8" name="bg object 218"/>
          <p:cNvSpPr/>
          <p:nvPr/>
        </p:nvSpPr>
        <p:spPr>
          <a:xfrm>
            <a:off x="3488299" y="1296547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9" name="bg object 219"/>
          <p:cNvSpPr/>
          <p:nvPr/>
        </p:nvSpPr>
        <p:spPr>
          <a:xfrm>
            <a:off x="3490754" y="1296405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0" name="bg object 220"/>
          <p:cNvSpPr/>
          <p:nvPr/>
        </p:nvSpPr>
        <p:spPr>
          <a:xfrm>
            <a:off x="3488299" y="1329223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1" name="bg object 221"/>
          <p:cNvSpPr/>
          <p:nvPr/>
        </p:nvSpPr>
        <p:spPr>
          <a:xfrm>
            <a:off x="3490754" y="1329081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2" name="bg object 222"/>
          <p:cNvSpPr/>
          <p:nvPr/>
        </p:nvSpPr>
        <p:spPr>
          <a:xfrm>
            <a:off x="3488299" y="1361898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3" name="bg object 223"/>
          <p:cNvSpPr/>
          <p:nvPr/>
        </p:nvSpPr>
        <p:spPr>
          <a:xfrm>
            <a:off x="3490754" y="1361756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4" name="bg object 224"/>
          <p:cNvSpPr/>
          <p:nvPr/>
        </p:nvSpPr>
        <p:spPr>
          <a:xfrm>
            <a:off x="3488299" y="1394574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5" name="bg object 225"/>
          <p:cNvSpPr/>
          <p:nvPr/>
        </p:nvSpPr>
        <p:spPr>
          <a:xfrm>
            <a:off x="3490754" y="1394432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6" name="bg object 226"/>
          <p:cNvSpPr/>
          <p:nvPr/>
        </p:nvSpPr>
        <p:spPr>
          <a:xfrm>
            <a:off x="3488299" y="1427249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7" name="bg object 227"/>
          <p:cNvSpPr/>
          <p:nvPr/>
        </p:nvSpPr>
        <p:spPr>
          <a:xfrm>
            <a:off x="3490754" y="1427108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8" name="bg object 228"/>
          <p:cNvSpPr/>
          <p:nvPr/>
        </p:nvSpPr>
        <p:spPr>
          <a:xfrm>
            <a:off x="3488299" y="1459925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9" name="bg object 229"/>
          <p:cNvSpPr/>
          <p:nvPr/>
        </p:nvSpPr>
        <p:spPr>
          <a:xfrm>
            <a:off x="3490754" y="1459784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0" name="bg object 230"/>
          <p:cNvSpPr/>
          <p:nvPr/>
        </p:nvSpPr>
        <p:spPr>
          <a:xfrm>
            <a:off x="3488299" y="1492601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1" name="bg object 231"/>
          <p:cNvSpPr/>
          <p:nvPr/>
        </p:nvSpPr>
        <p:spPr>
          <a:xfrm>
            <a:off x="3490754" y="1492459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2" name="bg object 232"/>
          <p:cNvSpPr/>
          <p:nvPr/>
        </p:nvSpPr>
        <p:spPr>
          <a:xfrm>
            <a:off x="3488299" y="1525277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3" name="bg object 233"/>
          <p:cNvSpPr/>
          <p:nvPr/>
        </p:nvSpPr>
        <p:spPr>
          <a:xfrm>
            <a:off x="3490754" y="1525135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4" name="bg object 234"/>
          <p:cNvSpPr/>
          <p:nvPr/>
        </p:nvSpPr>
        <p:spPr>
          <a:xfrm>
            <a:off x="3488299" y="1557952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5" name="bg object 235"/>
          <p:cNvSpPr/>
          <p:nvPr/>
        </p:nvSpPr>
        <p:spPr>
          <a:xfrm>
            <a:off x="3490754" y="1557810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6" name="bg object 236"/>
          <p:cNvSpPr/>
          <p:nvPr/>
        </p:nvSpPr>
        <p:spPr>
          <a:xfrm>
            <a:off x="3488299" y="1590628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7" name="bg object 237"/>
          <p:cNvSpPr/>
          <p:nvPr/>
        </p:nvSpPr>
        <p:spPr>
          <a:xfrm>
            <a:off x="3490754" y="1590486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2"/>
                </a:moveTo>
                <a:lnTo>
                  <a:pt x="0" y="33342"/>
                </a:lnTo>
                <a:lnTo>
                  <a:pt x="0" y="0"/>
                </a:lnTo>
                <a:lnTo>
                  <a:pt x="15081" y="0"/>
                </a:lnTo>
                <a:lnTo>
                  <a:pt x="15081" y="33342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8" name="bg object 238"/>
          <p:cNvSpPr/>
          <p:nvPr/>
        </p:nvSpPr>
        <p:spPr>
          <a:xfrm>
            <a:off x="3488299" y="1623303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3"/>
                </a:moveTo>
                <a:lnTo>
                  <a:pt x="0" y="33043"/>
                </a:lnTo>
                <a:lnTo>
                  <a:pt x="0" y="0"/>
                </a:lnTo>
                <a:lnTo>
                  <a:pt x="19991" y="0"/>
                </a:lnTo>
                <a:lnTo>
                  <a:pt x="19991" y="3304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9" name="bg object 239"/>
          <p:cNvSpPr/>
          <p:nvPr/>
        </p:nvSpPr>
        <p:spPr>
          <a:xfrm>
            <a:off x="3490754" y="1623161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0" name="bg object 240"/>
          <p:cNvSpPr/>
          <p:nvPr/>
        </p:nvSpPr>
        <p:spPr>
          <a:xfrm>
            <a:off x="3488299" y="1655979"/>
            <a:ext cx="20320" cy="33655"/>
          </a:xfrm>
          <a:custGeom>
            <a:avLst/>
            <a:gdLst/>
            <a:ahLst/>
            <a:cxnLst/>
            <a:rect l="l" t="t" r="r" b="b"/>
            <a:pathLst>
              <a:path w="20320" h="33655">
                <a:moveTo>
                  <a:pt x="19991" y="33044"/>
                </a:moveTo>
                <a:lnTo>
                  <a:pt x="0" y="33044"/>
                </a:lnTo>
                <a:lnTo>
                  <a:pt x="0" y="0"/>
                </a:lnTo>
                <a:lnTo>
                  <a:pt x="19991" y="0"/>
                </a:lnTo>
                <a:lnTo>
                  <a:pt x="19991" y="33044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1" name="bg object 241"/>
          <p:cNvSpPr/>
          <p:nvPr/>
        </p:nvSpPr>
        <p:spPr>
          <a:xfrm>
            <a:off x="3490754" y="1655837"/>
            <a:ext cx="15240" cy="33655"/>
          </a:xfrm>
          <a:custGeom>
            <a:avLst/>
            <a:gdLst/>
            <a:ahLst/>
            <a:cxnLst/>
            <a:rect l="l" t="t" r="r" b="b"/>
            <a:pathLst>
              <a:path w="15239" h="33655">
                <a:moveTo>
                  <a:pt x="15081" y="33343"/>
                </a:moveTo>
                <a:lnTo>
                  <a:pt x="0" y="33343"/>
                </a:lnTo>
                <a:lnTo>
                  <a:pt x="0" y="0"/>
                </a:lnTo>
                <a:lnTo>
                  <a:pt x="15081" y="0"/>
                </a:lnTo>
                <a:lnTo>
                  <a:pt x="15081" y="33343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2" name="bg object 242"/>
          <p:cNvSpPr/>
          <p:nvPr/>
        </p:nvSpPr>
        <p:spPr>
          <a:xfrm>
            <a:off x="3488299" y="1688654"/>
            <a:ext cx="22225" cy="32384"/>
          </a:xfrm>
          <a:custGeom>
            <a:avLst/>
            <a:gdLst/>
            <a:ahLst/>
            <a:cxnLst/>
            <a:rect l="l" t="t" r="r" b="b"/>
            <a:pathLst>
              <a:path w="22225" h="32385">
                <a:moveTo>
                  <a:pt x="21597" y="32166"/>
                </a:moveTo>
                <a:lnTo>
                  <a:pt x="8889" y="32166"/>
                </a:lnTo>
                <a:lnTo>
                  <a:pt x="8108" y="31903"/>
                </a:lnTo>
                <a:lnTo>
                  <a:pt x="0" y="0"/>
                </a:lnTo>
                <a:lnTo>
                  <a:pt x="19991" y="0"/>
                </a:lnTo>
                <a:lnTo>
                  <a:pt x="20070" y="12633"/>
                </a:lnTo>
                <a:lnTo>
                  <a:pt x="13583" y="12633"/>
                </a:lnTo>
                <a:lnTo>
                  <a:pt x="16722" y="13756"/>
                </a:lnTo>
                <a:lnTo>
                  <a:pt x="16369" y="13756"/>
                </a:lnTo>
                <a:lnTo>
                  <a:pt x="17144" y="14241"/>
                </a:lnTo>
                <a:lnTo>
                  <a:pt x="17818" y="14767"/>
                </a:lnTo>
                <a:lnTo>
                  <a:pt x="20105" y="18083"/>
                </a:lnTo>
                <a:lnTo>
                  <a:pt x="21597" y="18083"/>
                </a:lnTo>
                <a:lnTo>
                  <a:pt x="21597" y="32166"/>
                </a:lnTo>
                <a:close/>
              </a:path>
              <a:path w="22225" h="32385">
                <a:moveTo>
                  <a:pt x="20105" y="18083"/>
                </a:moveTo>
                <a:lnTo>
                  <a:pt x="16369" y="13756"/>
                </a:lnTo>
                <a:lnTo>
                  <a:pt x="16722" y="13756"/>
                </a:lnTo>
                <a:lnTo>
                  <a:pt x="13583" y="12633"/>
                </a:lnTo>
                <a:lnTo>
                  <a:pt x="20070" y="12633"/>
                </a:lnTo>
                <a:lnTo>
                  <a:pt x="20105" y="18083"/>
                </a:lnTo>
                <a:close/>
              </a:path>
              <a:path w="22225" h="32385">
                <a:moveTo>
                  <a:pt x="21597" y="18083"/>
                </a:moveTo>
                <a:lnTo>
                  <a:pt x="20105" y="18083"/>
                </a:lnTo>
                <a:lnTo>
                  <a:pt x="20070" y="12633"/>
                </a:lnTo>
                <a:lnTo>
                  <a:pt x="21597" y="12633"/>
                </a:lnTo>
                <a:lnTo>
                  <a:pt x="21597" y="18083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3" name="bg object 243"/>
          <p:cNvSpPr/>
          <p:nvPr/>
        </p:nvSpPr>
        <p:spPr>
          <a:xfrm>
            <a:off x="3490754" y="1688513"/>
            <a:ext cx="19685" cy="30480"/>
          </a:xfrm>
          <a:custGeom>
            <a:avLst/>
            <a:gdLst/>
            <a:ahLst/>
            <a:cxnLst/>
            <a:rect l="l" t="t" r="r" b="b"/>
            <a:pathLst>
              <a:path w="19685" h="30480">
                <a:moveTo>
                  <a:pt x="19301" y="29858"/>
                </a:moveTo>
                <a:lnTo>
                  <a:pt x="6826" y="29858"/>
                </a:lnTo>
                <a:lnTo>
                  <a:pt x="5939" y="29502"/>
                </a:lnTo>
                <a:lnTo>
                  <a:pt x="0" y="0"/>
                </a:lnTo>
                <a:lnTo>
                  <a:pt x="15081" y="0"/>
                </a:lnTo>
                <a:lnTo>
                  <a:pt x="15159" y="15229"/>
                </a:lnTo>
                <a:lnTo>
                  <a:pt x="11196" y="15229"/>
                </a:lnTo>
                <a:lnTo>
                  <a:pt x="14082" y="16767"/>
                </a:lnTo>
                <a:lnTo>
                  <a:pt x="13761" y="16767"/>
                </a:lnTo>
                <a:lnTo>
                  <a:pt x="14261" y="17251"/>
                </a:lnTo>
                <a:lnTo>
                  <a:pt x="14639" y="17708"/>
                </a:lnTo>
                <a:lnTo>
                  <a:pt x="15069" y="18395"/>
                </a:lnTo>
                <a:lnTo>
                  <a:pt x="15187" y="18648"/>
                </a:lnTo>
                <a:lnTo>
                  <a:pt x="15266" y="18841"/>
                </a:lnTo>
                <a:lnTo>
                  <a:pt x="19301" y="18841"/>
                </a:lnTo>
                <a:lnTo>
                  <a:pt x="19301" y="29858"/>
                </a:lnTo>
                <a:close/>
              </a:path>
              <a:path w="19685" h="30480">
                <a:moveTo>
                  <a:pt x="15239" y="18648"/>
                </a:moveTo>
                <a:lnTo>
                  <a:pt x="14639" y="17708"/>
                </a:lnTo>
                <a:lnTo>
                  <a:pt x="14261" y="17251"/>
                </a:lnTo>
                <a:lnTo>
                  <a:pt x="13761" y="16767"/>
                </a:lnTo>
                <a:lnTo>
                  <a:pt x="14082" y="16767"/>
                </a:lnTo>
                <a:lnTo>
                  <a:pt x="11196" y="15229"/>
                </a:lnTo>
                <a:lnTo>
                  <a:pt x="15159" y="15229"/>
                </a:lnTo>
                <a:lnTo>
                  <a:pt x="15239" y="18648"/>
                </a:lnTo>
                <a:close/>
              </a:path>
              <a:path w="19685" h="30480">
                <a:moveTo>
                  <a:pt x="19301" y="18841"/>
                </a:moveTo>
                <a:lnTo>
                  <a:pt x="15266" y="18841"/>
                </a:lnTo>
                <a:lnTo>
                  <a:pt x="15159" y="15229"/>
                </a:lnTo>
                <a:lnTo>
                  <a:pt x="19301" y="15229"/>
                </a:lnTo>
                <a:lnTo>
                  <a:pt x="19301" y="1884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4" name="bg object 244"/>
          <p:cNvSpPr/>
          <p:nvPr/>
        </p:nvSpPr>
        <p:spPr>
          <a:xfrm>
            <a:off x="3509529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5" name="bg object 245"/>
          <p:cNvSpPr/>
          <p:nvPr/>
        </p:nvSpPr>
        <p:spPr>
          <a:xfrm>
            <a:off x="3509388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3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3" y="0"/>
                </a:lnTo>
                <a:lnTo>
                  <a:pt x="33343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6" name="bg object 246"/>
          <p:cNvSpPr/>
          <p:nvPr/>
        </p:nvSpPr>
        <p:spPr>
          <a:xfrm>
            <a:off x="3542205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4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4" y="0"/>
                </a:lnTo>
                <a:lnTo>
                  <a:pt x="33044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7" name="bg object 247"/>
          <p:cNvSpPr/>
          <p:nvPr/>
        </p:nvSpPr>
        <p:spPr>
          <a:xfrm>
            <a:off x="3542064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8" name="bg object 248"/>
          <p:cNvSpPr/>
          <p:nvPr/>
        </p:nvSpPr>
        <p:spPr>
          <a:xfrm>
            <a:off x="3574881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9" name="bg object 249"/>
          <p:cNvSpPr/>
          <p:nvPr/>
        </p:nvSpPr>
        <p:spPr>
          <a:xfrm>
            <a:off x="3574740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0" name="bg object 250"/>
          <p:cNvSpPr/>
          <p:nvPr/>
        </p:nvSpPr>
        <p:spPr>
          <a:xfrm>
            <a:off x="3607557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1" name="bg object 251"/>
          <p:cNvSpPr/>
          <p:nvPr/>
        </p:nvSpPr>
        <p:spPr>
          <a:xfrm>
            <a:off x="3607415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2" name="bg object 252"/>
          <p:cNvSpPr/>
          <p:nvPr/>
        </p:nvSpPr>
        <p:spPr>
          <a:xfrm>
            <a:off x="3640232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3" name="bg object 253"/>
          <p:cNvSpPr/>
          <p:nvPr/>
        </p:nvSpPr>
        <p:spPr>
          <a:xfrm>
            <a:off x="3640090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4" name="bg object 254"/>
          <p:cNvSpPr/>
          <p:nvPr/>
        </p:nvSpPr>
        <p:spPr>
          <a:xfrm>
            <a:off x="3672908" y="1701288"/>
            <a:ext cx="33655" cy="20320"/>
          </a:xfrm>
          <a:custGeom>
            <a:avLst/>
            <a:gdLst/>
            <a:ahLst/>
            <a:cxnLst/>
            <a:rect l="l" t="t" r="r" b="b"/>
            <a:pathLst>
              <a:path w="33654" h="20319">
                <a:moveTo>
                  <a:pt x="33043" y="19991"/>
                </a:moveTo>
                <a:lnTo>
                  <a:pt x="0" y="19991"/>
                </a:lnTo>
                <a:lnTo>
                  <a:pt x="0" y="0"/>
                </a:lnTo>
                <a:lnTo>
                  <a:pt x="33043" y="0"/>
                </a:lnTo>
                <a:lnTo>
                  <a:pt x="33043" y="19991"/>
                </a:lnTo>
                <a:close/>
              </a:path>
            </a:pathLst>
          </a:custGeom>
          <a:solidFill>
            <a:srgbClr val="B55A56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5" name="bg object 255"/>
          <p:cNvSpPr/>
          <p:nvPr/>
        </p:nvSpPr>
        <p:spPr>
          <a:xfrm>
            <a:off x="3672766" y="1703743"/>
            <a:ext cx="33655" cy="15240"/>
          </a:xfrm>
          <a:custGeom>
            <a:avLst/>
            <a:gdLst/>
            <a:ahLst/>
            <a:cxnLst/>
            <a:rect l="l" t="t" r="r" b="b"/>
            <a:pathLst>
              <a:path w="33654" h="15239">
                <a:moveTo>
                  <a:pt x="33342" y="15081"/>
                </a:moveTo>
                <a:lnTo>
                  <a:pt x="0" y="15081"/>
                </a:lnTo>
                <a:lnTo>
                  <a:pt x="0" y="0"/>
                </a:lnTo>
                <a:lnTo>
                  <a:pt x="33342" y="0"/>
                </a:lnTo>
                <a:lnTo>
                  <a:pt x="33342" y="15081"/>
                </a:lnTo>
                <a:close/>
              </a:path>
            </a:pathLst>
          </a:custGeom>
          <a:solidFill>
            <a:srgbClr val="DEA9A7"/>
          </a:solidFill>
        </p:spPr>
        <p:txBody>
          <a:bodyPr wrap="square" lIns="0" tIns="0" rIns="0" bIns="0" rtlCol="0"/>
          <a:lstStyle/>
          <a:p/>
        </p:txBody>
      </p:sp>
      <p:pic>
        <p:nvPicPr>
          <p:cNvPr id="256" name="bg object 256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1437132" y="1882139"/>
            <a:ext cx="394715" cy="794003"/>
          </a:xfrm>
          <a:prstGeom prst="rect">
            <a:avLst/>
          </a:prstGeom>
        </p:spPr>
      </p:pic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57200" y="256032"/>
            <a:ext cx="8229600" cy="10241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57200" y="1472184"/>
            <a:ext cx="8229600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idx="5" sz="quarter"/>
          </p:nvPr>
        </p:nvSpPr>
        <p:spPr>
          <a:xfrm>
            <a:off x="3108960" y="5952744"/>
            <a:ext cx="2926080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idx="6" sz="half"/>
          </p:nvPr>
        </p:nvSpPr>
        <p:spPr>
          <a:xfrm>
            <a:off x="457200" y="5952744"/>
            <a:ext cx="2103120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</a:p>
        </p:txBody>
      </p:sp>
      <p:sp>
        <p:nvSpPr>
          <p:cNvPr id="6" name="Holder 6"/>
          <p:cNvSpPr>
            <a:spLocks noGrp="1"/>
          </p:cNvSpPr>
          <p:nvPr>
            <p:ph type="sldNum" idx="7" sz="quarter"/>
          </p:nvPr>
        </p:nvSpPr>
        <p:spPr>
          <a:xfrm>
            <a:off x="6583680" y="5952744"/>
            <a:ext cx="2103120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#</a:t>
            </a:fld>
          </a:p>
        </p:txBody>
      </p:sp>
    </p:spTree>
  </p:cSld>
  <p:clrMap folHlink="folHlink" hlink="hlink" accent1="accent1" accent2="accent2" accent3="accent3" accent4="accent4" accent5="accent5" accent6="accent6" tx2="dk2" bg2="lt2" tx1="dk1" bg1="lt1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
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/Relationships>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787224" y="2199012"/>
            <a:ext cx="408305" cy="13589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700" spc="-10">
                <a:latin typeface="Arial"/>
                <a:cs typeface="Arial"/>
              </a:rPr>
              <a:t>Reservoir</a:t>
            </a:r>
            <a:endParaRPr sz="700">
              <a:latin typeface="Arial"/>
              <a:cs typeface="Arial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1541092" y="1775296"/>
            <a:ext cx="617220" cy="13589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700" spc="-10">
                <a:latin typeface="Arial"/>
                <a:cs typeface="Arial"/>
              </a:rPr>
              <a:t>Oxygen</a:t>
            </a:r>
            <a:r>
              <a:rPr dirty="0" sz="700" spc="-5">
                <a:latin typeface="Arial"/>
                <a:cs typeface="Arial"/>
              </a:rPr>
              <a:t> </a:t>
            </a:r>
            <a:r>
              <a:rPr dirty="0" sz="700" spc="-10">
                <a:latin typeface="Arial"/>
                <a:cs typeface="Arial"/>
              </a:rPr>
              <a:t>supply</a:t>
            </a:r>
            <a:endParaRPr sz="700">
              <a:latin typeface="Arial"/>
              <a:cs typeface="Arial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583624" y="1447300"/>
            <a:ext cx="474345" cy="240665"/>
          </a:xfrm>
          <a:prstGeom prst="rect">
            <a:avLst/>
          </a:prstGeom>
        </p:spPr>
        <p:txBody>
          <a:bodyPr wrap="square" lIns="0" tIns="19685" rIns="0" bIns="0" rtlCol="0" vert="horz">
            <a:spAutoFit/>
          </a:bodyPr>
          <a:lstStyle/>
          <a:p>
            <a:pPr marL="119380" marR="5080" indent="-107314">
              <a:lnSpc>
                <a:spcPts val="830"/>
              </a:lnSpc>
              <a:spcBef>
                <a:spcPts val="155"/>
              </a:spcBef>
            </a:pPr>
            <a:r>
              <a:rPr dirty="0" sz="700" spc="-10">
                <a:latin typeface="Arial"/>
                <a:cs typeface="Arial"/>
              </a:rPr>
              <a:t>Centrifugal</a:t>
            </a:r>
            <a:r>
              <a:rPr dirty="0" sz="700" spc="500">
                <a:latin typeface="Arial"/>
                <a:cs typeface="Arial"/>
              </a:rPr>
              <a:t> </a:t>
            </a:r>
            <a:r>
              <a:rPr dirty="0" sz="700" spc="-20">
                <a:latin typeface="Arial"/>
                <a:cs typeface="Arial"/>
              </a:rPr>
              <a:t>pump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5" name="object 5"/>
          <p:cNvGrpSpPr/>
          <p:nvPr/>
        </p:nvGrpSpPr>
        <p:grpSpPr>
          <a:xfrm>
            <a:off x="2464307" y="1825751"/>
            <a:ext cx="166370" cy="399415"/>
            <a:chOff x="2464307" y="1825751"/>
            <a:chExt cx="166370" cy="399415"/>
          </a:xfrm>
        </p:grpSpPr>
        <p:pic>
          <p:nvPicPr>
            <p:cNvPr id="6" name="object 6"/>
            <p:cNvPicPr/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2464307" y="2177795"/>
              <a:ext cx="166115" cy="47243"/>
            </a:xfrm>
            <a:prstGeom prst="rect">
              <a:avLst/>
            </a:prstGeom>
          </p:spPr>
        </p:pic>
        <p:pic>
          <p:nvPicPr>
            <p:cNvPr id="7" name="object 7"/>
            <p:cNvPicPr/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2464307" y="1825751"/>
              <a:ext cx="166115" cy="47243"/>
            </a:xfrm>
            <a:prstGeom prst="rect">
              <a:avLst/>
            </a:prstGeom>
          </p:spPr>
        </p:pic>
      </p:grpSp>
      <p:pic>
        <p:nvPicPr>
          <p:cNvPr id="8" name="object 8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2217420" y="1347216"/>
            <a:ext cx="47243" cy="164591"/>
          </a:xfrm>
          <a:prstGeom prst="rect">
            <a:avLst/>
          </a:prstGeom>
        </p:spPr>
      </p:pic>
      <p:pic>
        <p:nvPicPr>
          <p:cNvPr id="9" name="object 9"/>
          <p:cNvPicPr/>
          <p:nvPr/>
        </p:nvPicPr>
        <p:blipFill>
          <a:blip r:embed="rId5" cstate="print"/>
          <a:stretch>
            <a:fillRect/>
          </a:stretch>
        </p:blipFill>
        <p:spPr>
          <a:xfrm>
            <a:off x="3346703" y="955547"/>
            <a:ext cx="164591" cy="48767"/>
          </a:xfrm>
          <a:prstGeom prst="rect">
            <a:avLst/>
          </a:prstGeom>
        </p:spPr>
      </p:pic>
      <p:grpSp>
        <p:nvGrpSpPr>
          <p:cNvPr id="10" name="object 10"/>
          <p:cNvGrpSpPr/>
          <p:nvPr/>
        </p:nvGrpSpPr>
        <p:grpSpPr>
          <a:xfrm>
            <a:off x="2144267" y="894588"/>
            <a:ext cx="551815" cy="350520"/>
            <a:chOff x="2144267" y="894588"/>
            <a:chExt cx="551815" cy="350520"/>
          </a:xfrm>
        </p:grpSpPr>
        <p:pic>
          <p:nvPicPr>
            <p:cNvPr id="11" name="object 11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2531363" y="949452"/>
              <a:ext cx="164591" cy="48767"/>
            </a:xfrm>
            <a:prstGeom prst="rect">
              <a:avLst/>
            </a:prstGeom>
          </p:spPr>
        </p:pic>
        <p:pic>
          <p:nvPicPr>
            <p:cNvPr id="12" name="object 12"/>
            <p:cNvPicPr/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2144267" y="894588"/>
              <a:ext cx="390143" cy="350519"/>
            </a:xfrm>
            <a:prstGeom prst="rect">
              <a:avLst/>
            </a:prstGeom>
          </p:spPr>
        </p:pic>
        <p:pic>
          <p:nvPicPr>
            <p:cNvPr id="13" name="object 13"/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2154935" y="905256"/>
              <a:ext cx="286511" cy="163067"/>
            </a:xfrm>
            <a:prstGeom prst="rect">
              <a:avLst/>
            </a:prstGeom>
          </p:spPr>
        </p:pic>
      </p:grpSp>
      <p:sp>
        <p:nvSpPr>
          <p:cNvPr id="14" name="object 14"/>
          <p:cNvSpPr txBox="1"/>
          <p:nvPr/>
        </p:nvSpPr>
        <p:spPr>
          <a:xfrm>
            <a:off x="2461077" y="2459423"/>
            <a:ext cx="682625" cy="135890"/>
          </a:xfrm>
          <a:prstGeom prst="rect">
            <a:avLst/>
          </a:prstGeom>
        </p:spPr>
        <p:txBody>
          <a:bodyPr wrap="square" lIns="0" tIns="1524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dirty="0" sz="700" spc="-20" b="1">
                <a:solidFill>
                  <a:srgbClr val="3A68AE"/>
                </a:solidFill>
                <a:latin typeface="Arial"/>
                <a:cs typeface="Arial"/>
              </a:rPr>
              <a:t>Venous</a:t>
            </a:r>
            <a:r>
              <a:rPr dirty="0" sz="700" spc="10" b="1">
                <a:solidFill>
                  <a:srgbClr val="3A68AE"/>
                </a:solidFill>
                <a:latin typeface="Arial"/>
                <a:cs typeface="Arial"/>
              </a:rPr>
              <a:t> </a:t>
            </a:r>
            <a:r>
              <a:rPr dirty="0" sz="700" spc="-10" b="1">
                <a:solidFill>
                  <a:srgbClr val="3A68AE"/>
                </a:solidFill>
                <a:latin typeface="Arial"/>
                <a:cs typeface="Arial"/>
              </a:rPr>
              <a:t>cannula</a:t>
            </a:r>
            <a:endParaRPr sz="700">
              <a:latin typeface="Arial"/>
              <a:cs typeface="Arial"/>
            </a:endParaRPr>
          </a:p>
        </p:txBody>
      </p:sp>
      <p:pic>
        <p:nvPicPr>
          <p:cNvPr id="15" name="object 15"/>
          <p:cNvPicPr/>
          <p:nvPr/>
        </p:nvPicPr>
        <p:blipFill>
          <a:blip r:embed="rId9" cstate="print"/>
          <a:stretch>
            <a:fillRect/>
          </a:stretch>
        </p:blipFill>
        <p:spPr>
          <a:xfrm>
            <a:off x="1851660" y="1972055"/>
            <a:ext cx="164591" cy="48767"/>
          </a:xfrm>
          <a:prstGeom prst="rect">
            <a:avLst/>
          </a:prstGeom>
        </p:spPr>
      </p:pic>
      <p:grpSp>
        <p:nvGrpSpPr>
          <p:cNvPr id="16" name="object 16"/>
          <p:cNvGrpSpPr/>
          <p:nvPr/>
        </p:nvGrpSpPr>
        <p:grpSpPr>
          <a:xfrm>
            <a:off x="2148839" y="1479803"/>
            <a:ext cx="1926589" cy="983615"/>
            <a:chOff x="2148839" y="1479803"/>
            <a:chExt cx="1926589" cy="983615"/>
          </a:xfrm>
        </p:grpSpPr>
        <p:pic>
          <p:nvPicPr>
            <p:cNvPr id="17" name="object 17"/>
            <p:cNvPicPr/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249167" y="2033015"/>
              <a:ext cx="48767" cy="164591"/>
            </a:xfrm>
            <a:prstGeom prst="rect">
              <a:avLst/>
            </a:prstGeom>
          </p:spPr>
        </p:pic>
        <p:pic>
          <p:nvPicPr>
            <p:cNvPr id="18" name="object 18"/>
            <p:cNvPicPr/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2148839" y="1720595"/>
              <a:ext cx="286511" cy="341375"/>
            </a:xfrm>
            <a:prstGeom prst="rect">
              <a:avLst/>
            </a:prstGeom>
          </p:spPr>
        </p:pic>
        <p:sp>
          <p:nvSpPr>
            <p:cNvPr id="19" name="object 19"/>
            <p:cNvSpPr/>
            <p:nvPr/>
          </p:nvSpPr>
          <p:spPr>
            <a:xfrm>
              <a:off x="2659800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0" name="object 20"/>
            <p:cNvSpPr/>
            <p:nvPr/>
          </p:nvSpPr>
          <p:spPr>
            <a:xfrm>
              <a:off x="2659640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1" name="object 21"/>
            <p:cNvSpPr/>
            <p:nvPr/>
          </p:nvSpPr>
          <p:spPr>
            <a:xfrm>
              <a:off x="2626515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2" name="object 22"/>
            <p:cNvSpPr/>
            <p:nvPr/>
          </p:nvSpPr>
          <p:spPr>
            <a:xfrm>
              <a:off x="2626354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5" y="0"/>
                  </a:lnTo>
                  <a:lnTo>
                    <a:pt x="33965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" name="object 23"/>
            <p:cNvSpPr/>
            <p:nvPr/>
          </p:nvSpPr>
          <p:spPr>
            <a:xfrm>
              <a:off x="2593230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" name="object 24"/>
            <p:cNvSpPr/>
            <p:nvPr/>
          </p:nvSpPr>
          <p:spPr>
            <a:xfrm>
              <a:off x="2593069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5" y="0"/>
                  </a:lnTo>
                  <a:lnTo>
                    <a:pt x="33965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" name="object 25"/>
            <p:cNvSpPr/>
            <p:nvPr/>
          </p:nvSpPr>
          <p:spPr>
            <a:xfrm>
              <a:off x="2559944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60" y="0"/>
                  </a:lnTo>
                  <a:lnTo>
                    <a:pt x="33660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" name="object 26"/>
            <p:cNvSpPr/>
            <p:nvPr/>
          </p:nvSpPr>
          <p:spPr>
            <a:xfrm>
              <a:off x="2559784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" name="object 27"/>
            <p:cNvSpPr/>
            <p:nvPr/>
          </p:nvSpPr>
          <p:spPr>
            <a:xfrm>
              <a:off x="2526659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60" y="0"/>
                  </a:lnTo>
                  <a:lnTo>
                    <a:pt x="33660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" name="object 28"/>
            <p:cNvSpPr/>
            <p:nvPr/>
          </p:nvSpPr>
          <p:spPr>
            <a:xfrm>
              <a:off x="2526499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" name="object 29"/>
            <p:cNvSpPr/>
            <p:nvPr/>
          </p:nvSpPr>
          <p:spPr>
            <a:xfrm>
              <a:off x="2493374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60" y="0"/>
                  </a:lnTo>
                  <a:lnTo>
                    <a:pt x="33660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" name="object 30"/>
            <p:cNvSpPr/>
            <p:nvPr/>
          </p:nvSpPr>
          <p:spPr>
            <a:xfrm>
              <a:off x="2493214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" name="object 31"/>
            <p:cNvSpPr/>
            <p:nvPr/>
          </p:nvSpPr>
          <p:spPr>
            <a:xfrm>
              <a:off x="2460089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" name="object 32"/>
            <p:cNvSpPr/>
            <p:nvPr/>
          </p:nvSpPr>
          <p:spPr>
            <a:xfrm>
              <a:off x="2459928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" name="object 33"/>
            <p:cNvSpPr/>
            <p:nvPr/>
          </p:nvSpPr>
          <p:spPr>
            <a:xfrm>
              <a:off x="2426803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" name="object 34"/>
            <p:cNvSpPr/>
            <p:nvPr/>
          </p:nvSpPr>
          <p:spPr>
            <a:xfrm>
              <a:off x="2426643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4" y="0"/>
                  </a:lnTo>
                  <a:lnTo>
                    <a:pt x="33964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" name="object 35"/>
            <p:cNvSpPr/>
            <p:nvPr/>
          </p:nvSpPr>
          <p:spPr>
            <a:xfrm>
              <a:off x="2393518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59" y="0"/>
                  </a:lnTo>
                  <a:lnTo>
                    <a:pt x="33659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" name="object 36"/>
            <p:cNvSpPr/>
            <p:nvPr/>
          </p:nvSpPr>
          <p:spPr>
            <a:xfrm>
              <a:off x="2393357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5" y="0"/>
                  </a:lnTo>
                  <a:lnTo>
                    <a:pt x="33965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" name="object 37"/>
            <p:cNvSpPr/>
            <p:nvPr/>
          </p:nvSpPr>
          <p:spPr>
            <a:xfrm>
              <a:off x="2360232" y="1781817"/>
              <a:ext cx="33655" cy="20955"/>
            </a:xfrm>
            <a:custGeom>
              <a:avLst/>
              <a:gdLst/>
              <a:ahLst/>
              <a:cxnLst/>
              <a:rect l="l" t="t" r="r" b="b"/>
              <a:pathLst>
                <a:path w="33655" h="20955">
                  <a:moveTo>
                    <a:pt x="0" y="0"/>
                  </a:moveTo>
                  <a:lnTo>
                    <a:pt x="33660" y="0"/>
                  </a:lnTo>
                  <a:lnTo>
                    <a:pt x="33660" y="20363"/>
                  </a:lnTo>
                  <a:lnTo>
                    <a:pt x="0" y="2036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" name="object 38"/>
            <p:cNvSpPr/>
            <p:nvPr/>
          </p:nvSpPr>
          <p:spPr>
            <a:xfrm>
              <a:off x="2360072" y="1784317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965" y="0"/>
                  </a:lnTo>
                  <a:lnTo>
                    <a:pt x="33965" y="15362"/>
                  </a:lnTo>
                  <a:lnTo>
                    <a:pt x="0" y="153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" name="object 39"/>
            <p:cNvSpPr/>
            <p:nvPr/>
          </p:nvSpPr>
          <p:spPr>
            <a:xfrm>
              <a:off x="2699444" y="1774574"/>
              <a:ext cx="105410" cy="37465"/>
            </a:xfrm>
            <a:custGeom>
              <a:avLst/>
              <a:gdLst/>
              <a:ahLst/>
              <a:cxnLst/>
              <a:rect l="l" t="t" r="r" b="b"/>
              <a:pathLst>
                <a:path w="105410" h="37464">
                  <a:moveTo>
                    <a:pt x="105140" y="0"/>
                  </a:moveTo>
                  <a:lnTo>
                    <a:pt x="105140" y="37278"/>
                  </a:lnTo>
                  <a:lnTo>
                    <a:pt x="0" y="37278"/>
                  </a:lnTo>
                  <a:lnTo>
                    <a:pt x="0" y="0"/>
                  </a:lnTo>
                  <a:lnTo>
                    <a:pt x="105140" y="0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" name="object 40"/>
            <p:cNvSpPr/>
            <p:nvPr/>
          </p:nvSpPr>
          <p:spPr>
            <a:xfrm>
              <a:off x="2699444" y="1774574"/>
              <a:ext cx="105410" cy="37465"/>
            </a:xfrm>
            <a:custGeom>
              <a:avLst/>
              <a:gdLst/>
              <a:ahLst/>
              <a:cxnLst/>
              <a:rect l="l" t="t" r="r" b="b"/>
              <a:pathLst>
                <a:path w="105410" h="37464">
                  <a:moveTo>
                    <a:pt x="0" y="0"/>
                  </a:moveTo>
                  <a:lnTo>
                    <a:pt x="0" y="37278"/>
                  </a:lnTo>
                  <a:lnTo>
                    <a:pt x="105140" y="37278"/>
                  </a:lnTo>
                  <a:lnTo>
                    <a:pt x="105140" y="0"/>
                  </a:lnTo>
                  <a:lnTo>
                    <a:pt x="0" y="0"/>
                  </a:lnTo>
                  <a:close/>
                </a:path>
              </a:pathLst>
            </a:custGeom>
            <a:ln w="4288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1" name="object 41"/>
            <p:cNvSpPr/>
            <p:nvPr/>
          </p:nvSpPr>
          <p:spPr>
            <a:xfrm>
              <a:off x="2683018" y="1768011"/>
              <a:ext cx="17145" cy="50800"/>
            </a:xfrm>
            <a:custGeom>
              <a:avLst/>
              <a:gdLst/>
              <a:ahLst/>
              <a:cxnLst/>
              <a:rect l="l" t="t" r="r" b="b"/>
              <a:pathLst>
                <a:path w="17144" h="50800">
                  <a:moveTo>
                    <a:pt x="16527" y="1503"/>
                  </a:moveTo>
                  <a:lnTo>
                    <a:pt x="16527" y="48903"/>
                  </a:lnTo>
                  <a:lnTo>
                    <a:pt x="15025" y="50406"/>
                  </a:lnTo>
                  <a:lnTo>
                    <a:pt x="1502" y="50406"/>
                  </a:lnTo>
                  <a:lnTo>
                    <a:pt x="0" y="48903"/>
                  </a:lnTo>
                  <a:lnTo>
                    <a:pt x="0" y="1503"/>
                  </a:lnTo>
                  <a:lnTo>
                    <a:pt x="1502" y="0"/>
                  </a:lnTo>
                  <a:lnTo>
                    <a:pt x="13172" y="0"/>
                  </a:lnTo>
                  <a:lnTo>
                    <a:pt x="15025" y="0"/>
                  </a:lnTo>
                  <a:lnTo>
                    <a:pt x="16527" y="1503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" name="object 42"/>
            <p:cNvSpPr/>
            <p:nvPr/>
          </p:nvSpPr>
          <p:spPr>
            <a:xfrm>
              <a:off x="2683018" y="1768011"/>
              <a:ext cx="17145" cy="50800"/>
            </a:xfrm>
            <a:custGeom>
              <a:avLst/>
              <a:gdLst/>
              <a:ahLst/>
              <a:cxnLst/>
              <a:rect l="l" t="t" r="r" b="b"/>
              <a:pathLst>
                <a:path w="17144" h="50800">
                  <a:moveTo>
                    <a:pt x="13172" y="0"/>
                  </a:moveTo>
                  <a:lnTo>
                    <a:pt x="3355" y="0"/>
                  </a:lnTo>
                  <a:lnTo>
                    <a:pt x="1502" y="0"/>
                  </a:lnTo>
                  <a:lnTo>
                    <a:pt x="0" y="1503"/>
                  </a:lnTo>
                  <a:lnTo>
                    <a:pt x="0" y="3355"/>
                  </a:lnTo>
                  <a:lnTo>
                    <a:pt x="0" y="47050"/>
                  </a:lnTo>
                  <a:lnTo>
                    <a:pt x="0" y="48903"/>
                  </a:lnTo>
                  <a:lnTo>
                    <a:pt x="1502" y="50406"/>
                  </a:lnTo>
                  <a:lnTo>
                    <a:pt x="3355" y="50406"/>
                  </a:lnTo>
                  <a:lnTo>
                    <a:pt x="13172" y="50406"/>
                  </a:lnTo>
                  <a:lnTo>
                    <a:pt x="15025" y="50406"/>
                  </a:lnTo>
                  <a:lnTo>
                    <a:pt x="16527" y="48903"/>
                  </a:lnTo>
                  <a:lnTo>
                    <a:pt x="16527" y="47050"/>
                  </a:lnTo>
                  <a:lnTo>
                    <a:pt x="16527" y="3355"/>
                  </a:lnTo>
                  <a:lnTo>
                    <a:pt x="16527" y="1503"/>
                  </a:lnTo>
                  <a:lnTo>
                    <a:pt x="15025" y="0"/>
                  </a:lnTo>
                  <a:lnTo>
                    <a:pt x="13172" y="0"/>
                  </a:lnTo>
                  <a:close/>
                </a:path>
              </a:pathLst>
            </a:custGeom>
            <a:ln w="4288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3" name="object 43"/>
            <p:cNvSpPr/>
            <p:nvPr/>
          </p:nvSpPr>
          <p:spPr>
            <a:xfrm>
              <a:off x="2718947" y="1768011"/>
              <a:ext cx="223520" cy="223520"/>
            </a:xfrm>
            <a:custGeom>
              <a:avLst/>
              <a:gdLst/>
              <a:ahLst/>
              <a:cxnLst/>
              <a:rect l="l" t="t" r="r" b="b"/>
              <a:pathLst>
                <a:path w="223519" h="223519">
                  <a:moveTo>
                    <a:pt x="0" y="111563"/>
                  </a:moveTo>
                  <a:lnTo>
                    <a:pt x="8767" y="68138"/>
                  </a:lnTo>
                  <a:lnTo>
                    <a:pt x="32676" y="32676"/>
                  </a:lnTo>
                  <a:lnTo>
                    <a:pt x="68138" y="8767"/>
                  </a:lnTo>
                  <a:lnTo>
                    <a:pt x="111563" y="0"/>
                  </a:lnTo>
                  <a:lnTo>
                    <a:pt x="154988" y="8767"/>
                  </a:lnTo>
                  <a:lnTo>
                    <a:pt x="190450" y="32676"/>
                  </a:lnTo>
                  <a:lnTo>
                    <a:pt x="214359" y="68138"/>
                  </a:lnTo>
                  <a:lnTo>
                    <a:pt x="223126" y="111563"/>
                  </a:lnTo>
                  <a:lnTo>
                    <a:pt x="214359" y="154988"/>
                  </a:lnTo>
                  <a:lnTo>
                    <a:pt x="190450" y="190450"/>
                  </a:lnTo>
                  <a:lnTo>
                    <a:pt x="154988" y="214359"/>
                  </a:lnTo>
                  <a:lnTo>
                    <a:pt x="111563" y="223126"/>
                  </a:lnTo>
                  <a:lnTo>
                    <a:pt x="68138" y="214359"/>
                  </a:lnTo>
                  <a:lnTo>
                    <a:pt x="32676" y="190450"/>
                  </a:lnTo>
                  <a:lnTo>
                    <a:pt x="8767" y="154988"/>
                  </a:lnTo>
                  <a:lnTo>
                    <a:pt x="0" y="111563"/>
                  </a:lnTo>
                  <a:close/>
                </a:path>
              </a:pathLst>
            </a:custGeom>
            <a:solidFill>
              <a:srgbClr val="EAEAEA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" name="object 44"/>
            <p:cNvSpPr/>
            <p:nvPr/>
          </p:nvSpPr>
          <p:spPr>
            <a:xfrm>
              <a:off x="2718947" y="1768011"/>
              <a:ext cx="223520" cy="223520"/>
            </a:xfrm>
            <a:custGeom>
              <a:avLst/>
              <a:gdLst/>
              <a:ahLst/>
              <a:cxnLst/>
              <a:rect l="l" t="t" r="r" b="b"/>
              <a:pathLst>
                <a:path w="223519" h="223519">
                  <a:moveTo>
                    <a:pt x="111563" y="0"/>
                  </a:moveTo>
                  <a:lnTo>
                    <a:pt x="68138" y="8767"/>
                  </a:lnTo>
                  <a:lnTo>
                    <a:pt x="32676" y="32676"/>
                  </a:lnTo>
                  <a:lnTo>
                    <a:pt x="8767" y="68138"/>
                  </a:lnTo>
                  <a:lnTo>
                    <a:pt x="0" y="111563"/>
                  </a:lnTo>
                  <a:lnTo>
                    <a:pt x="8767" y="154988"/>
                  </a:lnTo>
                  <a:lnTo>
                    <a:pt x="32676" y="190450"/>
                  </a:lnTo>
                  <a:lnTo>
                    <a:pt x="68138" y="214359"/>
                  </a:lnTo>
                  <a:lnTo>
                    <a:pt x="111563" y="223126"/>
                  </a:lnTo>
                  <a:lnTo>
                    <a:pt x="154988" y="214359"/>
                  </a:lnTo>
                  <a:lnTo>
                    <a:pt x="190450" y="190450"/>
                  </a:lnTo>
                  <a:lnTo>
                    <a:pt x="214359" y="154988"/>
                  </a:lnTo>
                  <a:lnTo>
                    <a:pt x="223126" y="111563"/>
                  </a:lnTo>
                  <a:lnTo>
                    <a:pt x="214359" y="68138"/>
                  </a:lnTo>
                  <a:lnTo>
                    <a:pt x="190450" y="32676"/>
                  </a:lnTo>
                  <a:lnTo>
                    <a:pt x="154988" y="8767"/>
                  </a:lnTo>
                  <a:lnTo>
                    <a:pt x="111563" y="0"/>
                  </a:lnTo>
                  <a:close/>
                </a:path>
              </a:pathLst>
            </a:custGeom>
            <a:ln w="4288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5" name="object 45"/>
            <p:cNvSpPr/>
            <p:nvPr/>
          </p:nvSpPr>
          <p:spPr>
            <a:xfrm>
              <a:off x="2787812" y="1836878"/>
              <a:ext cx="85725" cy="85725"/>
            </a:xfrm>
            <a:custGeom>
              <a:avLst/>
              <a:gdLst/>
              <a:ahLst/>
              <a:cxnLst/>
              <a:rect l="l" t="t" r="r" b="b"/>
              <a:pathLst>
                <a:path w="85725" h="85725">
                  <a:moveTo>
                    <a:pt x="0" y="42696"/>
                  </a:moveTo>
                  <a:lnTo>
                    <a:pt x="3355" y="26077"/>
                  </a:lnTo>
                  <a:lnTo>
                    <a:pt x="12505" y="12505"/>
                  </a:lnTo>
                  <a:lnTo>
                    <a:pt x="26077" y="3355"/>
                  </a:lnTo>
                  <a:lnTo>
                    <a:pt x="42696" y="0"/>
                  </a:lnTo>
                  <a:lnTo>
                    <a:pt x="59316" y="3355"/>
                  </a:lnTo>
                  <a:lnTo>
                    <a:pt x="72888" y="12505"/>
                  </a:lnTo>
                  <a:lnTo>
                    <a:pt x="82038" y="26077"/>
                  </a:lnTo>
                  <a:lnTo>
                    <a:pt x="85393" y="42696"/>
                  </a:lnTo>
                  <a:lnTo>
                    <a:pt x="82038" y="59316"/>
                  </a:lnTo>
                  <a:lnTo>
                    <a:pt x="72888" y="72888"/>
                  </a:lnTo>
                  <a:lnTo>
                    <a:pt x="59316" y="82038"/>
                  </a:lnTo>
                  <a:lnTo>
                    <a:pt x="42696" y="85393"/>
                  </a:lnTo>
                  <a:lnTo>
                    <a:pt x="26077" y="82038"/>
                  </a:lnTo>
                  <a:lnTo>
                    <a:pt x="12505" y="72888"/>
                  </a:lnTo>
                  <a:lnTo>
                    <a:pt x="3355" y="59316"/>
                  </a:lnTo>
                  <a:lnTo>
                    <a:pt x="0" y="42696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" name="object 46"/>
            <p:cNvSpPr/>
            <p:nvPr/>
          </p:nvSpPr>
          <p:spPr>
            <a:xfrm>
              <a:off x="2787812" y="1836878"/>
              <a:ext cx="85725" cy="85725"/>
            </a:xfrm>
            <a:custGeom>
              <a:avLst/>
              <a:gdLst/>
              <a:ahLst/>
              <a:cxnLst/>
              <a:rect l="l" t="t" r="r" b="b"/>
              <a:pathLst>
                <a:path w="85725" h="85725">
                  <a:moveTo>
                    <a:pt x="42696" y="0"/>
                  </a:moveTo>
                  <a:lnTo>
                    <a:pt x="26077" y="3355"/>
                  </a:lnTo>
                  <a:lnTo>
                    <a:pt x="12505" y="12505"/>
                  </a:lnTo>
                  <a:lnTo>
                    <a:pt x="3355" y="26077"/>
                  </a:lnTo>
                  <a:lnTo>
                    <a:pt x="0" y="42696"/>
                  </a:lnTo>
                  <a:lnTo>
                    <a:pt x="3355" y="59316"/>
                  </a:lnTo>
                  <a:lnTo>
                    <a:pt x="12505" y="72888"/>
                  </a:lnTo>
                  <a:lnTo>
                    <a:pt x="26077" y="82038"/>
                  </a:lnTo>
                  <a:lnTo>
                    <a:pt x="42696" y="85393"/>
                  </a:lnTo>
                  <a:lnTo>
                    <a:pt x="59316" y="82038"/>
                  </a:lnTo>
                  <a:lnTo>
                    <a:pt x="72888" y="72888"/>
                  </a:lnTo>
                  <a:lnTo>
                    <a:pt x="82038" y="59316"/>
                  </a:lnTo>
                  <a:lnTo>
                    <a:pt x="85393" y="42696"/>
                  </a:lnTo>
                  <a:lnTo>
                    <a:pt x="82038" y="26077"/>
                  </a:lnTo>
                  <a:lnTo>
                    <a:pt x="72888" y="12505"/>
                  </a:lnTo>
                  <a:lnTo>
                    <a:pt x="59316" y="3355"/>
                  </a:lnTo>
                  <a:lnTo>
                    <a:pt x="42696" y="0"/>
                  </a:lnTo>
                  <a:close/>
                </a:path>
              </a:pathLst>
            </a:custGeom>
            <a:ln w="4288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7" name="object 47"/>
            <p:cNvSpPr/>
            <p:nvPr/>
          </p:nvSpPr>
          <p:spPr>
            <a:xfrm>
              <a:off x="2755231" y="1814344"/>
              <a:ext cx="38100" cy="78740"/>
            </a:xfrm>
            <a:custGeom>
              <a:avLst/>
              <a:gdLst/>
              <a:ahLst/>
              <a:cxnLst/>
              <a:rect l="l" t="t" r="r" b="b"/>
              <a:pathLst>
                <a:path w="38100" h="78739">
                  <a:moveTo>
                    <a:pt x="37620" y="0"/>
                  </a:moveTo>
                  <a:lnTo>
                    <a:pt x="7425" y="32531"/>
                  </a:lnTo>
                  <a:lnTo>
                    <a:pt x="0" y="62694"/>
                  </a:lnTo>
                  <a:lnTo>
                    <a:pt x="156" y="70704"/>
                  </a:lnTo>
                  <a:lnTo>
                    <a:pt x="1160" y="78637"/>
                  </a:lnTo>
                </a:path>
              </a:pathLst>
            </a:custGeom>
            <a:ln w="8691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48" name="object 48"/>
            <p:cNvSpPr/>
            <p:nvPr/>
          </p:nvSpPr>
          <p:spPr>
            <a:xfrm>
              <a:off x="2737691" y="1880319"/>
              <a:ext cx="33020" cy="38735"/>
            </a:xfrm>
            <a:custGeom>
              <a:avLst/>
              <a:gdLst/>
              <a:ahLst/>
              <a:cxnLst/>
              <a:rect l="l" t="t" r="r" b="b"/>
              <a:pathLst>
                <a:path w="33019" h="38735">
                  <a:moveTo>
                    <a:pt x="0" y="12399"/>
                  </a:moveTo>
                  <a:lnTo>
                    <a:pt x="32477" y="0"/>
                  </a:lnTo>
                  <a:lnTo>
                    <a:pt x="28638" y="38677"/>
                  </a:lnTo>
                  <a:lnTo>
                    <a:pt x="0" y="12399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" name="object 49"/>
            <p:cNvSpPr/>
            <p:nvPr/>
          </p:nvSpPr>
          <p:spPr>
            <a:xfrm>
              <a:off x="2841339" y="1805035"/>
              <a:ext cx="64135" cy="105410"/>
            </a:xfrm>
            <a:custGeom>
              <a:avLst/>
              <a:gdLst/>
              <a:ahLst/>
              <a:cxnLst/>
              <a:rect l="l" t="t" r="r" b="b"/>
              <a:pathLst>
                <a:path w="64135" h="105410">
                  <a:moveTo>
                    <a:pt x="57990" y="105149"/>
                  </a:moveTo>
                  <a:lnTo>
                    <a:pt x="63768" y="84966"/>
                  </a:lnTo>
                  <a:lnTo>
                    <a:pt x="63798" y="64353"/>
                  </a:lnTo>
                  <a:lnTo>
                    <a:pt x="58245" y="44503"/>
                  </a:lnTo>
                  <a:lnTo>
                    <a:pt x="47270" y="26606"/>
                  </a:lnTo>
                  <a:lnTo>
                    <a:pt x="37332" y="16626"/>
                  </a:lnTo>
                  <a:lnTo>
                    <a:pt x="25917" y="8789"/>
                  </a:lnTo>
                  <a:lnTo>
                    <a:pt x="13360" y="3209"/>
                  </a:lnTo>
                  <a:lnTo>
                    <a:pt x="0" y="0"/>
                  </a:lnTo>
                </a:path>
              </a:pathLst>
            </a:custGeom>
            <a:ln w="8691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0" name="object 50"/>
            <p:cNvSpPr/>
            <p:nvPr/>
          </p:nvSpPr>
          <p:spPr>
            <a:xfrm>
              <a:off x="2813524" y="1787382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60" h="34925">
                  <a:moveTo>
                    <a:pt x="34011" y="0"/>
                  </a:moveTo>
                  <a:lnTo>
                    <a:pt x="35456" y="34734"/>
                  </a:lnTo>
                  <a:lnTo>
                    <a:pt x="0" y="18812"/>
                  </a:lnTo>
                  <a:lnTo>
                    <a:pt x="34011" y="0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" name="object 51"/>
            <p:cNvSpPr/>
            <p:nvPr/>
          </p:nvSpPr>
          <p:spPr>
            <a:xfrm>
              <a:off x="2779846" y="1935310"/>
              <a:ext cx="92075" cy="19685"/>
            </a:xfrm>
            <a:custGeom>
              <a:avLst/>
              <a:gdLst/>
              <a:ahLst/>
              <a:cxnLst/>
              <a:rect l="l" t="t" r="r" b="b"/>
              <a:pathLst>
                <a:path w="92075" h="19685">
                  <a:moveTo>
                    <a:pt x="0" y="0"/>
                  </a:moveTo>
                  <a:lnTo>
                    <a:pt x="12843" y="9402"/>
                  </a:lnTo>
                  <a:lnTo>
                    <a:pt x="27211" y="15841"/>
                  </a:lnTo>
                  <a:lnTo>
                    <a:pt x="42605" y="19153"/>
                  </a:lnTo>
                  <a:lnTo>
                    <a:pt x="58522" y="19174"/>
                  </a:lnTo>
                  <a:lnTo>
                    <a:pt x="67349" y="17714"/>
                  </a:lnTo>
                  <a:lnTo>
                    <a:pt x="75864" y="15244"/>
                  </a:lnTo>
                  <a:lnTo>
                    <a:pt x="83989" y="11811"/>
                  </a:lnTo>
                  <a:lnTo>
                    <a:pt x="91644" y="7460"/>
                  </a:lnTo>
                </a:path>
              </a:pathLst>
            </a:custGeom>
            <a:ln w="8691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2" name="object 52"/>
            <p:cNvSpPr/>
            <p:nvPr/>
          </p:nvSpPr>
          <p:spPr>
            <a:xfrm>
              <a:off x="2854496" y="1923554"/>
              <a:ext cx="37465" cy="36830"/>
            </a:xfrm>
            <a:custGeom>
              <a:avLst/>
              <a:gdLst/>
              <a:ahLst/>
              <a:cxnLst/>
              <a:rect l="l" t="t" r="r" b="b"/>
              <a:pathLst>
                <a:path w="37464" h="36830">
                  <a:moveTo>
                    <a:pt x="23976" y="36563"/>
                  </a:moveTo>
                  <a:lnTo>
                    <a:pt x="0" y="11390"/>
                  </a:lnTo>
                  <a:lnTo>
                    <a:pt x="37161" y="0"/>
                  </a:lnTo>
                  <a:lnTo>
                    <a:pt x="23976" y="36563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" name="object 53"/>
            <p:cNvSpPr/>
            <p:nvPr/>
          </p:nvSpPr>
          <p:spPr>
            <a:xfrm>
              <a:off x="2803455" y="1852521"/>
              <a:ext cx="54610" cy="54610"/>
            </a:xfrm>
            <a:custGeom>
              <a:avLst/>
              <a:gdLst/>
              <a:ahLst/>
              <a:cxnLst/>
              <a:rect l="l" t="t" r="r" b="b"/>
              <a:pathLst>
                <a:path w="54610" h="54610">
                  <a:moveTo>
                    <a:pt x="0" y="27053"/>
                  </a:moveTo>
                  <a:lnTo>
                    <a:pt x="2125" y="16523"/>
                  </a:lnTo>
                  <a:lnTo>
                    <a:pt x="7923" y="7923"/>
                  </a:lnTo>
                  <a:lnTo>
                    <a:pt x="16523" y="2125"/>
                  </a:lnTo>
                  <a:lnTo>
                    <a:pt x="27053" y="0"/>
                  </a:lnTo>
                  <a:lnTo>
                    <a:pt x="37584" y="2125"/>
                  </a:lnTo>
                  <a:lnTo>
                    <a:pt x="46183" y="7923"/>
                  </a:lnTo>
                  <a:lnTo>
                    <a:pt x="51981" y="16523"/>
                  </a:lnTo>
                  <a:lnTo>
                    <a:pt x="54107" y="27053"/>
                  </a:lnTo>
                  <a:lnTo>
                    <a:pt x="51981" y="37584"/>
                  </a:lnTo>
                  <a:lnTo>
                    <a:pt x="46183" y="46183"/>
                  </a:lnTo>
                  <a:lnTo>
                    <a:pt x="37584" y="51981"/>
                  </a:lnTo>
                  <a:lnTo>
                    <a:pt x="27053" y="54107"/>
                  </a:lnTo>
                  <a:lnTo>
                    <a:pt x="16523" y="51981"/>
                  </a:lnTo>
                  <a:lnTo>
                    <a:pt x="7923" y="46183"/>
                  </a:lnTo>
                  <a:lnTo>
                    <a:pt x="2125" y="37584"/>
                  </a:lnTo>
                  <a:lnTo>
                    <a:pt x="0" y="27053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" name="object 54"/>
            <p:cNvSpPr/>
            <p:nvPr/>
          </p:nvSpPr>
          <p:spPr>
            <a:xfrm>
              <a:off x="2803455" y="1852521"/>
              <a:ext cx="54610" cy="54610"/>
            </a:xfrm>
            <a:custGeom>
              <a:avLst/>
              <a:gdLst/>
              <a:ahLst/>
              <a:cxnLst/>
              <a:rect l="l" t="t" r="r" b="b"/>
              <a:pathLst>
                <a:path w="54610" h="54610">
                  <a:moveTo>
                    <a:pt x="27053" y="0"/>
                  </a:moveTo>
                  <a:lnTo>
                    <a:pt x="16523" y="2125"/>
                  </a:lnTo>
                  <a:lnTo>
                    <a:pt x="7923" y="7923"/>
                  </a:lnTo>
                  <a:lnTo>
                    <a:pt x="2125" y="16523"/>
                  </a:lnTo>
                  <a:lnTo>
                    <a:pt x="0" y="27053"/>
                  </a:lnTo>
                  <a:lnTo>
                    <a:pt x="2125" y="37584"/>
                  </a:lnTo>
                  <a:lnTo>
                    <a:pt x="7923" y="46183"/>
                  </a:lnTo>
                  <a:lnTo>
                    <a:pt x="16523" y="51981"/>
                  </a:lnTo>
                  <a:lnTo>
                    <a:pt x="27053" y="54107"/>
                  </a:lnTo>
                  <a:lnTo>
                    <a:pt x="37584" y="51981"/>
                  </a:lnTo>
                  <a:lnTo>
                    <a:pt x="46183" y="46183"/>
                  </a:lnTo>
                  <a:lnTo>
                    <a:pt x="51981" y="37584"/>
                  </a:lnTo>
                  <a:lnTo>
                    <a:pt x="54107" y="27053"/>
                  </a:lnTo>
                  <a:lnTo>
                    <a:pt x="51981" y="16523"/>
                  </a:lnTo>
                  <a:lnTo>
                    <a:pt x="46183" y="7923"/>
                  </a:lnTo>
                  <a:lnTo>
                    <a:pt x="37584" y="2125"/>
                  </a:lnTo>
                  <a:lnTo>
                    <a:pt x="27053" y="0"/>
                  </a:lnTo>
                  <a:close/>
                </a:path>
              </a:pathLst>
            </a:custGeom>
            <a:ln w="4285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5" name="object 55"/>
            <p:cNvSpPr/>
            <p:nvPr/>
          </p:nvSpPr>
          <p:spPr>
            <a:xfrm>
              <a:off x="2813577" y="1862642"/>
              <a:ext cx="34290" cy="34290"/>
            </a:xfrm>
            <a:custGeom>
              <a:avLst/>
              <a:gdLst/>
              <a:ahLst/>
              <a:cxnLst/>
              <a:rect l="l" t="t" r="r" b="b"/>
              <a:pathLst>
                <a:path w="34289" h="34289">
                  <a:moveTo>
                    <a:pt x="0" y="26284"/>
                  </a:moveTo>
                  <a:lnTo>
                    <a:pt x="0" y="7580"/>
                  </a:lnTo>
                  <a:lnTo>
                    <a:pt x="7580" y="0"/>
                  </a:lnTo>
                  <a:lnTo>
                    <a:pt x="16932" y="0"/>
                  </a:lnTo>
                  <a:lnTo>
                    <a:pt x="26284" y="0"/>
                  </a:lnTo>
                  <a:lnTo>
                    <a:pt x="33865" y="7580"/>
                  </a:lnTo>
                  <a:lnTo>
                    <a:pt x="33865" y="26284"/>
                  </a:lnTo>
                  <a:lnTo>
                    <a:pt x="26284" y="33865"/>
                  </a:lnTo>
                  <a:lnTo>
                    <a:pt x="7580" y="33865"/>
                  </a:lnTo>
                  <a:lnTo>
                    <a:pt x="0" y="26284"/>
                  </a:lnTo>
                  <a:close/>
                </a:path>
              </a:pathLst>
            </a:custGeom>
            <a:solidFill>
              <a:srgbClr val="7070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" name="object 56"/>
            <p:cNvSpPr/>
            <p:nvPr/>
          </p:nvSpPr>
          <p:spPr>
            <a:xfrm>
              <a:off x="2813577" y="1862642"/>
              <a:ext cx="34290" cy="34290"/>
            </a:xfrm>
            <a:custGeom>
              <a:avLst/>
              <a:gdLst/>
              <a:ahLst/>
              <a:cxnLst/>
              <a:rect l="l" t="t" r="r" b="b"/>
              <a:pathLst>
                <a:path w="34289" h="34289">
                  <a:moveTo>
                    <a:pt x="16932" y="0"/>
                  </a:moveTo>
                  <a:lnTo>
                    <a:pt x="7580" y="0"/>
                  </a:lnTo>
                  <a:lnTo>
                    <a:pt x="0" y="7580"/>
                  </a:lnTo>
                  <a:lnTo>
                    <a:pt x="0" y="16932"/>
                  </a:lnTo>
                  <a:lnTo>
                    <a:pt x="0" y="26284"/>
                  </a:lnTo>
                  <a:lnTo>
                    <a:pt x="7580" y="33865"/>
                  </a:lnTo>
                  <a:lnTo>
                    <a:pt x="16932" y="33865"/>
                  </a:lnTo>
                  <a:lnTo>
                    <a:pt x="26284" y="33865"/>
                  </a:lnTo>
                  <a:lnTo>
                    <a:pt x="33865" y="26284"/>
                  </a:lnTo>
                  <a:lnTo>
                    <a:pt x="33865" y="16932"/>
                  </a:lnTo>
                  <a:lnTo>
                    <a:pt x="33865" y="7580"/>
                  </a:lnTo>
                  <a:lnTo>
                    <a:pt x="26284" y="0"/>
                  </a:lnTo>
                  <a:lnTo>
                    <a:pt x="16932" y="0"/>
                  </a:lnTo>
                  <a:close/>
                </a:path>
              </a:pathLst>
            </a:custGeom>
            <a:ln w="3175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7" name="object 57"/>
            <p:cNvSpPr/>
            <p:nvPr/>
          </p:nvSpPr>
          <p:spPr>
            <a:xfrm>
              <a:off x="3681171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" name="object 58"/>
            <p:cNvSpPr/>
            <p:nvPr/>
          </p:nvSpPr>
          <p:spPr>
            <a:xfrm>
              <a:off x="3681021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" name="object 59"/>
            <p:cNvSpPr/>
            <p:nvPr/>
          </p:nvSpPr>
          <p:spPr>
            <a:xfrm>
              <a:off x="3650058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" name="object 60"/>
            <p:cNvSpPr/>
            <p:nvPr/>
          </p:nvSpPr>
          <p:spPr>
            <a:xfrm>
              <a:off x="3649909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" name="object 61"/>
            <p:cNvSpPr/>
            <p:nvPr/>
          </p:nvSpPr>
          <p:spPr>
            <a:xfrm>
              <a:off x="3618946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" name="object 62"/>
            <p:cNvSpPr/>
            <p:nvPr/>
          </p:nvSpPr>
          <p:spPr>
            <a:xfrm>
              <a:off x="3618796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" name="object 63"/>
            <p:cNvSpPr/>
            <p:nvPr/>
          </p:nvSpPr>
          <p:spPr>
            <a:xfrm>
              <a:off x="3587834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" name="object 64"/>
            <p:cNvSpPr/>
            <p:nvPr/>
          </p:nvSpPr>
          <p:spPr>
            <a:xfrm>
              <a:off x="3587684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" name="object 65"/>
            <p:cNvSpPr/>
            <p:nvPr/>
          </p:nvSpPr>
          <p:spPr>
            <a:xfrm>
              <a:off x="3556722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6" name="object 66"/>
            <p:cNvSpPr/>
            <p:nvPr/>
          </p:nvSpPr>
          <p:spPr>
            <a:xfrm>
              <a:off x="3556572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7" name="object 67"/>
            <p:cNvSpPr/>
            <p:nvPr/>
          </p:nvSpPr>
          <p:spPr>
            <a:xfrm>
              <a:off x="3525610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8" name="object 68"/>
            <p:cNvSpPr/>
            <p:nvPr/>
          </p:nvSpPr>
          <p:spPr>
            <a:xfrm>
              <a:off x="3525460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9" name="object 69"/>
            <p:cNvSpPr/>
            <p:nvPr/>
          </p:nvSpPr>
          <p:spPr>
            <a:xfrm>
              <a:off x="3494497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0" name="object 70"/>
            <p:cNvSpPr/>
            <p:nvPr/>
          </p:nvSpPr>
          <p:spPr>
            <a:xfrm>
              <a:off x="3494348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1" name="object 71"/>
            <p:cNvSpPr/>
            <p:nvPr/>
          </p:nvSpPr>
          <p:spPr>
            <a:xfrm>
              <a:off x="3463385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2" name="object 72"/>
            <p:cNvSpPr/>
            <p:nvPr/>
          </p:nvSpPr>
          <p:spPr>
            <a:xfrm>
              <a:off x="3463235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3" name="object 73"/>
            <p:cNvSpPr/>
            <p:nvPr/>
          </p:nvSpPr>
          <p:spPr>
            <a:xfrm>
              <a:off x="3432272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4" name="object 74"/>
            <p:cNvSpPr/>
            <p:nvPr/>
          </p:nvSpPr>
          <p:spPr>
            <a:xfrm>
              <a:off x="3432123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5" name="object 75"/>
            <p:cNvSpPr/>
            <p:nvPr/>
          </p:nvSpPr>
          <p:spPr>
            <a:xfrm>
              <a:off x="3401160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6" name="object 76"/>
            <p:cNvSpPr/>
            <p:nvPr/>
          </p:nvSpPr>
          <p:spPr>
            <a:xfrm>
              <a:off x="3401010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7" name="object 77"/>
            <p:cNvSpPr/>
            <p:nvPr/>
          </p:nvSpPr>
          <p:spPr>
            <a:xfrm>
              <a:off x="3370047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8" name="object 78"/>
            <p:cNvSpPr/>
            <p:nvPr/>
          </p:nvSpPr>
          <p:spPr>
            <a:xfrm>
              <a:off x="3369898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9" name="object 79"/>
            <p:cNvSpPr/>
            <p:nvPr/>
          </p:nvSpPr>
          <p:spPr>
            <a:xfrm>
              <a:off x="3338936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0" name="object 80"/>
            <p:cNvSpPr/>
            <p:nvPr/>
          </p:nvSpPr>
          <p:spPr>
            <a:xfrm>
              <a:off x="3338785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1" name="object 81"/>
            <p:cNvSpPr/>
            <p:nvPr/>
          </p:nvSpPr>
          <p:spPr>
            <a:xfrm>
              <a:off x="3307823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2" name="object 82"/>
            <p:cNvSpPr/>
            <p:nvPr/>
          </p:nvSpPr>
          <p:spPr>
            <a:xfrm>
              <a:off x="3307673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3" name="object 83"/>
            <p:cNvSpPr/>
            <p:nvPr/>
          </p:nvSpPr>
          <p:spPr>
            <a:xfrm>
              <a:off x="3276711" y="1731173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4"/>
                  </a:lnTo>
                  <a:lnTo>
                    <a:pt x="0" y="1903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4" name="object 84"/>
            <p:cNvSpPr/>
            <p:nvPr/>
          </p:nvSpPr>
          <p:spPr>
            <a:xfrm>
              <a:off x="3276561" y="173351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59"/>
                  </a:lnTo>
                  <a:lnTo>
                    <a:pt x="0" y="1435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5" name="object 85"/>
            <p:cNvSpPr/>
            <p:nvPr/>
          </p:nvSpPr>
          <p:spPr>
            <a:xfrm>
              <a:off x="3242572" y="1731173"/>
              <a:ext cx="34925" cy="20955"/>
            </a:xfrm>
            <a:custGeom>
              <a:avLst/>
              <a:gdLst/>
              <a:ahLst/>
              <a:cxnLst/>
              <a:rect l="l" t="t" r="r" b="b"/>
              <a:pathLst>
                <a:path w="34925" h="20955">
                  <a:moveTo>
                    <a:pt x="15802" y="0"/>
                  </a:moveTo>
                  <a:lnTo>
                    <a:pt x="34488" y="0"/>
                  </a:lnTo>
                  <a:lnTo>
                    <a:pt x="34488" y="19034"/>
                  </a:lnTo>
                  <a:lnTo>
                    <a:pt x="15802" y="19034"/>
                  </a:lnTo>
                  <a:lnTo>
                    <a:pt x="14001" y="19094"/>
                  </a:lnTo>
                  <a:lnTo>
                    <a:pt x="12216" y="19273"/>
                  </a:lnTo>
                  <a:lnTo>
                    <a:pt x="10452" y="19572"/>
                  </a:lnTo>
                  <a:lnTo>
                    <a:pt x="7869" y="20240"/>
                  </a:lnTo>
                  <a:lnTo>
                    <a:pt x="6606" y="20671"/>
                  </a:lnTo>
                  <a:lnTo>
                    <a:pt x="0" y="2820"/>
                  </a:lnTo>
                  <a:lnTo>
                    <a:pt x="12733" y="102"/>
                  </a:lnTo>
                  <a:lnTo>
                    <a:pt x="15802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6" name="object 86"/>
            <p:cNvSpPr/>
            <p:nvPr/>
          </p:nvSpPr>
          <p:spPr>
            <a:xfrm>
              <a:off x="3243214" y="1733510"/>
              <a:ext cx="34290" cy="16510"/>
            </a:xfrm>
            <a:custGeom>
              <a:avLst/>
              <a:gdLst/>
              <a:ahLst/>
              <a:cxnLst/>
              <a:rect l="l" t="t" r="r" b="b"/>
              <a:pathLst>
                <a:path w="34289" h="16510">
                  <a:moveTo>
                    <a:pt x="15160" y="0"/>
                  </a:moveTo>
                  <a:lnTo>
                    <a:pt x="33981" y="0"/>
                  </a:lnTo>
                  <a:lnTo>
                    <a:pt x="33981" y="14359"/>
                  </a:lnTo>
                  <a:lnTo>
                    <a:pt x="15160" y="14359"/>
                  </a:lnTo>
                  <a:lnTo>
                    <a:pt x="13204" y="14425"/>
                  </a:lnTo>
                  <a:lnTo>
                    <a:pt x="5041" y="16183"/>
                  </a:lnTo>
                  <a:lnTo>
                    <a:pt x="0" y="2737"/>
                  </a:lnTo>
                  <a:lnTo>
                    <a:pt x="12248" y="97"/>
                  </a:lnTo>
                  <a:lnTo>
                    <a:pt x="1516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7" name="object 87"/>
            <p:cNvSpPr/>
            <p:nvPr/>
          </p:nvSpPr>
          <p:spPr>
            <a:xfrm>
              <a:off x="3215653" y="1733842"/>
              <a:ext cx="34290" cy="34290"/>
            </a:xfrm>
            <a:custGeom>
              <a:avLst/>
              <a:gdLst/>
              <a:ahLst/>
              <a:cxnLst/>
              <a:rect l="l" t="t" r="r" b="b"/>
              <a:pathLst>
                <a:path w="34289" h="34289">
                  <a:moveTo>
                    <a:pt x="27334" y="0"/>
                  </a:moveTo>
                  <a:lnTo>
                    <a:pt x="33767" y="17914"/>
                  </a:lnTo>
                  <a:lnTo>
                    <a:pt x="32412" y="18444"/>
                  </a:lnTo>
                  <a:lnTo>
                    <a:pt x="30862" y="19159"/>
                  </a:lnTo>
                  <a:lnTo>
                    <a:pt x="17856" y="33686"/>
                  </a:lnTo>
                  <a:lnTo>
                    <a:pt x="0" y="27094"/>
                  </a:lnTo>
                  <a:lnTo>
                    <a:pt x="25770" y="594"/>
                  </a:lnTo>
                  <a:lnTo>
                    <a:pt x="27334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8" name="object 88"/>
            <p:cNvSpPr/>
            <p:nvPr/>
          </p:nvSpPr>
          <p:spPr>
            <a:xfrm>
              <a:off x="3217784" y="1735987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4" h="31114">
                  <a:moveTo>
                    <a:pt x="26147" y="0"/>
                  </a:moveTo>
                  <a:lnTo>
                    <a:pt x="30948" y="13534"/>
                  </a:lnTo>
                  <a:lnTo>
                    <a:pt x="29371" y="14146"/>
                  </a:lnTo>
                  <a:lnTo>
                    <a:pt x="27684" y="14925"/>
                  </a:lnTo>
                  <a:lnTo>
                    <a:pt x="13492" y="30843"/>
                  </a:lnTo>
                  <a:lnTo>
                    <a:pt x="0" y="25928"/>
                  </a:lnTo>
                  <a:lnTo>
                    <a:pt x="24560" y="598"/>
                  </a:lnTo>
                  <a:lnTo>
                    <a:pt x="26147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89" name="object 89"/>
            <p:cNvSpPr/>
            <p:nvPr/>
          </p:nvSpPr>
          <p:spPr>
            <a:xfrm>
              <a:off x="3212847" y="1760522"/>
              <a:ext cx="20955" cy="34925"/>
            </a:xfrm>
            <a:custGeom>
              <a:avLst/>
              <a:gdLst/>
              <a:ahLst/>
              <a:cxnLst/>
              <a:rect l="l" t="t" r="r" b="b"/>
              <a:pathLst>
                <a:path w="20955" h="34925">
                  <a:moveTo>
                    <a:pt x="2961" y="0"/>
                  </a:moveTo>
                  <a:lnTo>
                    <a:pt x="20753" y="6765"/>
                  </a:lnTo>
                  <a:lnTo>
                    <a:pt x="20286" y="8098"/>
                  </a:lnTo>
                  <a:lnTo>
                    <a:pt x="19892" y="9454"/>
                  </a:lnTo>
                  <a:lnTo>
                    <a:pt x="19572" y="10830"/>
                  </a:lnTo>
                  <a:lnTo>
                    <a:pt x="19273" y="12594"/>
                  </a:lnTo>
                  <a:lnTo>
                    <a:pt x="19094" y="14379"/>
                  </a:lnTo>
                  <a:lnTo>
                    <a:pt x="19034" y="16181"/>
                  </a:lnTo>
                  <a:lnTo>
                    <a:pt x="19034" y="34547"/>
                  </a:lnTo>
                  <a:lnTo>
                    <a:pt x="0" y="34547"/>
                  </a:lnTo>
                  <a:lnTo>
                    <a:pt x="0" y="16181"/>
                  </a:lnTo>
                  <a:lnTo>
                    <a:pt x="101" y="13113"/>
                  </a:lnTo>
                  <a:lnTo>
                    <a:pt x="409" y="10052"/>
                  </a:lnTo>
                  <a:lnTo>
                    <a:pt x="924" y="7015"/>
                  </a:lnTo>
                  <a:lnTo>
                    <a:pt x="1477" y="4641"/>
                  </a:lnTo>
                  <a:lnTo>
                    <a:pt x="2156" y="2300"/>
                  </a:lnTo>
                  <a:lnTo>
                    <a:pt x="2961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0" name="object 90"/>
            <p:cNvSpPr/>
            <p:nvPr/>
          </p:nvSpPr>
          <p:spPr>
            <a:xfrm>
              <a:off x="3215184" y="1761201"/>
              <a:ext cx="16510" cy="34290"/>
            </a:xfrm>
            <a:custGeom>
              <a:avLst/>
              <a:gdLst/>
              <a:ahLst/>
              <a:cxnLst/>
              <a:rect l="l" t="t" r="r" b="b"/>
              <a:pathLst>
                <a:path w="16510" h="34289">
                  <a:moveTo>
                    <a:pt x="2866" y="0"/>
                  </a:moveTo>
                  <a:lnTo>
                    <a:pt x="16269" y="5154"/>
                  </a:lnTo>
                  <a:lnTo>
                    <a:pt x="15744" y="6638"/>
                  </a:lnTo>
                  <a:lnTo>
                    <a:pt x="15303" y="8149"/>
                  </a:lnTo>
                  <a:lnTo>
                    <a:pt x="14945" y="9683"/>
                  </a:lnTo>
                  <a:lnTo>
                    <a:pt x="14619" y="11603"/>
                  </a:lnTo>
                  <a:lnTo>
                    <a:pt x="14424" y="13545"/>
                  </a:lnTo>
                  <a:lnTo>
                    <a:pt x="14359" y="15501"/>
                  </a:lnTo>
                  <a:lnTo>
                    <a:pt x="14359" y="34017"/>
                  </a:lnTo>
                  <a:lnTo>
                    <a:pt x="0" y="34017"/>
                  </a:lnTo>
                  <a:lnTo>
                    <a:pt x="0" y="15501"/>
                  </a:lnTo>
                  <a:lnTo>
                    <a:pt x="96" y="12589"/>
                  </a:lnTo>
                  <a:lnTo>
                    <a:pt x="388" y="9685"/>
                  </a:lnTo>
                  <a:lnTo>
                    <a:pt x="876" y="6804"/>
                  </a:lnTo>
                  <a:lnTo>
                    <a:pt x="1414" y="4501"/>
                  </a:lnTo>
                  <a:lnTo>
                    <a:pt x="2078" y="2230"/>
                  </a:lnTo>
                  <a:lnTo>
                    <a:pt x="2866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1" name="object 91"/>
            <p:cNvSpPr/>
            <p:nvPr/>
          </p:nvSpPr>
          <p:spPr>
            <a:xfrm>
              <a:off x="3212847" y="179472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2" name="object 92"/>
            <p:cNvSpPr/>
            <p:nvPr/>
          </p:nvSpPr>
          <p:spPr>
            <a:xfrm>
              <a:off x="3215184" y="1794585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3" name="object 93"/>
            <p:cNvSpPr/>
            <p:nvPr/>
          </p:nvSpPr>
          <p:spPr>
            <a:xfrm>
              <a:off x="3212847" y="182583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4" name="object 94"/>
            <p:cNvSpPr/>
            <p:nvPr/>
          </p:nvSpPr>
          <p:spPr>
            <a:xfrm>
              <a:off x="3215184" y="1825697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5" name="object 95"/>
            <p:cNvSpPr/>
            <p:nvPr/>
          </p:nvSpPr>
          <p:spPr>
            <a:xfrm>
              <a:off x="3212847" y="1856944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6" name="object 96"/>
            <p:cNvSpPr/>
            <p:nvPr/>
          </p:nvSpPr>
          <p:spPr>
            <a:xfrm>
              <a:off x="3215184" y="1856810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7" name="object 97"/>
            <p:cNvSpPr/>
            <p:nvPr/>
          </p:nvSpPr>
          <p:spPr>
            <a:xfrm>
              <a:off x="3212847" y="1888056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8" name="object 98"/>
            <p:cNvSpPr/>
            <p:nvPr/>
          </p:nvSpPr>
          <p:spPr>
            <a:xfrm>
              <a:off x="3215184" y="188792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99" name="object 99"/>
            <p:cNvSpPr/>
            <p:nvPr/>
          </p:nvSpPr>
          <p:spPr>
            <a:xfrm>
              <a:off x="3212847" y="1919169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0" name="object 100"/>
            <p:cNvSpPr/>
            <p:nvPr/>
          </p:nvSpPr>
          <p:spPr>
            <a:xfrm>
              <a:off x="3215184" y="1919033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1" name="object 101"/>
            <p:cNvSpPr/>
            <p:nvPr/>
          </p:nvSpPr>
          <p:spPr>
            <a:xfrm>
              <a:off x="3212847" y="195028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2" name="object 102"/>
            <p:cNvSpPr/>
            <p:nvPr/>
          </p:nvSpPr>
          <p:spPr>
            <a:xfrm>
              <a:off x="3215184" y="195014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3" name="object 103"/>
            <p:cNvSpPr/>
            <p:nvPr/>
          </p:nvSpPr>
          <p:spPr>
            <a:xfrm>
              <a:off x="3212847" y="1981394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4" name="object 104"/>
            <p:cNvSpPr/>
            <p:nvPr/>
          </p:nvSpPr>
          <p:spPr>
            <a:xfrm>
              <a:off x="3215184" y="1981258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5" name="object 105"/>
            <p:cNvSpPr/>
            <p:nvPr/>
          </p:nvSpPr>
          <p:spPr>
            <a:xfrm>
              <a:off x="3212847" y="2012506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6" name="object 106"/>
            <p:cNvSpPr/>
            <p:nvPr/>
          </p:nvSpPr>
          <p:spPr>
            <a:xfrm>
              <a:off x="3215184" y="201237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7" name="object 107"/>
            <p:cNvSpPr/>
            <p:nvPr/>
          </p:nvSpPr>
          <p:spPr>
            <a:xfrm>
              <a:off x="3212847" y="2043619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8" name="object 108"/>
            <p:cNvSpPr/>
            <p:nvPr/>
          </p:nvSpPr>
          <p:spPr>
            <a:xfrm>
              <a:off x="3215184" y="2043483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09" name="object 109"/>
            <p:cNvSpPr/>
            <p:nvPr/>
          </p:nvSpPr>
          <p:spPr>
            <a:xfrm>
              <a:off x="3212847" y="207473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0" name="object 110"/>
            <p:cNvSpPr/>
            <p:nvPr/>
          </p:nvSpPr>
          <p:spPr>
            <a:xfrm>
              <a:off x="3215184" y="207459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1" name="object 111"/>
            <p:cNvSpPr/>
            <p:nvPr/>
          </p:nvSpPr>
          <p:spPr>
            <a:xfrm>
              <a:off x="3212847" y="2105843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2" name="object 112"/>
            <p:cNvSpPr/>
            <p:nvPr/>
          </p:nvSpPr>
          <p:spPr>
            <a:xfrm>
              <a:off x="3215184" y="2105708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3" name="object 113"/>
            <p:cNvSpPr/>
            <p:nvPr/>
          </p:nvSpPr>
          <p:spPr>
            <a:xfrm>
              <a:off x="3212847" y="213695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4" name="object 114"/>
            <p:cNvSpPr/>
            <p:nvPr/>
          </p:nvSpPr>
          <p:spPr>
            <a:xfrm>
              <a:off x="3215184" y="2136820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5" name="object 115"/>
            <p:cNvSpPr/>
            <p:nvPr/>
          </p:nvSpPr>
          <p:spPr>
            <a:xfrm>
              <a:off x="3212847" y="2168067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6" name="object 116"/>
            <p:cNvSpPr/>
            <p:nvPr/>
          </p:nvSpPr>
          <p:spPr>
            <a:xfrm>
              <a:off x="3215184" y="2167932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7" name="object 117"/>
            <p:cNvSpPr/>
            <p:nvPr/>
          </p:nvSpPr>
          <p:spPr>
            <a:xfrm>
              <a:off x="3212847" y="219918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8" name="object 118"/>
            <p:cNvSpPr/>
            <p:nvPr/>
          </p:nvSpPr>
          <p:spPr>
            <a:xfrm>
              <a:off x="3215184" y="2199045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19" name="object 119"/>
            <p:cNvSpPr/>
            <p:nvPr/>
          </p:nvSpPr>
          <p:spPr>
            <a:xfrm>
              <a:off x="3212847" y="2230292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0" name="object 120"/>
            <p:cNvSpPr/>
            <p:nvPr/>
          </p:nvSpPr>
          <p:spPr>
            <a:xfrm>
              <a:off x="3215184" y="2230157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1" name="object 121"/>
            <p:cNvSpPr/>
            <p:nvPr/>
          </p:nvSpPr>
          <p:spPr>
            <a:xfrm>
              <a:off x="3212847" y="226140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2" name="object 122"/>
            <p:cNvSpPr/>
            <p:nvPr/>
          </p:nvSpPr>
          <p:spPr>
            <a:xfrm>
              <a:off x="3215184" y="2261270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3" name="object 123"/>
            <p:cNvSpPr/>
            <p:nvPr/>
          </p:nvSpPr>
          <p:spPr>
            <a:xfrm>
              <a:off x="3212847" y="2292517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4" name="object 124"/>
            <p:cNvSpPr/>
            <p:nvPr/>
          </p:nvSpPr>
          <p:spPr>
            <a:xfrm>
              <a:off x="3215184" y="2292382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5" name="object 125"/>
            <p:cNvSpPr/>
            <p:nvPr/>
          </p:nvSpPr>
          <p:spPr>
            <a:xfrm>
              <a:off x="3212847" y="2323629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6" name="object 126"/>
            <p:cNvSpPr/>
            <p:nvPr/>
          </p:nvSpPr>
          <p:spPr>
            <a:xfrm>
              <a:off x="3215184" y="2323494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7" name="object 127"/>
            <p:cNvSpPr/>
            <p:nvPr/>
          </p:nvSpPr>
          <p:spPr>
            <a:xfrm>
              <a:off x="3212847" y="235474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8" name="object 128"/>
            <p:cNvSpPr/>
            <p:nvPr/>
          </p:nvSpPr>
          <p:spPr>
            <a:xfrm>
              <a:off x="3215184" y="2354607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6"/>
                  </a:lnTo>
                  <a:lnTo>
                    <a:pt x="0" y="3174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29" name="object 129"/>
            <p:cNvSpPr/>
            <p:nvPr/>
          </p:nvSpPr>
          <p:spPr>
            <a:xfrm>
              <a:off x="3212847" y="2385854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4" y="0"/>
                  </a:lnTo>
                  <a:lnTo>
                    <a:pt x="19034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0" name="object 130"/>
            <p:cNvSpPr/>
            <p:nvPr/>
          </p:nvSpPr>
          <p:spPr>
            <a:xfrm>
              <a:off x="3215184" y="2385719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59" y="0"/>
                  </a:lnTo>
                  <a:lnTo>
                    <a:pt x="14359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1" name="object 131"/>
            <p:cNvSpPr/>
            <p:nvPr/>
          </p:nvSpPr>
          <p:spPr>
            <a:xfrm>
              <a:off x="3203737" y="2416966"/>
              <a:ext cx="28575" cy="35560"/>
            </a:xfrm>
            <a:custGeom>
              <a:avLst/>
              <a:gdLst/>
              <a:ahLst/>
              <a:cxnLst/>
              <a:rect l="l" t="t" r="r" b="b"/>
              <a:pathLst>
                <a:path w="28575" h="35560">
                  <a:moveTo>
                    <a:pt x="9109" y="0"/>
                  </a:moveTo>
                  <a:lnTo>
                    <a:pt x="28144" y="0"/>
                  </a:lnTo>
                  <a:lnTo>
                    <a:pt x="28041" y="3761"/>
                  </a:lnTo>
                  <a:lnTo>
                    <a:pt x="12515" y="35055"/>
                  </a:lnTo>
                  <a:lnTo>
                    <a:pt x="0" y="20714"/>
                  </a:lnTo>
                  <a:lnTo>
                    <a:pt x="1325" y="19475"/>
                  </a:lnTo>
                  <a:lnTo>
                    <a:pt x="2492" y="18232"/>
                  </a:lnTo>
                  <a:lnTo>
                    <a:pt x="9049" y="2492"/>
                  </a:lnTo>
                  <a:lnTo>
                    <a:pt x="9109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2" name="object 132"/>
            <p:cNvSpPr/>
            <p:nvPr/>
          </p:nvSpPr>
          <p:spPr>
            <a:xfrm>
              <a:off x="3205183" y="2416831"/>
              <a:ext cx="24765" cy="33655"/>
            </a:xfrm>
            <a:custGeom>
              <a:avLst/>
              <a:gdLst/>
              <a:ahLst/>
              <a:cxnLst/>
              <a:rect l="l" t="t" r="r" b="b"/>
              <a:pathLst>
                <a:path w="24764" h="33655">
                  <a:moveTo>
                    <a:pt x="10001" y="0"/>
                  </a:moveTo>
                  <a:lnTo>
                    <a:pt x="24361" y="0"/>
                  </a:lnTo>
                  <a:lnTo>
                    <a:pt x="24263" y="3741"/>
                  </a:lnTo>
                  <a:lnTo>
                    <a:pt x="9398" y="33548"/>
                  </a:lnTo>
                  <a:lnTo>
                    <a:pt x="0" y="22690"/>
                  </a:lnTo>
                  <a:lnTo>
                    <a:pt x="1532" y="21263"/>
                  </a:lnTo>
                  <a:lnTo>
                    <a:pt x="2801" y="19912"/>
                  </a:lnTo>
                  <a:lnTo>
                    <a:pt x="9935" y="2784"/>
                  </a:lnTo>
                  <a:lnTo>
                    <a:pt x="10001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3" name="object 133"/>
            <p:cNvSpPr/>
            <p:nvPr/>
          </p:nvSpPr>
          <p:spPr>
            <a:xfrm>
              <a:off x="3181020" y="2437511"/>
              <a:ext cx="35560" cy="26034"/>
            </a:xfrm>
            <a:custGeom>
              <a:avLst/>
              <a:gdLst/>
              <a:ahLst/>
              <a:cxnLst/>
              <a:rect l="l" t="t" r="r" b="b"/>
              <a:pathLst>
                <a:path w="35560" h="26035">
                  <a:moveTo>
                    <a:pt x="22911" y="0"/>
                  </a:moveTo>
                  <a:lnTo>
                    <a:pt x="35565" y="14218"/>
                  </a:lnTo>
                  <a:lnTo>
                    <a:pt x="34019" y="15534"/>
                  </a:lnTo>
                  <a:lnTo>
                    <a:pt x="32416" y="16780"/>
                  </a:lnTo>
                  <a:lnTo>
                    <a:pt x="5253" y="25747"/>
                  </a:lnTo>
                  <a:lnTo>
                    <a:pt x="0" y="25747"/>
                  </a:lnTo>
                  <a:lnTo>
                    <a:pt x="0" y="6713"/>
                  </a:lnTo>
                  <a:lnTo>
                    <a:pt x="5253" y="6713"/>
                  </a:lnTo>
                  <a:lnTo>
                    <a:pt x="7058" y="6653"/>
                  </a:lnTo>
                  <a:lnTo>
                    <a:pt x="22007" y="768"/>
                  </a:lnTo>
                  <a:lnTo>
                    <a:pt x="22911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4" name="object 134"/>
            <p:cNvSpPr/>
            <p:nvPr/>
          </p:nvSpPr>
          <p:spPr>
            <a:xfrm>
              <a:off x="3180870" y="2439184"/>
              <a:ext cx="34290" cy="22225"/>
            </a:xfrm>
            <a:custGeom>
              <a:avLst/>
              <a:gdLst/>
              <a:ahLst/>
              <a:cxnLst/>
              <a:rect l="l" t="t" r="r" b="b"/>
              <a:pathLst>
                <a:path w="34289" h="22225">
                  <a:moveTo>
                    <a:pt x="24695" y="0"/>
                  </a:moveTo>
                  <a:lnTo>
                    <a:pt x="34281" y="10691"/>
                  </a:lnTo>
                  <a:lnTo>
                    <a:pt x="32777" y="11979"/>
                  </a:lnTo>
                  <a:lnTo>
                    <a:pt x="31216" y="13197"/>
                  </a:lnTo>
                  <a:lnTo>
                    <a:pt x="5402" y="21737"/>
                  </a:lnTo>
                  <a:lnTo>
                    <a:pt x="0" y="21737"/>
                  </a:lnTo>
                  <a:lnTo>
                    <a:pt x="0" y="7376"/>
                  </a:lnTo>
                  <a:lnTo>
                    <a:pt x="5402" y="7376"/>
                  </a:lnTo>
                  <a:lnTo>
                    <a:pt x="7363" y="7311"/>
                  </a:lnTo>
                  <a:lnTo>
                    <a:pt x="23687" y="862"/>
                  </a:lnTo>
                  <a:lnTo>
                    <a:pt x="24695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5" name="object 135"/>
            <p:cNvSpPr/>
            <p:nvPr/>
          </p:nvSpPr>
          <p:spPr>
            <a:xfrm>
              <a:off x="3149907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6" name="object 136"/>
            <p:cNvSpPr/>
            <p:nvPr/>
          </p:nvSpPr>
          <p:spPr>
            <a:xfrm>
              <a:off x="3149758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7" name="object 137"/>
            <p:cNvSpPr/>
            <p:nvPr/>
          </p:nvSpPr>
          <p:spPr>
            <a:xfrm>
              <a:off x="3118796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8" name="object 138"/>
            <p:cNvSpPr/>
            <p:nvPr/>
          </p:nvSpPr>
          <p:spPr>
            <a:xfrm>
              <a:off x="3118645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39" name="object 139"/>
            <p:cNvSpPr/>
            <p:nvPr/>
          </p:nvSpPr>
          <p:spPr>
            <a:xfrm>
              <a:off x="3087683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0" name="object 140"/>
            <p:cNvSpPr/>
            <p:nvPr/>
          </p:nvSpPr>
          <p:spPr>
            <a:xfrm>
              <a:off x="3087533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1" name="object 141"/>
            <p:cNvSpPr/>
            <p:nvPr/>
          </p:nvSpPr>
          <p:spPr>
            <a:xfrm>
              <a:off x="3056571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2" name="object 142"/>
            <p:cNvSpPr/>
            <p:nvPr/>
          </p:nvSpPr>
          <p:spPr>
            <a:xfrm>
              <a:off x="3056421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3" name="object 143"/>
            <p:cNvSpPr/>
            <p:nvPr/>
          </p:nvSpPr>
          <p:spPr>
            <a:xfrm>
              <a:off x="3025458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4" name="object 144"/>
            <p:cNvSpPr/>
            <p:nvPr/>
          </p:nvSpPr>
          <p:spPr>
            <a:xfrm>
              <a:off x="3025309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5" name="object 145"/>
            <p:cNvSpPr/>
            <p:nvPr/>
          </p:nvSpPr>
          <p:spPr>
            <a:xfrm>
              <a:off x="2994346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6" name="object 146"/>
            <p:cNvSpPr/>
            <p:nvPr/>
          </p:nvSpPr>
          <p:spPr>
            <a:xfrm>
              <a:off x="2994196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7" name="object 147"/>
            <p:cNvSpPr/>
            <p:nvPr/>
          </p:nvSpPr>
          <p:spPr>
            <a:xfrm>
              <a:off x="2963234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8" name="object 148"/>
            <p:cNvSpPr/>
            <p:nvPr/>
          </p:nvSpPr>
          <p:spPr>
            <a:xfrm>
              <a:off x="2963084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49" name="object 149"/>
            <p:cNvSpPr/>
            <p:nvPr/>
          </p:nvSpPr>
          <p:spPr>
            <a:xfrm>
              <a:off x="2932121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0" name="object 150"/>
            <p:cNvSpPr/>
            <p:nvPr/>
          </p:nvSpPr>
          <p:spPr>
            <a:xfrm>
              <a:off x="2931972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1" name="object 151"/>
            <p:cNvSpPr/>
            <p:nvPr/>
          </p:nvSpPr>
          <p:spPr>
            <a:xfrm>
              <a:off x="2901009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2" name="object 152"/>
            <p:cNvSpPr/>
            <p:nvPr/>
          </p:nvSpPr>
          <p:spPr>
            <a:xfrm>
              <a:off x="2900859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3" name="object 153"/>
            <p:cNvSpPr/>
            <p:nvPr/>
          </p:nvSpPr>
          <p:spPr>
            <a:xfrm>
              <a:off x="2869897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4" name="object 154"/>
            <p:cNvSpPr/>
            <p:nvPr/>
          </p:nvSpPr>
          <p:spPr>
            <a:xfrm>
              <a:off x="2869747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5" name="object 155"/>
            <p:cNvSpPr/>
            <p:nvPr/>
          </p:nvSpPr>
          <p:spPr>
            <a:xfrm>
              <a:off x="2838785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6" name="object 156"/>
            <p:cNvSpPr/>
            <p:nvPr/>
          </p:nvSpPr>
          <p:spPr>
            <a:xfrm>
              <a:off x="2838634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7" name="object 157"/>
            <p:cNvSpPr/>
            <p:nvPr/>
          </p:nvSpPr>
          <p:spPr>
            <a:xfrm>
              <a:off x="2807672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8" name="object 158"/>
            <p:cNvSpPr/>
            <p:nvPr/>
          </p:nvSpPr>
          <p:spPr>
            <a:xfrm>
              <a:off x="2807523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59" name="object 159"/>
            <p:cNvSpPr/>
            <p:nvPr/>
          </p:nvSpPr>
          <p:spPr>
            <a:xfrm>
              <a:off x="2776560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0" name="object 160"/>
            <p:cNvSpPr/>
            <p:nvPr/>
          </p:nvSpPr>
          <p:spPr>
            <a:xfrm>
              <a:off x="2776410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1" name="object 161"/>
            <p:cNvSpPr/>
            <p:nvPr/>
          </p:nvSpPr>
          <p:spPr>
            <a:xfrm>
              <a:off x="2745447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2" name="object 162"/>
            <p:cNvSpPr/>
            <p:nvPr/>
          </p:nvSpPr>
          <p:spPr>
            <a:xfrm>
              <a:off x="2745298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3" name="object 163"/>
            <p:cNvSpPr/>
            <p:nvPr/>
          </p:nvSpPr>
          <p:spPr>
            <a:xfrm>
              <a:off x="2714335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4" name="object 164"/>
            <p:cNvSpPr/>
            <p:nvPr/>
          </p:nvSpPr>
          <p:spPr>
            <a:xfrm>
              <a:off x="2714185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5" name="object 165"/>
            <p:cNvSpPr/>
            <p:nvPr/>
          </p:nvSpPr>
          <p:spPr>
            <a:xfrm>
              <a:off x="2683222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6" name="object 166"/>
            <p:cNvSpPr/>
            <p:nvPr/>
          </p:nvSpPr>
          <p:spPr>
            <a:xfrm>
              <a:off x="2683073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7" name="object 167"/>
            <p:cNvSpPr/>
            <p:nvPr/>
          </p:nvSpPr>
          <p:spPr>
            <a:xfrm>
              <a:off x="2652110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8" name="object 168"/>
            <p:cNvSpPr/>
            <p:nvPr/>
          </p:nvSpPr>
          <p:spPr>
            <a:xfrm>
              <a:off x="2651960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69" name="object 169"/>
            <p:cNvSpPr/>
            <p:nvPr/>
          </p:nvSpPr>
          <p:spPr>
            <a:xfrm>
              <a:off x="2620998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0" name="object 170"/>
            <p:cNvSpPr/>
            <p:nvPr/>
          </p:nvSpPr>
          <p:spPr>
            <a:xfrm>
              <a:off x="2620848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1" name="object 171"/>
            <p:cNvSpPr/>
            <p:nvPr/>
          </p:nvSpPr>
          <p:spPr>
            <a:xfrm>
              <a:off x="2589886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2" name="object 172"/>
            <p:cNvSpPr/>
            <p:nvPr/>
          </p:nvSpPr>
          <p:spPr>
            <a:xfrm>
              <a:off x="2589735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3" name="object 173"/>
            <p:cNvSpPr/>
            <p:nvPr/>
          </p:nvSpPr>
          <p:spPr>
            <a:xfrm>
              <a:off x="2558773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4" name="object 174"/>
            <p:cNvSpPr/>
            <p:nvPr/>
          </p:nvSpPr>
          <p:spPr>
            <a:xfrm>
              <a:off x="2558624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5" name="object 175"/>
            <p:cNvSpPr/>
            <p:nvPr/>
          </p:nvSpPr>
          <p:spPr>
            <a:xfrm>
              <a:off x="2527661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6" name="object 176"/>
            <p:cNvSpPr/>
            <p:nvPr/>
          </p:nvSpPr>
          <p:spPr>
            <a:xfrm>
              <a:off x="2527511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7" name="object 177"/>
            <p:cNvSpPr/>
            <p:nvPr/>
          </p:nvSpPr>
          <p:spPr>
            <a:xfrm>
              <a:off x="2496549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8" name="object 178"/>
            <p:cNvSpPr/>
            <p:nvPr/>
          </p:nvSpPr>
          <p:spPr>
            <a:xfrm>
              <a:off x="2496399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79" name="object 179"/>
            <p:cNvSpPr/>
            <p:nvPr/>
          </p:nvSpPr>
          <p:spPr>
            <a:xfrm>
              <a:off x="2465436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0" name="object 180"/>
            <p:cNvSpPr/>
            <p:nvPr/>
          </p:nvSpPr>
          <p:spPr>
            <a:xfrm>
              <a:off x="2465287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6" y="0"/>
                  </a:lnTo>
                  <a:lnTo>
                    <a:pt x="31746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1" name="object 181"/>
            <p:cNvSpPr/>
            <p:nvPr/>
          </p:nvSpPr>
          <p:spPr>
            <a:xfrm>
              <a:off x="2434324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2" name="object 182"/>
            <p:cNvSpPr/>
            <p:nvPr/>
          </p:nvSpPr>
          <p:spPr>
            <a:xfrm>
              <a:off x="2434174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3" name="object 183"/>
            <p:cNvSpPr/>
            <p:nvPr/>
          </p:nvSpPr>
          <p:spPr>
            <a:xfrm>
              <a:off x="2403211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4" name="object 184"/>
            <p:cNvSpPr/>
            <p:nvPr/>
          </p:nvSpPr>
          <p:spPr>
            <a:xfrm>
              <a:off x="2403062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5" name="object 185"/>
            <p:cNvSpPr/>
            <p:nvPr/>
          </p:nvSpPr>
          <p:spPr>
            <a:xfrm>
              <a:off x="2372100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6" name="object 186"/>
            <p:cNvSpPr/>
            <p:nvPr/>
          </p:nvSpPr>
          <p:spPr>
            <a:xfrm>
              <a:off x="2371949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7" name="object 187"/>
            <p:cNvSpPr/>
            <p:nvPr/>
          </p:nvSpPr>
          <p:spPr>
            <a:xfrm>
              <a:off x="2340987" y="2444224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462" y="0"/>
                  </a:lnTo>
                  <a:lnTo>
                    <a:pt x="31462" y="19033"/>
                  </a:lnTo>
                  <a:lnTo>
                    <a:pt x="0" y="190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8" name="object 188"/>
            <p:cNvSpPr/>
            <p:nvPr/>
          </p:nvSpPr>
          <p:spPr>
            <a:xfrm>
              <a:off x="2340837" y="244656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747" y="0"/>
                  </a:lnTo>
                  <a:lnTo>
                    <a:pt x="31747" y="14360"/>
                  </a:lnTo>
                  <a:lnTo>
                    <a:pt x="0" y="1436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89" name="object 189"/>
            <p:cNvSpPr/>
            <p:nvPr/>
          </p:nvSpPr>
          <p:spPr>
            <a:xfrm>
              <a:off x="2305770" y="2437520"/>
              <a:ext cx="35560" cy="26034"/>
            </a:xfrm>
            <a:custGeom>
              <a:avLst/>
              <a:gdLst/>
              <a:ahLst/>
              <a:cxnLst/>
              <a:rect l="l" t="t" r="r" b="b"/>
              <a:pathLst>
                <a:path w="35560" h="26035">
                  <a:moveTo>
                    <a:pt x="12646" y="0"/>
                  </a:moveTo>
                  <a:lnTo>
                    <a:pt x="35566" y="6703"/>
                  </a:lnTo>
                  <a:lnTo>
                    <a:pt x="35566" y="25737"/>
                  </a:lnTo>
                  <a:lnTo>
                    <a:pt x="30287" y="25737"/>
                  </a:lnTo>
                  <a:lnTo>
                    <a:pt x="27213" y="25635"/>
                  </a:lnTo>
                  <a:lnTo>
                    <a:pt x="0" y="14226"/>
                  </a:lnTo>
                  <a:lnTo>
                    <a:pt x="12646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0" name="object 190"/>
            <p:cNvSpPr/>
            <p:nvPr/>
          </p:nvSpPr>
          <p:spPr>
            <a:xfrm>
              <a:off x="2307190" y="2439187"/>
              <a:ext cx="34290" cy="22225"/>
            </a:xfrm>
            <a:custGeom>
              <a:avLst/>
              <a:gdLst/>
              <a:ahLst/>
              <a:cxnLst/>
              <a:rect l="l" t="t" r="r" b="b"/>
              <a:pathLst>
                <a:path w="34289" h="22225">
                  <a:moveTo>
                    <a:pt x="9585" y="0"/>
                  </a:moveTo>
                  <a:lnTo>
                    <a:pt x="34282" y="7373"/>
                  </a:lnTo>
                  <a:lnTo>
                    <a:pt x="34282" y="21734"/>
                  </a:lnTo>
                  <a:lnTo>
                    <a:pt x="28868" y="21734"/>
                  </a:lnTo>
                  <a:lnTo>
                    <a:pt x="25950" y="21636"/>
                  </a:lnTo>
                  <a:lnTo>
                    <a:pt x="0" y="10692"/>
                  </a:lnTo>
                  <a:lnTo>
                    <a:pt x="9585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1" name="object 191"/>
            <p:cNvSpPr/>
            <p:nvPr/>
          </p:nvSpPr>
          <p:spPr>
            <a:xfrm>
              <a:off x="2290456" y="2416986"/>
              <a:ext cx="28575" cy="35560"/>
            </a:xfrm>
            <a:custGeom>
              <a:avLst/>
              <a:gdLst/>
              <a:ahLst/>
              <a:cxnLst/>
              <a:rect l="l" t="t" r="r" b="b"/>
              <a:pathLst>
                <a:path w="28575" h="35560">
                  <a:moveTo>
                    <a:pt x="0" y="0"/>
                  </a:moveTo>
                  <a:lnTo>
                    <a:pt x="19033" y="0"/>
                  </a:lnTo>
                  <a:lnTo>
                    <a:pt x="19093" y="2468"/>
                  </a:lnTo>
                  <a:lnTo>
                    <a:pt x="19273" y="4258"/>
                  </a:lnTo>
                  <a:lnTo>
                    <a:pt x="28154" y="20705"/>
                  </a:lnTo>
                  <a:lnTo>
                    <a:pt x="15646" y="35052"/>
                  </a:lnTo>
                  <a:lnTo>
                    <a:pt x="101" y="373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2" name="object 192"/>
            <p:cNvSpPr/>
            <p:nvPr/>
          </p:nvSpPr>
          <p:spPr>
            <a:xfrm>
              <a:off x="2292793" y="2416837"/>
              <a:ext cx="24765" cy="33655"/>
            </a:xfrm>
            <a:custGeom>
              <a:avLst/>
              <a:gdLst/>
              <a:ahLst/>
              <a:cxnLst/>
              <a:rect l="l" t="t" r="r" b="b"/>
              <a:pathLst>
                <a:path w="24764" h="33655">
                  <a:moveTo>
                    <a:pt x="0" y="0"/>
                  </a:moveTo>
                  <a:lnTo>
                    <a:pt x="14360" y="0"/>
                  </a:lnTo>
                  <a:lnTo>
                    <a:pt x="14425" y="2773"/>
                  </a:lnTo>
                  <a:lnTo>
                    <a:pt x="14620" y="4720"/>
                  </a:lnTo>
                  <a:lnTo>
                    <a:pt x="24364" y="22687"/>
                  </a:lnTo>
                  <a:lnTo>
                    <a:pt x="14968" y="33547"/>
                  </a:lnTo>
                  <a:lnTo>
                    <a:pt x="97" y="372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3" name="object 193"/>
            <p:cNvSpPr/>
            <p:nvPr/>
          </p:nvSpPr>
          <p:spPr>
            <a:xfrm>
              <a:off x="2290456" y="238587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9033" y="0"/>
                  </a:lnTo>
                  <a:lnTo>
                    <a:pt x="19033" y="31462"/>
                  </a:lnTo>
                  <a:lnTo>
                    <a:pt x="0" y="3146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194" name="object 194"/>
            <p:cNvSpPr/>
            <p:nvPr/>
          </p:nvSpPr>
          <p:spPr>
            <a:xfrm>
              <a:off x="2292793" y="2385724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5" h="31750">
                  <a:moveTo>
                    <a:pt x="0" y="0"/>
                  </a:moveTo>
                  <a:lnTo>
                    <a:pt x="14360" y="0"/>
                  </a:lnTo>
                  <a:lnTo>
                    <a:pt x="14360" y="31747"/>
                  </a:lnTo>
                  <a:lnTo>
                    <a:pt x="0" y="3174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195" name="object 195"/>
            <p:cNvPicPr/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2171699" y="1973579"/>
              <a:ext cx="260603" cy="452627"/>
            </a:xfrm>
            <a:prstGeom prst="rect">
              <a:avLst/>
            </a:prstGeom>
          </p:spPr>
        </p:pic>
        <p:pic>
          <p:nvPicPr>
            <p:cNvPr id="196" name="object 196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3683507" y="1479803"/>
              <a:ext cx="391667" cy="542543"/>
            </a:xfrm>
            <a:prstGeom prst="rect">
              <a:avLst/>
            </a:prstGeom>
          </p:spPr>
        </p:pic>
      </p:grpSp>
      <p:sp>
        <p:nvSpPr>
          <p:cNvPr id="197" name="object 197"/>
          <p:cNvSpPr txBox="1"/>
          <p:nvPr/>
        </p:nvSpPr>
        <p:spPr>
          <a:xfrm>
            <a:off x="1817682" y="646264"/>
            <a:ext cx="1569085" cy="386080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 marR="622300">
              <a:lnSpc>
                <a:spcPts val="830"/>
              </a:lnSpc>
              <a:spcBef>
                <a:spcPts val="114"/>
              </a:spcBef>
            </a:pPr>
            <a:r>
              <a:rPr dirty="0" sz="700" spc="-10" b="1">
                <a:latin typeface="Arial"/>
                <a:cs typeface="Arial"/>
              </a:rPr>
              <a:t>Temperature</a:t>
            </a:r>
            <a:endParaRPr sz="700">
              <a:latin typeface="Arial"/>
              <a:cs typeface="Arial"/>
            </a:endParaRPr>
          </a:p>
          <a:p>
            <a:pPr algn="ctr" marR="646430">
              <a:lnSpc>
                <a:spcPts val="830"/>
              </a:lnSpc>
            </a:pPr>
            <a:r>
              <a:rPr dirty="0" baseline="3968" sz="1050" spc="-240">
                <a:latin typeface="Arial"/>
                <a:cs typeface="Arial"/>
              </a:rPr>
              <a:t>Tem</a:t>
            </a:r>
            <a:r>
              <a:rPr dirty="0" sz="700" spc="-160" b="1">
                <a:latin typeface="Arial"/>
                <a:cs typeface="Arial"/>
              </a:rPr>
              <a:t>C</a:t>
            </a:r>
            <a:r>
              <a:rPr dirty="0" baseline="3968" sz="1050" spc="-240">
                <a:latin typeface="Arial"/>
                <a:cs typeface="Arial"/>
              </a:rPr>
              <a:t>p</a:t>
            </a:r>
            <a:r>
              <a:rPr dirty="0" sz="700" spc="-160" b="1">
                <a:latin typeface="Arial"/>
                <a:cs typeface="Arial"/>
              </a:rPr>
              <a:t>o</a:t>
            </a:r>
            <a:r>
              <a:rPr dirty="0" baseline="3968" sz="1050" spc="-240">
                <a:latin typeface="Arial"/>
                <a:cs typeface="Arial"/>
              </a:rPr>
              <a:t>e</a:t>
            </a:r>
            <a:r>
              <a:rPr dirty="0" sz="700" spc="-160" b="1">
                <a:latin typeface="Arial"/>
                <a:cs typeface="Arial"/>
              </a:rPr>
              <a:t>n</a:t>
            </a:r>
            <a:r>
              <a:rPr dirty="0" baseline="3968" sz="1050" spc="-240">
                <a:latin typeface="Arial"/>
                <a:cs typeface="Arial"/>
              </a:rPr>
              <a:t>r</a:t>
            </a:r>
            <a:r>
              <a:rPr dirty="0" sz="700" spc="-160" b="1">
                <a:latin typeface="Arial"/>
                <a:cs typeface="Arial"/>
              </a:rPr>
              <a:t>t</a:t>
            </a:r>
            <a:r>
              <a:rPr dirty="0" baseline="3968" sz="1050" spc="-240">
                <a:latin typeface="Arial"/>
                <a:cs typeface="Arial"/>
              </a:rPr>
              <a:t>a</a:t>
            </a:r>
            <a:r>
              <a:rPr dirty="0" sz="700" spc="-160" b="1">
                <a:latin typeface="Arial"/>
                <a:cs typeface="Arial"/>
              </a:rPr>
              <a:t>r</a:t>
            </a:r>
            <a:r>
              <a:rPr dirty="0" baseline="3968" sz="1050" spc="-240">
                <a:latin typeface="Arial"/>
                <a:cs typeface="Arial"/>
              </a:rPr>
              <a:t>t</a:t>
            </a:r>
            <a:r>
              <a:rPr dirty="0" sz="700" spc="-160" b="1">
                <a:latin typeface="Arial"/>
                <a:cs typeface="Arial"/>
              </a:rPr>
              <a:t>o</a:t>
            </a:r>
            <a:r>
              <a:rPr dirty="0" baseline="3968" sz="1050" spc="-240">
                <a:latin typeface="Arial"/>
                <a:cs typeface="Arial"/>
              </a:rPr>
              <a:t>u</a:t>
            </a:r>
            <a:r>
              <a:rPr dirty="0" sz="700" spc="-160" b="1">
                <a:latin typeface="Arial"/>
                <a:cs typeface="Arial"/>
              </a:rPr>
              <a:t>l</a:t>
            </a:r>
            <a:r>
              <a:rPr dirty="0" baseline="3968" sz="1050" spc="-240">
                <a:latin typeface="Arial"/>
                <a:cs typeface="Arial"/>
              </a:rPr>
              <a:t>r</a:t>
            </a:r>
            <a:r>
              <a:rPr dirty="0" sz="700" spc="-160" b="1">
                <a:latin typeface="Arial"/>
                <a:cs typeface="Arial"/>
              </a:rPr>
              <a:t>-</a:t>
            </a:r>
            <a:r>
              <a:rPr dirty="0" baseline="3968" sz="1050" spc="-15">
                <a:latin typeface="Arial"/>
                <a:cs typeface="Arial"/>
              </a:rPr>
              <a:t>e</a:t>
            </a:r>
            <a:r>
              <a:rPr dirty="0" baseline="3968" sz="1050" spc="7">
                <a:latin typeface="Arial"/>
                <a:cs typeface="Arial"/>
              </a:rPr>
              <a:t> </a:t>
            </a:r>
            <a:r>
              <a:rPr dirty="0" sz="700" spc="-70" b="1">
                <a:latin typeface="Arial"/>
                <a:cs typeface="Arial"/>
              </a:rPr>
              <a:t>3</a:t>
            </a:r>
            <a:r>
              <a:rPr dirty="0" baseline="3968" sz="1050" spc="-104">
                <a:latin typeface="Arial"/>
                <a:cs typeface="Arial"/>
              </a:rPr>
              <a:t>C</a:t>
            </a:r>
            <a:r>
              <a:rPr dirty="0" sz="700" spc="-70" b="1">
                <a:latin typeface="Arial"/>
                <a:cs typeface="Arial"/>
              </a:rPr>
              <a:t>2</a:t>
            </a:r>
            <a:r>
              <a:rPr dirty="0" baseline="3968" sz="1050" spc="-104">
                <a:latin typeface="Arial"/>
                <a:cs typeface="Arial"/>
              </a:rPr>
              <a:t>o</a:t>
            </a:r>
            <a:r>
              <a:rPr dirty="0" baseline="34722" sz="600" spc="-104" b="1">
                <a:latin typeface="Arial"/>
                <a:cs typeface="Arial"/>
              </a:rPr>
              <a:t>o</a:t>
            </a:r>
            <a:r>
              <a:rPr dirty="0" baseline="3968" sz="1050" spc="-104">
                <a:latin typeface="Arial"/>
                <a:cs typeface="Arial"/>
              </a:rPr>
              <a:t>n</a:t>
            </a:r>
            <a:r>
              <a:rPr dirty="0" sz="700" spc="-70" b="1">
                <a:latin typeface="Arial"/>
                <a:cs typeface="Arial"/>
              </a:rPr>
              <a:t>C</a:t>
            </a:r>
            <a:r>
              <a:rPr dirty="0" baseline="3968" sz="1050" spc="-104">
                <a:latin typeface="Arial"/>
                <a:cs typeface="Arial"/>
              </a:rPr>
              <a:t>trol</a:t>
            </a:r>
            <a:endParaRPr baseline="3968" sz="1050">
              <a:latin typeface="Arial"/>
              <a:cs typeface="Arial"/>
            </a:endParaRPr>
          </a:p>
          <a:p>
            <a:pPr algn="ctr" marL="835025">
              <a:lnSpc>
                <a:spcPct val="100000"/>
              </a:lnSpc>
              <a:spcBef>
                <a:spcPts val="315"/>
              </a:spcBef>
            </a:pPr>
            <a:r>
              <a:rPr dirty="0" sz="700" spc="-10" b="1">
                <a:solidFill>
                  <a:srgbClr val="C03830"/>
                </a:solidFill>
                <a:latin typeface="Arial"/>
                <a:cs typeface="Arial"/>
              </a:rPr>
              <a:t>Arterial</a:t>
            </a:r>
            <a:r>
              <a:rPr dirty="0" sz="700" spc="15" b="1">
                <a:solidFill>
                  <a:srgbClr val="C03830"/>
                </a:solidFill>
                <a:latin typeface="Arial"/>
                <a:cs typeface="Arial"/>
              </a:rPr>
              <a:t> </a:t>
            </a:r>
            <a:r>
              <a:rPr dirty="0" sz="700" spc="-10" b="1">
                <a:solidFill>
                  <a:srgbClr val="C03830"/>
                </a:solidFill>
                <a:latin typeface="Arial"/>
                <a:cs typeface="Arial"/>
              </a:rPr>
              <a:t>cannula</a:t>
            </a:r>
            <a:endParaRPr sz="700">
              <a:latin typeface="Arial"/>
              <a:cs typeface="Arial"/>
            </a:endParaRPr>
          </a:p>
        </p:txBody>
      </p:sp>
      <p:sp>
        <p:nvSpPr>
          <p:cNvPr id="198" name="object 198"/>
          <p:cNvSpPr txBox="1"/>
          <p:nvPr/>
        </p:nvSpPr>
        <p:spPr>
          <a:xfrm>
            <a:off x="2045765" y="3016350"/>
            <a:ext cx="14268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Red</a:t>
            </a:r>
            <a:r>
              <a:rPr dirty="0" sz="700" spc="-2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ell</a:t>
            </a:r>
            <a:r>
              <a:rPr dirty="0" sz="700" spc="-20" b="1">
                <a:latin typeface="Arial"/>
                <a:cs typeface="Arial"/>
              </a:rPr>
              <a:t> Based</a:t>
            </a:r>
            <a:r>
              <a:rPr dirty="0" sz="700" spc="-2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Perfusion</a:t>
            </a:r>
            <a:r>
              <a:rPr dirty="0" sz="700" spc="-20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Solution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8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199" name="object 199"/>
          <p:cNvGrpSpPr/>
          <p:nvPr/>
        </p:nvGrpSpPr>
        <p:grpSpPr>
          <a:xfrm>
            <a:off x="1662683" y="3872484"/>
            <a:ext cx="509270" cy="777240"/>
            <a:chOff x="1662683" y="3872484"/>
            <a:chExt cx="509270" cy="777240"/>
          </a:xfrm>
        </p:grpSpPr>
        <p:pic>
          <p:nvPicPr>
            <p:cNvPr id="200" name="object 200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1662683" y="3872484"/>
              <a:ext cx="509015" cy="440435"/>
            </a:xfrm>
            <a:prstGeom prst="rect">
              <a:avLst/>
            </a:prstGeom>
          </p:spPr>
        </p:pic>
        <p:sp>
          <p:nvSpPr>
            <p:cNvPr id="201" name="object 201"/>
            <p:cNvSpPr/>
            <p:nvPr/>
          </p:nvSpPr>
          <p:spPr>
            <a:xfrm>
              <a:off x="1895077" y="4244872"/>
              <a:ext cx="0" cy="341630"/>
            </a:xfrm>
            <a:custGeom>
              <a:avLst/>
              <a:gdLst/>
              <a:ahLst/>
              <a:cxnLst/>
              <a:rect l="l" t="t" r="r" b="b"/>
              <a:pathLst>
                <a:path w="0" h="341629">
                  <a:moveTo>
                    <a:pt x="0" y="0"/>
                  </a:moveTo>
                  <a:lnTo>
                    <a:pt x="0" y="341557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2" name="object 202"/>
            <p:cNvSpPr/>
            <p:nvPr/>
          </p:nvSpPr>
          <p:spPr>
            <a:xfrm>
              <a:off x="1855800" y="4570776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203" name="object 203"/>
          <p:cNvGrpSpPr/>
          <p:nvPr/>
        </p:nvGrpSpPr>
        <p:grpSpPr>
          <a:xfrm>
            <a:off x="2409926" y="3872485"/>
            <a:ext cx="509270" cy="777240"/>
            <a:chOff x="2409926" y="3872485"/>
            <a:chExt cx="509270" cy="777240"/>
          </a:xfrm>
        </p:grpSpPr>
        <p:sp>
          <p:nvSpPr>
            <p:cNvPr id="204" name="object 204"/>
            <p:cNvSpPr/>
            <p:nvPr/>
          </p:nvSpPr>
          <p:spPr>
            <a:xfrm>
              <a:off x="2760159" y="4244872"/>
              <a:ext cx="0" cy="341630"/>
            </a:xfrm>
            <a:custGeom>
              <a:avLst/>
              <a:gdLst/>
              <a:ahLst/>
              <a:cxnLst/>
              <a:rect l="l" t="t" r="r" b="b"/>
              <a:pathLst>
                <a:path w="0" h="341629">
                  <a:moveTo>
                    <a:pt x="0" y="0"/>
                  </a:moveTo>
                  <a:lnTo>
                    <a:pt x="0" y="341557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5" name="object 205"/>
            <p:cNvSpPr/>
            <p:nvPr/>
          </p:nvSpPr>
          <p:spPr>
            <a:xfrm>
              <a:off x="2720882" y="4570776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206" name="object 206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2409926" y="3872485"/>
              <a:ext cx="509015" cy="440435"/>
            </a:xfrm>
            <a:prstGeom prst="rect">
              <a:avLst/>
            </a:prstGeom>
          </p:spPr>
        </p:pic>
      </p:grpSp>
      <p:grpSp>
        <p:nvGrpSpPr>
          <p:cNvPr id="207" name="object 207"/>
          <p:cNvGrpSpPr/>
          <p:nvPr/>
        </p:nvGrpSpPr>
        <p:grpSpPr>
          <a:xfrm>
            <a:off x="1864647" y="3276993"/>
            <a:ext cx="1797050" cy="394970"/>
            <a:chOff x="1864647" y="3276993"/>
            <a:chExt cx="1797050" cy="394970"/>
          </a:xfrm>
        </p:grpSpPr>
        <p:sp>
          <p:nvSpPr>
            <p:cNvPr id="208" name="object 208"/>
            <p:cNvSpPr/>
            <p:nvPr/>
          </p:nvSpPr>
          <p:spPr>
            <a:xfrm>
              <a:off x="2763110" y="3288423"/>
              <a:ext cx="0" cy="86360"/>
            </a:xfrm>
            <a:custGeom>
              <a:avLst/>
              <a:gdLst/>
              <a:ahLst/>
              <a:cxnLst/>
              <a:rect l="l" t="t" r="r" b="b"/>
              <a:pathLst>
                <a:path w="0" h="86360">
                  <a:moveTo>
                    <a:pt x="0" y="0"/>
                  </a:moveTo>
                  <a:lnTo>
                    <a:pt x="0" y="86269"/>
                  </a:lnTo>
                </a:path>
              </a:pathLst>
            </a:custGeom>
            <a:ln w="22444">
              <a:solidFill>
                <a:srgbClr val="9D343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09" name="object 209"/>
            <p:cNvSpPr/>
            <p:nvPr/>
          </p:nvSpPr>
          <p:spPr>
            <a:xfrm>
              <a:off x="1903924" y="3362838"/>
              <a:ext cx="1718945" cy="246379"/>
            </a:xfrm>
            <a:custGeom>
              <a:avLst/>
              <a:gdLst/>
              <a:ahLst/>
              <a:cxnLst/>
              <a:rect l="l" t="t" r="r" b="b"/>
              <a:pathLst>
                <a:path w="1718945" h="246379">
                  <a:moveTo>
                    <a:pt x="1718365" y="246208"/>
                  </a:moveTo>
                  <a:lnTo>
                    <a:pt x="1718365" y="88585"/>
                  </a:lnTo>
                  <a:lnTo>
                    <a:pt x="1711403" y="54103"/>
                  </a:lnTo>
                  <a:lnTo>
                    <a:pt x="1692419" y="25946"/>
                  </a:lnTo>
                  <a:lnTo>
                    <a:pt x="1664261" y="6961"/>
                  </a:lnTo>
                  <a:lnTo>
                    <a:pt x="1629779" y="0"/>
                  </a:lnTo>
                  <a:lnTo>
                    <a:pt x="856555" y="0"/>
                  </a:lnTo>
                  <a:lnTo>
                    <a:pt x="88585" y="0"/>
                  </a:lnTo>
                  <a:lnTo>
                    <a:pt x="54103" y="6961"/>
                  </a:lnTo>
                  <a:lnTo>
                    <a:pt x="25946" y="25946"/>
                  </a:lnTo>
                  <a:lnTo>
                    <a:pt x="6961" y="54103"/>
                  </a:lnTo>
                  <a:lnTo>
                    <a:pt x="0" y="88585"/>
                  </a:lnTo>
                  <a:lnTo>
                    <a:pt x="0" y="246208"/>
                  </a:lnTo>
                </a:path>
              </a:pathLst>
            </a:custGeom>
            <a:ln w="22444">
              <a:solidFill>
                <a:srgbClr val="9D343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0" name="object 210"/>
            <p:cNvSpPr/>
            <p:nvPr/>
          </p:nvSpPr>
          <p:spPr>
            <a:xfrm>
              <a:off x="1864639" y="3593375"/>
              <a:ext cx="1797050" cy="78740"/>
            </a:xfrm>
            <a:custGeom>
              <a:avLst/>
              <a:gdLst/>
              <a:ahLst/>
              <a:cxnLst/>
              <a:rect l="l" t="t" r="r" b="b"/>
              <a:pathLst>
                <a:path w="1797050" h="78739">
                  <a:moveTo>
                    <a:pt x="78562" y="12"/>
                  </a:moveTo>
                  <a:lnTo>
                    <a:pt x="0" y="12"/>
                  </a:lnTo>
                  <a:lnTo>
                    <a:pt x="39281" y="78562"/>
                  </a:lnTo>
                  <a:lnTo>
                    <a:pt x="78562" y="12"/>
                  </a:lnTo>
                  <a:close/>
                </a:path>
                <a:path w="1797050" h="78739">
                  <a:moveTo>
                    <a:pt x="1796923" y="0"/>
                  </a:moveTo>
                  <a:lnTo>
                    <a:pt x="1718360" y="0"/>
                  </a:lnTo>
                  <a:lnTo>
                    <a:pt x="1757641" y="78549"/>
                  </a:lnTo>
                  <a:lnTo>
                    <a:pt x="1796923" y="0"/>
                  </a:lnTo>
                  <a:close/>
                </a:path>
              </a:pathLst>
            </a:custGeom>
            <a:solidFill>
              <a:srgbClr val="9D343C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11" name="object 211"/>
          <p:cNvSpPr txBox="1"/>
          <p:nvPr/>
        </p:nvSpPr>
        <p:spPr>
          <a:xfrm>
            <a:off x="1712081" y="3664975"/>
            <a:ext cx="396240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0"/>
              </a:lnSpc>
              <a:spcBef>
                <a:spcPts val="114"/>
              </a:spcBef>
            </a:pPr>
            <a:r>
              <a:rPr dirty="0" sz="700" spc="-10" b="1">
                <a:latin typeface="Arial"/>
                <a:cs typeface="Arial"/>
              </a:rPr>
              <a:t>Pre-</a:t>
            </a:r>
            <a:r>
              <a:rPr dirty="0" sz="700" spc="-25" b="1">
                <a:latin typeface="Arial"/>
                <a:cs typeface="Arial"/>
              </a:rPr>
              <a:t>SMP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sp>
        <p:nvSpPr>
          <p:cNvPr id="212" name="object 212"/>
          <p:cNvSpPr txBox="1"/>
          <p:nvPr/>
        </p:nvSpPr>
        <p:spPr>
          <a:xfrm>
            <a:off x="2477725" y="3664973"/>
            <a:ext cx="565150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0"/>
              </a:lnSpc>
              <a:spcBef>
                <a:spcPts val="114"/>
              </a:spcBef>
            </a:pPr>
            <a:r>
              <a:rPr dirty="0" sz="700" b="1">
                <a:latin typeface="Arial"/>
                <a:cs typeface="Arial"/>
              </a:rPr>
              <a:t>6 </a:t>
            </a:r>
            <a:r>
              <a:rPr dirty="0" sz="700" spc="-20" b="1">
                <a:latin typeface="Arial"/>
                <a:cs typeface="Arial"/>
              </a:rPr>
              <a:t>Hours</a:t>
            </a:r>
            <a:r>
              <a:rPr dirty="0" sz="700" b="1">
                <a:latin typeface="Arial"/>
                <a:cs typeface="Arial"/>
              </a:rPr>
              <a:t> </a:t>
            </a:r>
            <a:r>
              <a:rPr dirty="0" sz="700" spc="-25" b="1">
                <a:latin typeface="Arial"/>
                <a:cs typeface="Arial"/>
              </a:rPr>
              <a:t>SMP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sp>
        <p:nvSpPr>
          <p:cNvPr id="213" name="object 213"/>
          <p:cNvSpPr txBox="1"/>
          <p:nvPr/>
        </p:nvSpPr>
        <p:spPr>
          <a:xfrm>
            <a:off x="1613857" y="4677289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214" name="object 214"/>
          <p:cNvGrpSpPr/>
          <p:nvPr/>
        </p:nvGrpSpPr>
        <p:grpSpPr>
          <a:xfrm>
            <a:off x="1855804" y="4937352"/>
            <a:ext cx="78740" cy="196850"/>
            <a:chOff x="1855804" y="4937352"/>
            <a:chExt cx="78740" cy="196850"/>
          </a:xfrm>
        </p:grpSpPr>
        <p:sp>
          <p:nvSpPr>
            <p:cNvPr id="215" name="object 215"/>
            <p:cNvSpPr/>
            <p:nvPr/>
          </p:nvSpPr>
          <p:spPr>
            <a:xfrm>
              <a:off x="1895081" y="4937352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16" name="object 216"/>
            <p:cNvSpPr/>
            <p:nvPr/>
          </p:nvSpPr>
          <p:spPr>
            <a:xfrm>
              <a:off x="1855804" y="5055600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17" name="object 217"/>
          <p:cNvSpPr txBox="1"/>
          <p:nvPr/>
        </p:nvSpPr>
        <p:spPr>
          <a:xfrm>
            <a:off x="1637564" y="5136723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sp>
        <p:nvSpPr>
          <p:cNvPr id="218" name="object 218"/>
          <p:cNvSpPr txBox="1"/>
          <p:nvPr/>
        </p:nvSpPr>
        <p:spPr>
          <a:xfrm>
            <a:off x="2493543" y="5136723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219" name="object 219"/>
          <p:cNvGrpSpPr/>
          <p:nvPr/>
        </p:nvGrpSpPr>
        <p:grpSpPr>
          <a:xfrm>
            <a:off x="2720882" y="4937350"/>
            <a:ext cx="78740" cy="196850"/>
            <a:chOff x="2720882" y="4937350"/>
            <a:chExt cx="78740" cy="196850"/>
          </a:xfrm>
        </p:grpSpPr>
        <p:sp>
          <p:nvSpPr>
            <p:cNvPr id="220" name="object 220"/>
            <p:cNvSpPr/>
            <p:nvPr/>
          </p:nvSpPr>
          <p:spPr>
            <a:xfrm>
              <a:off x="2760159" y="4937350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21" name="object 221"/>
            <p:cNvSpPr/>
            <p:nvPr/>
          </p:nvSpPr>
          <p:spPr>
            <a:xfrm>
              <a:off x="2720882" y="5055598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222" name="object 222"/>
          <p:cNvSpPr txBox="1"/>
          <p:nvPr/>
        </p:nvSpPr>
        <p:spPr>
          <a:xfrm>
            <a:off x="2478944" y="4677289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223" name="object 223"/>
          <p:cNvGrpSpPr/>
          <p:nvPr/>
        </p:nvGrpSpPr>
        <p:grpSpPr>
          <a:xfrm>
            <a:off x="6352196" y="2696312"/>
            <a:ext cx="78740" cy="278130"/>
            <a:chOff x="6352196" y="2696312"/>
            <a:chExt cx="78740" cy="278130"/>
          </a:xfrm>
        </p:grpSpPr>
        <p:sp>
          <p:nvSpPr>
            <p:cNvPr id="224" name="object 224"/>
            <p:cNvSpPr/>
            <p:nvPr/>
          </p:nvSpPr>
          <p:spPr>
            <a:xfrm>
              <a:off x="6391473" y="2696312"/>
              <a:ext cx="0" cy="215265"/>
            </a:xfrm>
            <a:custGeom>
              <a:avLst/>
              <a:gdLst/>
              <a:ahLst/>
              <a:cxnLst/>
              <a:rect l="l" t="t" r="r" b="b"/>
              <a:pathLst>
                <a:path w="0" h="215264">
                  <a:moveTo>
                    <a:pt x="0" y="0"/>
                  </a:moveTo>
                  <a:lnTo>
                    <a:pt x="0" y="214863"/>
                  </a:lnTo>
                </a:path>
              </a:pathLst>
            </a:custGeom>
            <a:ln w="22444">
              <a:solidFill>
                <a:srgbClr val="E2D4A9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225" name="object 225"/>
            <p:cNvSpPr/>
            <p:nvPr/>
          </p:nvSpPr>
          <p:spPr>
            <a:xfrm>
              <a:off x="6352196" y="2895474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D4A9"/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226" name="object 226"/>
          <p:cNvGrpSpPr/>
          <p:nvPr/>
        </p:nvGrpSpPr>
        <p:grpSpPr>
          <a:xfrm>
            <a:off x="5054844" y="1068518"/>
            <a:ext cx="2258695" cy="1649730"/>
            <a:chOff x="5054844" y="1068518"/>
            <a:chExt cx="2258695" cy="1649730"/>
          </a:xfrm>
        </p:grpSpPr>
        <p:sp>
          <p:nvSpPr>
            <p:cNvPr id="227" name="object 227"/>
            <p:cNvSpPr/>
            <p:nvPr/>
          </p:nvSpPr>
          <p:spPr>
            <a:xfrm>
              <a:off x="6432478" y="2013808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0"/>
                  </a:move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28" name="object 228"/>
            <p:cNvSpPr/>
            <p:nvPr/>
          </p:nvSpPr>
          <p:spPr>
            <a:xfrm>
              <a:off x="6434963" y="2013665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0"/>
                  </a:move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29" name="object 229"/>
            <p:cNvSpPr/>
            <p:nvPr/>
          </p:nvSpPr>
          <p:spPr>
            <a:xfrm>
              <a:off x="6432478" y="2046890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0"/>
                  </a:move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0" name="object 230"/>
            <p:cNvSpPr/>
            <p:nvPr/>
          </p:nvSpPr>
          <p:spPr>
            <a:xfrm>
              <a:off x="6434963" y="2046746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0"/>
                  </a:move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1" name="object 231"/>
            <p:cNvSpPr/>
            <p:nvPr/>
          </p:nvSpPr>
          <p:spPr>
            <a:xfrm>
              <a:off x="6432478" y="2079971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0"/>
                  </a:move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2" name="object 232"/>
            <p:cNvSpPr/>
            <p:nvPr/>
          </p:nvSpPr>
          <p:spPr>
            <a:xfrm>
              <a:off x="6434963" y="2079827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0"/>
                  </a:move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3" name="object 233"/>
            <p:cNvSpPr/>
            <p:nvPr/>
          </p:nvSpPr>
          <p:spPr>
            <a:xfrm>
              <a:off x="6432478" y="2113052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0"/>
                  </a:move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4" name="object 234"/>
            <p:cNvSpPr/>
            <p:nvPr/>
          </p:nvSpPr>
          <p:spPr>
            <a:xfrm>
              <a:off x="6434963" y="2112908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0"/>
                  </a:move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5" name="object 235"/>
            <p:cNvSpPr/>
            <p:nvPr/>
          </p:nvSpPr>
          <p:spPr>
            <a:xfrm>
              <a:off x="6425315" y="2146134"/>
              <a:ext cx="27940" cy="38100"/>
            </a:xfrm>
            <a:custGeom>
              <a:avLst/>
              <a:gdLst/>
              <a:ahLst/>
              <a:cxnLst/>
              <a:rect l="l" t="t" r="r" b="b"/>
              <a:pathLst>
                <a:path w="27939" h="38100">
                  <a:moveTo>
                    <a:pt x="7162" y="0"/>
                  </a:moveTo>
                  <a:lnTo>
                    <a:pt x="27401" y="0"/>
                  </a:lnTo>
                  <a:lnTo>
                    <a:pt x="27401" y="5536"/>
                  </a:lnTo>
                  <a:lnTo>
                    <a:pt x="15100" y="37812"/>
                  </a:lnTo>
                  <a:lnTo>
                    <a:pt x="0" y="24337"/>
                  </a:lnTo>
                  <a:lnTo>
                    <a:pt x="1607" y="22364"/>
                  </a:lnTo>
                  <a:lnTo>
                    <a:pt x="2343" y="21326"/>
                  </a:lnTo>
                  <a:lnTo>
                    <a:pt x="7098" y="7457"/>
                  </a:lnTo>
                  <a:lnTo>
                    <a:pt x="7162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6" name="object 236"/>
            <p:cNvSpPr/>
            <p:nvPr/>
          </p:nvSpPr>
          <p:spPr>
            <a:xfrm>
              <a:off x="6427084" y="2145990"/>
              <a:ext cx="23495" cy="36830"/>
            </a:xfrm>
            <a:custGeom>
              <a:avLst/>
              <a:gdLst/>
              <a:ahLst/>
              <a:cxnLst/>
              <a:rect l="l" t="t" r="r" b="b"/>
              <a:pathLst>
                <a:path w="23495" h="36830">
                  <a:moveTo>
                    <a:pt x="7879" y="0"/>
                  </a:moveTo>
                  <a:lnTo>
                    <a:pt x="23147" y="0"/>
                  </a:lnTo>
                  <a:lnTo>
                    <a:pt x="23147" y="5680"/>
                  </a:lnTo>
                  <a:lnTo>
                    <a:pt x="11350" y="36443"/>
                  </a:lnTo>
                  <a:lnTo>
                    <a:pt x="0" y="26230"/>
                  </a:lnTo>
                  <a:lnTo>
                    <a:pt x="1807" y="24024"/>
                  </a:lnTo>
                  <a:lnTo>
                    <a:pt x="2633" y="22861"/>
                  </a:lnTo>
                  <a:lnTo>
                    <a:pt x="7809" y="7766"/>
                  </a:lnTo>
                  <a:lnTo>
                    <a:pt x="7879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7" name="object 237"/>
            <p:cNvSpPr/>
            <p:nvPr/>
          </p:nvSpPr>
          <p:spPr>
            <a:xfrm>
              <a:off x="6403446" y="2170265"/>
              <a:ext cx="37465" cy="30480"/>
            </a:xfrm>
            <a:custGeom>
              <a:avLst/>
              <a:gdLst/>
              <a:ahLst/>
              <a:cxnLst/>
              <a:rect l="l" t="t" r="r" b="b"/>
              <a:pathLst>
                <a:path w="37464" h="30480">
                  <a:moveTo>
                    <a:pt x="22051" y="0"/>
                  </a:moveTo>
                  <a:lnTo>
                    <a:pt x="37281" y="13328"/>
                  </a:lnTo>
                  <a:lnTo>
                    <a:pt x="35067" y="15695"/>
                  </a:lnTo>
                  <a:lnTo>
                    <a:pt x="32806" y="17817"/>
                  </a:lnTo>
                  <a:lnTo>
                    <a:pt x="0" y="29897"/>
                  </a:lnTo>
                  <a:lnTo>
                    <a:pt x="0" y="9658"/>
                  </a:lnTo>
                  <a:lnTo>
                    <a:pt x="2698" y="9594"/>
                  </a:lnTo>
                  <a:lnTo>
                    <a:pt x="4601" y="9403"/>
                  </a:lnTo>
                  <a:lnTo>
                    <a:pt x="19433" y="2624"/>
                  </a:lnTo>
                  <a:lnTo>
                    <a:pt x="22051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8" name="object 238"/>
            <p:cNvSpPr/>
            <p:nvPr/>
          </p:nvSpPr>
          <p:spPr>
            <a:xfrm>
              <a:off x="6403286" y="2171815"/>
              <a:ext cx="36195" cy="26034"/>
            </a:xfrm>
            <a:custGeom>
              <a:avLst/>
              <a:gdLst/>
              <a:ahLst/>
              <a:cxnLst/>
              <a:rect l="l" t="t" r="r" b="b"/>
              <a:pathLst>
                <a:path w="36195" h="26035">
                  <a:moveTo>
                    <a:pt x="24157" y="0"/>
                  </a:moveTo>
                  <a:lnTo>
                    <a:pt x="35685" y="10012"/>
                  </a:lnTo>
                  <a:lnTo>
                    <a:pt x="33470" y="12388"/>
                  </a:lnTo>
                  <a:lnTo>
                    <a:pt x="31323" y="14401"/>
                  </a:lnTo>
                  <a:lnTo>
                    <a:pt x="0" y="25862"/>
                  </a:lnTo>
                  <a:lnTo>
                    <a:pt x="0" y="10593"/>
                  </a:lnTo>
                  <a:lnTo>
                    <a:pt x="3023" y="10524"/>
                  </a:lnTo>
                  <a:lnTo>
                    <a:pt x="5093" y="10316"/>
                  </a:lnTo>
                  <a:lnTo>
                    <a:pt x="23675" y="541"/>
                  </a:lnTo>
                  <a:lnTo>
                    <a:pt x="24157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39" name="object 239"/>
            <p:cNvSpPr/>
            <p:nvPr/>
          </p:nvSpPr>
          <p:spPr>
            <a:xfrm>
              <a:off x="6370365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2" y="0"/>
                  </a:lnTo>
                  <a:lnTo>
                    <a:pt x="33452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0" name="object 240"/>
            <p:cNvSpPr/>
            <p:nvPr/>
          </p:nvSpPr>
          <p:spPr>
            <a:xfrm>
              <a:off x="6370205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1" name="object 241"/>
            <p:cNvSpPr/>
            <p:nvPr/>
          </p:nvSpPr>
          <p:spPr>
            <a:xfrm>
              <a:off x="6337283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2" name="object 242"/>
            <p:cNvSpPr/>
            <p:nvPr/>
          </p:nvSpPr>
          <p:spPr>
            <a:xfrm>
              <a:off x="6337123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3" name="object 243"/>
            <p:cNvSpPr/>
            <p:nvPr/>
          </p:nvSpPr>
          <p:spPr>
            <a:xfrm>
              <a:off x="6304202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4" name="object 244"/>
            <p:cNvSpPr/>
            <p:nvPr/>
          </p:nvSpPr>
          <p:spPr>
            <a:xfrm>
              <a:off x="6304042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5" name="object 245"/>
            <p:cNvSpPr/>
            <p:nvPr/>
          </p:nvSpPr>
          <p:spPr>
            <a:xfrm>
              <a:off x="6271121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6" name="object 246"/>
            <p:cNvSpPr/>
            <p:nvPr/>
          </p:nvSpPr>
          <p:spPr>
            <a:xfrm>
              <a:off x="6270961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7" name="object 247"/>
            <p:cNvSpPr/>
            <p:nvPr/>
          </p:nvSpPr>
          <p:spPr>
            <a:xfrm>
              <a:off x="6238040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8" name="object 248"/>
            <p:cNvSpPr/>
            <p:nvPr/>
          </p:nvSpPr>
          <p:spPr>
            <a:xfrm>
              <a:off x="6237881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49" name="object 249"/>
            <p:cNvSpPr/>
            <p:nvPr/>
          </p:nvSpPr>
          <p:spPr>
            <a:xfrm>
              <a:off x="6204958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0" name="object 250"/>
            <p:cNvSpPr/>
            <p:nvPr/>
          </p:nvSpPr>
          <p:spPr>
            <a:xfrm>
              <a:off x="6204799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1" name="object 251"/>
            <p:cNvSpPr/>
            <p:nvPr/>
          </p:nvSpPr>
          <p:spPr>
            <a:xfrm>
              <a:off x="6171877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2" name="object 252"/>
            <p:cNvSpPr/>
            <p:nvPr/>
          </p:nvSpPr>
          <p:spPr>
            <a:xfrm>
              <a:off x="6171718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3" name="object 253"/>
            <p:cNvSpPr/>
            <p:nvPr/>
          </p:nvSpPr>
          <p:spPr>
            <a:xfrm>
              <a:off x="6138796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4" name="object 254"/>
            <p:cNvSpPr/>
            <p:nvPr/>
          </p:nvSpPr>
          <p:spPr>
            <a:xfrm>
              <a:off x="6138637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5" name="object 255"/>
            <p:cNvSpPr/>
            <p:nvPr/>
          </p:nvSpPr>
          <p:spPr>
            <a:xfrm>
              <a:off x="6105715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6" name="object 256"/>
            <p:cNvSpPr/>
            <p:nvPr/>
          </p:nvSpPr>
          <p:spPr>
            <a:xfrm>
              <a:off x="6105555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7" name="object 257"/>
            <p:cNvSpPr/>
            <p:nvPr/>
          </p:nvSpPr>
          <p:spPr>
            <a:xfrm>
              <a:off x="6072633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8" name="object 258"/>
            <p:cNvSpPr/>
            <p:nvPr/>
          </p:nvSpPr>
          <p:spPr>
            <a:xfrm>
              <a:off x="6072474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59" name="object 259"/>
            <p:cNvSpPr/>
            <p:nvPr/>
          </p:nvSpPr>
          <p:spPr>
            <a:xfrm>
              <a:off x="6039552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0" name="object 260"/>
            <p:cNvSpPr/>
            <p:nvPr/>
          </p:nvSpPr>
          <p:spPr>
            <a:xfrm>
              <a:off x="6039393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1" name="object 261"/>
            <p:cNvSpPr/>
            <p:nvPr/>
          </p:nvSpPr>
          <p:spPr>
            <a:xfrm>
              <a:off x="6006471" y="2179923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2" name="object 262"/>
            <p:cNvSpPr/>
            <p:nvPr/>
          </p:nvSpPr>
          <p:spPr>
            <a:xfrm>
              <a:off x="6006312" y="2182409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3" name="object 263"/>
            <p:cNvSpPr/>
            <p:nvPr/>
          </p:nvSpPr>
          <p:spPr>
            <a:xfrm>
              <a:off x="5900499" y="1157657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4" name="object 264"/>
            <p:cNvSpPr/>
            <p:nvPr/>
          </p:nvSpPr>
          <p:spPr>
            <a:xfrm>
              <a:off x="5902984" y="1157514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5" name="object 265"/>
            <p:cNvSpPr/>
            <p:nvPr/>
          </p:nvSpPr>
          <p:spPr>
            <a:xfrm>
              <a:off x="5900499" y="1190739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6" name="object 266"/>
            <p:cNvSpPr/>
            <p:nvPr/>
          </p:nvSpPr>
          <p:spPr>
            <a:xfrm>
              <a:off x="5902984" y="1190595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7" name="object 267"/>
            <p:cNvSpPr/>
            <p:nvPr/>
          </p:nvSpPr>
          <p:spPr>
            <a:xfrm>
              <a:off x="5900499" y="1223820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8" name="object 268"/>
            <p:cNvSpPr/>
            <p:nvPr/>
          </p:nvSpPr>
          <p:spPr>
            <a:xfrm>
              <a:off x="5902984" y="1223676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69" name="object 269"/>
            <p:cNvSpPr/>
            <p:nvPr/>
          </p:nvSpPr>
          <p:spPr>
            <a:xfrm>
              <a:off x="5900499" y="1256901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0" name="object 270"/>
            <p:cNvSpPr/>
            <p:nvPr/>
          </p:nvSpPr>
          <p:spPr>
            <a:xfrm>
              <a:off x="5902984" y="1256757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1" name="object 271"/>
            <p:cNvSpPr/>
            <p:nvPr/>
          </p:nvSpPr>
          <p:spPr>
            <a:xfrm>
              <a:off x="5900499" y="1289983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2" name="object 272"/>
            <p:cNvSpPr/>
            <p:nvPr/>
          </p:nvSpPr>
          <p:spPr>
            <a:xfrm>
              <a:off x="5902984" y="1289839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3" name="object 273"/>
            <p:cNvSpPr/>
            <p:nvPr/>
          </p:nvSpPr>
          <p:spPr>
            <a:xfrm>
              <a:off x="5900499" y="1323064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4" name="object 274"/>
            <p:cNvSpPr/>
            <p:nvPr/>
          </p:nvSpPr>
          <p:spPr>
            <a:xfrm>
              <a:off x="5902984" y="1322920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5" name="object 275"/>
            <p:cNvSpPr/>
            <p:nvPr/>
          </p:nvSpPr>
          <p:spPr>
            <a:xfrm>
              <a:off x="5900499" y="1356145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2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2"/>
                  </a:lnTo>
                  <a:lnTo>
                    <a:pt x="0" y="33452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6" name="object 276"/>
            <p:cNvSpPr/>
            <p:nvPr/>
          </p:nvSpPr>
          <p:spPr>
            <a:xfrm>
              <a:off x="5902984" y="1356001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7" name="object 277"/>
            <p:cNvSpPr/>
            <p:nvPr/>
          </p:nvSpPr>
          <p:spPr>
            <a:xfrm>
              <a:off x="5900499" y="1389226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2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2"/>
                  </a:lnTo>
                  <a:lnTo>
                    <a:pt x="0" y="33452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8" name="object 278"/>
            <p:cNvSpPr/>
            <p:nvPr/>
          </p:nvSpPr>
          <p:spPr>
            <a:xfrm>
              <a:off x="5902984" y="1389083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79" name="object 279"/>
            <p:cNvSpPr/>
            <p:nvPr/>
          </p:nvSpPr>
          <p:spPr>
            <a:xfrm>
              <a:off x="5900499" y="1422307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0" name="object 280"/>
            <p:cNvSpPr/>
            <p:nvPr/>
          </p:nvSpPr>
          <p:spPr>
            <a:xfrm>
              <a:off x="5902984" y="1422164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1" name="object 281"/>
            <p:cNvSpPr/>
            <p:nvPr/>
          </p:nvSpPr>
          <p:spPr>
            <a:xfrm>
              <a:off x="5900499" y="1455388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2" name="object 282"/>
            <p:cNvSpPr/>
            <p:nvPr/>
          </p:nvSpPr>
          <p:spPr>
            <a:xfrm>
              <a:off x="5902984" y="1455245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3" name="object 283"/>
            <p:cNvSpPr/>
            <p:nvPr/>
          </p:nvSpPr>
          <p:spPr>
            <a:xfrm>
              <a:off x="5900499" y="1488469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4" name="object 284"/>
            <p:cNvSpPr/>
            <p:nvPr/>
          </p:nvSpPr>
          <p:spPr>
            <a:xfrm>
              <a:off x="5902984" y="1488326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5" name="object 285"/>
            <p:cNvSpPr/>
            <p:nvPr/>
          </p:nvSpPr>
          <p:spPr>
            <a:xfrm>
              <a:off x="5900499" y="1521551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6" name="object 286"/>
            <p:cNvSpPr/>
            <p:nvPr/>
          </p:nvSpPr>
          <p:spPr>
            <a:xfrm>
              <a:off x="5902984" y="1521408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5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5"/>
                  </a:lnTo>
                  <a:lnTo>
                    <a:pt x="0" y="33755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7" name="object 287"/>
            <p:cNvSpPr/>
            <p:nvPr/>
          </p:nvSpPr>
          <p:spPr>
            <a:xfrm>
              <a:off x="5900499" y="1554632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8" name="object 288"/>
            <p:cNvSpPr/>
            <p:nvPr/>
          </p:nvSpPr>
          <p:spPr>
            <a:xfrm>
              <a:off x="5902984" y="1554489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5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5"/>
                  </a:lnTo>
                  <a:lnTo>
                    <a:pt x="0" y="33755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89" name="object 289"/>
            <p:cNvSpPr/>
            <p:nvPr/>
          </p:nvSpPr>
          <p:spPr>
            <a:xfrm>
              <a:off x="5900499" y="1587713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0" name="object 290"/>
            <p:cNvSpPr/>
            <p:nvPr/>
          </p:nvSpPr>
          <p:spPr>
            <a:xfrm>
              <a:off x="5902984" y="1587570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90">
                  <a:moveTo>
                    <a:pt x="0" y="33755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5"/>
                  </a:lnTo>
                  <a:lnTo>
                    <a:pt x="0" y="33755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1" name="object 291"/>
            <p:cNvSpPr/>
            <p:nvPr/>
          </p:nvSpPr>
          <p:spPr>
            <a:xfrm>
              <a:off x="5900499" y="1620794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2" name="object 292"/>
            <p:cNvSpPr/>
            <p:nvPr/>
          </p:nvSpPr>
          <p:spPr>
            <a:xfrm>
              <a:off x="5902984" y="1620651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5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5"/>
                  </a:lnTo>
                  <a:lnTo>
                    <a:pt x="0" y="33755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3" name="object 293"/>
            <p:cNvSpPr/>
            <p:nvPr/>
          </p:nvSpPr>
          <p:spPr>
            <a:xfrm>
              <a:off x="5900499" y="1653876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4" name="object 294"/>
            <p:cNvSpPr/>
            <p:nvPr/>
          </p:nvSpPr>
          <p:spPr>
            <a:xfrm>
              <a:off x="5902984" y="1653733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5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5"/>
                  </a:lnTo>
                  <a:lnTo>
                    <a:pt x="0" y="33755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5" name="object 295"/>
            <p:cNvSpPr/>
            <p:nvPr/>
          </p:nvSpPr>
          <p:spPr>
            <a:xfrm>
              <a:off x="5900499" y="1686957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6" name="object 296"/>
            <p:cNvSpPr/>
            <p:nvPr/>
          </p:nvSpPr>
          <p:spPr>
            <a:xfrm>
              <a:off x="5902984" y="1686813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7" name="object 297"/>
            <p:cNvSpPr/>
            <p:nvPr/>
          </p:nvSpPr>
          <p:spPr>
            <a:xfrm>
              <a:off x="5900499" y="1720038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8" name="object 298"/>
            <p:cNvSpPr/>
            <p:nvPr/>
          </p:nvSpPr>
          <p:spPr>
            <a:xfrm>
              <a:off x="5902984" y="1719894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299" name="object 299"/>
            <p:cNvSpPr/>
            <p:nvPr/>
          </p:nvSpPr>
          <p:spPr>
            <a:xfrm>
              <a:off x="5900499" y="1753119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0" name="object 300"/>
            <p:cNvSpPr/>
            <p:nvPr/>
          </p:nvSpPr>
          <p:spPr>
            <a:xfrm>
              <a:off x="5902984" y="1752976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1" name="object 301"/>
            <p:cNvSpPr/>
            <p:nvPr/>
          </p:nvSpPr>
          <p:spPr>
            <a:xfrm>
              <a:off x="5900499" y="1786201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2" name="object 302"/>
            <p:cNvSpPr/>
            <p:nvPr/>
          </p:nvSpPr>
          <p:spPr>
            <a:xfrm>
              <a:off x="5902984" y="1786057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3" name="object 303"/>
            <p:cNvSpPr/>
            <p:nvPr/>
          </p:nvSpPr>
          <p:spPr>
            <a:xfrm>
              <a:off x="5900499" y="1819282"/>
              <a:ext cx="20320" cy="33655"/>
            </a:xfrm>
            <a:custGeom>
              <a:avLst/>
              <a:gdLst/>
              <a:ahLst/>
              <a:cxnLst/>
              <a:rect l="l" t="t" r="r" b="b"/>
              <a:pathLst>
                <a:path w="20320" h="33655">
                  <a:moveTo>
                    <a:pt x="0" y="33453"/>
                  </a:moveTo>
                  <a:lnTo>
                    <a:pt x="0" y="0"/>
                  </a:lnTo>
                  <a:lnTo>
                    <a:pt x="20238" y="0"/>
                  </a:lnTo>
                  <a:lnTo>
                    <a:pt x="20238" y="33453"/>
                  </a:lnTo>
                  <a:lnTo>
                    <a:pt x="0" y="33453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4" name="object 304"/>
            <p:cNvSpPr/>
            <p:nvPr/>
          </p:nvSpPr>
          <p:spPr>
            <a:xfrm>
              <a:off x="5902984" y="1819138"/>
              <a:ext cx="15875" cy="34290"/>
            </a:xfrm>
            <a:custGeom>
              <a:avLst/>
              <a:gdLst/>
              <a:ahLst/>
              <a:cxnLst/>
              <a:rect l="l" t="t" r="r" b="b"/>
              <a:pathLst>
                <a:path w="15875" h="34289">
                  <a:moveTo>
                    <a:pt x="0" y="33756"/>
                  </a:moveTo>
                  <a:lnTo>
                    <a:pt x="0" y="0"/>
                  </a:lnTo>
                  <a:lnTo>
                    <a:pt x="15268" y="0"/>
                  </a:lnTo>
                  <a:lnTo>
                    <a:pt x="15268" y="33756"/>
                  </a:lnTo>
                  <a:lnTo>
                    <a:pt x="0" y="3375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5" name="object 305"/>
            <p:cNvSpPr/>
            <p:nvPr/>
          </p:nvSpPr>
          <p:spPr>
            <a:xfrm>
              <a:off x="5256179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6" name="object 306"/>
            <p:cNvSpPr/>
            <p:nvPr/>
          </p:nvSpPr>
          <p:spPr>
            <a:xfrm>
              <a:off x="5256036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5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5" y="0"/>
                  </a:lnTo>
                  <a:lnTo>
                    <a:pt x="33755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7" name="object 307"/>
            <p:cNvSpPr/>
            <p:nvPr/>
          </p:nvSpPr>
          <p:spPr>
            <a:xfrm>
              <a:off x="5289260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8" name="object 308"/>
            <p:cNvSpPr/>
            <p:nvPr/>
          </p:nvSpPr>
          <p:spPr>
            <a:xfrm>
              <a:off x="5289118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5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5" y="0"/>
                  </a:lnTo>
                  <a:lnTo>
                    <a:pt x="33755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09" name="object 309"/>
            <p:cNvSpPr/>
            <p:nvPr/>
          </p:nvSpPr>
          <p:spPr>
            <a:xfrm>
              <a:off x="5322342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0" name="object 310"/>
            <p:cNvSpPr/>
            <p:nvPr/>
          </p:nvSpPr>
          <p:spPr>
            <a:xfrm>
              <a:off x="5322199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5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5" y="0"/>
                  </a:lnTo>
                  <a:lnTo>
                    <a:pt x="33755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1" name="object 311"/>
            <p:cNvSpPr/>
            <p:nvPr/>
          </p:nvSpPr>
          <p:spPr>
            <a:xfrm>
              <a:off x="5355423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2" name="object 312"/>
            <p:cNvSpPr/>
            <p:nvPr/>
          </p:nvSpPr>
          <p:spPr>
            <a:xfrm>
              <a:off x="5355280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5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5" y="0"/>
                  </a:lnTo>
                  <a:lnTo>
                    <a:pt x="33755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3" name="object 313"/>
            <p:cNvSpPr/>
            <p:nvPr/>
          </p:nvSpPr>
          <p:spPr>
            <a:xfrm>
              <a:off x="5388504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4" name="object 314"/>
            <p:cNvSpPr/>
            <p:nvPr/>
          </p:nvSpPr>
          <p:spPr>
            <a:xfrm>
              <a:off x="5388361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5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5" y="0"/>
                  </a:lnTo>
                  <a:lnTo>
                    <a:pt x="33755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5" name="object 315"/>
            <p:cNvSpPr/>
            <p:nvPr/>
          </p:nvSpPr>
          <p:spPr>
            <a:xfrm>
              <a:off x="5421586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6" name="object 316"/>
            <p:cNvSpPr/>
            <p:nvPr/>
          </p:nvSpPr>
          <p:spPr>
            <a:xfrm>
              <a:off x="5421442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7" name="object 317"/>
            <p:cNvSpPr/>
            <p:nvPr/>
          </p:nvSpPr>
          <p:spPr>
            <a:xfrm>
              <a:off x="5454667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8" name="object 318"/>
            <p:cNvSpPr/>
            <p:nvPr/>
          </p:nvSpPr>
          <p:spPr>
            <a:xfrm>
              <a:off x="5454523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19" name="object 319"/>
            <p:cNvSpPr/>
            <p:nvPr/>
          </p:nvSpPr>
          <p:spPr>
            <a:xfrm>
              <a:off x="5487748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0" name="object 320"/>
            <p:cNvSpPr/>
            <p:nvPr/>
          </p:nvSpPr>
          <p:spPr>
            <a:xfrm>
              <a:off x="5487604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1" name="object 321"/>
            <p:cNvSpPr/>
            <p:nvPr/>
          </p:nvSpPr>
          <p:spPr>
            <a:xfrm>
              <a:off x="5520829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2" name="object 322"/>
            <p:cNvSpPr/>
            <p:nvPr/>
          </p:nvSpPr>
          <p:spPr>
            <a:xfrm>
              <a:off x="5520686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3" name="object 323"/>
            <p:cNvSpPr/>
            <p:nvPr/>
          </p:nvSpPr>
          <p:spPr>
            <a:xfrm>
              <a:off x="5553911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4" name="object 324"/>
            <p:cNvSpPr/>
            <p:nvPr/>
          </p:nvSpPr>
          <p:spPr>
            <a:xfrm>
              <a:off x="5553767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5" name="object 325"/>
            <p:cNvSpPr/>
            <p:nvPr/>
          </p:nvSpPr>
          <p:spPr>
            <a:xfrm>
              <a:off x="5586992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6" name="object 326"/>
            <p:cNvSpPr/>
            <p:nvPr/>
          </p:nvSpPr>
          <p:spPr>
            <a:xfrm>
              <a:off x="5586848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7" name="object 327"/>
            <p:cNvSpPr/>
            <p:nvPr/>
          </p:nvSpPr>
          <p:spPr>
            <a:xfrm>
              <a:off x="5620073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8" name="object 328"/>
            <p:cNvSpPr/>
            <p:nvPr/>
          </p:nvSpPr>
          <p:spPr>
            <a:xfrm>
              <a:off x="5619929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29" name="object 329"/>
            <p:cNvSpPr/>
            <p:nvPr/>
          </p:nvSpPr>
          <p:spPr>
            <a:xfrm>
              <a:off x="5653154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0" name="object 330"/>
            <p:cNvSpPr/>
            <p:nvPr/>
          </p:nvSpPr>
          <p:spPr>
            <a:xfrm>
              <a:off x="5653011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1" name="object 331"/>
            <p:cNvSpPr/>
            <p:nvPr/>
          </p:nvSpPr>
          <p:spPr>
            <a:xfrm>
              <a:off x="5686236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2" name="object 332"/>
            <p:cNvSpPr/>
            <p:nvPr/>
          </p:nvSpPr>
          <p:spPr>
            <a:xfrm>
              <a:off x="5686092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3" name="object 333"/>
            <p:cNvSpPr/>
            <p:nvPr/>
          </p:nvSpPr>
          <p:spPr>
            <a:xfrm>
              <a:off x="5719317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4" name="object 334"/>
            <p:cNvSpPr/>
            <p:nvPr/>
          </p:nvSpPr>
          <p:spPr>
            <a:xfrm>
              <a:off x="5719173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5" name="object 335"/>
            <p:cNvSpPr/>
            <p:nvPr/>
          </p:nvSpPr>
          <p:spPr>
            <a:xfrm>
              <a:off x="5752398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6" name="object 336"/>
            <p:cNvSpPr/>
            <p:nvPr/>
          </p:nvSpPr>
          <p:spPr>
            <a:xfrm>
              <a:off x="5752254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7" name="object 337"/>
            <p:cNvSpPr/>
            <p:nvPr/>
          </p:nvSpPr>
          <p:spPr>
            <a:xfrm>
              <a:off x="5785480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8" name="object 338"/>
            <p:cNvSpPr/>
            <p:nvPr/>
          </p:nvSpPr>
          <p:spPr>
            <a:xfrm>
              <a:off x="5785336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39" name="object 339"/>
            <p:cNvSpPr/>
            <p:nvPr/>
          </p:nvSpPr>
          <p:spPr>
            <a:xfrm>
              <a:off x="5818561" y="1985546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33453" y="20238"/>
                  </a:moveTo>
                  <a:lnTo>
                    <a:pt x="0" y="20238"/>
                  </a:lnTo>
                  <a:lnTo>
                    <a:pt x="0" y="0"/>
                  </a:lnTo>
                  <a:lnTo>
                    <a:pt x="33453" y="0"/>
                  </a:lnTo>
                  <a:lnTo>
                    <a:pt x="33453" y="20238"/>
                  </a:lnTo>
                  <a:close/>
                </a:path>
              </a:pathLst>
            </a:custGeom>
            <a:solidFill>
              <a:srgbClr val="7071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0" name="object 340"/>
            <p:cNvSpPr/>
            <p:nvPr/>
          </p:nvSpPr>
          <p:spPr>
            <a:xfrm>
              <a:off x="5818417" y="1988031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33756" y="15268"/>
                  </a:moveTo>
                  <a:lnTo>
                    <a:pt x="0" y="15268"/>
                  </a:lnTo>
                  <a:lnTo>
                    <a:pt x="0" y="0"/>
                  </a:lnTo>
                  <a:lnTo>
                    <a:pt x="33756" y="0"/>
                  </a:lnTo>
                  <a:lnTo>
                    <a:pt x="33756" y="15268"/>
                  </a:lnTo>
                  <a:close/>
                </a:path>
              </a:pathLst>
            </a:custGeom>
            <a:solidFill>
              <a:srgbClr val="CECDC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1" name="object 341"/>
            <p:cNvSpPr/>
            <p:nvPr/>
          </p:nvSpPr>
          <p:spPr>
            <a:xfrm>
              <a:off x="5976404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2" name="object 342"/>
            <p:cNvSpPr/>
            <p:nvPr/>
          </p:nvSpPr>
          <p:spPr>
            <a:xfrm>
              <a:off x="5976263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3" name="object 343"/>
            <p:cNvSpPr/>
            <p:nvPr/>
          </p:nvSpPr>
          <p:spPr>
            <a:xfrm>
              <a:off x="6008880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4" name="object 344"/>
            <p:cNvSpPr/>
            <p:nvPr/>
          </p:nvSpPr>
          <p:spPr>
            <a:xfrm>
              <a:off x="600873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5" name="object 345"/>
            <p:cNvSpPr/>
            <p:nvPr/>
          </p:nvSpPr>
          <p:spPr>
            <a:xfrm>
              <a:off x="6041355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6" name="object 346"/>
            <p:cNvSpPr/>
            <p:nvPr/>
          </p:nvSpPr>
          <p:spPr>
            <a:xfrm>
              <a:off x="6041214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7" name="object 347"/>
            <p:cNvSpPr/>
            <p:nvPr/>
          </p:nvSpPr>
          <p:spPr>
            <a:xfrm>
              <a:off x="6073830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8" name="object 348"/>
            <p:cNvSpPr/>
            <p:nvPr/>
          </p:nvSpPr>
          <p:spPr>
            <a:xfrm>
              <a:off x="607368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49" name="object 349"/>
            <p:cNvSpPr/>
            <p:nvPr/>
          </p:nvSpPr>
          <p:spPr>
            <a:xfrm>
              <a:off x="6106306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0" name="object 350"/>
            <p:cNvSpPr/>
            <p:nvPr/>
          </p:nvSpPr>
          <p:spPr>
            <a:xfrm>
              <a:off x="6106165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1" name="object 351"/>
            <p:cNvSpPr/>
            <p:nvPr/>
          </p:nvSpPr>
          <p:spPr>
            <a:xfrm>
              <a:off x="6138781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2" name="object 352"/>
            <p:cNvSpPr/>
            <p:nvPr/>
          </p:nvSpPr>
          <p:spPr>
            <a:xfrm>
              <a:off x="6138640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3" name="object 353"/>
            <p:cNvSpPr/>
            <p:nvPr/>
          </p:nvSpPr>
          <p:spPr>
            <a:xfrm>
              <a:off x="6171256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4" name="object 354"/>
            <p:cNvSpPr/>
            <p:nvPr/>
          </p:nvSpPr>
          <p:spPr>
            <a:xfrm>
              <a:off x="6171116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5" name="object 355"/>
            <p:cNvSpPr/>
            <p:nvPr/>
          </p:nvSpPr>
          <p:spPr>
            <a:xfrm>
              <a:off x="6203732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6" name="object 356"/>
            <p:cNvSpPr/>
            <p:nvPr/>
          </p:nvSpPr>
          <p:spPr>
            <a:xfrm>
              <a:off x="6203591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7" name="object 357"/>
            <p:cNvSpPr/>
            <p:nvPr/>
          </p:nvSpPr>
          <p:spPr>
            <a:xfrm>
              <a:off x="6236207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8" name="object 358"/>
            <p:cNvSpPr/>
            <p:nvPr/>
          </p:nvSpPr>
          <p:spPr>
            <a:xfrm>
              <a:off x="6236067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59" name="object 359"/>
            <p:cNvSpPr/>
            <p:nvPr/>
          </p:nvSpPr>
          <p:spPr>
            <a:xfrm>
              <a:off x="6268683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0" name="object 360"/>
            <p:cNvSpPr/>
            <p:nvPr/>
          </p:nvSpPr>
          <p:spPr>
            <a:xfrm>
              <a:off x="6268542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1" name="object 361"/>
            <p:cNvSpPr/>
            <p:nvPr/>
          </p:nvSpPr>
          <p:spPr>
            <a:xfrm>
              <a:off x="6301158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2" name="object 362"/>
            <p:cNvSpPr/>
            <p:nvPr/>
          </p:nvSpPr>
          <p:spPr>
            <a:xfrm>
              <a:off x="6301017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3" name="object 363"/>
            <p:cNvSpPr/>
            <p:nvPr/>
          </p:nvSpPr>
          <p:spPr>
            <a:xfrm>
              <a:off x="6333633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4" name="object 364"/>
            <p:cNvSpPr/>
            <p:nvPr/>
          </p:nvSpPr>
          <p:spPr>
            <a:xfrm>
              <a:off x="6333492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5" name="object 365"/>
            <p:cNvSpPr/>
            <p:nvPr/>
          </p:nvSpPr>
          <p:spPr>
            <a:xfrm>
              <a:off x="6366108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6" name="object 366"/>
            <p:cNvSpPr/>
            <p:nvPr/>
          </p:nvSpPr>
          <p:spPr>
            <a:xfrm>
              <a:off x="6365968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7" name="object 367"/>
            <p:cNvSpPr/>
            <p:nvPr/>
          </p:nvSpPr>
          <p:spPr>
            <a:xfrm>
              <a:off x="6398584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8" name="object 368"/>
            <p:cNvSpPr/>
            <p:nvPr/>
          </p:nvSpPr>
          <p:spPr>
            <a:xfrm>
              <a:off x="6398443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69" name="object 369"/>
            <p:cNvSpPr/>
            <p:nvPr/>
          </p:nvSpPr>
          <p:spPr>
            <a:xfrm>
              <a:off x="6431059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0" name="object 370"/>
            <p:cNvSpPr/>
            <p:nvPr/>
          </p:nvSpPr>
          <p:spPr>
            <a:xfrm>
              <a:off x="6430918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1" name="object 371"/>
            <p:cNvSpPr/>
            <p:nvPr/>
          </p:nvSpPr>
          <p:spPr>
            <a:xfrm>
              <a:off x="6463535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2" name="object 372"/>
            <p:cNvSpPr/>
            <p:nvPr/>
          </p:nvSpPr>
          <p:spPr>
            <a:xfrm>
              <a:off x="6463394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3" name="object 373"/>
            <p:cNvSpPr/>
            <p:nvPr/>
          </p:nvSpPr>
          <p:spPr>
            <a:xfrm>
              <a:off x="6496009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4" name="object 374"/>
            <p:cNvSpPr/>
            <p:nvPr/>
          </p:nvSpPr>
          <p:spPr>
            <a:xfrm>
              <a:off x="649586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5" name="object 375"/>
            <p:cNvSpPr/>
            <p:nvPr/>
          </p:nvSpPr>
          <p:spPr>
            <a:xfrm>
              <a:off x="6528485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6" name="object 376"/>
            <p:cNvSpPr/>
            <p:nvPr/>
          </p:nvSpPr>
          <p:spPr>
            <a:xfrm>
              <a:off x="6528344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7" name="object 377"/>
            <p:cNvSpPr/>
            <p:nvPr/>
          </p:nvSpPr>
          <p:spPr>
            <a:xfrm>
              <a:off x="6560960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8" name="object 378"/>
            <p:cNvSpPr/>
            <p:nvPr/>
          </p:nvSpPr>
          <p:spPr>
            <a:xfrm>
              <a:off x="656081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79" name="object 379"/>
            <p:cNvSpPr/>
            <p:nvPr/>
          </p:nvSpPr>
          <p:spPr>
            <a:xfrm>
              <a:off x="6593436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0" name="object 380"/>
            <p:cNvSpPr/>
            <p:nvPr/>
          </p:nvSpPr>
          <p:spPr>
            <a:xfrm>
              <a:off x="6593295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1" name="object 381"/>
            <p:cNvSpPr/>
            <p:nvPr/>
          </p:nvSpPr>
          <p:spPr>
            <a:xfrm>
              <a:off x="6625911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2" name="object 382"/>
            <p:cNvSpPr/>
            <p:nvPr/>
          </p:nvSpPr>
          <p:spPr>
            <a:xfrm>
              <a:off x="6625770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3" name="object 383"/>
            <p:cNvSpPr/>
            <p:nvPr/>
          </p:nvSpPr>
          <p:spPr>
            <a:xfrm>
              <a:off x="6658387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4" name="object 384"/>
            <p:cNvSpPr/>
            <p:nvPr/>
          </p:nvSpPr>
          <p:spPr>
            <a:xfrm>
              <a:off x="6658246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5" name="object 385"/>
            <p:cNvSpPr/>
            <p:nvPr/>
          </p:nvSpPr>
          <p:spPr>
            <a:xfrm>
              <a:off x="6690862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6" name="object 386"/>
            <p:cNvSpPr/>
            <p:nvPr/>
          </p:nvSpPr>
          <p:spPr>
            <a:xfrm>
              <a:off x="6690721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7" name="object 387"/>
            <p:cNvSpPr/>
            <p:nvPr/>
          </p:nvSpPr>
          <p:spPr>
            <a:xfrm>
              <a:off x="6723337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8" name="object 388"/>
            <p:cNvSpPr/>
            <p:nvPr/>
          </p:nvSpPr>
          <p:spPr>
            <a:xfrm>
              <a:off x="6723197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89" name="object 389"/>
            <p:cNvSpPr/>
            <p:nvPr/>
          </p:nvSpPr>
          <p:spPr>
            <a:xfrm>
              <a:off x="6755812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0" name="object 390"/>
            <p:cNvSpPr/>
            <p:nvPr/>
          </p:nvSpPr>
          <p:spPr>
            <a:xfrm>
              <a:off x="6755671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1" name="object 391"/>
            <p:cNvSpPr/>
            <p:nvPr/>
          </p:nvSpPr>
          <p:spPr>
            <a:xfrm>
              <a:off x="6788288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2" name="object 392"/>
            <p:cNvSpPr/>
            <p:nvPr/>
          </p:nvSpPr>
          <p:spPr>
            <a:xfrm>
              <a:off x="6788147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3" name="object 393"/>
            <p:cNvSpPr/>
            <p:nvPr/>
          </p:nvSpPr>
          <p:spPr>
            <a:xfrm>
              <a:off x="6820763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4" name="object 394"/>
            <p:cNvSpPr/>
            <p:nvPr/>
          </p:nvSpPr>
          <p:spPr>
            <a:xfrm>
              <a:off x="6820622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5" name="object 395"/>
            <p:cNvSpPr/>
            <p:nvPr/>
          </p:nvSpPr>
          <p:spPr>
            <a:xfrm>
              <a:off x="6853239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6" name="object 396"/>
            <p:cNvSpPr/>
            <p:nvPr/>
          </p:nvSpPr>
          <p:spPr>
            <a:xfrm>
              <a:off x="6853098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7" name="object 397"/>
            <p:cNvSpPr/>
            <p:nvPr/>
          </p:nvSpPr>
          <p:spPr>
            <a:xfrm>
              <a:off x="6885714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8" name="object 398"/>
            <p:cNvSpPr/>
            <p:nvPr/>
          </p:nvSpPr>
          <p:spPr>
            <a:xfrm>
              <a:off x="6885573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399" name="object 399"/>
            <p:cNvSpPr/>
            <p:nvPr/>
          </p:nvSpPr>
          <p:spPr>
            <a:xfrm>
              <a:off x="6918190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0" name="object 400"/>
            <p:cNvSpPr/>
            <p:nvPr/>
          </p:nvSpPr>
          <p:spPr>
            <a:xfrm>
              <a:off x="691804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1" name="object 401"/>
            <p:cNvSpPr/>
            <p:nvPr/>
          </p:nvSpPr>
          <p:spPr>
            <a:xfrm>
              <a:off x="6950664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2" name="object 402"/>
            <p:cNvSpPr/>
            <p:nvPr/>
          </p:nvSpPr>
          <p:spPr>
            <a:xfrm>
              <a:off x="6950524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3" name="object 403"/>
            <p:cNvSpPr/>
            <p:nvPr/>
          </p:nvSpPr>
          <p:spPr>
            <a:xfrm>
              <a:off x="6983140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4" name="object 404"/>
            <p:cNvSpPr/>
            <p:nvPr/>
          </p:nvSpPr>
          <p:spPr>
            <a:xfrm>
              <a:off x="6982999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5" name="object 405"/>
            <p:cNvSpPr/>
            <p:nvPr/>
          </p:nvSpPr>
          <p:spPr>
            <a:xfrm>
              <a:off x="7015615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6" name="object 406"/>
            <p:cNvSpPr/>
            <p:nvPr/>
          </p:nvSpPr>
          <p:spPr>
            <a:xfrm>
              <a:off x="7015474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7" name="object 407"/>
            <p:cNvSpPr/>
            <p:nvPr/>
          </p:nvSpPr>
          <p:spPr>
            <a:xfrm>
              <a:off x="7048091" y="1068518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8" name="object 408"/>
            <p:cNvSpPr/>
            <p:nvPr/>
          </p:nvSpPr>
          <p:spPr>
            <a:xfrm>
              <a:off x="7047950" y="1070958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40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09" name="object 409"/>
            <p:cNvSpPr/>
            <p:nvPr/>
          </p:nvSpPr>
          <p:spPr>
            <a:xfrm>
              <a:off x="7080566" y="1068518"/>
              <a:ext cx="36195" cy="20320"/>
            </a:xfrm>
            <a:custGeom>
              <a:avLst/>
              <a:gdLst/>
              <a:ahLst/>
              <a:cxnLst/>
              <a:rect l="l" t="t" r="r" b="b"/>
              <a:pathLst>
                <a:path w="36195" h="20319">
                  <a:moveTo>
                    <a:pt x="2155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23644" y="0"/>
                  </a:lnTo>
                  <a:lnTo>
                    <a:pt x="25975" y="461"/>
                  </a:lnTo>
                  <a:lnTo>
                    <a:pt x="25822" y="461"/>
                  </a:lnTo>
                  <a:lnTo>
                    <a:pt x="26414" y="639"/>
                  </a:lnTo>
                  <a:lnTo>
                    <a:pt x="35847" y="15495"/>
                  </a:lnTo>
                  <a:lnTo>
                    <a:pt x="15931" y="15495"/>
                  </a:lnTo>
                  <a:lnTo>
                    <a:pt x="16007" y="18699"/>
                  </a:lnTo>
                  <a:lnTo>
                    <a:pt x="18537" y="18699"/>
                  </a:lnTo>
                  <a:lnTo>
                    <a:pt x="18891" y="18926"/>
                  </a:lnTo>
                  <a:lnTo>
                    <a:pt x="19554" y="19260"/>
                  </a:lnTo>
                  <a:lnTo>
                    <a:pt x="19895" y="19401"/>
                  </a:lnTo>
                  <a:lnTo>
                    <a:pt x="19688" y="19401"/>
                  </a:lnTo>
                  <a:lnTo>
                    <a:pt x="21550" y="19868"/>
                  </a:lnTo>
                  <a:close/>
                </a:path>
                <a:path w="36195" h="20319">
                  <a:moveTo>
                    <a:pt x="35875" y="18699"/>
                  </a:moveTo>
                  <a:lnTo>
                    <a:pt x="18537" y="18699"/>
                  </a:lnTo>
                  <a:lnTo>
                    <a:pt x="18271" y="18529"/>
                  </a:lnTo>
                  <a:lnTo>
                    <a:pt x="15931" y="15495"/>
                  </a:lnTo>
                  <a:lnTo>
                    <a:pt x="35847" y="15495"/>
                  </a:lnTo>
                  <a:lnTo>
                    <a:pt x="35875" y="18699"/>
                  </a:lnTo>
                  <a:close/>
                </a:path>
                <a:path w="36195" h="20319">
                  <a:moveTo>
                    <a:pt x="18537" y="18699"/>
                  </a:moveTo>
                  <a:lnTo>
                    <a:pt x="16007" y="18699"/>
                  </a:lnTo>
                  <a:lnTo>
                    <a:pt x="15937" y="15732"/>
                  </a:lnTo>
                  <a:lnTo>
                    <a:pt x="16699" y="16984"/>
                  </a:lnTo>
                  <a:lnTo>
                    <a:pt x="17247" y="17641"/>
                  </a:lnTo>
                  <a:lnTo>
                    <a:pt x="17722" y="18095"/>
                  </a:lnTo>
                  <a:lnTo>
                    <a:pt x="18271" y="18529"/>
                  </a:lnTo>
                  <a:lnTo>
                    <a:pt x="18537" y="18699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0" name="object 410"/>
            <p:cNvSpPr/>
            <p:nvPr/>
          </p:nvSpPr>
          <p:spPr>
            <a:xfrm>
              <a:off x="7080425" y="1070958"/>
              <a:ext cx="33655" cy="16510"/>
            </a:xfrm>
            <a:custGeom>
              <a:avLst/>
              <a:gdLst/>
              <a:ahLst/>
              <a:cxnLst/>
              <a:rect l="l" t="t" r="r" b="b"/>
              <a:pathLst>
                <a:path w="33654" h="16509">
                  <a:moveTo>
                    <a:pt x="18545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23906" y="0"/>
                  </a:lnTo>
                  <a:lnTo>
                    <a:pt x="25796" y="518"/>
                  </a:lnTo>
                  <a:lnTo>
                    <a:pt x="33473" y="12441"/>
                  </a:lnTo>
                  <a:lnTo>
                    <a:pt x="18435" y="12441"/>
                  </a:lnTo>
                  <a:lnTo>
                    <a:pt x="18545" y="14989"/>
                  </a:lnTo>
                  <a:close/>
                </a:path>
                <a:path w="33654" h="16509">
                  <a:moveTo>
                    <a:pt x="33540" y="14989"/>
                  </a:moveTo>
                  <a:lnTo>
                    <a:pt x="21642" y="14989"/>
                  </a:lnTo>
                  <a:lnTo>
                    <a:pt x="19843" y="14240"/>
                  </a:lnTo>
                  <a:lnTo>
                    <a:pt x="20031" y="14240"/>
                  </a:lnTo>
                  <a:lnTo>
                    <a:pt x="19640" y="13961"/>
                  </a:lnTo>
                  <a:lnTo>
                    <a:pt x="19157" y="13521"/>
                  </a:lnTo>
                  <a:lnTo>
                    <a:pt x="18811" y="13108"/>
                  </a:lnTo>
                  <a:lnTo>
                    <a:pt x="18525" y="12638"/>
                  </a:lnTo>
                  <a:lnTo>
                    <a:pt x="18435" y="12441"/>
                  </a:lnTo>
                  <a:lnTo>
                    <a:pt x="33473" y="12441"/>
                  </a:lnTo>
                  <a:lnTo>
                    <a:pt x="33540" y="14989"/>
                  </a:lnTo>
                  <a:close/>
                </a:path>
                <a:path w="33654" h="16509">
                  <a:moveTo>
                    <a:pt x="33577" y="16416"/>
                  </a:moveTo>
                  <a:lnTo>
                    <a:pt x="18588" y="16416"/>
                  </a:lnTo>
                  <a:lnTo>
                    <a:pt x="18476" y="12638"/>
                  </a:lnTo>
                  <a:lnTo>
                    <a:pt x="18811" y="13108"/>
                  </a:lnTo>
                  <a:lnTo>
                    <a:pt x="19157" y="13521"/>
                  </a:lnTo>
                  <a:lnTo>
                    <a:pt x="19640" y="13961"/>
                  </a:lnTo>
                  <a:lnTo>
                    <a:pt x="20031" y="14240"/>
                  </a:lnTo>
                  <a:lnTo>
                    <a:pt x="19843" y="14240"/>
                  </a:lnTo>
                  <a:lnTo>
                    <a:pt x="21642" y="14989"/>
                  </a:lnTo>
                  <a:lnTo>
                    <a:pt x="33540" y="14989"/>
                  </a:lnTo>
                  <a:lnTo>
                    <a:pt x="33577" y="1641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1" name="object 411"/>
            <p:cNvSpPr/>
            <p:nvPr/>
          </p:nvSpPr>
          <p:spPr>
            <a:xfrm>
              <a:off x="7096574" y="1086852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2" name="object 412"/>
            <p:cNvSpPr/>
            <p:nvPr/>
          </p:nvSpPr>
          <p:spPr>
            <a:xfrm>
              <a:off x="7099013" y="1086711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3" name="object 413"/>
            <p:cNvSpPr/>
            <p:nvPr/>
          </p:nvSpPr>
          <p:spPr>
            <a:xfrm>
              <a:off x="7096574" y="1119328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4" name="object 414"/>
            <p:cNvSpPr/>
            <p:nvPr/>
          </p:nvSpPr>
          <p:spPr>
            <a:xfrm>
              <a:off x="7099013" y="1119187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5" name="object 415"/>
            <p:cNvSpPr/>
            <p:nvPr/>
          </p:nvSpPr>
          <p:spPr>
            <a:xfrm>
              <a:off x="7096574" y="1151802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6" name="object 416"/>
            <p:cNvSpPr/>
            <p:nvPr/>
          </p:nvSpPr>
          <p:spPr>
            <a:xfrm>
              <a:off x="7099013" y="1151662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7" name="object 417"/>
            <p:cNvSpPr/>
            <p:nvPr/>
          </p:nvSpPr>
          <p:spPr>
            <a:xfrm>
              <a:off x="7096574" y="1184278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8" name="object 418"/>
            <p:cNvSpPr/>
            <p:nvPr/>
          </p:nvSpPr>
          <p:spPr>
            <a:xfrm>
              <a:off x="7099013" y="1184137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19" name="object 419"/>
            <p:cNvSpPr/>
            <p:nvPr/>
          </p:nvSpPr>
          <p:spPr>
            <a:xfrm>
              <a:off x="7096574" y="1216753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0" name="object 420"/>
            <p:cNvSpPr/>
            <p:nvPr/>
          </p:nvSpPr>
          <p:spPr>
            <a:xfrm>
              <a:off x="7099013" y="1216612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1" name="object 421"/>
            <p:cNvSpPr/>
            <p:nvPr/>
          </p:nvSpPr>
          <p:spPr>
            <a:xfrm>
              <a:off x="7096574" y="1249229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2" name="object 422"/>
            <p:cNvSpPr/>
            <p:nvPr/>
          </p:nvSpPr>
          <p:spPr>
            <a:xfrm>
              <a:off x="7099013" y="1249088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3" name="object 423"/>
            <p:cNvSpPr/>
            <p:nvPr/>
          </p:nvSpPr>
          <p:spPr>
            <a:xfrm>
              <a:off x="7096574" y="1281704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4" name="object 424"/>
            <p:cNvSpPr/>
            <p:nvPr/>
          </p:nvSpPr>
          <p:spPr>
            <a:xfrm>
              <a:off x="7099013" y="1281563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5" name="object 425"/>
            <p:cNvSpPr/>
            <p:nvPr/>
          </p:nvSpPr>
          <p:spPr>
            <a:xfrm>
              <a:off x="7096574" y="1314180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6" name="object 426"/>
            <p:cNvSpPr/>
            <p:nvPr/>
          </p:nvSpPr>
          <p:spPr>
            <a:xfrm>
              <a:off x="7099013" y="1314039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7" name="object 427"/>
            <p:cNvSpPr/>
            <p:nvPr/>
          </p:nvSpPr>
          <p:spPr>
            <a:xfrm>
              <a:off x="7096574" y="1346655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8" name="object 428"/>
            <p:cNvSpPr/>
            <p:nvPr/>
          </p:nvSpPr>
          <p:spPr>
            <a:xfrm>
              <a:off x="7099013" y="1346514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29" name="object 429"/>
            <p:cNvSpPr/>
            <p:nvPr/>
          </p:nvSpPr>
          <p:spPr>
            <a:xfrm>
              <a:off x="7096574" y="1379130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0" name="object 430"/>
            <p:cNvSpPr/>
            <p:nvPr/>
          </p:nvSpPr>
          <p:spPr>
            <a:xfrm>
              <a:off x="7099013" y="1378990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1" name="object 431"/>
            <p:cNvSpPr/>
            <p:nvPr/>
          </p:nvSpPr>
          <p:spPr>
            <a:xfrm>
              <a:off x="7096574" y="1411605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2" name="object 432"/>
            <p:cNvSpPr/>
            <p:nvPr/>
          </p:nvSpPr>
          <p:spPr>
            <a:xfrm>
              <a:off x="7099013" y="1411464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3" name="object 433"/>
            <p:cNvSpPr/>
            <p:nvPr/>
          </p:nvSpPr>
          <p:spPr>
            <a:xfrm>
              <a:off x="7096574" y="1444081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4" name="object 434"/>
            <p:cNvSpPr/>
            <p:nvPr/>
          </p:nvSpPr>
          <p:spPr>
            <a:xfrm>
              <a:off x="7099013" y="1443940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5" name="object 435"/>
            <p:cNvSpPr/>
            <p:nvPr/>
          </p:nvSpPr>
          <p:spPr>
            <a:xfrm>
              <a:off x="7096574" y="1476556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6" name="object 436"/>
            <p:cNvSpPr/>
            <p:nvPr/>
          </p:nvSpPr>
          <p:spPr>
            <a:xfrm>
              <a:off x="7099013" y="1476415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7" name="object 437"/>
            <p:cNvSpPr/>
            <p:nvPr/>
          </p:nvSpPr>
          <p:spPr>
            <a:xfrm>
              <a:off x="7096574" y="1509032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8" name="object 438"/>
            <p:cNvSpPr/>
            <p:nvPr/>
          </p:nvSpPr>
          <p:spPr>
            <a:xfrm>
              <a:off x="7099013" y="1508891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39" name="object 439"/>
            <p:cNvSpPr/>
            <p:nvPr/>
          </p:nvSpPr>
          <p:spPr>
            <a:xfrm>
              <a:off x="7096574" y="1541507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0" name="object 440"/>
            <p:cNvSpPr/>
            <p:nvPr/>
          </p:nvSpPr>
          <p:spPr>
            <a:xfrm>
              <a:off x="7099013" y="1541366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1" name="object 441"/>
            <p:cNvSpPr/>
            <p:nvPr/>
          </p:nvSpPr>
          <p:spPr>
            <a:xfrm>
              <a:off x="7096574" y="1573982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0"/>
                  </a:moveTo>
                  <a:lnTo>
                    <a:pt x="0" y="32840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2" name="object 442"/>
            <p:cNvSpPr/>
            <p:nvPr/>
          </p:nvSpPr>
          <p:spPr>
            <a:xfrm>
              <a:off x="7099013" y="1573842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3" name="object 443"/>
            <p:cNvSpPr/>
            <p:nvPr/>
          </p:nvSpPr>
          <p:spPr>
            <a:xfrm>
              <a:off x="7096574" y="1606457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4" name="object 444"/>
            <p:cNvSpPr/>
            <p:nvPr/>
          </p:nvSpPr>
          <p:spPr>
            <a:xfrm>
              <a:off x="7099013" y="1606317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7"/>
                  </a:moveTo>
                  <a:lnTo>
                    <a:pt x="0" y="33137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7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5" name="object 445"/>
            <p:cNvSpPr/>
            <p:nvPr/>
          </p:nvSpPr>
          <p:spPr>
            <a:xfrm>
              <a:off x="7096574" y="1638933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6" name="object 446"/>
            <p:cNvSpPr/>
            <p:nvPr/>
          </p:nvSpPr>
          <p:spPr>
            <a:xfrm>
              <a:off x="7099013" y="1638792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7" name="object 447"/>
            <p:cNvSpPr/>
            <p:nvPr/>
          </p:nvSpPr>
          <p:spPr>
            <a:xfrm>
              <a:off x="7096574" y="1671408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8" name="object 448"/>
            <p:cNvSpPr/>
            <p:nvPr/>
          </p:nvSpPr>
          <p:spPr>
            <a:xfrm>
              <a:off x="7099013" y="1671267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49" name="object 449"/>
            <p:cNvSpPr/>
            <p:nvPr/>
          </p:nvSpPr>
          <p:spPr>
            <a:xfrm>
              <a:off x="7096574" y="1703884"/>
              <a:ext cx="20320" cy="33020"/>
            </a:xfrm>
            <a:custGeom>
              <a:avLst/>
              <a:gdLst/>
              <a:ahLst/>
              <a:cxnLst/>
              <a:rect l="l" t="t" r="r" b="b"/>
              <a:pathLst>
                <a:path w="20320" h="33019">
                  <a:moveTo>
                    <a:pt x="19868" y="32841"/>
                  </a:moveTo>
                  <a:lnTo>
                    <a:pt x="0" y="32841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868" y="32841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0" name="object 450"/>
            <p:cNvSpPr/>
            <p:nvPr/>
          </p:nvSpPr>
          <p:spPr>
            <a:xfrm>
              <a:off x="7099013" y="1703743"/>
              <a:ext cx="15240" cy="33655"/>
            </a:xfrm>
            <a:custGeom>
              <a:avLst/>
              <a:gdLst/>
              <a:ahLst/>
              <a:cxnLst/>
              <a:rect l="l" t="t" r="r" b="b"/>
              <a:pathLst>
                <a:path w="15240" h="33655">
                  <a:moveTo>
                    <a:pt x="14989" y="33138"/>
                  </a:moveTo>
                  <a:lnTo>
                    <a:pt x="0" y="33138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4989" y="33138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1" name="object 451"/>
            <p:cNvSpPr/>
            <p:nvPr/>
          </p:nvSpPr>
          <p:spPr>
            <a:xfrm>
              <a:off x="7096574" y="1736359"/>
              <a:ext cx="21590" cy="32384"/>
            </a:xfrm>
            <a:custGeom>
              <a:avLst/>
              <a:gdLst/>
              <a:ahLst/>
              <a:cxnLst/>
              <a:rect l="l" t="t" r="r" b="b"/>
              <a:pathLst>
                <a:path w="21590" h="32385">
                  <a:moveTo>
                    <a:pt x="21465" y="31969"/>
                  </a:moveTo>
                  <a:lnTo>
                    <a:pt x="8834" y="31969"/>
                  </a:lnTo>
                  <a:lnTo>
                    <a:pt x="8058" y="31707"/>
                  </a:lnTo>
                  <a:lnTo>
                    <a:pt x="0" y="0"/>
                  </a:lnTo>
                  <a:lnTo>
                    <a:pt x="19868" y="0"/>
                  </a:lnTo>
                  <a:lnTo>
                    <a:pt x="19946" y="12555"/>
                  </a:lnTo>
                  <a:lnTo>
                    <a:pt x="13503" y="12555"/>
                  </a:lnTo>
                  <a:lnTo>
                    <a:pt x="16613" y="13672"/>
                  </a:lnTo>
                  <a:lnTo>
                    <a:pt x="16268" y="13672"/>
                  </a:lnTo>
                  <a:lnTo>
                    <a:pt x="17038" y="14154"/>
                  </a:lnTo>
                  <a:lnTo>
                    <a:pt x="17707" y="14676"/>
                  </a:lnTo>
                  <a:lnTo>
                    <a:pt x="19980" y="17927"/>
                  </a:lnTo>
                  <a:lnTo>
                    <a:pt x="21465" y="17927"/>
                  </a:lnTo>
                  <a:lnTo>
                    <a:pt x="21465" y="31969"/>
                  </a:lnTo>
                  <a:close/>
                </a:path>
                <a:path w="21590" h="32385">
                  <a:moveTo>
                    <a:pt x="19979" y="17720"/>
                  </a:moveTo>
                  <a:lnTo>
                    <a:pt x="16268" y="13672"/>
                  </a:lnTo>
                  <a:lnTo>
                    <a:pt x="16613" y="13672"/>
                  </a:lnTo>
                  <a:lnTo>
                    <a:pt x="13503" y="12555"/>
                  </a:lnTo>
                  <a:lnTo>
                    <a:pt x="19946" y="12555"/>
                  </a:lnTo>
                  <a:lnTo>
                    <a:pt x="19979" y="17720"/>
                  </a:lnTo>
                  <a:close/>
                </a:path>
                <a:path w="21590" h="32385">
                  <a:moveTo>
                    <a:pt x="21465" y="17927"/>
                  </a:moveTo>
                  <a:lnTo>
                    <a:pt x="19980" y="17927"/>
                  </a:lnTo>
                  <a:lnTo>
                    <a:pt x="19946" y="12555"/>
                  </a:lnTo>
                  <a:lnTo>
                    <a:pt x="21465" y="12555"/>
                  </a:lnTo>
                  <a:lnTo>
                    <a:pt x="21465" y="17927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2" name="object 452"/>
            <p:cNvSpPr/>
            <p:nvPr/>
          </p:nvSpPr>
          <p:spPr>
            <a:xfrm>
              <a:off x="7099013" y="1736218"/>
              <a:ext cx="19685" cy="29845"/>
            </a:xfrm>
            <a:custGeom>
              <a:avLst/>
              <a:gdLst/>
              <a:ahLst/>
              <a:cxnLst/>
              <a:rect l="l" t="t" r="r" b="b"/>
              <a:pathLst>
                <a:path w="19684" h="29844">
                  <a:moveTo>
                    <a:pt x="19182" y="29675"/>
                  </a:moveTo>
                  <a:lnTo>
                    <a:pt x="6784" y="29675"/>
                  </a:lnTo>
                  <a:lnTo>
                    <a:pt x="5902" y="29321"/>
                  </a:lnTo>
                  <a:lnTo>
                    <a:pt x="0" y="0"/>
                  </a:lnTo>
                  <a:lnTo>
                    <a:pt x="14989" y="0"/>
                  </a:lnTo>
                  <a:lnTo>
                    <a:pt x="15066" y="15136"/>
                  </a:lnTo>
                  <a:lnTo>
                    <a:pt x="11120" y="15136"/>
                  </a:lnTo>
                  <a:lnTo>
                    <a:pt x="14002" y="16665"/>
                  </a:lnTo>
                  <a:lnTo>
                    <a:pt x="13676" y="16665"/>
                  </a:lnTo>
                  <a:lnTo>
                    <a:pt x="14173" y="17145"/>
                  </a:lnTo>
                  <a:lnTo>
                    <a:pt x="14549" y="17600"/>
                  </a:lnTo>
                  <a:lnTo>
                    <a:pt x="14976" y="18283"/>
                  </a:lnTo>
                  <a:lnTo>
                    <a:pt x="15094" y="18533"/>
                  </a:lnTo>
                  <a:lnTo>
                    <a:pt x="15172" y="18726"/>
                  </a:lnTo>
                  <a:lnTo>
                    <a:pt x="19182" y="18726"/>
                  </a:lnTo>
                  <a:lnTo>
                    <a:pt x="19182" y="29675"/>
                  </a:lnTo>
                  <a:close/>
                </a:path>
                <a:path w="19684" h="29844">
                  <a:moveTo>
                    <a:pt x="15145" y="18533"/>
                  </a:moveTo>
                  <a:lnTo>
                    <a:pt x="14549" y="17600"/>
                  </a:lnTo>
                  <a:lnTo>
                    <a:pt x="14173" y="17145"/>
                  </a:lnTo>
                  <a:lnTo>
                    <a:pt x="13676" y="16665"/>
                  </a:lnTo>
                  <a:lnTo>
                    <a:pt x="14002" y="16665"/>
                  </a:lnTo>
                  <a:lnTo>
                    <a:pt x="11120" y="15136"/>
                  </a:lnTo>
                  <a:lnTo>
                    <a:pt x="15066" y="15136"/>
                  </a:lnTo>
                  <a:lnTo>
                    <a:pt x="15145" y="18533"/>
                  </a:lnTo>
                  <a:close/>
                </a:path>
                <a:path w="19684" h="29844">
                  <a:moveTo>
                    <a:pt x="19182" y="18726"/>
                  </a:moveTo>
                  <a:lnTo>
                    <a:pt x="15172" y="18726"/>
                  </a:lnTo>
                  <a:lnTo>
                    <a:pt x="15066" y="15136"/>
                  </a:lnTo>
                  <a:lnTo>
                    <a:pt x="19182" y="15136"/>
                  </a:lnTo>
                  <a:lnTo>
                    <a:pt x="19182" y="18726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3" name="object 453"/>
            <p:cNvSpPr/>
            <p:nvPr/>
          </p:nvSpPr>
          <p:spPr>
            <a:xfrm>
              <a:off x="7117674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4" name="object 454"/>
            <p:cNvSpPr/>
            <p:nvPr/>
          </p:nvSpPr>
          <p:spPr>
            <a:xfrm>
              <a:off x="7117533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5" name="object 455"/>
            <p:cNvSpPr/>
            <p:nvPr/>
          </p:nvSpPr>
          <p:spPr>
            <a:xfrm>
              <a:off x="7150149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6" name="object 456"/>
            <p:cNvSpPr/>
            <p:nvPr/>
          </p:nvSpPr>
          <p:spPr>
            <a:xfrm>
              <a:off x="7150008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7" name="object 457"/>
            <p:cNvSpPr/>
            <p:nvPr/>
          </p:nvSpPr>
          <p:spPr>
            <a:xfrm>
              <a:off x="7182625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0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0" y="0"/>
                  </a:lnTo>
                  <a:lnTo>
                    <a:pt x="32840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8" name="object 458"/>
            <p:cNvSpPr/>
            <p:nvPr/>
          </p:nvSpPr>
          <p:spPr>
            <a:xfrm>
              <a:off x="7182484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59" name="object 459"/>
            <p:cNvSpPr/>
            <p:nvPr/>
          </p:nvSpPr>
          <p:spPr>
            <a:xfrm>
              <a:off x="7215099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0" name="object 460"/>
            <p:cNvSpPr/>
            <p:nvPr/>
          </p:nvSpPr>
          <p:spPr>
            <a:xfrm>
              <a:off x="7214959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7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7" y="0"/>
                  </a:lnTo>
                  <a:lnTo>
                    <a:pt x="33137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1" name="object 461"/>
            <p:cNvSpPr/>
            <p:nvPr/>
          </p:nvSpPr>
          <p:spPr>
            <a:xfrm>
              <a:off x="7247575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2" name="object 462"/>
            <p:cNvSpPr/>
            <p:nvPr/>
          </p:nvSpPr>
          <p:spPr>
            <a:xfrm>
              <a:off x="7247434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3" name="object 463"/>
            <p:cNvSpPr/>
            <p:nvPr/>
          </p:nvSpPr>
          <p:spPr>
            <a:xfrm>
              <a:off x="7280050" y="1748915"/>
              <a:ext cx="33020" cy="20320"/>
            </a:xfrm>
            <a:custGeom>
              <a:avLst/>
              <a:gdLst/>
              <a:ahLst/>
              <a:cxnLst/>
              <a:rect l="l" t="t" r="r" b="b"/>
              <a:pathLst>
                <a:path w="33020" h="20319">
                  <a:moveTo>
                    <a:pt x="32841" y="19868"/>
                  </a:moveTo>
                  <a:lnTo>
                    <a:pt x="0" y="19868"/>
                  </a:lnTo>
                  <a:lnTo>
                    <a:pt x="0" y="0"/>
                  </a:lnTo>
                  <a:lnTo>
                    <a:pt x="32841" y="0"/>
                  </a:lnTo>
                  <a:lnTo>
                    <a:pt x="32841" y="19868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64" name="object 464"/>
            <p:cNvSpPr/>
            <p:nvPr/>
          </p:nvSpPr>
          <p:spPr>
            <a:xfrm>
              <a:off x="7279909" y="1751354"/>
              <a:ext cx="33655" cy="15240"/>
            </a:xfrm>
            <a:custGeom>
              <a:avLst/>
              <a:gdLst/>
              <a:ahLst/>
              <a:cxnLst/>
              <a:rect l="l" t="t" r="r" b="b"/>
              <a:pathLst>
                <a:path w="33654" h="15239">
                  <a:moveTo>
                    <a:pt x="33138" y="14989"/>
                  </a:moveTo>
                  <a:lnTo>
                    <a:pt x="0" y="14989"/>
                  </a:lnTo>
                  <a:lnTo>
                    <a:pt x="0" y="0"/>
                  </a:lnTo>
                  <a:lnTo>
                    <a:pt x="33138" y="0"/>
                  </a:lnTo>
                  <a:lnTo>
                    <a:pt x="33138" y="14989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465" name="object 465"/>
            <p:cNvPicPr/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5054844" y="1928658"/>
              <a:ext cx="392296" cy="789137"/>
            </a:xfrm>
            <a:prstGeom prst="rect">
              <a:avLst/>
            </a:prstGeom>
          </p:spPr>
        </p:pic>
      </p:grpSp>
      <p:sp>
        <p:nvSpPr>
          <p:cNvPr id="466" name="object 466"/>
          <p:cNvSpPr txBox="1"/>
          <p:nvPr/>
        </p:nvSpPr>
        <p:spPr>
          <a:xfrm>
            <a:off x="5628162" y="646271"/>
            <a:ext cx="652780" cy="240029"/>
          </a:xfrm>
          <a:prstGeom prst="rect">
            <a:avLst/>
          </a:prstGeom>
        </p:spPr>
        <p:txBody>
          <a:bodyPr wrap="square" lIns="0" tIns="19685" rIns="0" bIns="0" rtlCol="0" vert="horz">
            <a:spAutoFit/>
          </a:bodyPr>
          <a:lstStyle/>
          <a:p>
            <a:pPr marL="38100" marR="30480" indent="25400">
              <a:lnSpc>
                <a:spcPts val="830"/>
              </a:lnSpc>
              <a:spcBef>
                <a:spcPts val="155"/>
              </a:spcBef>
            </a:pPr>
            <a:r>
              <a:rPr dirty="0" sz="700" spc="-10" b="1">
                <a:latin typeface="Arial"/>
                <a:cs typeface="Arial"/>
              </a:rPr>
              <a:t>Temperature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5" b="1">
                <a:latin typeface="Arial"/>
                <a:cs typeface="Arial"/>
              </a:rPr>
              <a:t>Control</a:t>
            </a:r>
            <a:r>
              <a:rPr dirty="0" sz="700" spc="15" b="1">
                <a:latin typeface="Arial"/>
                <a:cs typeface="Arial"/>
              </a:rPr>
              <a:t> </a:t>
            </a:r>
            <a:r>
              <a:rPr dirty="0" sz="700" b="1">
                <a:latin typeface="Arial"/>
                <a:cs typeface="Arial"/>
              </a:rPr>
              <a:t>-</a:t>
            </a:r>
            <a:r>
              <a:rPr dirty="0" sz="700" spc="20" b="1">
                <a:latin typeface="Arial"/>
                <a:cs typeface="Arial"/>
              </a:rPr>
              <a:t> </a:t>
            </a:r>
            <a:r>
              <a:rPr dirty="0" sz="700" spc="-20" b="1">
                <a:latin typeface="Arial"/>
                <a:cs typeface="Arial"/>
              </a:rPr>
              <a:t>32</a:t>
            </a:r>
            <a:r>
              <a:rPr dirty="0" baseline="34722" sz="600" spc="-30" b="1">
                <a:latin typeface="Arial"/>
                <a:cs typeface="Arial"/>
              </a:rPr>
              <a:t>o</a:t>
            </a:r>
            <a:r>
              <a:rPr dirty="0" sz="700" spc="-20" b="1">
                <a:latin typeface="Arial"/>
                <a:cs typeface="Arial"/>
              </a:rPr>
              <a:t>C</a:t>
            </a:r>
            <a:endParaRPr sz="700">
              <a:latin typeface="Arial"/>
              <a:cs typeface="Arial"/>
            </a:endParaRPr>
          </a:p>
        </p:txBody>
      </p:sp>
      <p:sp>
        <p:nvSpPr>
          <p:cNvPr id="467" name="object 467"/>
          <p:cNvSpPr txBox="1"/>
          <p:nvPr/>
        </p:nvSpPr>
        <p:spPr>
          <a:xfrm>
            <a:off x="5393726" y="2244036"/>
            <a:ext cx="417830" cy="135255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dirty="0" sz="700" spc="-10" b="1">
                <a:latin typeface="Arial"/>
                <a:cs typeface="Arial"/>
              </a:rPr>
              <a:t>Reservoir</a:t>
            </a:r>
            <a:endParaRPr sz="700">
              <a:latin typeface="Arial"/>
              <a:cs typeface="Arial"/>
            </a:endParaRPr>
          </a:p>
        </p:txBody>
      </p:sp>
      <p:sp>
        <p:nvSpPr>
          <p:cNvPr id="468" name="object 468"/>
          <p:cNvSpPr txBox="1"/>
          <p:nvPr/>
        </p:nvSpPr>
        <p:spPr>
          <a:xfrm>
            <a:off x="5148777" y="1822917"/>
            <a:ext cx="626110" cy="135255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dirty="0" sz="700" spc="-30" b="1">
                <a:latin typeface="Arial"/>
                <a:cs typeface="Arial"/>
              </a:rPr>
              <a:t>Oxygen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supply</a:t>
            </a:r>
            <a:endParaRPr sz="700">
              <a:latin typeface="Arial"/>
              <a:cs typeface="Arial"/>
            </a:endParaRPr>
          </a:p>
        </p:txBody>
      </p:sp>
      <p:sp>
        <p:nvSpPr>
          <p:cNvPr id="469" name="object 469"/>
          <p:cNvSpPr txBox="1"/>
          <p:nvPr/>
        </p:nvSpPr>
        <p:spPr>
          <a:xfrm>
            <a:off x="6191624" y="1496931"/>
            <a:ext cx="482600" cy="240029"/>
          </a:xfrm>
          <a:prstGeom prst="rect">
            <a:avLst/>
          </a:prstGeom>
        </p:spPr>
        <p:txBody>
          <a:bodyPr wrap="square" lIns="0" tIns="19685" rIns="0" bIns="0" rtlCol="0" vert="horz">
            <a:spAutoFit/>
          </a:bodyPr>
          <a:lstStyle/>
          <a:p>
            <a:pPr marL="124460" marR="5080" indent="-112395">
              <a:lnSpc>
                <a:spcPts val="830"/>
              </a:lnSpc>
              <a:spcBef>
                <a:spcPts val="155"/>
              </a:spcBef>
            </a:pPr>
            <a:r>
              <a:rPr dirty="0" sz="700" spc="-20" b="1">
                <a:latin typeface="Arial"/>
                <a:cs typeface="Arial"/>
              </a:rPr>
              <a:t>Centrifugal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0" b="1">
                <a:latin typeface="Arial"/>
                <a:cs typeface="Arial"/>
              </a:rPr>
              <a:t>pump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470" name="object 470"/>
          <p:cNvGrpSpPr/>
          <p:nvPr/>
        </p:nvGrpSpPr>
        <p:grpSpPr>
          <a:xfrm>
            <a:off x="5832347" y="1002791"/>
            <a:ext cx="1287780" cy="1268095"/>
            <a:chOff x="5832347" y="1002791"/>
            <a:chExt cx="1287780" cy="1268095"/>
          </a:xfrm>
        </p:grpSpPr>
        <p:pic>
          <p:nvPicPr>
            <p:cNvPr id="471" name="object 471"/>
            <p:cNvPicPr/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6079235" y="2221991"/>
              <a:ext cx="164591" cy="48767"/>
            </a:xfrm>
            <a:prstGeom prst="rect">
              <a:avLst/>
            </a:prstGeom>
          </p:spPr>
        </p:pic>
        <p:pic>
          <p:nvPicPr>
            <p:cNvPr id="472" name="object 472"/>
            <p:cNvPicPr/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6079235" y="1871472"/>
              <a:ext cx="164591" cy="48767"/>
            </a:xfrm>
            <a:prstGeom prst="rect">
              <a:avLst/>
            </a:prstGeom>
          </p:spPr>
        </p:pic>
        <p:pic>
          <p:nvPicPr>
            <p:cNvPr id="473" name="object 473"/>
            <p:cNvPicPr/>
            <p:nvPr/>
          </p:nvPicPr>
          <p:blipFill>
            <a:blip r:embed="rId18" cstate="print"/>
            <a:stretch>
              <a:fillRect/>
            </a:stretch>
          </p:blipFill>
          <p:spPr>
            <a:xfrm>
              <a:off x="5832347" y="1397507"/>
              <a:ext cx="48767" cy="163067"/>
            </a:xfrm>
            <a:prstGeom prst="rect">
              <a:avLst/>
            </a:prstGeom>
          </p:spPr>
        </p:pic>
        <p:pic>
          <p:nvPicPr>
            <p:cNvPr id="474" name="object 474"/>
            <p:cNvPicPr/>
            <p:nvPr/>
          </p:nvPicPr>
          <p:blipFill>
            <a:blip r:embed="rId19" cstate="print"/>
            <a:stretch>
              <a:fillRect/>
            </a:stretch>
          </p:blipFill>
          <p:spPr>
            <a:xfrm>
              <a:off x="6144767" y="1002791"/>
              <a:ext cx="164591" cy="47243"/>
            </a:xfrm>
            <a:prstGeom prst="rect">
              <a:avLst/>
            </a:prstGeom>
          </p:spPr>
        </p:pic>
        <p:pic>
          <p:nvPicPr>
            <p:cNvPr id="475" name="object 475"/>
            <p:cNvPicPr/>
            <p:nvPr/>
          </p:nvPicPr>
          <p:blipFill>
            <a:blip r:embed="rId20" cstate="print"/>
            <a:stretch>
              <a:fillRect/>
            </a:stretch>
          </p:blipFill>
          <p:spPr>
            <a:xfrm>
              <a:off x="6955535" y="1008887"/>
              <a:ext cx="164591" cy="47243"/>
            </a:xfrm>
            <a:prstGeom prst="rect">
              <a:avLst/>
            </a:prstGeom>
          </p:spPr>
        </p:pic>
      </p:grpSp>
      <p:sp>
        <p:nvSpPr>
          <p:cNvPr id="476" name="object 476"/>
          <p:cNvSpPr txBox="1"/>
          <p:nvPr/>
        </p:nvSpPr>
        <p:spPr>
          <a:xfrm>
            <a:off x="6291739" y="949794"/>
            <a:ext cx="678815" cy="135255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dirty="0" sz="700" spc="-10" b="1">
                <a:solidFill>
                  <a:srgbClr val="C03830"/>
                </a:solidFill>
                <a:latin typeface="Arial"/>
                <a:cs typeface="Arial"/>
              </a:rPr>
              <a:t>Arterial</a:t>
            </a:r>
            <a:r>
              <a:rPr dirty="0" sz="700" spc="10" b="1">
                <a:solidFill>
                  <a:srgbClr val="C03830"/>
                </a:solidFill>
                <a:latin typeface="Arial"/>
                <a:cs typeface="Arial"/>
              </a:rPr>
              <a:t> </a:t>
            </a:r>
            <a:r>
              <a:rPr dirty="0" sz="700" spc="-10" b="1">
                <a:solidFill>
                  <a:srgbClr val="C03830"/>
                </a:solidFill>
                <a:latin typeface="Arial"/>
                <a:cs typeface="Arial"/>
              </a:rPr>
              <a:t>cannula</a:t>
            </a:r>
            <a:endParaRPr sz="700">
              <a:latin typeface="Arial"/>
              <a:cs typeface="Arial"/>
            </a:endParaRPr>
          </a:p>
        </p:txBody>
      </p:sp>
      <p:sp>
        <p:nvSpPr>
          <p:cNvPr id="477" name="object 477"/>
          <p:cNvSpPr txBox="1"/>
          <p:nvPr/>
        </p:nvSpPr>
        <p:spPr>
          <a:xfrm>
            <a:off x="6075602" y="2502851"/>
            <a:ext cx="678815" cy="135255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14"/>
              </a:spcBef>
            </a:pPr>
            <a:r>
              <a:rPr dirty="0" sz="700" spc="-20" b="1">
                <a:solidFill>
                  <a:srgbClr val="3A68AE"/>
                </a:solidFill>
                <a:latin typeface="Arial"/>
                <a:cs typeface="Arial"/>
              </a:rPr>
              <a:t>Venous </a:t>
            </a:r>
            <a:r>
              <a:rPr dirty="0" sz="700" spc="-10" b="1">
                <a:solidFill>
                  <a:srgbClr val="3A68AE"/>
                </a:solidFill>
                <a:latin typeface="Arial"/>
                <a:cs typeface="Arial"/>
              </a:rPr>
              <a:t>cannula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478" name="object 478"/>
          <p:cNvGrpSpPr/>
          <p:nvPr/>
        </p:nvGrpSpPr>
        <p:grpSpPr>
          <a:xfrm>
            <a:off x="5469635" y="947159"/>
            <a:ext cx="2210435" cy="1559560"/>
            <a:chOff x="5469635" y="947159"/>
            <a:chExt cx="2210435" cy="1559560"/>
          </a:xfrm>
        </p:grpSpPr>
        <p:pic>
          <p:nvPicPr>
            <p:cNvPr id="479" name="object 479"/>
            <p:cNvPicPr/>
            <p:nvPr/>
          </p:nvPicPr>
          <p:blipFill>
            <a:blip r:embed="rId21" cstate="print"/>
            <a:stretch>
              <a:fillRect/>
            </a:stretch>
          </p:blipFill>
          <p:spPr>
            <a:xfrm>
              <a:off x="6859523" y="2078736"/>
              <a:ext cx="48767" cy="164591"/>
            </a:xfrm>
            <a:prstGeom prst="rect">
              <a:avLst/>
            </a:prstGeom>
          </p:spPr>
        </p:pic>
        <p:pic>
          <p:nvPicPr>
            <p:cNvPr id="480" name="object 480"/>
            <p:cNvPicPr/>
            <p:nvPr/>
          </p:nvPicPr>
          <p:blipFill>
            <a:blip r:embed="rId22" cstate="print"/>
            <a:stretch>
              <a:fillRect/>
            </a:stretch>
          </p:blipFill>
          <p:spPr>
            <a:xfrm>
              <a:off x="5765291" y="1767840"/>
              <a:ext cx="283463" cy="339851"/>
            </a:xfrm>
            <a:prstGeom prst="rect">
              <a:avLst/>
            </a:prstGeom>
          </p:spPr>
        </p:pic>
        <p:sp>
          <p:nvSpPr>
            <p:cNvPr id="481" name="object 481"/>
            <p:cNvSpPr/>
            <p:nvPr/>
          </p:nvSpPr>
          <p:spPr>
            <a:xfrm>
              <a:off x="6273152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2" name="object 482"/>
            <p:cNvSpPr/>
            <p:nvPr/>
          </p:nvSpPr>
          <p:spPr>
            <a:xfrm>
              <a:off x="6272993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3" name="object 483"/>
            <p:cNvSpPr/>
            <p:nvPr/>
          </p:nvSpPr>
          <p:spPr>
            <a:xfrm>
              <a:off x="6240071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4" name="object 484"/>
            <p:cNvSpPr/>
            <p:nvPr/>
          </p:nvSpPr>
          <p:spPr>
            <a:xfrm>
              <a:off x="6239911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5" name="object 485"/>
            <p:cNvSpPr/>
            <p:nvPr/>
          </p:nvSpPr>
          <p:spPr>
            <a:xfrm>
              <a:off x="6206989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6" name="object 486"/>
            <p:cNvSpPr/>
            <p:nvPr/>
          </p:nvSpPr>
          <p:spPr>
            <a:xfrm>
              <a:off x="6206830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7" name="object 487"/>
            <p:cNvSpPr/>
            <p:nvPr/>
          </p:nvSpPr>
          <p:spPr>
            <a:xfrm>
              <a:off x="6173909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2" y="0"/>
                  </a:lnTo>
                  <a:lnTo>
                    <a:pt x="33452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8" name="object 488"/>
            <p:cNvSpPr/>
            <p:nvPr/>
          </p:nvSpPr>
          <p:spPr>
            <a:xfrm>
              <a:off x="6173749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89" name="object 489"/>
            <p:cNvSpPr/>
            <p:nvPr/>
          </p:nvSpPr>
          <p:spPr>
            <a:xfrm>
              <a:off x="6140828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2" y="0"/>
                  </a:lnTo>
                  <a:lnTo>
                    <a:pt x="33452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0" name="object 490"/>
            <p:cNvSpPr/>
            <p:nvPr/>
          </p:nvSpPr>
          <p:spPr>
            <a:xfrm>
              <a:off x="6140668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1" name="object 491"/>
            <p:cNvSpPr/>
            <p:nvPr/>
          </p:nvSpPr>
          <p:spPr>
            <a:xfrm>
              <a:off x="6107746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2" name="object 492"/>
            <p:cNvSpPr/>
            <p:nvPr/>
          </p:nvSpPr>
          <p:spPr>
            <a:xfrm>
              <a:off x="6107586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3" name="object 493"/>
            <p:cNvSpPr/>
            <p:nvPr/>
          </p:nvSpPr>
          <p:spPr>
            <a:xfrm>
              <a:off x="6074665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4" name="object 494"/>
            <p:cNvSpPr/>
            <p:nvPr/>
          </p:nvSpPr>
          <p:spPr>
            <a:xfrm>
              <a:off x="6074505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6" y="0"/>
                  </a:lnTo>
                  <a:lnTo>
                    <a:pt x="33756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5" name="object 495"/>
            <p:cNvSpPr/>
            <p:nvPr/>
          </p:nvSpPr>
          <p:spPr>
            <a:xfrm>
              <a:off x="6041584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6" name="object 496"/>
            <p:cNvSpPr/>
            <p:nvPr/>
          </p:nvSpPr>
          <p:spPr>
            <a:xfrm>
              <a:off x="6041425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7" name="object 497"/>
            <p:cNvSpPr/>
            <p:nvPr/>
          </p:nvSpPr>
          <p:spPr>
            <a:xfrm>
              <a:off x="6008503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8" name="object 498"/>
            <p:cNvSpPr/>
            <p:nvPr/>
          </p:nvSpPr>
          <p:spPr>
            <a:xfrm>
              <a:off x="6008343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499" name="object 499"/>
            <p:cNvSpPr/>
            <p:nvPr/>
          </p:nvSpPr>
          <p:spPr>
            <a:xfrm>
              <a:off x="5975421" y="1828950"/>
              <a:ext cx="33655" cy="20320"/>
            </a:xfrm>
            <a:custGeom>
              <a:avLst/>
              <a:gdLst/>
              <a:ahLst/>
              <a:cxnLst/>
              <a:rect l="l" t="t" r="r" b="b"/>
              <a:pathLst>
                <a:path w="33654" h="20319">
                  <a:moveTo>
                    <a:pt x="0" y="0"/>
                  </a:moveTo>
                  <a:lnTo>
                    <a:pt x="33453" y="0"/>
                  </a:lnTo>
                  <a:lnTo>
                    <a:pt x="33453" y="20238"/>
                  </a:lnTo>
                  <a:lnTo>
                    <a:pt x="0" y="2023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15482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00" name="object 500"/>
            <p:cNvSpPr/>
            <p:nvPr/>
          </p:nvSpPr>
          <p:spPr>
            <a:xfrm>
              <a:off x="5975262" y="1831435"/>
              <a:ext cx="34290" cy="15875"/>
            </a:xfrm>
            <a:custGeom>
              <a:avLst/>
              <a:gdLst/>
              <a:ahLst/>
              <a:cxnLst/>
              <a:rect l="l" t="t" r="r" b="b"/>
              <a:pathLst>
                <a:path w="34289" h="15875">
                  <a:moveTo>
                    <a:pt x="0" y="0"/>
                  </a:moveTo>
                  <a:lnTo>
                    <a:pt x="33755" y="0"/>
                  </a:lnTo>
                  <a:lnTo>
                    <a:pt x="33755" y="15268"/>
                  </a:lnTo>
                  <a:lnTo>
                    <a:pt x="0" y="1526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B4C1DC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501" name="object 501"/>
            <p:cNvPicPr/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5760780" y="947159"/>
              <a:ext cx="387752" cy="348371"/>
            </a:xfrm>
            <a:prstGeom prst="rect">
              <a:avLst/>
            </a:prstGeom>
          </p:spPr>
        </p:pic>
        <p:pic>
          <p:nvPicPr>
            <p:cNvPr id="502" name="object 502"/>
            <p:cNvPicPr/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5771382" y="957762"/>
              <a:ext cx="284755" cy="162068"/>
            </a:xfrm>
            <a:prstGeom prst="rect">
              <a:avLst/>
            </a:prstGeom>
          </p:spPr>
        </p:pic>
        <p:sp>
          <p:nvSpPr>
            <p:cNvPr id="503" name="object 503"/>
            <p:cNvSpPr/>
            <p:nvPr/>
          </p:nvSpPr>
          <p:spPr>
            <a:xfrm>
              <a:off x="6312553" y="1821752"/>
              <a:ext cx="104775" cy="37465"/>
            </a:xfrm>
            <a:custGeom>
              <a:avLst/>
              <a:gdLst/>
              <a:ahLst/>
              <a:cxnLst/>
              <a:rect l="l" t="t" r="r" b="b"/>
              <a:pathLst>
                <a:path w="104775" h="37464">
                  <a:moveTo>
                    <a:pt x="104494" y="0"/>
                  </a:moveTo>
                  <a:lnTo>
                    <a:pt x="104494" y="37050"/>
                  </a:lnTo>
                  <a:lnTo>
                    <a:pt x="0" y="37050"/>
                  </a:lnTo>
                  <a:lnTo>
                    <a:pt x="0" y="0"/>
                  </a:lnTo>
                  <a:lnTo>
                    <a:pt x="104494" y="0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04" name="object 504"/>
            <p:cNvSpPr/>
            <p:nvPr/>
          </p:nvSpPr>
          <p:spPr>
            <a:xfrm>
              <a:off x="6312553" y="1821752"/>
              <a:ext cx="104775" cy="37465"/>
            </a:xfrm>
            <a:custGeom>
              <a:avLst/>
              <a:gdLst/>
              <a:ahLst/>
              <a:cxnLst/>
              <a:rect l="l" t="t" r="r" b="b"/>
              <a:pathLst>
                <a:path w="104775" h="37464">
                  <a:moveTo>
                    <a:pt x="0" y="0"/>
                  </a:moveTo>
                  <a:lnTo>
                    <a:pt x="0" y="37050"/>
                  </a:lnTo>
                  <a:lnTo>
                    <a:pt x="104494" y="37050"/>
                  </a:lnTo>
                  <a:lnTo>
                    <a:pt x="104494" y="0"/>
                  </a:lnTo>
                  <a:lnTo>
                    <a:pt x="0" y="0"/>
                  </a:lnTo>
                  <a:close/>
                </a:path>
              </a:pathLst>
            </a:custGeom>
            <a:ln w="4262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05" name="object 505"/>
            <p:cNvSpPr/>
            <p:nvPr/>
          </p:nvSpPr>
          <p:spPr>
            <a:xfrm>
              <a:off x="6296227" y="1815229"/>
              <a:ext cx="16510" cy="50165"/>
            </a:xfrm>
            <a:custGeom>
              <a:avLst/>
              <a:gdLst/>
              <a:ahLst/>
              <a:cxnLst/>
              <a:rect l="l" t="t" r="r" b="b"/>
              <a:pathLst>
                <a:path w="16510" h="50164">
                  <a:moveTo>
                    <a:pt x="16426" y="1492"/>
                  </a:moveTo>
                  <a:lnTo>
                    <a:pt x="16426" y="48603"/>
                  </a:lnTo>
                  <a:lnTo>
                    <a:pt x="14933" y="50095"/>
                  </a:lnTo>
                  <a:lnTo>
                    <a:pt x="1493" y="50095"/>
                  </a:lnTo>
                  <a:lnTo>
                    <a:pt x="0" y="48603"/>
                  </a:lnTo>
                  <a:lnTo>
                    <a:pt x="0" y="1492"/>
                  </a:lnTo>
                  <a:lnTo>
                    <a:pt x="1493" y="0"/>
                  </a:lnTo>
                  <a:lnTo>
                    <a:pt x="13092" y="0"/>
                  </a:lnTo>
                  <a:lnTo>
                    <a:pt x="14933" y="0"/>
                  </a:lnTo>
                  <a:lnTo>
                    <a:pt x="16426" y="1492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06" name="object 506"/>
            <p:cNvSpPr/>
            <p:nvPr/>
          </p:nvSpPr>
          <p:spPr>
            <a:xfrm>
              <a:off x="6296227" y="1815229"/>
              <a:ext cx="16510" cy="50165"/>
            </a:xfrm>
            <a:custGeom>
              <a:avLst/>
              <a:gdLst/>
              <a:ahLst/>
              <a:cxnLst/>
              <a:rect l="l" t="t" r="r" b="b"/>
              <a:pathLst>
                <a:path w="16510" h="50164">
                  <a:moveTo>
                    <a:pt x="13092" y="0"/>
                  </a:moveTo>
                  <a:lnTo>
                    <a:pt x="3334" y="0"/>
                  </a:lnTo>
                  <a:lnTo>
                    <a:pt x="1493" y="0"/>
                  </a:lnTo>
                  <a:lnTo>
                    <a:pt x="0" y="1492"/>
                  </a:lnTo>
                  <a:lnTo>
                    <a:pt x="0" y="3334"/>
                  </a:lnTo>
                  <a:lnTo>
                    <a:pt x="0" y="46761"/>
                  </a:lnTo>
                  <a:lnTo>
                    <a:pt x="0" y="48603"/>
                  </a:lnTo>
                  <a:lnTo>
                    <a:pt x="1493" y="50095"/>
                  </a:lnTo>
                  <a:lnTo>
                    <a:pt x="3334" y="50095"/>
                  </a:lnTo>
                  <a:lnTo>
                    <a:pt x="13092" y="50095"/>
                  </a:lnTo>
                  <a:lnTo>
                    <a:pt x="14933" y="50095"/>
                  </a:lnTo>
                  <a:lnTo>
                    <a:pt x="16426" y="48603"/>
                  </a:lnTo>
                  <a:lnTo>
                    <a:pt x="16426" y="46761"/>
                  </a:lnTo>
                  <a:lnTo>
                    <a:pt x="16426" y="3334"/>
                  </a:lnTo>
                  <a:lnTo>
                    <a:pt x="16426" y="1492"/>
                  </a:lnTo>
                  <a:lnTo>
                    <a:pt x="14933" y="0"/>
                  </a:lnTo>
                  <a:lnTo>
                    <a:pt x="13092" y="0"/>
                  </a:lnTo>
                  <a:close/>
                </a:path>
              </a:pathLst>
            </a:custGeom>
            <a:ln w="4262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07" name="object 507"/>
            <p:cNvSpPr/>
            <p:nvPr/>
          </p:nvSpPr>
          <p:spPr>
            <a:xfrm>
              <a:off x="6331937" y="1815229"/>
              <a:ext cx="222250" cy="222250"/>
            </a:xfrm>
            <a:custGeom>
              <a:avLst/>
              <a:gdLst/>
              <a:ahLst/>
              <a:cxnLst/>
              <a:rect l="l" t="t" r="r" b="b"/>
              <a:pathLst>
                <a:path w="222250" h="222250">
                  <a:moveTo>
                    <a:pt x="0" y="110879"/>
                  </a:moveTo>
                  <a:lnTo>
                    <a:pt x="8713" y="67720"/>
                  </a:lnTo>
                  <a:lnTo>
                    <a:pt x="32475" y="32475"/>
                  </a:lnTo>
                  <a:lnTo>
                    <a:pt x="67720" y="8713"/>
                  </a:lnTo>
                  <a:lnTo>
                    <a:pt x="110879" y="0"/>
                  </a:lnTo>
                  <a:lnTo>
                    <a:pt x="154038" y="8713"/>
                  </a:lnTo>
                  <a:lnTo>
                    <a:pt x="189283" y="32475"/>
                  </a:lnTo>
                  <a:lnTo>
                    <a:pt x="213045" y="67720"/>
                  </a:lnTo>
                  <a:lnTo>
                    <a:pt x="221759" y="110879"/>
                  </a:lnTo>
                  <a:lnTo>
                    <a:pt x="213045" y="154038"/>
                  </a:lnTo>
                  <a:lnTo>
                    <a:pt x="189283" y="189283"/>
                  </a:lnTo>
                  <a:lnTo>
                    <a:pt x="154038" y="213045"/>
                  </a:lnTo>
                  <a:lnTo>
                    <a:pt x="110879" y="221759"/>
                  </a:lnTo>
                  <a:lnTo>
                    <a:pt x="67720" y="213045"/>
                  </a:lnTo>
                  <a:lnTo>
                    <a:pt x="32475" y="189283"/>
                  </a:lnTo>
                  <a:lnTo>
                    <a:pt x="8713" y="154038"/>
                  </a:lnTo>
                  <a:lnTo>
                    <a:pt x="0" y="110879"/>
                  </a:lnTo>
                  <a:close/>
                </a:path>
              </a:pathLst>
            </a:custGeom>
            <a:solidFill>
              <a:srgbClr val="EAEAEA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08" name="object 508"/>
            <p:cNvSpPr/>
            <p:nvPr/>
          </p:nvSpPr>
          <p:spPr>
            <a:xfrm>
              <a:off x="6331937" y="1815229"/>
              <a:ext cx="222250" cy="222250"/>
            </a:xfrm>
            <a:custGeom>
              <a:avLst/>
              <a:gdLst/>
              <a:ahLst/>
              <a:cxnLst/>
              <a:rect l="l" t="t" r="r" b="b"/>
              <a:pathLst>
                <a:path w="222250" h="222250">
                  <a:moveTo>
                    <a:pt x="110879" y="0"/>
                  </a:moveTo>
                  <a:lnTo>
                    <a:pt x="67720" y="8713"/>
                  </a:lnTo>
                  <a:lnTo>
                    <a:pt x="32475" y="32475"/>
                  </a:lnTo>
                  <a:lnTo>
                    <a:pt x="8713" y="67720"/>
                  </a:lnTo>
                  <a:lnTo>
                    <a:pt x="0" y="110879"/>
                  </a:lnTo>
                  <a:lnTo>
                    <a:pt x="8713" y="154038"/>
                  </a:lnTo>
                  <a:lnTo>
                    <a:pt x="32475" y="189283"/>
                  </a:lnTo>
                  <a:lnTo>
                    <a:pt x="67720" y="213045"/>
                  </a:lnTo>
                  <a:lnTo>
                    <a:pt x="110879" y="221759"/>
                  </a:lnTo>
                  <a:lnTo>
                    <a:pt x="154038" y="213045"/>
                  </a:lnTo>
                  <a:lnTo>
                    <a:pt x="189283" y="189283"/>
                  </a:lnTo>
                  <a:lnTo>
                    <a:pt x="213045" y="154038"/>
                  </a:lnTo>
                  <a:lnTo>
                    <a:pt x="221759" y="110879"/>
                  </a:lnTo>
                  <a:lnTo>
                    <a:pt x="213045" y="67720"/>
                  </a:lnTo>
                  <a:lnTo>
                    <a:pt x="189283" y="32475"/>
                  </a:lnTo>
                  <a:lnTo>
                    <a:pt x="154038" y="8713"/>
                  </a:lnTo>
                  <a:lnTo>
                    <a:pt x="110879" y="0"/>
                  </a:lnTo>
                  <a:close/>
                </a:path>
              </a:pathLst>
            </a:custGeom>
            <a:ln w="4262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09" name="object 509"/>
            <p:cNvSpPr/>
            <p:nvPr/>
          </p:nvSpPr>
          <p:spPr>
            <a:xfrm>
              <a:off x="6400379" y="1883673"/>
              <a:ext cx="85090" cy="85090"/>
            </a:xfrm>
            <a:custGeom>
              <a:avLst/>
              <a:gdLst/>
              <a:ahLst/>
              <a:cxnLst/>
              <a:rect l="l" t="t" r="r" b="b"/>
              <a:pathLst>
                <a:path w="85089" h="85089">
                  <a:moveTo>
                    <a:pt x="0" y="42435"/>
                  </a:moveTo>
                  <a:lnTo>
                    <a:pt x="3334" y="25918"/>
                  </a:lnTo>
                  <a:lnTo>
                    <a:pt x="12429" y="12429"/>
                  </a:lnTo>
                  <a:lnTo>
                    <a:pt x="25918" y="3334"/>
                  </a:lnTo>
                  <a:lnTo>
                    <a:pt x="42435" y="0"/>
                  </a:lnTo>
                  <a:lnTo>
                    <a:pt x="58953" y="3334"/>
                  </a:lnTo>
                  <a:lnTo>
                    <a:pt x="72442" y="12429"/>
                  </a:lnTo>
                  <a:lnTo>
                    <a:pt x="81536" y="25918"/>
                  </a:lnTo>
                  <a:lnTo>
                    <a:pt x="84871" y="42435"/>
                  </a:lnTo>
                  <a:lnTo>
                    <a:pt x="81536" y="58953"/>
                  </a:lnTo>
                  <a:lnTo>
                    <a:pt x="72442" y="72442"/>
                  </a:lnTo>
                  <a:lnTo>
                    <a:pt x="58953" y="81536"/>
                  </a:lnTo>
                  <a:lnTo>
                    <a:pt x="42435" y="84871"/>
                  </a:lnTo>
                  <a:lnTo>
                    <a:pt x="25918" y="81536"/>
                  </a:lnTo>
                  <a:lnTo>
                    <a:pt x="12429" y="72442"/>
                  </a:lnTo>
                  <a:lnTo>
                    <a:pt x="3334" y="58953"/>
                  </a:lnTo>
                  <a:lnTo>
                    <a:pt x="0" y="42435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0" name="object 510"/>
            <p:cNvSpPr/>
            <p:nvPr/>
          </p:nvSpPr>
          <p:spPr>
            <a:xfrm>
              <a:off x="6400379" y="1883673"/>
              <a:ext cx="85090" cy="85090"/>
            </a:xfrm>
            <a:custGeom>
              <a:avLst/>
              <a:gdLst/>
              <a:ahLst/>
              <a:cxnLst/>
              <a:rect l="l" t="t" r="r" b="b"/>
              <a:pathLst>
                <a:path w="85089" h="85089">
                  <a:moveTo>
                    <a:pt x="42435" y="0"/>
                  </a:moveTo>
                  <a:lnTo>
                    <a:pt x="25918" y="3334"/>
                  </a:lnTo>
                  <a:lnTo>
                    <a:pt x="12429" y="12429"/>
                  </a:lnTo>
                  <a:lnTo>
                    <a:pt x="3334" y="25918"/>
                  </a:lnTo>
                  <a:lnTo>
                    <a:pt x="0" y="42435"/>
                  </a:lnTo>
                  <a:lnTo>
                    <a:pt x="3334" y="58953"/>
                  </a:lnTo>
                  <a:lnTo>
                    <a:pt x="12429" y="72442"/>
                  </a:lnTo>
                  <a:lnTo>
                    <a:pt x="25918" y="81536"/>
                  </a:lnTo>
                  <a:lnTo>
                    <a:pt x="42435" y="84871"/>
                  </a:lnTo>
                  <a:lnTo>
                    <a:pt x="58953" y="81536"/>
                  </a:lnTo>
                  <a:lnTo>
                    <a:pt x="72442" y="72442"/>
                  </a:lnTo>
                  <a:lnTo>
                    <a:pt x="81536" y="58953"/>
                  </a:lnTo>
                  <a:lnTo>
                    <a:pt x="84871" y="42435"/>
                  </a:lnTo>
                  <a:lnTo>
                    <a:pt x="81536" y="25918"/>
                  </a:lnTo>
                  <a:lnTo>
                    <a:pt x="72442" y="12429"/>
                  </a:lnTo>
                  <a:lnTo>
                    <a:pt x="58953" y="3334"/>
                  </a:lnTo>
                  <a:lnTo>
                    <a:pt x="42435" y="0"/>
                  </a:lnTo>
                  <a:close/>
                </a:path>
              </a:pathLst>
            </a:custGeom>
            <a:ln w="4262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1" name="object 511"/>
            <p:cNvSpPr/>
            <p:nvPr/>
          </p:nvSpPr>
          <p:spPr>
            <a:xfrm>
              <a:off x="6367999" y="1861278"/>
              <a:ext cx="37465" cy="78740"/>
            </a:xfrm>
            <a:custGeom>
              <a:avLst/>
              <a:gdLst/>
              <a:ahLst/>
              <a:cxnLst/>
              <a:rect l="l" t="t" r="r" b="b"/>
              <a:pathLst>
                <a:path w="37464" h="78739">
                  <a:moveTo>
                    <a:pt x="37390" y="0"/>
                  </a:moveTo>
                  <a:lnTo>
                    <a:pt x="7379" y="32332"/>
                  </a:lnTo>
                  <a:lnTo>
                    <a:pt x="0" y="62310"/>
                  </a:lnTo>
                  <a:lnTo>
                    <a:pt x="155" y="70271"/>
                  </a:lnTo>
                  <a:lnTo>
                    <a:pt x="1153" y="78155"/>
                  </a:lnTo>
                </a:path>
              </a:pathLst>
            </a:custGeom>
            <a:ln w="8637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2" name="object 512"/>
            <p:cNvSpPr/>
            <p:nvPr/>
          </p:nvSpPr>
          <p:spPr>
            <a:xfrm>
              <a:off x="6350566" y="1926849"/>
              <a:ext cx="32384" cy="38735"/>
            </a:xfrm>
            <a:custGeom>
              <a:avLst/>
              <a:gdLst/>
              <a:ahLst/>
              <a:cxnLst/>
              <a:rect l="l" t="t" r="r" b="b"/>
              <a:pathLst>
                <a:path w="32385" h="38735">
                  <a:moveTo>
                    <a:pt x="0" y="12323"/>
                  </a:moveTo>
                  <a:lnTo>
                    <a:pt x="32278" y="0"/>
                  </a:lnTo>
                  <a:lnTo>
                    <a:pt x="28462" y="38440"/>
                  </a:lnTo>
                  <a:lnTo>
                    <a:pt x="0" y="12323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3" name="object 513"/>
            <p:cNvSpPr/>
            <p:nvPr/>
          </p:nvSpPr>
          <p:spPr>
            <a:xfrm>
              <a:off x="6453579" y="1852026"/>
              <a:ext cx="63500" cy="104775"/>
            </a:xfrm>
            <a:custGeom>
              <a:avLst/>
              <a:gdLst/>
              <a:ahLst/>
              <a:cxnLst/>
              <a:rect l="l" t="t" r="r" b="b"/>
              <a:pathLst>
                <a:path w="63500" h="104775">
                  <a:moveTo>
                    <a:pt x="57635" y="104505"/>
                  </a:moveTo>
                  <a:lnTo>
                    <a:pt x="63377" y="84445"/>
                  </a:lnTo>
                  <a:lnTo>
                    <a:pt x="63407" y="63959"/>
                  </a:lnTo>
                  <a:lnTo>
                    <a:pt x="57888" y="44230"/>
                  </a:lnTo>
                  <a:lnTo>
                    <a:pt x="46980" y="26443"/>
                  </a:lnTo>
                  <a:lnTo>
                    <a:pt x="37103" y="16525"/>
                  </a:lnTo>
                  <a:lnTo>
                    <a:pt x="25758" y="8735"/>
                  </a:lnTo>
                  <a:lnTo>
                    <a:pt x="13278" y="3189"/>
                  </a:lnTo>
                  <a:lnTo>
                    <a:pt x="0" y="0"/>
                  </a:lnTo>
                </a:path>
              </a:pathLst>
            </a:custGeom>
            <a:ln w="8637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4" name="object 514"/>
            <p:cNvSpPr/>
            <p:nvPr/>
          </p:nvSpPr>
          <p:spPr>
            <a:xfrm>
              <a:off x="6425934" y="1834482"/>
              <a:ext cx="35560" cy="34925"/>
            </a:xfrm>
            <a:custGeom>
              <a:avLst/>
              <a:gdLst/>
              <a:ahLst/>
              <a:cxnLst/>
              <a:rect l="l" t="t" r="r" b="b"/>
              <a:pathLst>
                <a:path w="35560" h="34925">
                  <a:moveTo>
                    <a:pt x="33803" y="0"/>
                  </a:moveTo>
                  <a:lnTo>
                    <a:pt x="35239" y="34521"/>
                  </a:lnTo>
                  <a:lnTo>
                    <a:pt x="0" y="18696"/>
                  </a:lnTo>
                  <a:lnTo>
                    <a:pt x="33803" y="0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5" name="object 515"/>
            <p:cNvSpPr/>
            <p:nvPr/>
          </p:nvSpPr>
          <p:spPr>
            <a:xfrm>
              <a:off x="6392463" y="1981502"/>
              <a:ext cx="91440" cy="19685"/>
            </a:xfrm>
            <a:custGeom>
              <a:avLst/>
              <a:gdLst/>
              <a:ahLst/>
              <a:cxnLst/>
              <a:rect l="l" t="t" r="r" b="b"/>
              <a:pathLst>
                <a:path w="91439" h="19685">
                  <a:moveTo>
                    <a:pt x="0" y="0"/>
                  </a:moveTo>
                  <a:lnTo>
                    <a:pt x="12764" y="9344"/>
                  </a:lnTo>
                  <a:lnTo>
                    <a:pt x="27045" y="15744"/>
                  </a:lnTo>
                  <a:lnTo>
                    <a:pt x="42344" y="19036"/>
                  </a:lnTo>
                  <a:lnTo>
                    <a:pt x="58163" y="19056"/>
                  </a:lnTo>
                  <a:lnTo>
                    <a:pt x="66936" y="17605"/>
                  </a:lnTo>
                  <a:lnTo>
                    <a:pt x="75399" y="15151"/>
                  </a:lnTo>
                  <a:lnTo>
                    <a:pt x="83474" y="11738"/>
                  </a:lnTo>
                  <a:lnTo>
                    <a:pt x="91081" y="7415"/>
                  </a:lnTo>
                </a:path>
              </a:pathLst>
            </a:custGeom>
            <a:ln w="8637">
              <a:solidFill>
                <a:srgbClr val="3A68AE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6" name="object 516"/>
            <p:cNvSpPr/>
            <p:nvPr/>
          </p:nvSpPr>
          <p:spPr>
            <a:xfrm>
              <a:off x="6466655" y="1969819"/>
              <a:ext cx="37465" cy="36830"/>
            </a:xfrm>
            <a:custGeom>
              <a:avLst/>
              <a:gdLst/>
              <a:ahLst/>
              <a:cxnLst/>
              <a:rect l="l" t="t" r="r" b="b"/>
              <a:pathLst>
                <a:path w="37465" h="36830">
                  <a:moveTo>
                    <a:pt x="23829" y="36338"/>
                  </a:moveTo>
                  <a:lnTo>
                    <a:pt x="0" y="11320"/>
                  </a:lnTo>
                  <a:lnTo>
                    <a:pt x="36933" y="0"/>
                  </a:lnTo>
                  <a:lnTo>
                    <a:pt x="23829" y="36338"/>
                  </a:lnTo>
                  <a:close/>
                </a:path>
              </a:pathLst>
            </a:custGeom>
            <a:solidFill>
              <a:srgbClr val="3A68AE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7" name="object 517"/>
            <p:cNvSpPr/>
            <p:nvPr/>
          </p:nvSpPr>
          <p:spPr>
            <a:xfrm>
              <a:off x="6415927" y="1899220"/>
              <a:ext cx="53975" cy="53975"/>
            </a:xfrm>
            <a:custGeom>
              <a:avLst/>
              <a:gdLst/>
              <a:ahLst/>
              <a:cxnLst/>
              <a:rect l="l" t="t" r="r" b="b"/>
              <a:pathLst>
                <a:path w="53975" h="53975">
                  <a:moveTo>
                    <a:pt x="0" y="26888"/>
                  </a:moveTo>
                  <a:lnTo>
                    <a:pt x="2112" y="16421"/>
                  </a:lnTo>
                  <a:lnTo>
                    <a:pt x="7875" y="7875"/>
                  </a:lnTo>
                  <a:lnTo>
                    <a:pt x="16421" y="2112"/>
                  </a:lnTo>
                  <a:lnTo>
                    <a:pt x="26888" y="0"/>
                  </a:lnTo>
                  <a:lnTo>
                    <a:pt x="37354" y="2112"/>
                  </a:lnTo>
                  <a:lnTo>
                    <a:pt x="45901" y="7875"/>
                  </a:lnTo>
                  <a:lnTo>
                    <a:pt x="51663" y="16421"/>
                  </a:lnTo>
                  <a:lnTo>
                    <a:pt x="53776" y="26888"/>
                  </a:lnTo>
                  <a:lnTo>
                    <a:pt x="51663" y="37354"/>
                  </a:lnTo>
                  <a:lnTo>
                    <a:pt x="45901" y="45901"/>
                  </a:lnTo>
                  <a:lnTo>
                    <a:pt x="37354" y="51663"/>
                  </a:lnTo>
                  <a:lnTo>
                    <a:pt x="26888" y="53776"/>
                  </a:lnTo>
                  <a:lnTo>
                    <a:pt x="16421" y="51663"/>
                  </a:lnTo>
                  <a:lnTo>
                    <a:pt x="7875" y="45901"/>
                  </a:lnTo>
                  <a:lnTo>
                    <a:pt x="2112" y="37354"/>
                  </a:lnTo>
                  <a:lnTo>
                    <a:pt x="0" y="26888"/>
                  </a:lnTo>
                  <a:close/>
                </a:path>
              </a:pathLst>
            </a:custGeom>
            <a:solidFill>
              <a:srgbClr val="D0D2D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18" name="object 518"/>
            <p:cNvSpPr/>
            <p:nvPr/>
          </p:nvSpPr>
          <p:spPr>
            <a:xfrm>
              <a:off x="6415927" y="1899220"/>
              <a:ext cx="53975" cy="53975"/>
            </a:xfrm>
            <a:custGeom>
              <a:avLst/>
              <a:gdLst/>
              <a:ahLst/>
              <a:cxnLst/>
              <a:rect l="l" t="t" r="r" b="b"/>
              <a:pathLst>
                <a:path w="53975" h="53975">
                  <a:moveTo>
                    <a:pt x="26888" y="0"/>
                  </a:moveTo>
                  <a:lnTo>
                    <a:pt x="16421" y="2112"/>
                  </a:lnTo>
                  <a:lnTo>
                    <a:pt x="7875" y="7875"/>
                  </a:lnTo>
                  <a:lnTo>
                    <a:pt x="2112" y="16421"/>
                  </a:lnTo>
                  <a:lnTo>
                    <a:pt x="0" y="26888"/>
                  </a:lnTo>
                  <a:lnTo>
                    <a:pt x="2112" y="37354"/>
                  </a:lnTo>
                  <a:lnTo>
                    <a:pt x="7875" y="45901"/>
                  </a:lnTo>
                  <a:lnTo>
                    <a:pt x="16421" y="51663"/>
                  </a:lnTo>
                  <a:lnTo>
                    <a:pt x="26888" y="53776"/>
                  </a:lnTo>
                  <a:lnTo>
                    <a:pt x="37354" y="51663"/>
                  </a:lnTo>
                  <a:lnTo>
                    <a:pt x="45901" y="45901"/>
                  </a:lnTo>
                  <a:lnTo>
                    <a:pt x="51663" y="37354"/>
                  </a:lnTo>
                  <a:lnTo>
                    <a:pt x="53776" y="26888"/>
                  </a:lnTo>
                  <a:lnTo>
                    <a:pt x="51663" y="16421"/>
                  </a:lnTo>
                  <a:lnTo>
                    <a:pt x="45901" y="7875"/>
                  </a:lnTo>
                  <a:lnTo>
                    <a:pt x="37354" y="2112"/>
                  </a:lnTo>
                  <a:lnTo>
                    <a:pt x="26888" y="0"/>
                  </a:lnTo>
                  <a:close/>
                </a:path>
              </a:pathLst>
            </a:custGeom>
            <a:ln w="4259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519" name="object 519"/>
            <p:cNvSpPr/>
            <p:nvPr/>
          </p:nvSpPr>
          <p:spPr>
            <a:xfrm>
              <a:off x="6425986" y="1909280"/>
              <a:ext cx="33655" cy="33655"/>
            </a:xfrm>
            <a:custGeom>
              <a:avLst/>
              <a:gdLst/>
              <a:ahLst/>
              <a:cxnLst/>
              <a:rect l="l" t="t" r="r" b="b"/>
              <a:pathLst>
                <a:path w="33654" h="33655">
                  <a:moveTo>
                    <a:pt x="0" y="26123"/>
                  </a:moveTo>
                  <a:lnTo>
                    <a:pt x="0" y="7534"/>
                  </a:lnTo>
                  <a:lnTo>
                    <a:pt x="7534" y="0"/>
                  </a:lnTo>
                  <a:lnTo>
                    <a:pt x="16828" y="0"/>
                  </a:lnTo>
                  <a:lnTo>
                    <a:pt x="26123" y="0"/>
                  </a:lnTo>
                  <a:lnTo>
                    <a:pt x="33657" y="7534"/>
                  </a:lnTo>
                  <a:lnTo>
                    <a:pt x="33657" y="26123"/>
                  </a:lnTo>
                  <a:lnTo>
                    <a:pt x="26123" y="33657"/>
                  </a:lnTo>
                  <a:lnTo>
                    <a:pt x="7534" y="33657"/>
                  </a:lnTo>
                  <a:lnTo>
                    <a:pt x="0" y="26123"/>
                  </a:lnTo>
                  <a:close/>
                </a:path>
              </a:pathLst>
            </a:custGeom>
            <a:solidFill>
              <a:srgbClr val="707071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0" name="object 520"/>
            <p:cNvSpPr/>
            <p:nvPr/>
          </p:nvSpPr>
          <p:spPr>
            <a:xfrm>
              <a:off x="6425986" y="1909280"/>
              <a:ext cx="33655" cy="33655"/>
            </a:xfrm>
            <a:custGeom>
              <a:avLst/>
              <a:gdLst/>
              <a:ahLst/>
              <a:cxnLst/>
              <a:rect l="l" t="t" r="r" b="b"/>
              <a:pathLst>
                <a:path w="33654" h="33655">
                  <a:moveTo>
                    <a:pt x="16828" y="0"/>
                  </a:moveTo>
                  <a:lnTo>
                    <a:pt x="7534" y="0"/>
                  </a:lnTo>
                  <a:lnTo>
                    <a:pt x="0" y="7534"/>
                  </a:lnTo>
                  <a:lnTo>
                    <a:pt x="0" y="16828"/>
                  </a:lnTo>
                  <a:lnTo>
                    <a:pt x="0" y="26123"/>
                  </a:lnTo>
                  <a:lnTo>
                    <a:pt x="7534" y="33657"/>
                  </a:lnTo>
                  <a:lnTo>
                    <a:pt x="16828" y="33657"/>
                  </a:lnTo>
                  <a:lnTo>
                    <a:pt x="26123" y="33657"/>
                  </a:lnTo>
                  <a:lnTo>
                    <a:pt x="33657" y="26123"/>
                  </a:lnTo>
                  <a:lnTo>
                    <a:pt x="33657" y="16828"/>
                  </a:lnTo>
                  <a:lnTo>
                    <a:pt x="33657" y="7534"/>
                  </a:lnTo>
                  <a:lnTo>
                    <a:pt x="26123" y="0"/>
                  </a:lnTo>
                  <a:lnTo>
                    <a:pt x="16828" y="0"/>
                  </a:lnTo>
                  <a:close/>
                </a:path>
              </a:pathLst>
            </a:custGeom>
            <a:ln w="3175">
              <a:solidFill>
                <a:srgbClr val="707071"/>
              </a:solidFill>
            </a:ln>
          </p:spPr>
          <p:txBody>
            <a:bodyPr wrap="square" lIns="0" tIns="0" rIns="0" bIns="0" rtlCol="0"/>
            <a:lstStyle/>
            <a:p/>
          </p:txBody>
        </p:sp>
        <p:pic>
          <p:nvPicPr>
            <p:cNvPr id="521" name="object 521"/>
            <p:cNvPicPr/>
            <p:nvPr/>
          </p:nvPicPr>
          <p:blipFill>
            <a:blip r:embed="rId23" cstate="print"/>
            <a:stretch>
              <a:fillRect/>
            </a:stretch>
          </p:blipFill>
          <p:spPr>
            <a:xfrm>
              <a:off x="5469635" y="2017776"/>
              <a:ext cx="164591" cy="48767"/>
            </a:xfrm>
            <a:prstGeom prst="rect">
              <a:avLst/>
            </a:prstGeom>
          </p:spPr>
        </p:pic>
        <p:sp>
          <p:nvSpPr>
            <p:cNvPr id="522" name="object 522"/>
            <p:cNvSpPr/>
            <p:nvPr/>
          </p:nvSpPr>
          <p:spPr>
            <a:xfrm>
              <a:off x="7288263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3" name="object 523"/>
            <p:cNvSpPr/>
            <p:nvPr/>
          </p:nvSpPr>
          <p:spPr>
            <a:xfrm>
              <a:off x="7288114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4" name="object 524"/>
            <p:cNvSpPr/>
            <p:nvPr/>
          </p:nvSpPr>
          <p:spPr>
            <a:xfrm>
              <a:off x="7257341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5" name="object 525"/>
            <p:cNvSpPr/>
            <p:nvPr/>
          </p:nvSpPr>
          <p:spPr>
            <a:xfrm>
              <a:off x="7257193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6" name="object 526"/>
            <p:cNvSpPr/>
            <p:nvPr/>
          </p:nvSpPr>
          <p:spPr>
            <a:xfrm>
              <a:off x="7226419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7" name="object 527"/>
            <p:cNvSpPr/>
            <p:nvPr/>
          </p:nvSpPr>
          <p:spPr>
            <a:xfrm>
              <a:off x="7226271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8" name="object 528"/>
            <p:cNvSpPr/>
            <p:nvPr/>
          </p:nvSpPr>
          <p:spPr>
            <a:xfrm>
              <a:off x="7195498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29" name="object 529"/>
            <p:cNvSpPr/>
            <p:nvPr/>
          </p:nvSpPr>
          <p:spPr>
            <a:xfrm>
              <a:off x="7195349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0" name="object 530"/>
            <p:cNvSpPr/>
            <p:nvPr/>
          </p:nvSpPr>
          <p:spPr>
            <a:xfrm>
              <a:off x="7164576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1" name="object 531"/>
            <p:cNvSpPr/>
            <p:nvPr/>
          </p:nvSpPr>
          <p:spPr>
            <a:xfrm>
              <a:off x="7164428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2" name="object 532"/>
            <p:cNvSpPr/>
            <p:nvPr/>
          </p:nvSpPr>
          <p:spPr>
            <a:xfrm>
              <a:off x="7133654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3" name="object 533"/>
            <p:cNvSpPr/>
            <p:nvPr/>
          </p:nvSpPr>
          <p:spPr>
            <a:xfrm>
              <a:off x="7133506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4" name="object 534"/>
            <p:cNvSpPr/>
            <p:nvPr/>
          </p:nvSpPr>
          <p:spPr>
            <a:xfrm>
              <a:off x="7102733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5" name="object 535"/>
            <p:cNvSpPr/>
            <p:nvPr/>
          </p:nvSpPr>
          <p:spPr>
            <a:xfrm>
              <a:off x="7102584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6" name="object 536"/>
            <p:cNvSpPr/>
            <p:nvPr/>
          </p:nvSpPr>
          <p:spPr>
            <a:xfrm>
              <a:off x="7071811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7" name="object 537"/>
            <p:cNvSpPr/>
            <p:nvPr/>
          </p:nvSpPr>
          <p:spPr>
            <a:xfrm>
              <a:off x="7071663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8" name="object 538"/>
            <p:cNvSpPr/>
            <p:nvPr/>
          </p:nvSpPr>
          <p:spPr>
            <a:xfrm>
              <a:off x="7040889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39" name="object 539"/>
            <p:cNvSpPr/>
            <p:nvPr/>
          </p:nvSpPr>
          <p:spPr>
            <a:xfrm>
              <a:off x="7040741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0" name="object 540"/>
            <p:cNvSpPr/>
            <p:nvPr/>
          </p:nvSpPr>
          <p:spPr>
            <a:xfrm>
              <a:off x="7009968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1" name="object 541"/>
            <p:cNvSpPr/>
            <p:nvPr/>
          </p:nvSpPr>
          <p:spPr>
            <a:xfrm>
              <a:off x="7009819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2" name="object 542"/>
            <p:cNvSpPr/>
            <p:nvPr/>
          </p:nvSpPr>
          <p:spPr>
            <a:xfrm>
              <a:off x="6979046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3" name="object 543"/>
            <p:cNvSpPr/>
            <p:nvPr/>
          </p:nvSpPr>
          <p:spPr>
            <a:xfrm>
              <a:off x="6978898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4" name="object 544"/>
            <p:cNvSpPr/>
            <p:nvPr/>
          </p:nvSpPr>
          <p:spPr>
            <a:xfrm>
              <a:off x="6948124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5" name="object 545"/>
            <p:cNvSpPr/>
            <p:nvPr/>
          </p:nvSpPr>
          <p:spPr>
            <a:xfrm>
              <a:off x="6947976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6" name="object 546"/>
            <p:cNvSpPr/>
            <p:nvPr/>
          </p:nvSpPr>
          <p:spPr>
            <a:xfrm>
              <a:off x="6917203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7" name="object 547"/>
            <p:cNvSpPr/>
            <p:nvPr/>
          </p:nvSpPr>
          <p:spPr>
            <a:xfrm>
              <a:off x="6917054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8" name="object 548"/>
            <p:cNvSpPr/>
            <p:nvPr/>
          </p:nvSpPr>
          <p:spPr>
            <a:xfrm>
              <a:off x="6886281" y="177861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49" name="object 549"/>
            <p:cNvSpPr/>
            <p:nvPr/>
          </p:nvSpPr>
          <p:spPr>
            <a:xfrm>
              <a:off x="6886133" y="1780940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0" name="object 550"/>
            <p:cNvSpPr/>
            <p:nvPr/>
          </p:nvSpPr>
          <p:spPr>
            <a:xfrm>
              <a:off x="6852352" y="1778617"/>
              <a:ext cx="34290" cy="20955"/>
            </a:xfrm>
            <a:custGeom>
              <a:avLst/>
              <a:gdLst/>
              <a:ahLst/>
              <a:cxnLst/>
              <a:rect l="l" t="t" r="r" b="b"/>
              <a:pathLst>
                <a:path w="34290" h="20955">
                  <a:moveTo>
                    <a:pt x="15705" y="0"/>
                  </a:moveTo>
                  <a:lnTo>
                    <a:pt x="34276" y="0"/>
                  </a:lnTo>
                  <a:lnTo>
                    <a:pt x="34276" y="18917"/>
                  </a:lnTo>
                  <a:lnTo>
                    <a:pt x="15705" y="18917"/>
                  </a:lnTo>
                  <a:lnTo>
                    <a:pt x="13916" y="18977"/>
                  </a:lnTo>
                  <a:lnTo>
                    <a:pt x="12142" y="19155"/>
                  </a:lnTo>
                  <a:lnTo>
                    <a:pt x="10388" y="19452"/>
                  </a:lnTo>
                  <a:lnTo>
                    <a:pt x="7820" y="20115"/>
                  </a:lnTo>
                  <a:lnTo>
                    <a:pt x="6566" y="20544"/>
                  </a:lnTo>
                  <a:lnTo>
                    <a:pt x="0" y="2803"/>
                  </a:lnTo>
                  <a:lnTo>
                    <a:pt x="12656" y="100"/>
                  </a:lnTo>
                  <a:lnTo>
                    <a:pt x="15705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1" name="object 551"/>
            <p:cNvSpPr/>
            <p:nvPr/>
          </p:nvSpPr>
          <p:spPr>
            <a:xfrm>
              <a:off x="6852991" y="1780940"/>
              <a:ext cx="34290" cy="16510"/>
            </a:xfrm>
            <a:custGeom>
              <a:avLst/>
              <a:gdLst/>
              <a:ahLst/>
              <a:cxnLst/>
              <a:rect l="l" t="t" r="r" b="b"/>
              <a:pathLst>
                <a:path w="34290" h="16510">
                  <a:moveTo>
                    <a:pt x="15067" y="0"/>
                  </a:moveTo>
                  <a:lnTo>
                    <a:pt x="33772" y="0"/>
                  </a:lnTo>
                  <a:lnTo>
                    <a:pt x="33772" y="14272"/>
                  </a:lnTo>
                  <a:lnTo>
                    <a:pt x="15067" y="14272"/>
                  </a:lnTo>
                  <a:lnTo>
                    <a:pt x="13123" y="14336"/>
                  </a:lnTo>
                  <a:lnTo>
                    <a:pt x="5010" y="16083"/>
                  </a:lnTo>
                  <a:lnTo>
                    <a:pt x="0" y="2720"/>
                  </a:lnTo>
                  <a:lnTo>
                    <a:pt x="12172" y="96"/>
                  </a:lnTo>
                  <a:lnTo>
                    <a:pt x="15067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2" name="object 552"/>
            <p:cNvSpPr/>
            <p:nvPr/>
          </p:nvSpPr>
          <p:spPr>
            <a:xfrm>
              <a:off x="6825598" y="1781269"/>
              <a:ext cx="33655" cy="33655"/>
            </a:xfrm>
            <a:custGeom>
              <a:avLst/>
              <a:gdLst/>
              <a:ahLst/>
              <a:cxnLst/>
              <a:rect l="l" t="t" r="r" b="b"/>
              <a:pathLst>
                <a:path w="33654" h="33655">
                  <a:moveTo>
                    <a:pt x="27168" y="0"/>
                  </a:moveTo>
                  <a:lnTo>
                    <a:pt x="33560" y="17805"/>
                  </a:lnTo>
                  <a:lnTo>
                    <a:pt x="32213" y="18331"/>
                  </a:lnTo>
                  <a:lnTo>
                    <a:pt x="30674" y="19042"/>
                  </a:lnTo>
                  <a:lnTo>
                    <a:pt x="17747" y="33480"/>
                  </a:lnTo>
                  <a:lnTo>
                    <a:pt x="0" y="26929"/>
                  </a:lnTo>
                  <a:lnTo>
                    <a:pt x="25612" y="591"/>
                  </a:lnTo>
                  <a:lnTo>
                    <a:pt x="27168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3" name="object 553"/>
            <p:cNvSpPr/>
            <p:nvPr/>
          </p:nvSpPr>
          <p:spPr>
            <a:xfrm>
              <a:off x="6827715" y="1783401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5" h="31114">
                  <a:moveTo>
                    <a:pt x="25987" y="0"/>
                  </a:moveTo>
                  <a:lnTo>
                    <a:pt x="30759" y="13450"/>
                  </a:lnTo>
                  <a:lnTo>
                    <a:pt x="29191" y="14059"/>
                  </a:lnTo>
                  <a:lnTo>
                    <a:pt x="27514" y="14833"/>
                  </a:lnTo>
                  <a:lnTo>
                    <a:pt x="13410" y="30654"/>
                  </a:lnTo>
                  <a:lnTo>
                    <a:pt x="0" y="25768"/>
                  </a:lnTo>
                  <a:lnTo>
                    <a:pt x="24410" y="594"/>
                  </a:lnTo>
                  <a:lnTo>
                    <a:pt x="25987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4" name="object 554"/>
            <p:cNvSpPr/>
            <p:nvPr/>
          </p:nvSpPr>
          <p:spPr>
            <a:xfrm>
              <a:off x="6822809" y="1807785"/>
              <a:ext cx="20955" cy="34925"/>
            </a:xfrm>
            <a:custGeom>
              <a:avLst/>
              <a:gdLst/>
              <a:ahLst/>
              <a:cxnLst/>
              <a:rect l="l" t="t" r="r" b="b"/>
              <a:pathLst>
                <a:path w="20954" h="34925">
                  <a:moveTo>
                    <a:pt x="2943" y="0"/>
                  </a:moveTo>
                  <a:lnTo>
                    <a:pt x="20626" y="6724"/>
                  </a:lnTo>
                  <a:lnTo>
                    <a:pt x="20162" y="8049"/>
                  </a:lnTo>
                  <a:lnTo>
                    <a:pt x="19771" y="9397"/>
                  </a:lnTo>
                  <a:lnTo>
                    <a:pt x="19452" y="10765"/>
                  </a:lnTo>
                  <a:lnTo>
                    <a:pt x="19155" y="12518"/>
                  </a:lnTo>
                  <a:lnTo>
                    <a:pt x="18977" y="14292"/>
                  </a:lnTo>
                  <a:lnTo>
                    <a:pt x="18918" y="16082"/>
                  </a:lnTo>
                  <a:lnTo>
                    <a:pt x="18918" y="34336"/>
                  </a:lnTo>
                  <a:lnTo>
                    <a:pt x="0" y="34336"/>
                  </a:lnTo>
                  <a:lnTo>
                    <a:pt x="0" y="16082"/>
                  </a:lnTo>
                  <a:lnTo>
                    <a:pt x="101" y="13033"/>
                  </a:lnTo>
                  <a:lnTo>
                    <a:pt x="407" y="9991"/>
                  </a:lnTo>
                  <a:lnTo>
                    <a:pt x="919" y="6973"/>
                  </a:lnTo>
                  <a:lnTo>
                    <a:pt x="1467" y="4613"/>
                  </a:lnTo>
                  <a:lnTo>
                    <a:pt x="2144" y="2286"/>
                  </a:lnTo>
                  <a:lnTo>
                    <a:pt x="2943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5" name="object 555"/>
            <p:cNvSpPr/>
            <p:nvPr/>
          </p:nvSpPr>
          <p:spPr>
            <a:xfrm>
              <a:off x="6825132" y="1808461"/>
              <a:ext cx="16510" cy="34290"/>
            </a:xfrm>
            <a:custGeom>
              <a:avLst/>
              <a:gdLst/>
              <a:ahLst/>
              <a:cxnLst/>
              <a:rect l="l" t="t" r="r" b="b"/>
              <a:pathLst>
                <a:path w="16509" h="34289">
                  <a:moveTo>
                    <a:pt x="2848" y="0"/>
                  </a:moveTo>
                  <a:lnTo>
                    <a:pt x="16169" y="5123"/>
                  </a:lnTo>
                  <a:lnTo>
                    <a:pt x="15648" y="6598"/>
                  </a:lnTo>
                  <a:lnTo>
                    <a:pt x="15209" y="8100"/>
                  </a:lnTo>
                  <a:lnTo>
                    <a:pt x="14854" y="9624"/>
                  </a:lnTo>
                  <a:lnTo>
                    <a:pt x="14530" y="11532"/>
                  </a:lnTo>
                  <a:lnTo>
                    <a:pt x="14337" y="13462"/>
                  </a:lnTo>
                  <a:lnTo>
                    <a:pt x="14272" y="15406"/>
                  </a:lnTo>
                  <a:lnTo>
                    <a:pt x="14272" y="33809"/>
                  </a:lnTo>
                  <a:lnTo>
                    <a:pt x="0" y="33809"/>
                  </a:lnTo>
                  <a:lnTo>
                    <a:pt x="0" y="15406"/>
                  </a:lnTo>
                  <a:lnTo>
                    <a:pt x="96" y="12512"/>
                  </a:lnTo>
                  <a:lnTo>
                    <a:pt x="386" y="9625"/>
                  </a:lnTo>
                  <a:lnTo>
                    <a:pt x="871" y="6763"/>
                  </a:lnTo>
                  <a:lnTo>
                    <a:pt x="1405" y="4473"/>
                  </a:lnTo>
                  <a:lnTo>
                    <a:pt x="2065" y="2217"/>
                  </a:lnTo>
                  <a:lnTo>
                    <a:pt x="2848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6" name="object 556"/>
            <p:cNvSpPr/>
            <p:nvPr/>
          </p:nvSpPr>
          <p:spPr>
            <a:xfrm>
              <a:off x="6822809" y="1841773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7" name="object 557"/>
            <p:cNvSpPr/>
            <p:nvPr/>
          </p:nvSpPr>
          <p:spPr>
            <a:xfrm>
              <a:off x="6825132" y="1841639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3"/>
                  </a:lnTo>
                  <a:lnTo>
                    <a:pt x="0" y="3155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8" name="object 558"/>
            <p:cNvSpPr/>
            <p:nvPr/>
          </p:nvSpPr>
          <p:spPr>
            <a:xfrm>
              <a:off x="6822809" y="187269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59" name="object 559"/>
            <p:cNvSpPr/>
            <p:nvPr/>
          </p:nvSpPr>
          <p:spPr>
            <a:xfrm>
              <a:off x="6825132" y="187256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0" name="object 560"/>
            <p:cNvSpPr/>
            <p:nvPr/>
          </p:nvSpPr>
          <p:spPr>
            <a:xfrm>
              <a:off x="6822809" y="1903616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1" name="object 561"/>
            <p:cNvSpPr/>
            <p:nvPr/>
          </p:nvSpPr>
          <p:spPr>
            <a:xfrm>
              <a:off x="6825132" y="1903483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2" name="object 562"/>
            <p:cNvSpPr/>
            <p:nvPr/>
          </p:nvSpPr>
          <p:spPr>
            <a:xfrm>
              <a:off x="6822809" y="1934538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3" name="object 563"/>
            <p:cNvSpPr/>
            <p:nvPr/>
          </p:nvSpPr>
          <p:spPr>
            <a:xfrm>
              <a:off x="6825132" y="1934404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4" name="object 564"/>
            <p:cNvSpPr/>
            <p:nvPr/>
          </p:nvSpPr>
          <p:spPr>
            <a:xfrm>
              <a:off x="6822809" y="196546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5" name="object 565"/>
            <p:cNvSpPr/>
            <p:nvPr/>
          </p:nvSpPr>
          <p:spPr>
            <a:xfrm>
              <a:off x="6825132" y="196532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6" name="object 566"/>
            <p:cNvSpPr/>
            <p:nvPr/>
          </p:nvSpPr>
          <p:spPr>
            <a:xfrm>
              <a:off x="6822809" y="199638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7" name="object 567"/>
            <p:cNvSpPr/>
            <p:nvPr/>
          </p:nvSpPr>
          <p:spPr>
            <a:xfrm>
              <a:off x="6825132" y="1996248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8" name="object 568"/>
            <p:cNvSpPr/>
            <p:nvPr/>
          </p:nvSpPr>
          <p:spPr>
            <a:xfrm>
              <a:off x="6822809" y="2027303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69" name="object 569"/>
            <p:cNvSpPr/>
            <p:nvPr/>
          </p:nvSpPr>
          <p:spPr>
            <a:xfrm>
              <a:off x="6825132" y="2027169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0" name="object 570"/>
            <p:cNvSpPr/>
            <p:nvPr/>
          </p:nvSpPr>
          <p:spPr>
            <a:xfrm>
              <a:off x="6822809" y="205822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1" name="object 571"/>
            <p:cNvSpPr/>
            <p:nvPr/>
          </p:nvSpPr>
          <p:spPr>
            <a:xfrm>
              <a:off x="6825132" y="205809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2" name="object 572"/>
            <p:cNvSpPr/>
            <p:nvPr/>
          </p:nvSpPr>
          <p:spPr>
            <a:xfrm>
              <a:off x="6822809" y="2089146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3" name="object 573"/>
            <p:cNvSpPr/>
            <p:nvPr/>
          </p:nvSpPr>
          <p:spPr>
            <a:xfrm>
              <a:off x="6825132" y="2089013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4" name="object 574"/>
            <p:cNvSpPr/>
            <p:nvPr/>
          </p:nvSpPr>
          <p:spPr>
            <a:xfrm>
              <a:off x="6822809" y="2120068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5" name="object 575"/>
            <p:cNvSpPr/>
            <p:nvPr/>
          </p:nvSpPr>
          <p:spPr>
            <a:xfrm>
              <a:off x="6825132" y="2119934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6" name="object 576"/>
            <p:cNvSpPr/>
            <p:nvPr/>
          </p:nvSpPr>
          <p:spPr>
            <a:xfrm>
              <a:off x="6822809" y="215099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7" name="object 577"/>
            <p:cNvSpPr/>
            <p:nvPr/>
          </p:nvSpPr>
          <p:spPr>
            <a:xfrm>
              <a:off x="6825132" y="215085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8" name="object 578"/>
            <p:cNvSpPr/>
            <p:nvPr/>
          </p:nvSpPr>
          <p:spPr>
            <a:xfrm>
              <a:off x="6822809" y="218191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79" name="object 579"/>
            <p:cNvSpPr/>
            <p:nvPr/>
          </p:nvSpPr>
          <p:spPr>
            <a:xfrm>
              <a:off x="6825132" y="2181778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0" name="object 580"/>
            <p:cNvSpPr/>
            <p:nvPr/>
          </p:nvSpPr>
          <p:spPr>
            <a:xfrm>
              <a:off x="6822809" y="2212833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1" name="object 581"/>
            <p:cNvSpPr/>
            <p:nvPr/>
          </p:nvSpPr>
          <p:spPr>
            <a:xfrm>
              <a:off x="6825132" y="2212699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2" name="object 582"/>
            <p:cNvSpPr/>
            <p:nvPr/>
          </p:nvSpPr>
          <p:spPr>
            <a:xfrm>
              <a:off x="6822809" y="224375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3" name="object 583"/>
            <p:cNvSpPr/>
            <p:nvPr/>
          </p:nvSpPr>
          <p:spPr>
            <a:xfrm>
              <a:off x="6825132" y="224362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4" name="object 584"/>
            <p:cNvSpPr/>
            <p:nvPr/>
          </p:nvSpPr>
          <p:spPr>
            <a:xfrm>
              <a:off x="6822809" y="2274676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5" name="object 585"/>
            <p:cNvSpPr/>
            <p:nvPr/>
          </p:nvSpPr>
          <p:spPr>
            <a:xfrm>
              <a:off x="6825132" y="2274543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6" name="object 586"/>
            <p:cNvSpPr/>
            <p:nvPr/>
          </p:nvSpPr>
          <p:spPr>
            <a:xfrm>
              <a:off x="6822809" y="2305598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7" name="object 587"/>
            <p:cNvSpPr/>
            <p:nvPr/>
          </p:nvSpPr>
          <p:spPr>
            <a:xfrm>
              <a:off x="6825132" y="2305464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8" name="object 588"/>
            <p:cNvSpPr/>
            <p:nvPr/>
          </p:nvSpPr>
          <p:spPr>
            <a:xfrm>
              <a:off x="6822809" y="2336520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89" name="object 589"/>
            <p:cNvSpPr/>
            <p:nvPr/>
          </p:nvSpPr>
          <p:spPr>
            <a:xfrm>
              <a:off x="6825132" y="233638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0" name="object 590"/>
            <p:cNvSpPr/>
            <p:nvPr/>
          </p:nvSpPr>
          <p:spPr>
            <a:xfrm>
              <a:off x="6822809" y="2367441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70"/>
                  </a:lnTo>
                  <a:lnTo>
                    <a:pt x="0" y="3127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1" name="object 591"/>
            <p:cNvSpPr/>
            <p:nvPr/>
          </p:nvSpPr>
          <p:spPr>
            <a:xfrm>
              <a:off x="6825132" y="2367308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2" name="object 592"/>
            <p:cNvSpPr/>
            <p:nvPr/>
          </p:nvSpPr>
          <p:spPr>
            <a:xfrm>
              <a:off x="6822809" y="2398363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3" name="object 593"/>
            <p:cNvSpPr/>
            <p:nvPr/>
          </p:nvSpPr>
          <p:spPr>
            <a:xfrm>
              <a:off x="6825132" y="2398229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4" name="object 594"/>
            <p:cNvSpPr/>
            <p:nvPr/>
          </p:nvSpPr>
          <p:spPr>
            <a:xfrm>
              <a:off x="6822809" y="242928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5" name="object 595"/>
            <p:cNvSpPr/>
            <p:nvPr/>
          </p:nvSpPr>
          <p:spPr>
            <a:xfrm>
              <a:off x="6825132" y="2429151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6" name="object 596"/>
            <p:cNvSpPr/>
            <p:nvPr/>
          </p:nvSpPr>
          <p:spPr>
            <a:xfrm>
              <a:off x="6813755" y="2460206"/>
              <a:ext cx="28575" cy="34925"/>
            </a:xfrm>
            <a:custGeom>
              <a:avLst/>
              <a:gdLst/>
              <a:ahLst/>
              <a:cxnLst/>
              <a:rect l="l" t="t" r="r" b="b"/>
              <a:pathLst>
                <a:path w="28575" h="34925">
                  <a:moveTo>
                    <a:pt x="9053" y="0"/>
                  </a:moveTo>
                  <a:lnTo>
                    <a:pt x="27972" y="0"/>
                  </a:lnTo>
                  <a:lnTo>
                    <a:pt x="27870" y="3738"/>
                  </a:lnTo>
                  <a:lnTo>
                    <a:pt x="12439" y="34841"/>
                  </a:lnTo>
                  <a:lnTo>
                    <a:pt x="0" y="20588"/>
                  </a:lnTo>
                  <a:lnTo>
                    <a:pt x="1317" y="19356"/>
                  </a:lnTo>
                  <a:lnTo>
                    <a:pt x="2477" y="18121"/>
                  </a:lnTo>
                  <a:lnTo>
                    <a:pt x="8994" y="2478"/>
                  </a:lnTo>
                  <a:lnTo>
                    <a:pt x="9053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7" name="object 597"/>
            <p:cNvSpPr/>
            <p:nvPr/>
          </p:nvSpPr>
          <p:spPr>
            <a:xfrm>
              <a:off x="6815193" y="2460073"/>
              <a:ext cx="24765" cy="33655"/>
            </a:xfrm>
            <a:custGeom>
              <a:avLst/>
              <a:gdLst/>
              <a:ahLst/>
              <a:cxnLst/>
              <a:rect l="l" t="t" r="r" b="b"/>
              <a:pathLst>
                <a:path w="24765" h="33655">
                  <a:moveTo>
                    <a:pt x="9939" y="0"/>
                  </a:moveTo>
                  <a:lnTo>
                    <a:pt x="24211" y="0"/>
                  </a:lnTo>
                  <a:lnTo>
                    <a:pt x="24114" y="3717"/>
                  </a:lnTo>
                  <a:lnTo>
                    <a:pt x="9340" y="33341"/>
                  </a:lnTo>
                  <a:lnTo>
                    <a:pt x="0" y="22550"/>
                  </a:lnTo>
                  <a:lnTo>
                    <a:pt x="1523" y="21133"/>
                  </a:lnTo>
                  <a:lnTo>
                    <a:pt x="2784" y="19789"/>
                  </a:lnTo>
                  <a:lnTo>
                    <a:pt x="9874" y="2766"/>
                  </a:lnTo>
                  <a:lnTo>
                    <a:pt x="9939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8" name="object 598"/>
            <p:cNvSpPr/>
            <p:nvPr/>
          </p:nvSpPr>
          <p:spPr>
            <a:xfrm>
              <a:off x="6791177" y="2480625"/>
              <a:ext cx="35560" cy="26034"/>
            </a:xfrm>
            <a:custGeom>
              <a:avLst/>
              <a:gdLst/>
              <a:ahLst/>
              <a:cxnLst/>
              <a:rect l="l" t="t" r="r" b="b"/>
              <a:pathLst>
                <a:path w="35559" h="26035">
                  <a:moveTo>
                    <a:pt x="22770" y="0"/>
                  </a:moveTo>
                  <a:lnTo>
                    <a:pt x="35347" y="14131"/>
                  </a:lnTo>
                  <a:lnTo>
                    <a:pt x="33810" y="15439"/>
                  </a:lnTo>
                  <a:lnTo>
                    <a:pt x="32217" y="16678"/>
                  </a:lnTo>
                  <a:lnTo>
                    <a:pt x="5220" y="25589"/>
                  </a:lnTo>
                  <a:lnTo>
                    <a:pt x="0" y="25589"/>
                  </a:lnTo>
                  <a:lnTo>
                    <a:pt x="0" y="6672"/>
                  </a:lnTo>
                  <a:lnTo>
                    <a:pt x="5220" y="6672"/>
                  </a:lnTo>
                  <a:lnTo>
                    <a:pt x="7016" y="6612"/>
                  </a:lnTo>
                  <a:lnTo>
                    <a:pt x="21872" y="763"/>
                  </a:lnTo>
                  <a:lnTo>
                    <a:pt x="2277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599" name="object 599"/>
            <p:cNvSpPr/>
            <p:nvPr/>
          </p:nvSpPr>
          <p:spPr>
            <a:xfrm>
              <a:off x="6791029" y="2482288"/>
              <a:ext cx="34290" cy="22225"/>
            </a:xfrm>
            <a:custGeom>
              <a:avLst/>
              <a:gdLst/>
              <a:ahLst/>
              <a:cxnLst/>
              <a:rect l="l" t="t" r="r" b="b"/>
              <a:pathLst>
                <a:path w="34290" h="22225">
                  <a:moveTo>
                    <a:pt x="24544" y="0"/>
                  </a:moveTo>
                  <a:lnTo>
                    <a:pt x="34071" y="10626"/>
                  </a:lnTo>
                  <a:lnTo>
                    <a:pt x="32576" y="11906"/>
                  </a:lnTo>
                  <a:lnTo>
                    <a:pt x="31024" y="13117"/>
                  </a:lnTo>
                  <a:lnTo>
                    <a:pt x="5369" y="21603"/>
                  </a:lnTo>
                  <a:lnTo>
                    <a:pt x="0" y="21603"/>
                  </a:lnTo>
                  <a:lnTo>
                    <a:pt x="0" y="7331"/>
                  </a:lnTo>
                  <a:lnTo>
                    <a:pt x="5369" y="7331"/>
                  </a:lnTo>
                  <a:lnTo>
                    <a:pt x="7319" y="7266"/>
                  </a:lnTo>
                  <a:lnTo>
                    <a:pt x="23542" y="857"/>
                  </a:lnTo>
                  <a:lnTo>
                    <a:pt x="24544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0" name="object 600"/>
            <p:cNvSpPr/>
            <p:nvPr/>
          </p:nvSpPr>
          <p:spPr>
            <a:xfrm>
              <a:off x="6760256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1" name="object 601"/>
            <p:cNvSpPr/>
            <p:nvPr/>
          </p:nvSpPr>
          <p:spPr>
            <a:xfrm>
              <a:off x="6760107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2" name="object 602"/>
            <p:cNvSpPr/>
            <p:nvPr/>
          </p:nvSpPr>
          <p:spPr>
            <a:xfrm>
              <a:off x="6729334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3" name="object 603"/>
            <p:cNvSpPr/>
            <p:nvPr/>
          </p:nvSpPr>
          <p:spPr>
            <a:xfrm>
              <a:off x="6729186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4" name="object 604"/>
            <p:cNvSpPr/>
            <p:nvPr/>
          </p:nvSpPr>
          <p:spPr>
            <a:xfrm>
              <a:off x="6698412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5" name="object 605"/>
            <p:cNvSpPr/>
            <p:nvPr/>
          </p:nvSpPr>
          <p:spPr>
            <a:xfrm>
              <a:off x="6698264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6" name="object 606"/>
            <p:cNvSpPr/>
            <p:nvPr/>
          </p:nvSpPr>
          <p:spPr>
            <a:xfrm>
              <a:off x="6667491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7" name="object 607"/>
            <p:cNvSpPr/>
            <p:nvPr/>
          </p:nvSpPr>
          <p:spPr>
            <a:xfrm>
              <a:off x="6667342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8" name="object 608"/>
            <p:cNvSpPr/>
            <p:nvPr/>
          </p:nvSpPr>
          <p:spPr>
            <a:xfrm>
              <a:off x="6636569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09" name="object 609"/>
            <p:cNvSpPr/>
            <p:nvPr/>
          </p:nvSpPr>
          <p:spPr>
            <a:xfrm>
              <a:off x="6636421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0" name="object 610"/>
            <p:cNvSpPr/>
            <p:nvPr/>
          </p:nvSpPr>
          <p:spPr>
            <a:xfrm>
              <a:off x="6605647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1" name="object 611"/>
            <p:cNvSpPr/>
            <p:nvPr/>
          </p:nvSpPr>
          <p:spPr>
            <a:xfrm>
              <a:off x="6605499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2" name="object 612"/>
            <p:cNvSpPr/>
            <p:nvPr/>
          </p:nvSpPr>
          <p:spPr>
            <a:xfrm>
              <a:off x="6574726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3" name="object 613"/>
            <p:cNvSpPr/>
            <p:nvPr/>
          </p:nvSpPr>
          <p:spPr>
            <a:xfrm>
              <a:off x="6574577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4" name="object 614"/>
            <p:cNvSpPr/>
            <p:nvPr/>
          </p:nvSpPr>
          <p:spPr>
            <a:xfrm>
              <a:off x="6543804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5" name="object 615"/>
            <p:cNvSpPr/>
            <p:nvPr/>
          </p:nvSpPr>
          <p:spPr>
            <a:xfrm>
              <a:off x="6543656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6" name="object 616"/>
            <p:cNvSpPr/>
            <p:nvPr/>
          </p:nvSpPr>
          <p:spPr>
            <a:xfrm>
              <a:off x="6512882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7" name="object 617"/>
            <p:cNvSpPr/>
            <p:nvPr/>
          </p:nvSpPr>
          <p:spPr>
            <a:xfrm>
              <a:off x="6512734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8" name="object 618"/>
            <p:cNvSpPr/>
            <p:nvPr/>
          </p:nvSpPr>
          <p:spPr>
            <a:xfrm>
              <a:off x="6481961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19" name="object 619"/>
            <p:cNvSpPr/>
            <p:nvPr/>
          </p:nvSpPr>
          <p:spPr>
            <a:xfrm>
              <a:off x="6481812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0" name="object 620"/>
            <p:cNvSpPr/>
            <p:nvPr/>
          </p:nvSpPr>
          <p:spPr>
            <a:xfrm>
              <a:off x="6451039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1" name="object 621"/>
            <p:cNvSpPr/>
            <p:nvPr/>
          </p:nvSpPr>
          <p:spPr>
            <a:xfrm>
              <a:off x="6450891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2" name="object 622"/>
            <p:cNvSpPr/>
            <p:nvPr/>
          </p:nvSpPr>
          <p:spPr>
            <a:xfrm>
              <a:off x="6420118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3" name="object 623"/>
            <p:cNvSpPr/>
            <p:nvPr/>
          </p:nvSpPr>
          <p:spPr>
            <a:xfrm>
              <a:off x="6419969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4" name="object 624"/>
            <p:cNvSpPr/>
            <p:nvPr/>
          </p:nvSpPr>
          <p:spPr>
            <a:xfrm>
              <a:off x="6389196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5" name="object 625"/>
            <p:cNvSpPr/>
            <p:nvPr/>
          </p:nvSpPr>
          <p:spPr>
            <a:xfrm>
              <a:off x="6389047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6" name="object 626"/>
            <p:cNvSpPr/>
            <p:nvPr/>
          </p:nvSpPr>
          <p:spPr>
            <a:xfrm>
              <a:off x="6358274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7" name="object 627"/>
            <p:cNvSpPr/>
            <p:nvPr/>
          </p:nvSpPr>
          <p:spPr>
            <a:xfrm>
              <a:off x="6358126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8" name="object 628"/>
            <p:cNvSpPr/>
            <p:nvPr/>
          </p:nvSpPr>
          <p:spPr>
            <a:xfrm>
              <a:off x="6327353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70" y="0"/>
                  </a:lnTo>
                  <a:lnTo>
                    <a:pt x="31270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29" name="object 629"/>
            <p:cNvSpPr/>
            <p:nvPr/>
          </p:nvSpPr>
          <p:spPr>
            <a:xfrm>
              <a:off x="6327204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0" name="object 630"/>
            <p:cNvSpPr/>
            <p:nvPr/>
          </p:nvSpPr>
          <p:spPr>
            <a:xfrm>
              <a:off x="6296432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1" name="object 631"/>
            <p:cNvSpPr/>
            <p:nvPr/>
          </p:nvSpPr>
          <p:spPr>
            <a:xfrm>
              <a:off x="6296282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2" name="object 632"/>
            <p:cNvSpPr/>
            <p:nvPr/>
          </p:nvSpPr>
          <p:spPr>
            <a:xfrm>
              <a:off x="6265510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3" name="object 633"/>
            <p:cNvSpPr/>
            <p:nvPr/>
          </p:nvSpPr>
          <p:spPr>
            <a:xfrm>
              <a:off x="6265361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4" name="object 634"/>
            <p:cNvSpPr/>
            <p:nvPr/>
          </p:nvSpPr>
          <p:spPr>
            <a:xfrm>
              <a:off x="6234588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70" y="0"/>
                  </a:lnTo>
                  <a:lnTo>
                    <a:pt x="31270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5" name="object 635"/>
            <p:cNvSpPr/>
            <p:nvPr/>
          </p:nvSpPr>
          <p:spPr>
            <a:xfrm>
              <a:off x="6234439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6" name="object 636"/>
            <p:cNvSpPr/>
            <p:nvPr/>
          </p:nvSpPr>
          <p:spPr>
            <a:xfrm>
              <a:off x="6203667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7" name="object 637"/>
            <p:cNvSpPr/>
            <p:nvPr/>
          </p:nvSpPr>
          <p:spPr>
            <a:xfrm>
              <a:off x="6203517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8" name="object 638"/>
            <p:cNvSpPr/>
            <p:nvPr/>
          </p:nvSpPr>
          <p:spPr>
            <a:xfrm>
              <a:off x="6172745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39" name="object 639"/>
            <p:cNvSpPr/>
            <p:nvPr/>
          </p:nvSpPr>
          <p:spPr>
            <a:xfrm>
              <a:off x="6172596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0" name="object 640"/>
            <p:cNvSpPr/>
            <p:nvPr/>
          </p:nvSpPr>
          <p:spPr>
            <a:xfrm>
              <a:off x="6141823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70" y="0"/>
                  </a:lnTo>
                  <a:lnTo>
                    <a:pt x="31270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1" name="object 641"/>
            <p:cNvSpPr/>
            <p:nvPr/>
          </p:nvSpPr>
          <p:spPr>
            <a:xfrm>
              <a:off x="6141674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2" name="object 642"/>
            <p:cNvSpPr/>
            <p:nvPr/>
          </p:nvSpPr>
          <p:spPr>
            <a:xfrm>
              <a:off x="6110902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3" name="object 643"/>
            <p:cNvSpPr/>
            <p:nvPr/>
          </p:nvSpPr>
          <p:spPr>
            <a:xfrm>
              <a:off x="6110752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4" name="object 644"/>
            <p:cNvSpPr/>
            <p:nvPr/>
          </p:nvSpPr>
          <p:spPr>
            <a:xfrm>
              <a:off x="6079980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5" name="object 645"/>
            <p:cNvSpPr/>
            <p:nvPr/>
          </p:nvSpPr>
          <p:spPr>
            <a:xfrm>
              <a:off x="6079831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6" name="object 646"/>
            <p:cNvSpPr/>
            <p:nvPr/>
          </p:nvSpPr>
          <p:spPr>
            <a:xfrm>
              <a:off x="6049058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70" y="0"/>
                  </a:lnTo>
                  <a:lnTo>
                    <a:pt x="31270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7" name="object 647"/>
            <p:cNvSpPr/>
            <p:nvPr/>
          </p:nvSpPr>
          <p:spPr>
            <a:xfrm>
              <a:off x="6048909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8" name="object 648"/>
            <p:cNvSpPr/>
            <p:nvPr/>
          </p:nvSpPr>
          <p:spPr>
            <a:xfrm>
              <a:off x="6018137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49" name="object 649"/>
            <p:cNvSpPr/>
            <p:nvPr/>
          </p:nvSpPr>
          <p:spPr>
            <a:xfrm>
              <a:off x="6017987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3" y="0"/>
                  </a:lnTo>
                  <a:lnTo>
                    <a:pt x="31553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0" name="object 650"/>
            <p:cNvSpPr/>
            <p:nvPr/>
          </p:nvSpPr>
          <p:spPr>
            <a:xfrm>
              <a:off x="5987215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69" y="0"/>
                  </a:lnTo>
                  <a:lnTo>
                    <a:pt x="31269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1" name="object 651"/>
            <p:cNvSpPr/>
            <p:nvPr/>
          </p:nvSpPr>
          <p:spPr>
            <a:xfrm>
              <a:off x="5987066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2" name="object 652"/>
            <p:cNvSpPr/>
            <p:nvPr/>
          </p:nvSpPr>
          <p:spPr>
            <a:xfrm>
              <a:off x="5956293" y="2487297"/>
              <a:ext cx="31750" cy="19050"/>
            </a:xfrm>
            <a:custGeom>
              <a:avLst/>
              <a:gdLst/>
              <a:ahLst/>
              <a:cxnLst/>
              <a:rect l="l" t="t" r="r" b="b"/>
              <a:pathLst>
                <a:path w="31750" h="19050">
                  <a:moveTo>
                    <a:pt x="0" y="0"/>
                  </a:moveTo>
                  <a:lnTo>
                    <a:pt x="31270" y="0"/>
                  </a:lnTo>
                  <a:lnTo>
                    <a:pt x="31270" y="18917"/>
                  </a:lnTo>
                  <a:lnTo>
                    <a:pt x="0" y="1891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3" name="object 653"/>
            <p:cNvSpPr/>
            <p:nvPr/>
          </p:nvSpPr>
          <p:spPr>
            <a:xfrm>
              <a:off x="5956144" y="2489619"/>
              <a:ext cx="31750" cy="14604"/>
            </a:xfrm>
            <a:custGeom>
              <a:avLst/>
              <a:gdLst/>
              <a:ahLst/>
              <a:cxnLst/>
              <a:rect l="l" t="t" r="r" b="b"/>
              <a:pathLst>
                <a:path w="31750" h="14605">
                  <a:moveTo>
                    <a:pt x="0" y="0"/>
                  </a:moveTo>
                  <a:lnTo>
                    <a:pt x="31552" y="0"/>
                  </a:lnTo>
                  <a:lnTo>
                    <a:pt x="31552" y="14272"/>
                  </a:lnTo>
                  <a:lnTo>
                    <a:pt x="0" y="1427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4" name="object 654"/>
            <p:cNvSpPr/>
            <p:nvPr/>
          </p:nvSpPr>
          <p:spPr>
            <a:xfrm>
              <a:off x="5921293" y="2480634"/>
              <a:ext cx="35560" cy="26034"/>
            </a:xfrm>
            <a:custGeom>
              <a:avLst/>
              <a:gdLst/>
              <a:ahLst/>
              <a:cxnLst/>
              <a:rect l="l" t="t" r="r" b="b"/>
              <a:pathLst>
                <a:path w="35560" h="26035">
                  <a:moveTo>
                    <a:pt x="12568" y="0"/>
                  </a:moveTo>
                  <a:lnTo>
                    <a:pt x="35348" y="6662"/>
                  </a:lnTo>
                  <a:lnTo>
                    <a:pt x="35348" y="25580"/>
                  </a:lnTo>
                  <a:lnTo>
                    <a:pt x="30100" y="25580"/>
                  </a:lnTo>
                  <a:lnTo>
                    <a:pt x="27046" y="25478"/>
                  </a:lnTo>
                  <a:lnTo>
                    <a:pt x="0" y="14138"/>
                  </a:lnTo>
                  <a:lnTo>
                    <a:pt x="12568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5" name="object 655"/>
            <p:cNvSpPr/>
            <p:nvPr/>
          </p:nvSpPr>
          <p:spPr>
            <a:xfrm>
              <a:off x="5922703" y="2482291"/>
              <a:ext cx="34290" cy="22225"/>
            </a:xfrm>
            <a:custGeom>
              <a:avLst/>
              <a:gdLst/>
              <a:ahLst/>
              <a:cxnLst/>
              <a:rect l="l" t="t" r="r" b="b"/>
              <a:pathLst>
                <a:path w="34289" h="22225">
                  <a:moveTo>
                    <a:pt x="9526" y="0"/>
                  </a:moveTo>
                  <a:lnTo>
                    <a:pt x="34072" y="7328"/>
                  </a:lnTo>
                  <a:lnTo>
                    <a:pt x="34072" y="21600"/>
                  </a:lnTo>
                  <a:lnTo>
                    <a:pt x="28691" y="21600"/>
                  </a:lnTo>
                  <a:lnTo>
                    <a:pt x="25791" y="21504"/>
                  </a:lnTo>
                  <a:lnTo>
                    <a:pt x="0" y="10627"/>
                  </a:lnTo>
                  <a:lnTo>
                    <a:pt x="9526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6" name="object 656"/>
            <p:cNvSpPr/>
            <p:nvPr/>
          </p:nvSpPr>
          <p:spPr>
            <a:xfrm>
              <a:off x="5906071" y="2460227"/>
              <a:ext cx="28575" cy="34925"/>
            </a:xfrm>
            <a:custGeom>
              <a:avLst/>
              <a:gdLst/>
              <a:ahLst/>
              <a:cxnLst/>
              <a:rect l="l" t="t" r="r" b="b"/>
              <a:pathLst>
                <a:path w="28575" h="34925">
                  <a:moveTo>
                    <a:pt x="0" y="0"/>
                  </a:moveTo>
                  <a:lnTo>
                    <a:pt x="18918" y="0"/>
                  </a:lnTo>
                  <a:lnTo>
                    <a:pt x="18977" y="2452"/>
                  </a:lnTo>
                  <a:lnTo>
                    <a:pt x="19156" y="4231"/>
                  </a:lnTo>
                  <a:lnTo>
                    <a:pt x="27983" y="20577"/>
                  </a:lnTo>
                  <a:lnTo>
                    <a:pt x="15551" y="34836"/>
                  </a:lnTo>
                  <a:lnTo>
                    <a:pt x="101" y="371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7" name="object 657"/>
            <p:cNvSpPr/>
            <p:nvPr/>
          </p:nvSpPr>
          <p:spPr>
            <a:xfrm>
              <a:off x="5908394" y="2460077"/>
              <a:ext cx="24765" cy="33655"/>
            </a:xfrm>
            <a:custGeom>
              <a:avLst/>
              <a:gdLst/>
              <a:ahLst/>
              <a:cxnLst/>
              <a:rect l="l" t="t" r="r" b="b"/>
              <a:pathLst>
                <a:path w="24764" h="33655">
                  <a:moveTo>
                    <a:pt x="0" y="0"/>
                  </a:moveTo>
                  <a:lnTo>
                    <a:pt x="14272" y="0"/>
                  </a:lnTo>
                  <a:lnTo>
                    <a:pt x="14337" y="2756"/>
                  </a:lnTo>
                  <a:lnTo>
                    <a:pt x="14531" y="4692"/>
                  </a:lnTo>
                  <a:lnTo>
                    <a:pt x="24215" y="22548"/>
                  </a:lnTo>
                  <a:lnTo>
                    <a:pt x="14876" y="33341"/>
                  </a:lnTo>
                  <a:lnTo>
                    <a:pt x="96" y="3705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8" name="object 658"/>
            <p:cNvSpPr/>
            <p:nvPr/>
          </p:nvSpPr>
          <p:spPr>
            <a:xfrm>
              <a:off x="5906071" y="2429305"/>
              <a:ext cx="19050" cy="31750"/>
            </a:xfrm>
            <a:custGeom>
              <a:avLst/>
              <a:gdLst/>
              <a:ahLst/>
              <a:cxnLst/>
              <a:rect l="l" t="t" r="r" b="b"/>
              <a:pathLst>
                <a:path w="19050" h="31750">
                  <a:moveTo>
                    <a:pt x="0" y="0"/>
                  </a:moveTo>
                  <a:lnTo>
                    <a:pt x="18918" y="0"/>
                  </a:lnTo>
                  <a:lnTo>
                    <a:pt x="18918" y="31269"/>
                  </a:lnTo>
                  <a:lnTo>
                    <a:pt x="0" y="3126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CBAC45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659" name="object 659"/>
            <p:cNvSpPr/>
            <p:nvPr/>
          </p:nvSpPr>
          <p:spPr>
            <a:xfrm>
              <a:off x="5908394" y="2429156"/>
              <a:ext cx="14604" cy="31750"/>
            </a:xfrm>
            <a:custGeom>
              <a:avLst/>
              <a:gdLst/>
              <a:ahLst/>
              <a:cxnLst/>
              <a:rect l="l" t="t" r="r" b="b"/>
              <a:pathLst>
                <a:path w="14604" h="31750">
                  <a:moveTo>
                    <a:pt x="0" y="0"/>
                  </a:moveTo>
                  <a:lnTo>
                    <a:pt x="14272" y="0"/>
                  </a:lnTo>
                  <a:lnTo>
                    <a:pt x="14272" y="31552"/>
                  </a:lnTo>
                  <a:lnTo>
                    <a:pt x="0" y="3155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4E29F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660" name="object 660"/>
            <p:cNvPicPr/>
            <p:nvPr/>
          </p:nvPicPr>
          <p:blipFill>
            <a:blip r:embed="rId24" cstate="print"/>
            <a:stretch>
              <a:fillRect/>
            </a:stretch>
          </p:blipFill>
          <p:spPr>
            <a:xfrm>
              <a:off x="5788151" y="2019300"/>
              <a:ext cx="259079" cy="449579"/>
            </a:xfrm>
            <a:prstGeom prst="rect">
              <a:avLst/>
            </a:prstGeom>
          </p:spPr>
        </p:pic>
        <p:pic>
          <p:nvPicPr>
            <p:cNvPr id="661" name="object 661"/>
            <p:cNvPicPr/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7290585" y="1528788"/>
              <a:ext cx="389267" cy="539218"/>
            </a:xfrm>
            <a:prstGeom prst="rect">
              <a:avLst/>
            </a:prstGeom>
          </p:spPr>
        </p:pic>
      </p:grpSp>
      <p:sp>
        <p:nvSpPr>
          <p:cNvPr id="662" name="object 662"/>
          <p:cNvSpPr txBox="1"/>
          <p:nvPr/>
        </p:nvSpPr>
        <p:spPr>
          <a:xfrm>
            <a:off x="5665944" y="3016347"/>
            <a:ext cx="1452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0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Acellular</a:t>
            </a:r>
            <a:r>
              <a:rPr dirty="0" sz="700" b="1">
                <a:latin typeface="Arial"/>
                <a:cs typeface="Arial"/>
              </a:rPr>
              <a:t> </a:t>
            </a:r>
            <a:r>
              <a:rPr dirty="0" sz="700" spc="-20" b="1">
                <a:latin typeface="Arial"/>
                <a:cs typeface="Arial"/>
              </a:rPr>
              <a:t>Based</a:t>
            </a:r>
            <a:r>
              <a:rPr dirty="0" sz="700" spc="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Perfusion</a:t>
            </a:r>
            <a:r>
              <a:rPr dirty="0" sz="700" spc="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Solution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8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63" name="object 663"/>
          <p:cNvGrpSpPr/>
          <p:nvPr/>
        </p:nvGrpSpPr>
        <p:grpSpPr>
          <a:xfrm>
            <a:off x="3307170" y="4098335"/>
            <a:ext cx="509270" cy="568960"/>
            <a:chOff x="3307170" y="4098335"/>
            <a:chExt cx="509270" cy="568960"/>
          </a:xfrm>
        </p:grpSpPr>
        <p:pic>
          <p:nvPicPr>
            <p:cNvPr id="664" name="object 664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3307170" y="4098335"/>
              <a:ext cx="509015" cy="440435"/>
            </a:xfrm>
            <a:prstGeom prst="rect">
              <a:avLst/>
            </a:prstGeom>
          </p:spPr>
        </p:pic>
        <p:sp>
          <p:nvSpPr>
            <p:cNvPr id="665" name="object 665"/>
            <p:cNvSpPr/>
            <p:nvPr/>
          </p:nvSpPr>
          <p:spPr>
            <a:xfrm>
              <a:off x="3643349" y="4444507"/>
              <a:ext cx="0" cy="160020"/>
            </a:xfrm>
            <a:custGeom>
              <a:avLst/>
              <a:gdLst/>
              <a:ahLst/>
              <a:cxnLst/>
              <a:rect l="l" t="t" r="r" b="b"/>
              <a:pathLst>
                <a:path w="0" h="160020">
                  <a:moveTo>
                    <a:pt x="0" y="0"/>
                  </a:moveTo>
                  <a:lnTo>
                    <a:pt x="0" y="159830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66" name="object 666"/>
            <p:cNvSpPr/>
            <p:nvPr/>
          </p:nvSpPr>
          <p:spPr>
            <a:xfrm>
              <a:off x="3604072" y="4588628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667" name="object 667"/>
          <p:cNvSpPr txBox="1"/>
          <p:nvPr/>
        </p:nvSpPr>
        <p:spPr>
          <a:xfrm>
            <a:off x="3362128" y="4695140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68" name="object 668"/>
          <p:cNvGrpSpPr/>
          <p:nvPr/>
        </p:nvGrpSpPr>
        <p:grpSpPr>
          <a:xfrm>
            <a:off x="3604074" y="4955201"/>
            <a:ext cx="78740" cy="196850"/>
            <a:chOff x="3604074" y="4955201"/>
            <a:chExt cx="78740" cy="196850"/>
          </a:xfrm>
        </p:grpSpPr>
        <p:sp>
          <p:nvSpPr>
            <p:cNvPr id="669" name="object 669"/>
            <p:cNvSpPr/>
            <p:nvPr/>
          </p:nvSpPr>
          <p:spPr>
            <a:xfrm>
              <a:off x="3643352" y="4955201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70" name="object 670"/>
            <p:cNvSpPr/>
            <p:nvPr/>
          </p:nvSpPr>
          <p:spPr>
            <a:xfrm>
              <a:off x="3604074" y="5073449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671" name="object 671"/>
          <p:cNvSpPr txBox="1"/>
          <p:nvPr/>
        </p:nvSpPr>
        <p:spPr>
          <a:xfrm>
            <a:off x="3385835" y="5154572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5</a:t>
            </a:r>
            <a:endParaRPr sz="700">
              <a:latin typeface="Arial"/>
              <a:cs typeface="Arial"/>
            </a:endParaRPr>
          </a:p>
        </p:txBody>
      </p:sp>
      <p:sp>
        <p:nvSpPr>
          <p:cNvPr id="672" name="object 672"/>
          <p:cNvSpPr txBox="1"/>
          <p:nvPr/>
        </p:nvSpPr>
        <p:spPr>
          <a:xfrm>
            <a:off x="3321026" y="3668914"/>
            <a:ext cx="721360" cy="449580"/>
          </a:xfrm>
          <a:prstGeom prst="rect">
            <a:avLst/>
          </a:prstGeom>
        </p:spPr>
        <p:txBody>
          <a:bodyPr wrap="square" lIns="0" tIns="19685" rIns="0" bIns="0" rtlCol="0" vert="horz">
            <a:spAutoFit/>
          </a:bodyPr>
          <a:lstStyle/>
          <a:p>
            <a:pPr algn="ctr" marL="12065" marR="5080" indent="-635">
              <a:lnSpc>
                <a:spcPts val="830"/>
              </a:lnSpc>
              <a:spcBef>
                <a:spcPts val="155"/>
              </a:spcBef>
            </a:pPr>
            <a:r>
              <a:rPr dirty="0" sz="700" b="1">
                <a:latin typeface="Arial"/>
                <a:cs typeface="Arial"/>
              </a:rPr>
              <a:t>4 </a:t>
            </a:r>
            <a:r>
              <a:rPr dirty="0" sz="700" spc="-10" b="1">
                <a:latin typeface="Arial"/>
                <a:cs typeface="Arial"/>
              </a:rPr>
              <a:t>Hours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0" b="1">
                <a:latin typeface="Arial"/>
                <a:cs typeface="Arial"/>
              </a:rPr>
              <a:t>Reperfusion</a:t>
            </a:r>
            <a:r>
              <a:rPr dirty="0" sz="700" spc="40" b="1">
                <a:latin typeface="Arial"/>
                <a:cs typeface="Arial"/>
              </a:rPr>
              <a:t> </a:t>
            </a:r>
            <a:r>
              <a:rPr dirty="0" sz="700" spc="-25" b="1">
                <a:latin typeface="Arial"/>
                <a:cs typeface="Arial"/>
              </a:rPr>
              <a:t>with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40" b="1">
                <a:latin typeface="Arial"/>
                <a:cs typeface="Arial"/>
              </a:rPr>
              <a:t>RBC</a:t>
            </a:r>
            <a:r>
              <a:rPr dirty="0" sz="700" spc="-20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solution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73" name="object 673"/>
          <p:cNvGrpSpPr/>
          <p:nvPr/>
        </p:nvGrpSpPr>
        <p:grpSpPr>
          <a:xfrm>
            <a:off x="2721019" y="3370479"/>
            <a:ext cx="78740" cy="305435"/>
            <a:chOff x="2721019" y="3370479"/>
            <a:chExt cx="78740" cy="305435"/>
          </a:xfrm>
        </p:grpSpPr>
        <p:sp>
          <p:nvSpPr>
            <p:cNvPr id="674" name="object 674"/>
            <p:cNvSpPr/>
            <p:nvPr/>
          </p:nvSpPr>
          <p:spPr>
            <a:xfrm>
              <a:off x="2760296" y="3370479"/>
              <a:ext cx="0" cy="242570"/>
            </a:xfrm>
            <a:custGeom>
              <a:avLst/>
              <a:gdLst/>
              <a:ahLst/>
              <a:cxnLst/>
              <a:rect l="l" t="t" r="r" b="b"/>
              <a:pathLst>
                <a:path w="0" h="242570">
                  <a:moveTo>
                    <a:pt x="0" y="0"/>
                  </a:moveTo>
                  <a:lnTo>
                    <a:pt x="0" y="242545"/>
                  </a:lnTo>
                </a:path>
              </a:pathLst>
            </a:custGeom>
            <a:ln w="22444">
              <a:solidFill>
                <a:srgbClr val="9D343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75" name="object 675"/>
            <p:cNvSpPr/>
            <p:nvPr/>
          </p:nvSpPr>
          <p:spPr>
            <a:xfrm>
              <a:off x="2721019" y="3597325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D343C"/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676" name="object 676"/>
          <p:cNvGrpSpPr/>
          <p:nvPr/>
        </p:nvGrpSpPr>
        <p:grpSpPr>
          <a:xfrm>
            <a:off x="5286401" y="3872488"/>
            <a:ext cx="509270" cy="777240"/>
            <a:chOff x="5286401" y="3872488"/>
            <a:chExt cx="509270" cy="777240"/>
          </a:xfrm>
        </p:grpSpPr>
        <p:pic>
          <p:nvPicPr>
            <p:cNvPr id="677" name="object 677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5286401" y="3872488"/>
              <a:ext cx="509015" cy="440435"/>
            </a:xfrm>
            <a:prstGeom prst="rect">
              <a:avLst/>
            </a:prstGeom>
          </p:spPr>
        </p:pic>
        <p:sp>
          <p:nvSpPr>
            <p:cNvPr id="678" name="object 678"/>
            <p:cNvSpPr/>
            <p:nvPr/>
          </p:nvSpPr>
          <p:spPr>
            <a:xfrm>
              <a:off x="5518795" y="4244876"/>
              <a:ext cx="0" cy="341630"/>
            </a:xfrm>
            <a:custGeom>
              <a:avLst/>
              <a:gdLst/>
              <a:ahLst/>
              <a:cxnLst/>
              <a:rect l="l" t="t" r="r" b="b"/>
              <a:pathLst>
                <a:path w="0" h="341629">
                  <a:moveTo>
                    <a:pt x="0" y="0"/>
                  </a:moveTo>
                  <a:lnTo>
                    <a:pt x="0" y="341557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79" name="object 679"/>
            <p:cNvSpPr/>
            <p:nvPr/>
          </p:nvSpPr>
          <p:spPr>
            <a:xfrm>
              <a:off x="5479518" y="4570780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680" name="object 680"/>
          <p:cNvGrpSpPr/>
          <p:nvPr/>
        </p:nvGrpSpPr>
        <p:grpSpPr>
          <a:xfrm>
            <a:off x="6033644" y="3872489"/>
            <a:ext cx="509270" cy="777240"/>
            <a:chOff x="6033644" y="3872489"/>
            <a:chExt cx="509270" cy="777240"/>
          </a:xfrm>
        </p:grpSpPr>
        <p:sp>
          <p:nvSpPr>
            <p:cNvPr id="681" name="object 681"/>
            <p:cNvSpPr/>
            <p:nvPr/>
          </p:nvSpPr>
          <p:spPr>
            <a:xfrm>
              <a:off x="6383877" y="4244876"/>
              <a:ext cx="0" cy="341630"/>
            </a:xfrm>
            <a:custGeom>
              <a:avLst/>
              <a:gdLst/>
              <a:ahLst/>
              <a:cxnLst/>
              <a:rect l="l" t="t" r="r" b="b"/>
              <a:pathLst>
                <a:path w="0" h="341629">
                  <a:moveTo>
                    <a:pt x="0" y="0"/>
                  </a:moveTo>
                  <a:lnTo>
                    <a:pt x="0" y="341557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82" name="object 682"/>
            <p:cNvSpPr/>
            <p:nvPr/>
          </p:nvSpPr>
          <p:spPr>
            <a:xfrm>
              <a:off x="6344600" y="4570780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683" name="object 683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6033644" y="3872489"/>
              <a:ext cx="509015" cy="440435"/>
            </a:xfrm>
            <a:prstGeom prst="rect">
              <a:avLst/>
            </a:prstGeom>
          </p:spPr>
        </p:pic>
      </p:grpSp>
      <p:sp>
        <p:nvSpPr>
          <p:cNvPr id="684" name="object 684"/>
          <p:cNvSpPr txBox="1"/>
          <p:nvPr/>
        </p:nvSpPr>
        <p:spPr>
          <a:xfrm>
            <a:off x="5335799" y="3664979"/>
            <a:ext cx="396240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0"/>
              </a:lnSpc>
              <a:spcBef>
                <a:spcPts val="114"/>
              </a:spcBef>
            </a:pPr>
            <a:r>
              <a:rPr dirty="0" sz="700" spc="-10" b="1">
                <a:latin typeface="Arial"/>
                <a:cs typeface="Arial"/>
              </a:rPr>
              <a:t>Pre-</a:t>
            </a:r>
            <a:r>
              <a:rPr dirty="0" sz="700" spc="-25" b="1">
                <a:latin typeface="Arial"/>
                <a:cs typeface="Arial"/>
              </a:rPr>
              <a:t>SMP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sp>
        <p:nvSpPr>
          <p:cNvPr id="685" name="object 685"/>
          <p:cNvSpPr txBox="1"/>
          <p:nvPr/>
        </p:nvSpPr>
        <p:spPr>
          <a:xfrm>
            <a:off x="6101443" y="3664977"/>
            <a:ext cx="565150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0"/>
              </a:lnSpc>
              <a:spcBef>
                <a:spcPts val="114"/>
              </a:spcBef>
            </a:pPr>
            <a:r>
              <a:rPr dirty="0" sz="700" b="1">
                <a:latin typeface="Arial"/>
                <a:cs typeface="Arial"/>
              </a:rPr>
              <a:t>6 </a:t>
            </a:r>
            <a:r>
              <a:rPr dirty="0" sz="700" spc="-20" b="1">
                <a:latin typeface="Arial"/>
                <a:cs typeface="Arial"/>
              </a:rPr>
              <a:t>Hours</a:t>
            </a:r>
            <a:r>
              <a:rPr dirty="0" sz="700" b="1">
                <a:latin typeface="Arial"/>
                <a:cs typeface="Arial"/>
              </a:rPr>
              <a:t> </a:t>
            </a:r>
            <a:r>
              <a:rPr dirty="0" sz="700" spc="-25" b="1">
                <a:latin typeface="Arial"/>
                <a:cs typeface="Arial"/>
              </a:rPr>
              <a:t>SMP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sp>
        <p:nvSpPr>
          <p:cNvPr id="686" name="object 686"/>
          <p:cNvSpPr txBox="1"/>
          <p:nvPr/>
        </p:nvSpPr>
        <p:spPr>
          <a:xfrm>
            <a:off x="5237575" y="4677293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87" name="object 687"/>
          <p:cNvGrpSpPr/>
          <p:nvPr/>
        </p:nvGrpSpPr>
        <p:grpSpPr>
          <a:xfrm>
            <a:off x="5479522" y="4937356"/>
            <a:ext cx="78740" cy="196850"/>
            <a:chOff x="5479522" y="4937356"/>
            <a:chExt cx="78740" cy="196850"/>
          </a:xfrm>
        </p:grpSpPr>
        <p:sp>
          <p:nvSpPr>
            <p:cNvPr id="688" name="object 688"/>
            <p:cNvSpPr/>
            <p:nvPr/>
          </p:nvSpPr>
          <p:spPr>
            <a:xfrm>
              <a:off x="5518799" y="4937356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89" name="object 689"/>
            <p:cNvSpPr/>
            <p:nvPr/>
          </p:nvSpPr>
          <p:spPr>
            <a:xfrm>
              <a:off x="5479522" y="5055604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690" name="object 690"/>
          <p:cNvSpPr txBox="1"/>
          <p:nvPr/>
        </p:nvSpPr>
        <p:spPr>
          <a:xfrm>
            <a:off x="5261282" y="5136727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5</a:t>
            </a:r>
            <a:endParaRPr sz="700">
              <a:latin typeface="Arial"/>
              <a:cs typeface="Arial"/>
            </a:endParaRPr>
          </a:p>
        </p:txBody>
      </p:sp>
      <p:sp>
        <p:nvSpPr>
          <p:cNvPr id="691" name="object 691"/>
          <p:cNvSpPr txBox="1"/>
          <p:nvPr/>
        </p:nvSpPr>
        <p:spPr>
          <a:xfrm>
            <a:off x="6117261" y="5136727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6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92" name="object 692"/>
          <p:cNvGrpSpPr/>
          <p:nvPr/>
        </p:nvGrpSpPr>
        <p:grpSpPr>
          <a:xfrm>
            <a:off x="6344600" y="4937354"/>
            <a:ext cx="78740" cy="196850"/>
            <a:chOff x="6344600" y="4937354"/>
            <a:chExt cx="78740" cy="196850"/>
          </a:xfrm>
        </p:grpSpPr>
        <p:sp>
          <p:nvSpPr>
            <p:cNvPr id="693" name="object 693"/>
            <p:cNvSpPr/>
            <p:nvPr/>
          </p:nvSpPr>
          <p:spPr>
            <a:xfrm>
              <a:off x="6383877" y="4937354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94" name="object 694"/>
            <p:cNvSpPr/>
            <p:nvPr/>
          </p:nvSpPr>
          <p:spPr>
            <a:xfrm>
              <a:off x="6344600" y="5055602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695" name="object 695"/>
          <p:cNvSpPr txBox="1"/>
          <p:nvPr/>
        </p:nvSpPr>
        <p:spPr>
          <a:xfrm>
            <a:off x="6102661" y="4677293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696" name="object 696"/>
          <p:cNvGrpSpPr/>
          <p:nvPr/>
        </p:nvGrpSpPr>
        <p:grpSpPr>
          <a:xfrm>
            <a:off x="6930888" y="4098339"/>
            <a:ext cx="509270" cy="568960"/>
            <a:chOff x="6930888" y="4098339"/>
            <a:chExt cx="509270" cy="568960"/>
          </a:xfrm>
        </p:grpSpPr>
        <p:pic>
          <p:nvPicPr>
            <p:cNvPr id="697" name="object 697"/>
            <p:cNvPicPr/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6930888" y="4098339"/>
              <a:ext cx="509015" cy="440435"/>
            </a:xfrm>
            <a:prstGeom prst="rect">
              <a:avLst/>
            </a:prstGeom>
          </p:spPr>
        </p:pic>
        <p:sp>
          <p:nvSpPr>
            <p:cNvPr id="698" name="object 698"/>
            <p:cNvSpPr/>
            <p:nvPr/>
          </p:nvSpPr>
          <p:spPr>
            <a:xfrm>
              <a:off x="7267067" y="4444511"/>
              <a:ext cx="0" cy="160020"/>
            </a:xfrm>
            <a:custGeom>
              <a:avLst/>
              <a:gdLst/>
              <a:ahLst/>
              <a:cxnLst/>
              <a:rect l="l" t="t" r="r" b="b"/>
              <a:pathLst>
                <a:path w="0" h="160020">
                  <a:moveTo>
                    <a:pt x="0" y="0"/>
                  </a:moveTo>
                  <a:lnTo>
                    <a:pt x="0" y="159830"/>
                  </a:lnTo>
                </a:path>
              </a:pathLst>
            </a:custGeom>
            <a:ln w="22444">
              <a:solidFill>
                <a:srgbClr val="825CA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699" name="object 699"/>
            <p:cNvSpPr/>
            <p:nvPr/>
          </p:nvSpPr>
          <p:spPr>
            <a:xfrm>
              <a:off x="7227790" y="4588632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40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25CA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700" name="object 700"/>
          <p:cNvSpPr txBox="1"/>
          <p:nvPr/>
        </p:nvSpPr>
        <p:spPr>
          <a:xfrm>
            <a:off x="6985845" y="4695145"/>
            <a:ext cx="563245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5" b="1">
                <a:latin typeface="Arial"/>
                <a:cs typeface="Arial"/>
              </a:rPr>
              <a:t>Bulk</a:t>
            </a:r>
            <a:r>
              <a:rPr dirty="0" sz="700" spc="-1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RNAseq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701" name="object 701"/>
          <p:cNvGrpSpPr/>
          <p:nvPr/>
        </p:nvGrpSpPr>
        <p:grpSpPr>
          <a:xfrm>
            <a:off x="7227792" y="4955206"/>
            <a:ext cx="78740" cy="196850"/>
            <a:chOff x="7227792" y="4955206"/>
            <a:chExt cx="78740" cy="196850"/>
          </a:xfrm>
        </p:grpSpPr>
        <p:sp>
          <p:nvSpPr>
            <p:cNvPr id="702" name="object 702"/>
            <p:cNvSpPr/>
            <p:nvPr/>
          </p:nvSpPr>
          <p:spPr>
            <a:xfrm>
              <a:off x="7267070" y="4955206"/>
              <a:ext cx="0" cy="133985"/>
            </a:xfrm>
            <a:custGeom>
              <a:avLst/>
              <a:gdLst/>
              <a:ahLst/>
              <a:cxnLst/>
              <a:rect l="l" t="t" r="r" b="b"/>
              <a:pathLst>
                <a:path w="0" h="133985">
                  <a:moveTo>
                    <a:pt x="0" y="0"/>
                  </a:moveTo>
                  <a:lnTo>
                    <a:pt x="0" y="133956"/>
                  </a:lnTo>
                </a:path>
              </a:pathLst>
            </a:custGeom>
            <a:ln w="22444">
              <a:solidFill>
                <a:srgbClr val="5AAA46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703" name="object 703"/>
            <p:cNvSpPr/>
            <p:nvPr/>
          </p:nvSpPr>
          <p:spPr>
            <a:xfrm>
              <a:off x="7227792" y="5073454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40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AAA46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704" name="object 704"/>
          <p:cNvSpPr txBox="1"/>
          <p:nvPr/>
        </p:nvSpPr>
        <p:spPr>
          <a:xfrm>
            <a:off x="7009553" y="5154577"/>
            <a:ext cx="514984" cy="240029"/>
          </a:xfrm>
          <a:prstGeom prst="rect">
            <a:avLst/>
          </a:prstGeom>
        </p:spPr>
        <p:txBody>
          <a:bodyPr wrap="square" lIns="0" tIns="14604" rIns="0" bIns="0" rtlCol="0" vert="horz">
            <a:spAutoFit/>
          </a:bodyPr>
          <a:lstStyle/>
          <a:p>
            <a:pPr algn="ctr">
              <a:lnSpc>
                <a:spcPts val="835"/>
              </a:lnSpc>
              <a:spcBef>
                <a:spcPts val="114"/>
              </a:spcBef>
            </a:pPr>
            <a:r>
              <a:rPr dirty="0" sz="700" spc="-20" b="1">
                <a:latin typeface="Arial"/>
                <a:cs typeface="Arial"/>
              </a:rPr>
              <a:t>Final</a:t>
            </a:r>
            <a:r>
              <a:rPr dirty="0" sz="700" spc="-5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cohort</a:t>
            </a:r>
            <a:endParaRPr sz="700">
              <a:latin typeface="Arial"/>
              <a:cs typeface="Arial"/>
            </a:endParaRPr>
          </a:p>
          <a:p>
            <a:pPr algn="ctr">
              <a:lnSpc>
                <a:spcPts val="835"/>
              </a:lnSpc>
            </a:pPr>
            <a:r>
              <a:rPr dirty="0" sz="700" spc="-25">
                <a:latin typeface="Arial"/>
                <a:cs typeface="Arial"/>
              </a:rPr>
              <a:t>n=6</a:t>
            </a:r>
            <a:endParaRPr sz="700">
              <a:latin typeface="Arial"/>
              <a:cs typeface="Arial"/>
            </a:endParaRPr>
          </a:p>
        </p:txBody>
      </p:sp>
      <p:sp>
        <p:nvSpPr>
          <p:cNvPr id="705" name="object 705"/>
          <p:cNvSpPr txBox="1"/>
          <p:nvPr/>
        </p:nvSpPr>
        <p:spPr>
          <a:xfrm>
            <a:off x="6944744" y="3668918"/>
            <a:ext cx="721360" cy="449580"/>
          </a:xfrm>
          <a:prstGeom prst="rect">
            <a:avLst/>
          </a:prstGeom>
        </p:spPr>
        <p:txBody>
          <a:bodyPr wrap="square" lIns="0" tIns="19685" rIns="0" bIns="0" rtlCol="0" vert="horz">
            <a:spAutoFit/>
          </a:bodyPr>
          <a:lstStyle/>
          <a:p>
            <a:pPr algn="ctr" marL="12700" marR="5080" indent="-635">
              <a:lnSpc>
                <a:spcPts val="830"/>
              </a:lnSpc>
              <a:spcBef>
                <a:spcPts val="155"/>
              </a:spcBef>
            </a:pPr>
            <a:r>
              <a:rPr dirty="0" sz="700" b="1">
                <a:latin typeface="Arial"/>
                <a:cs typeface="Arial"/>
              </a:rPr>
              <a:t>4 </a:t>
            </a:r>
            <a:r>
              <a:rPr dirty="0" sz="700" spc="-10" b="1">
                <a:latin typeface="Arial"/>
                <a:cs typeface="Arial"/>
              </a:rPr>
              <a:t>Hours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0" b="1">
                <a:latin typeface="Arial"/>
                <a:cs typeface="Arial"/>
              </a:rPr>
              <a:t>Reperfusion</a:t>
            </a:r>
            <a:r>
              <a:rPr dirty="0" sz="700" spc="40" b="1">
                <a:latin typeface="Arial"/>
                <a:cs typeface="Arial"/>
              </a:rPr>
              <a:t> </a:t>
            </a:r>
            <a:r>
              <a:rPr dirty="0" sz="700" spc="-25" b="1">
                <a:latin typeface="Arial"/>
                <a:cs typeface="Arial"/>
              </a:rPr>
              <a:t>with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40" b="1">
                <a:latin typeface="Arial"/>
                <a:cs typeface="Arial"/>
              </a:rPr>
              <a:t>RBC</a:t>
            </a:r>
            <a:r>
              <a:rPr dirty="0" sz="700" spc="-20" b="1">
                <a:latin typeface="Arial"/>
                <a:cs typeface="Arial"/>
              </a:rPr>
              <a:t> </a:t>
            </a:r>
            <a:r>
              <a:rPr dirty="0" sz="700" spc="-10" b="1">
                <a:latin typeface="Arial"/>
                <a:cs typeface="Arial"/>
              </a:rPr>
              <a:t>solution</a:t>
            </a:r>
            <a:r>
              <a:rPr dirty="0" sz="700" spc="500" b="1">
                <a:latin typeface="Arial"/>
                <a:cs typeface="Arial"/>
              </a:rPr>
              <a:t> </a:t>
            </a:r>
            <a:r>
              <a:rPr dirty="0" sz="700" spc="-25">
                <a:latin typeface="Arial"/>
                <a:cs typeface="Arial"/>
              </a:rPr>
              <a:t>n=7</a:t>
            </a:r>
            <a:endParaRPr sz="700">
              <a:latin typeface="Arial"/>
              <a:cs typeface="Arial"/>
            </a:endParaRPr>
          </a:p>
        </p:txBody>
      </p:sp>
      <p:grpSp>
        <p:nvGrpSpPr>
          <p:cNvPr id="706" name="object 706"/>
          <p:cNvGrpSpPr/>
          <p:nvPr/>
        </p:nvGrpSpPr>
        <p:grpSpPr>
          <a:xfrm>
            <a:off x="5487870" y="3239267"/>
            <a:ext cx="1818639" cy="377825"/>
            <a:chOff x="5487870" y="3239267"/>
            <a:chExt cx="1818639" cy="377825"/>
          </a:xfrm>
        </p:grpSpPr>
        <p:sp>
          <p:nvSpPr>
            <p:cNvPr id="707" name="object 707"/>
            <p:cNvSpPr/>
            <p:nvPr/>
          </p:nvSpPr>
          <p:spPr>
            <a:xfrm>
              <a:off x="6403218" y="3239267"/>
              <a:ext cx="0" cy="303530"/>
            </a:xfrm>
            <a:custGeom>
              <a:avLst/>
              <a:gdLst/>
              <a:ahLst/>
              <a:cxnLst/>
              <a:rect l="l" t="t" r="r" b="b"/>
              <a:pathLst>
                <a:path w="0" h="303529">
                  <a:moveTo>
                    <a:pt x="0" y="0"/>
                  </a:moveTo>
                  <a:lnTo>
                    <a:pt x="0" y="303007"/>
                  </a:lnTo>
                </a:path>
              </a:pathLst>
            </a:custGeom>
            <a:ln w="22444">
              <a:solidFill>
                <a:srgbClr val="E2D4A9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708" name="object 708"/>
            <p:cNvSpPr/>
            <p:nvPr/>
          </p:nvSpPr>
          <p:spPr>
            <a:xfrm>
              <a:off x="6363941" y="3526607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554" y="0"/>
                  </a:lnTo>
                  <a:lnTo>
                    <a:pt x="39277" y="7855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D4A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09" name="object 709"/>
            <p:cNvSpPr/>
            <p:nvPr/>
          </p:nvSpPr>
          <p:spPr>
            <a:xfrm>
              <a:off x="5527042" y="3299740"/>
              <a:ext cx="876300" cy="254635"/>
            </a:xfrm>
            <a:custGeom>
              <a:avLst/>
              <a:gdLst/>
              <a:ahLst/>
              <a:cxnLst/>
              <a:rect l="l" t="t" r="r" b="b"/>
              <a:pathLst>
                <a:path w="876300" h="254635">
                  <a:moveTo>
                    <a:pt x="876207" y="0"/>
                  </a:moveTo>
                  <a:lnTo>
                    <a:pt x="95249" y="0"/>
                  </a:lnTo>
                  <a:lnTo>
                    <a:pt x="58174" y="7485"/>
                  </a:lnTo>
                  <a:lnTo>
                    <a:pt x="27898" y="27897"/>
                  </a:lnTo>
                  <a:lnTo>
                    <a:pt x="7485" y="58174"/>
                  </a:lnTo>
                  <a:lnTo>
                    <a:pt x="0" y="95250"/>
                  </a:lnTo>
                  <a:lnTo>
                    <a:pt x="0" y="254577"/>
                  </a:lnTo>
                </a:path>
              </a:pathLst>
            </a:custGeom>
            <a:ln w="22383">
              <a:solidFill>
                <a:srgbClr val="E2D4A9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710" name="object 710"/>
            <p:cNvSpPr/>
            <p:nvPr/>
          </p:nvSpPr>
          <p:spPr>
            <a:xfrm>
              <a:off x="5487870" y="3538703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39" h="78739">
                  <a:moveTo>
                    <a:pt x="0" y="0"/>
                  </a:moveTo>
                  <a:lnTo>
                    <a:pt x="78343" y="0"/>
                  </a:lnTo>
                  <a:lnTo>
                    <a:pt x="39171" y="783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E2D4A9"/>
            </a:solidFill>
          </p:spPr>
          <p:txBody>
            <a:bodyPr wrap="square" lIns="0" tIns="0" rIns="0" bIns="0" rtlCol="0"/>
            <a:lstStyle/>
            <a:p/>
          </p:txBody>
        </p:sp>
        <p:sp>
          <p:nvSpPr>
            <p:cNvPr id="711" name="object 711"/>
            <p:cNvSpPr/>
            <p:nvPr/>
          </p:nvSpPr>
          <p:spPr>
            <a:xfrm>
              <a:off x="6412069" y="3299735"/>
              <a:ext cx="855344" cy="249554"/>
            </a:xfrm>
            <a:custGeom>
              <a:avLst/>
              <a:gdLst/>
              <a:ahLst/>
              <a:cxnLst/>
              <a:rect l="l" t="t" r="r" b="b"/>
              <a:pathLst>
                <a:path w="855345" h="249554">
                  <a:moveTo>
                    <a:pt x="855026" y="249042"/>
                  </a:moveTo>
                  <a:lnTo>
                    <a:pt x="855026" y="95250"/>
                  </a:lnTo>
                  <a:lnTo>
                    <a:pt x="847541" y="58174"/>
                  </a:lnTo>
                  <a:lnTo>
                    <a:pt x="827128" y="27898"/>
                  </a:lnTo>
                  <a:lnTo>
                    <a:pt x="796852" y="7485"/>
                  </a:lnTo>
                  <a:lnTo>
                    <a:pt x="759776" y="0"/>
                  </a:lnTo>
                  <a:lnTo>
                    <a:pt x="0" y="0"/>
                  </a:lnTo>
                </a:path>
              </a:pathLst>
            </a:custGeom>
            <a:ln w="22383">
              <a:solidFill>
                <a:srgbClr val="9D343C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712" name="object 712"/>
            <p:cNvSpPr/>
            <p:nvPr/>
          </p:nvSpPr>
          <p:spPr>
            <a:xfrm>
              <a:off x="7227924" y="3533115"/>
              <a:ext cx="78740" cy="78740"/>
            </a:xfrm>
            <a:custGeom>
              <a:avLst/>
              <a:gdLst/>
              <a:ahLst/>
              <a:cxnLst/>
              <a:rect l="l" t="t" r="r" b="b"/>
              <a:pathLst>
                <a:path w="78740" h="78739">
                  <a:moveTo>
                    <a:pt x="0" y="0"/>
                  </a:moveTo>
                  <a:lnTo>
                    <a:pt x="78343" y="0"/>
                  </a:lnTo>
                  <a:lnTo>
                    <a:pt x="39171" y="7834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9D343C"/>
            </a:solidFill>
          </p:spPr>
          <p:txBody>
            <a:bodyPr wrap="square" lIns="0" tIns="0" rIns="0" bIns="0" rtlCol="0"/>
            <a:lstStyle/>
            <a:p/>
          </p:txBody>
        </p:sp>
      </p:grpSp>
      <p:sp>
        <p:nvSpPr>
          <p:cNvPr id="713" name="object 713"/>
          <p:cNvSpPr txBox="1"/>
          <p:nvPr/>
        </p:nvSpPr>
        <p:spPr>
          <a:xfrm>
            <a:off x="400206" y="234436"/>
            <a:ext cx="145415" cy="238760"/>
          </a:xfrm>
          <a:prstGeom prst="rect">
            <a:avLst/>
          </a:prstGeom>
        </p:spPr>
        <p:txBody>
          <a:bodyPr wrap="square" lIns="0" tIns="12700" rIns="0" bIns="0" rtlCol="0" vert="horz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dirty="0" sz="1400" spc="-50" b="1">
                <a:latin typeface="Arial"/>
                <a:cs typeface="Arial"/>
              </a:rPr>
              <a:t>A</a:t>
            </a:r>
            <a:endParaRPr sz="140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Microsoft Office PowerPoint</Application>
  <PresentationFormat>On-screen Show (4:3)</PresentationFormat>
  <ScaleCrop>false</ScaleCrop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6-01-06T11:51:37Z</dcterms:created>
  <dcterms:modified xsi:type="dcterms:W3CDTF">2026-01-06T11:51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5-07-26T00:00:00Z</vt:filetime>
  </property>
  <property fmtid="{D5CDD505-2E9C-101B-9397-08002B2CF9AE}" pid="3" name="Creator">
    <vt:lpwstr>PDFKit</vt:lpwstr>
  </property>
  <property fmtid="{D5CDD505-2E9C-101B-9397-08002B2CF9AE}" pid="4" name="LastSaved">
    <vt:filetime>2026-01-06T00:00:00Z</vt:filetime>
  </property>
  <property fmtid="{D5CDD505-2E9C-101B-9397-08002B2CF9AE}" pid="5" name="Producer">
    <vt:lpwstr>PDFKit</vt:lpwstr>
  </property>
</Properties>
</file>